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7"/>
  </p:normalViewPr>
  <p:slideViewPr>
    <p:cSldViewPr snapToObjects="1">
      <p:cViewPr varScale="1">
        <p:scale>
          <a:sx n="78" d="100"/>
          <a:sy n="78" d="100"/>
        </p:scale>
        <p:origin x="3160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7BC379-32A7-2D4C-8789-809E0CD83E5C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8F3568-5268-E543-A81B-272DF85E704C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A661B-0A39-524D-B843-540E1A65FE04}" type="datetimeFigureOut">
              <a:rPr lang="fr-FR" smtClean="0"/>
              <a:pPr/>
              <a:t>21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/>
          <p:cNvSpPr txBox="1"/>
          <p:nvPr/>
        </p:nvSpPr>
        <p:spPr>
          <a:xfrm>
            <a:off x="4191000" y="8305800"/>
            <a:ext cx="2454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5: Le Deunff et al., 2019</a:t>
            </a:r>
          </a:p>
        </p:txBody>
      </p:sp>
      <p:sp>
        <p:nvSpPr>
          <p:cNvPr id="3" name="TextBox 3"/>
          <p:cNvSpPr txBox="1"/>
          <p:nvPr/>
        </p:nvSpPr>
        <p:spPr>
          <a:xfrm>
            <a:off x="319635" y="5561111"/>
            <a:ext cx="632588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noProof="1" smtClean="0">
                <a:latin typeface="Times New Roman" pitchFamily="18" charset="0"/>
                <a:cs typeface="Times New Roman" pitchFamily="18" charset="0"/>
              </a:rPr>
              <a:t>Fig. S5: </a:t>
            </a:r>
            <a:r>
              <a:rPr lang="en-GB" sz="1200" noProof="1" smtClean="0">
                <a:latin typeface="Times New Roman"/>
                <a:cs typeface="Times New Roman"/>
              </a:rPr>
              <a:t>Mean </a:t>
            </a:r>
            <a:r>
              <a:rPr lang="en-GB" sz="1200" noProof="1" smtClean="0">
                <a:solidFill>
                  <a:srgbClr val="000000"/>
                </a:solidFill>
                <a:latin typeface="Times New Roman"/>
                <a:cs typeface="Times New Roman"/>
              </a:rPr>
              <a:t>contents</a:t>
            </a:r>
            <a:r>
              <a:rPr lang="en-GB" sz="1200" noProof="1" smtClean="0">
                <a:latin typeface="Times New Roman"/>
                <a:cs typeface="Times New Roman"/>
              </a:rPr>
              <a:t> of amino acid families in the roots (A) and shoots (B) tissues of </a:t>
            </a:r>
            <a:r>
              <a:rPr lang="en-GB" sz="1200" i="1" noProof="1" smtClean="0">
                <a:latin typeface="Times New Roman"/>
                <a:cs typeface="Times New Roman"/>
              </a:rPr>
              <a:t>Brassica napus </a:t>
            </a:r>
            <a:r>
              <a:rPr lang="en-GB" sz="1200" noProof="1" smtClean="0">
                <a:latin typeface="Times New Roman"/>
                <a:cs typeface="Times New Roman"/>
              </a:rPr>
              <a:t>seedlings treated with 10 </a:t>
            </a:r>
            <a:r>
              <a:rPr lang="en-GB" sz="1200" noProof="1" smtClean="0">
                <a:latin typeface="Symbol" charset="2"/>
                <a:cs typeface="Symbol" charset="2"/>
              </a:rPr>
              <a:t>m</a:t>
            </a:r>
            <a:r>
              <a:rPr lang="en-GB" sz="1200" noProof="1" smtClean="0">
                <a:latin typeface="Times New Roman"/>
                <a:cs typeface="Times New Roman"/>
              </a:rPr>
              <a:t>M AVG or 10 </a:t>
            </a:r>
            <a:r>
              <a:rPr lang="en-GB" sz="1200" noProof="1" smtClean="0">
                <a:latin typeface="Symbol" charset="2"/>
                <a:cs typeface="Symbol" charset="2"/>
              </a:rPr>
              <a:t>m</a:t>
            </a:r>
            <a:r>
              <a:rPr lang="en-GB" sz="1200" noProof="1" smtClean="0">
                <a:latin typeface="Times New Roman"/>
                <a:cs typeface="Times New Roman"/>
              </a:rPr>
              <a:t>M AVG + 1 mM Glu relative to those in KNO</a:t>
            </a:r>
            <a:r>
              <a:rPr lang="en-GB" sz="1200" baseline="-25000" noProof="1" smtClean="0">
                <a:latin typeface="Times New Roman"/>
                <a:cs typeface="Times New Roman"/>
              </a:rPr>
              <a:t>3</a:t>
            </a:r>
            <a:r>
              <a:rPr lang="en-GB" sz="1200" noProof="1" smtClean="0">
                <a:latin typeface="Times New Roman"/>
                <a:cs typeface="Times New Roman"/>
              </a:rPr>
              <a:t> treated seedlings (control). Seedlings were growing on agar plates under homogeneous feeding of 1 mM KNO</a:t>
            </a:r>
            <a:r>
              <a:rPr lang="en-GB" sz="1200" baseline="-25000" noProof="1" smtClean="0">
                <a:latin typeface="Times New Roman"/>
                <a:cs typeface="Times New Roman"/>
              </a:rPr>
              <a:t>3</a:t>
            </a:r>
            <a:r>
              <a:rPr lang="en-GB" sz="1200" noProof="1" smtClean="0">
                <a:latin typeface="Times New Roman"/>
                <a:cs typeface="Times New Roman"/>
              </a:rPr>
              <a:t> whatever the treatment. </a:t>
            </a:r>
            <a:r>
              <a:rPr lang="en-GB" sz="1200" noProof="1" smtClean="0">
                <a:latin typeface="Times New Roman" pitchFamily="18" charset="0"/>
                <a:cs typeface="Times New Roman" pitchFamily="18" charset="0"/>
              </a:rPr>
              <a:t>Values are the average (</a:t>
            </a:r>
            <a:r>
              <a:rPr lang="en-GB" sz="1200" noProof="1" smtClean="0"/>
              <a:t>± </a:t>
            </a:r>
            <a:r>
              <a:rPr lang="en-GB" sz="1200" noProof="1" smtClean="0">
                <a:latin typeface="Times New Roman" pitchFamily="18" charset="0"/>
                <a:cs typeface="Times New Roman" pitchFamily="18" charset="0"/>
              </a:rPr>
              <a:t>SE) of 3 agar plates (n = 3) of four seedlings each.</a:t>
            </a:r>
            <a:r>
              <a:rPr lang="en-GB" sz="1200" noProof="1" smtClean="0"/>
              <a:t> </a:t>
            </a:r>
            <a:r>
              <a:rPr lang="en-GB" sz="1200" noProof="1" smtClean="0">
                <a:latin typeface="Times New Roman"/>
                <a:cs typeface="Times New Roman"/>
              </a:rPr>
              <a:t>A significant difference in amino acid ratio is indicated by * P&lt;0.05 (Benjamini and Hochberg correction for multiple t-test analyses with a false discovery rate of 0.05 between the treatments and KNO</a:t>
            </a:r>
            <a:r>
              <a:rPr lang="en-GB" sz="1200" baseline="-25000" noProof="1" smtClean="0">
                <a:latin typeface="Times New Roman"/>
                <a:cs typeface="Times New Roman"/>
              </a:rPr>
              <a:t>3</a:t>
            </a:r>
            <a:r>
              <a:rPr lang="en-GB" sz="1200" noProof="1" smtClean="0">
                <a:latin typeface="Times New Roman"/>
                <a:cs typeface="Times New Roman"/>
              </a:rPr>
              <a:t> control plants have been done). The composition of the amino acid families is as follows: Pentose-P (His), </a:t>
            </a:r>
            <a:r>
              <a:rPr lang="en-GB" sz="1200" noProof="1" smtClean="0">
                <a:solidFill>
                  <a:srgbClr val="000000"/>
                </a:solidFill>
                <a:latin typeface="Symbol" charset="2"/>
                <a:cs typeface="Symbol" charset="2"/>
              </a:rPr>
              <a:t>a</a:t>
            </a:r>
            <a:r>
              <a:rPr lang="en-GB" sz="1200" noProof="1" smtClean="0">
                <a:solidFill>
                  <a:srgbClr val="000000"/>
                </a:solidFill>
                <a:latin typeface="Times New Roman"/>
                <a:cs typeface="Times New Roman"/>
              </a:rPr>
              <a:t>-KG (</a:t>
            </a:r>
            <a:r>
              <a:rPr lang="en-GB" sz="1200" noProof="1" smtClean="0">
                <a:latin typeface="Times New Roman"/>
                <a:cs typeface="Times New Roman"/>
              </a:rPr>
              <a:t>Glu, Gln, Arg, </a:t>
            </a:r>
            <a:r>
              <a:rPr lang="en-GB" sz="1200" noProof="1" smtClean="0">
                <a:solidFill>
                  <a:srgbClr val="000000"/>
                </a:solidFill>
                <a:latin typeface="Times New Roman"/>
                <a:cs typeface="Times New Roman"/>
              </a:rPr>
              <a:t>GABA</a:t>
            </a:r>
            <a:r>
              <a:rPr lang="en-GB" sz="1200" noProof="1" smtClean="0">
                <a:latin typeface="Times New Roman"/>
                <a:cs typeface="Times New Roman"/>
              </a:rPr>
              <a:t> and Pro), Aspartate (Asn, Asp, Thr, Met, Ile and Lys), PEP (Trp, Phe and Tyr), Pyruvate (</a:t>
            </a:r>
            <a:r>
              <a:rPr lang="en-GB" sz="1200" noProof="1" smtClean="0">
                <a:latin typeface="Symbol" charset="2"/>
                <a:cs typeface="Symbol" charset="2"/>
              </a:rPr>
              <a:t>a</a:t>
            </a:r>
            <a:r>
              <a:rPr lang="en-GB" sz="1200" noProof="1" smtClean="0">
                <a:latin typeface="Times New Roman"/>
                <a:cs typeface="Times New Roman"/>
              </a:rPr>
              <a:t>-Ala; </a:t>
            </a:r>
            <a:r>
              <a:rPr lang="en-GB" sz="1200" noProof="1" smtClean="0">
                <a:latin typeface="Symbol" charset="2"/>
                <a:cs typeface="Symbol" charset="2"/>
              </a:rPr>
              <a:t>b</a:t>
            </a:r>
            <a:r>
              <a:rPr lang="en-GB" sz="1200" noProof="1" smtClean="0">
                <a:latin typeface="Times New Roman"/>
                <a:cs typeface="Times New Roman"/>
              </a:rPr>
              <a:t>-Ala, Val and Leu) and GA3P (Ser and Gly). </a:t>
            </a:r>
          </a:p>
          <a:p>
            <a:pPr algn="just"/>
            <a:endParaRPr lang="en-GB" sz="1200" noProof="1" smtClean="0">
              <a:latin typeface="Times New Roman"/>
              <a:cs typeface="Times New Roman"/>
            </a:endParaRPr>
          </a:p>
          <a:p>
            <a:pPr algn="just"/>
            <a:endParaRPr lang="en-GB" sz="1200" noProof="1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" name="Grouper 322"/>
          <p:cNvGrpSpPr/>
          <p:nvPr/>
        </p:nvGrpSpPr>
        <p:grpSpPr>
          <a:xfrm>
            <a:off x="1704200" y="325291"/>
            <a:ext cx="3248800" cy="2580555"/>
            <a:chOff x="1704200" y="325291"/>
            <a:chExt cx="3248800" cy="2580555"/>
          </a:xfrm>
        </p:grpSpPr>
        <p:grpSp>
          <p:nvGrpSpPr>
            <p:cNvPr id="5" name="Grouper 236"/>
            <p:cNvGrpSpPr/>
            <p:nvPr/>
          </p:nvGrpSpPr>
          <p:grpSpPr>
            <a:xfrm>
              <a:off x="2046282" y="640483"/>
              <a:ext cx="128240" cy="1815697"/>
              <a:chOff x="1608138" y="1468438"/>
              <a:chExt cx="100577" cy="2499957"/>
            </a:xfrm>
          </p:grpSpPr>
          <p:sp>
            <p:nvSpPr>
              <p:cNvPr id="238" name="Rectangle 115"/>
              <p:cNvSpPr>
                <a:spLocks noChangeArrowheads="1"/>
              </p:cNvSpPr>
              <p:nvPr/>
            </p:nvSpPr>
            <p:spPr bwMode="auto">
              <a:xfrm>
                <a:off x="1608138" y="3798889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0.0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39" name="Rectangle 116"/>
              <p:cNvSpPr>
                <a:spLocks noChangeArrowheads="1"/>
              </p:cNvSpPr>
              <p:nvPr/>
            </p:nvSpPr>
            <p:spPr bwMode="auto">
              <a:xfrm>
                <a:off x="1608138" y="3409950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0.5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40" name="Rectangle 117"/>
              <p:cNvSpPr>
                <a:spLocks noChangeArrowheads="1"/>
              </p:cNvSpPr>
              <p:nvPr/>
            </p:nvSpPr>
            <p:spPr bwMode="auto">
              <a:xfrm>
                <a:off x="1608138" y="3022600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1.0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41" name="Rectangle 118"/>
              <p:cNvSpPr>
                <a:spLocks noChangeArrowheads="1"/>
              </p:cNvSpPr>
              <p:nvPr/>
            </p:nvSpPr>
            <p:spPr bwMode="auto">
              <a:xfrm>
                <a:off x="1608138" y="2633663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1.5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42" name="Rectangle 119"/>
              <p:cNvSpPr>
                <a:spLocks noChangeArrowheads="1"/>
              </p:cNvSpPr>
              <p:nvPr/>
            </p:nvSpPr>
            <p:spPr bwMode="auto">
              <a:xfrm>
                <a:off x="1608138" y="2244724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2.0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43" name="Rectangle 120"/>
              <p:cNvSpPr>
                <a:spLocks noChangeArrowheads="1"/>
              </p:cNvSpPr>
              <p:nvPr/>
            </p:nvSpPr>
            <p:spPr bwMode="auto">
              <a:xfrm>
                <a:off x="1608138" y="1857376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2.5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44" name="Rectangle 121"/>
              <p:cNvSpPr>
                <a:spLocks noChangeArrowheads="1"/>
              </p:cNvSpPr>
              <p:nvPr/>
            </p:nvSpPr>
            <p:spPr bwMode="auto">
              <a:xfrm>
                <a:off x="1608138" y="1468438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3.0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</p:grpSp>
        <p:sp>
          <p:nvSpPr>
            <p:cNvPr id="245" name="Rectangle 122"/>
            <p:cNvSpPr>
              <a:spLocks noChangeArrowheads="1"/>
            </p:cNvSpPr>
            <p:nvPr/>
          </p:nvSpPr>
          <p:spPr bwMode="auto">
            <a:xfrm>
              <a:off x="2324645" y="2448645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Pentose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46" name="Rectangle 123"/>
            <p:cNvSpPr>
              <a:spLocks noChangeArrowheads="1"/>
            </p:cNvSpPr>
            <p:nvPr/>
          </p:nvSpPr>
          <p:spPr bwMode="auto">
            <a:xfrm>
              <a:off x="2819400" y="2448645"/>
              <a:ext cx="21079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Keto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47" name="Rectangle 124"/>
            <p:cNvSpPr>
              <a:spLocks noChangeArrowheads="1"/>
            </p:cNvSpPr>
            <p:nvPr/>
          </p:nvSpPr>
          <p:spPr bwMode="auto">
            <a:xfrm>
              <a:off x="3276600" y="2448645"/>
              <a:ext cx="19236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PEP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48" name="Rectangle 125"/>
            <p:cNvSpPr>
              <a:spLocks noChangeArrowheads="1"/>
            </p:cNvSpPr>
            <p:nvPr/>
          </p:nvSpPr>
          <p:spPr bwMode="auto">
            <a:xfrm>
              <a:off x="3693096" y="2448645"/>
              <a:ext cx="2693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GA3P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49" name="Rectangle 126"/>
            <p:cNvSpPr>
              <a:spLocks noChangeArrowheads="1"/>
            </p:cNvSpPr>
            <p:nvPr/>
          </p:nvSpPr>
          <p:spPr bwMode="auto">
            <a:xfrm>
              <a:off x="4085431" y="2448645"/>
              <a:ext cx="4103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Pyruvate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50" name="Rectangle 127"/>
            <p:cNvSpPr>
              <a:spLocks noChangeArrowheads="1"/>
            </p:cNvSpPr>
            <p:nvPr/>
          </p:nvSpPr>
          <p:spPr bwMode="auto">
            <a:xfrm>
              <a:off x="4495800" y="2448645"/>
              <a:ext cx="4360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Aspartate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251" name="Rectangle 75"/>
            <p:cNvSpPr>
              <a:spLocks noChangeArrowheads="1"/>
            </p:cNvSpPr>
            <p:nvPr/>
          </p:nvSpPr>
          <p:spPr bwMode="auto">
            <a:xfrm>
              <a:off x="2355096" y="1102299"/>
              <a:ext cx="127296" cy="131865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52" name="Freeform 76"/>
            <p:cNvSpPr>
              <a:spLocks noEditPoints="1"/>
            </p:cNvSpPr>
            <p:nvPr/>
          </p:nvSpPr>
          <p:spPr bwMode="auto">
            <a:xfrm>
              <a:off x="2350381" y="1097672"/>
              <a:ext cx="136725" cy="1327907"/>
            </a:xfrm>
            <a:custGeom>
              <a:avLst/>
              <a:gdLst>
                <a:gd name="T0" fmla="*/ 0 w 1936"/>
                <a:gd name="T1" fmla="*/ 64 h 19136"/>
                <a:gd name="T2" fmla="*/ 64 w 1936"/>
                <a:gd name="T3" fmla="*/ 0 h 19136"/>
                <a:gd name="T4" fmla="*/ 1872 w 1936"/>
                <a:gd name="T5" fmla="*/ 0 h 19136"/>
                <a:gd name="T6" fmla="*/ 1936 w 1936"/>
                <a:gd name="T7" fmla="*/ 64 h 19136"/>
                <a:gd name="T8" fmla="*/ 1936 w 1936"/>
                <a:gd name="T9" fmla="*/ 19072 h 19136"/>
                <a:gd name="T10" fmla="*/ 1872 w 1936"/>
                <a:gd name="T11" fmla="*/ 19136 h 19136"/>
                <a:gd name="T12" fmla="*/ 64 w 1936"/>
                <a:gd name="T13" fmla="*/ 19136 h 19136"/>
                <a:gd name="T14" fmla="*/ 0 w 1936"/>
                <a:gd name="T15" fmla="*/ 19072 h 19136"/>
                <a:gd name="T16" fmla="*/ 0 w 1936"/>
                <a:gd name="T17" fmla="*/ 64 h 19136"/>
                <a:gd name="T18" fmla="*/ 128 w 1936"/>
                <a:gd name="T19" fmla="*/ 19072 h 19136"/>
                <a:gd name="T20" fmla="*/ 64 w 1936"/>
                <a:gd name="T21" fmla="*/ 19008 h 19136"/>
                <a:gd name="T22" fmla="*/ 1872 w 1936"/>
                <a:gd name="T23" fmla="*/ 19008 h 19136"/>
                <a:gd name="T24" fmla="*/ 1808 w 1936"/>
                <a:gd name="T25" fmla="*/ 19072 h 19136"/>
                <a:gd name="T26" fmla="*/ 1808 w 1936"/>
                <a:gd name="T27" fmla="*/ 64 h 19136"/>
                <a:gd name="T28" fmla="*/ 1872 w 1936"/>
                <a:gd name="T29" fmla="*/ 128 h 19136"/>
                <a:gd name="T30" fmla="*/ 64 w 1936"/>
                <a:gd name="T31" fmla="*/ 128 h 19136"/>
                <a:gd name="T32" fmla="*/ 128 w 1936"/>
                <a:gd name="T33" fmla="*/ 64 h 19136"/>
                <a:gd name="T34" fmla="*/ 128 w 1936"/>
                <a:gd name="T35" fmla="*/ 19072 h 19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36" h="19136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72" y="0"/>
                  </a:lnTo>
                  <a:cubicBezTo>
                    <a:pt x="1908" y="0"/>
                    <a:pt x="1936" y="29"/>
                    <a:pt x="1936" y="64"/>
                  </a:cubicBezTo>
                  <a:lnTo>
                    <a:pt x="1936" y="19072"/>
                  </a:lnTo>
                  <a:cubicBezTo>
                    <a:pt x="1936" y="19108"/>
                    <a:pt x="1908" y="19136"/>
                    <a:pt x="1872" y="19136"/>
                  </a:cubicBezTo>
                  <a:lnTo>
                    <a:pt x="64" y="19136"/>
                  </a:lnTo>
                  <a:cubicBezTo>
                    <a:pt x="29" y="19136"/>
                    <a:pt x="0" y="19108"/>
                    <a:pt x="0" y="19072"/>
                  </a:cubicBezTo>
                  <a:lnTo>
                    <a:pt x="0" y="64"/>
                  </a:lnTo>
                  <a:close/>
                  <a:moveTo>
                    <a:pt x="128" y="19072"/>
                  </a:moveTo>
                  <a:lnTo>
                    <a:pt x="64" y="19008"/>
                  </a:lnTo>
                  <a:lnTo>
                    <a:pt x="1872" y="19008"/>
                  </a:lnTo>
                  <a:lnTo>
                    <a:pt x="1808" y="19072"/>
                  </a:lnTo>
                  <a:lnTo>
                    <a:pt x="1808" y="64"/>
                  </a:lnTo>
                  <a:lnTo>
                    <a:pt x="187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907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53" name="Rectangle 77"/>
            <p:cNvSpPr>
              <a:spLocks noChangeArrowheads="1"/>
            </p:cNvSpPr>
            <p:nvPr/>
          </p:nvSpPr>
          <p:spPr bwMode="auto">
            <a:xfrm>
              <a:off x="2801809" y="1463193"/>
              <a:ext cx="127296" cy="95775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54" name="Freeform 78"/>
            <p:cNvSpPr>
              <a:spLocks noEditPoints="1"/>
            </p:cNvSpPr>
            <p:nvPr/>
          </p:nvSpPr>
          <p:spPr bwMode="auto">
            <a:xfrm>
              <a:off x="2797095" y="1458566"/>
              <a:ext cx="136725" cy="967012"/>
            </a:xfrm>
            <a:custGeom>
              <a:avLst/>
              <a:gdLst>
                <a:gd name="T0" fmla="*/ 0 w 1936"/>
                <a:gd name="T1" fmla="*/ 64 h 13936"/>
                <a:gd name="T2" fmla="*/ 64 w 1936"/>
                <a:gd name="T3" fmla="*/ 0 h 13936"/>
                <a:gd name="T4" fmla="*/ 1872 w 1936"/>
                <a:gd name="T5" fmla="*/ 0 h 13936"/>
                <a:gd name="T6" fmla="*/ 1936 w 1936"/>
                <a:gd name="T7" fmla="*/ 64 h 13936"/>
                <a:gd name="T8" fmla="*/ 1936 w 1936"/>
                <a:gd name="T9" fmla="*/ 13872 h 13936"/>
                <a:gd name="T10" fmla="*/ 1872 w 1936"/>
                <a:gd name="T11" fmla="*/ 13936 h 13936"/>
                <a:gd name="T12" fmla="*/ 64 w 1936"/>
                <a:gd name="T13" fmla="*/ 13936 h 13936"/>
                <a:gd name="T14" fmla="*/ 0 w 1936"/>
                <a:gd name="T15" fmla="*/ 13872 h 13936"/>
                <a:gd name="T16" fmla="*/ 0 w 1936"/>
                <a:gd name="T17" fmla="*/ 64 h 13936"/>
                <a:gd name="T18" fmla="*/ 128 w 1936"/>
                <a:gd name="T19" fmla="*/ 13872 h 13936"/>
                <a:gd name="T20" fmla="*/ 64 w 1936"/>
                <a:gd name="T21" fmla="*/ 13808 h 13936"/>
                <a:gd name="T22" fmla="*/ 1872 w 1936"/>
                <a:gd name="T23" fmla="*/ 13808 h 13936"/>
                <a:gd name="T24" fmla="*/ 1808 w 1936"/>
                <a:gd name="T25" fmla="*/ 13872 h 13936"/>
                <a:gd name="T26" fmla="*/ 1808 w 1936"/>
                <a:gd name="T27" fmla="*/ 64 h 13936"/>
                <a:gd name="T28" fmla="*/ 1872 w 1936"/>
                <a:gd name="T29" fmla="*/ 128 h 13936"/>
                <a:gd name="T30" fmla="*/ 64 w 1936"/>
                <a:gd name="T31" fmla="*/ 128 h 13936"/>
                <a:gd name="T32" fmla="*/ 128 w 1936"/>
                <a:gd name="T33" fmla="*/ 64 h 13936"/>
                <a:gd name="T34" fmla="*/ 128 w 1936"/>
                <a:gd name="T35" fmla="*/ 13872 h 139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36" h="13936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72" y="0"/>
                  </a:lnTo>
                  <a:cubicBezTo>
                    <a:pt x="1908" y="0"/>
                    <a:pt x="1936" y="29"/>
                    <a:pt x="1936" y="64"/>
                  </a:cubicBezTo>
                  <a:lnTo>
                    <a:pt x="1936" y="13872"/>
                  </a:lnTo>
                  <a:cubicBezTo>
                    <a:pt x="1936" y="13908"/>
                    <a:pt x="1908" y="13936"/>
                    <a:pt x="1872" y="13936"/>
                  </a:cubicBezTo>
                  <a:lnTo>
                    <a:pt x="64" y="13936"/>
                  </a:lnTo>
                  <a:cubicBezTo>
                    <a:pt x="29" y="13936"/>
                    <a:pt x="0" y="13908"/>
                    <a:pt x="0" y="13872"/>
                  </a:cubicBezTo>
                  <a:lnTo>
                    <a:pt x="0" y="64"/>
                  </a:lnTo>
                  <a:close/>
                  <a:moveTo>
                    <a:pt x="128" y="13872"/>
                  </a:moveTo>
                  <a:lnTo>
                    <a:pt x="64" y="13808"/>
                  </a:lnTo>
                  <a:lnTo>
                    <a:pt x="1872" y="13808"/>
                  </a:lnTo>
                  <a:lnTo>
                    <a:pt x="1808" y="13872"/>
                  </a:lnTo>
                  <a:lnTo>
                    <a:pt x="1808" y="64"/>
                  </a:lnTo>
                  <a:lnTo>
                    <a:pt x="187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387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55" name="Rectangle 79"/>
            <p:cNvSpPr>
              <a:spLocks noChangeArrowheads="1"/>
            </p:cNvSpPr>
            <p:nvPr/>
          </p:nvSpPr>
          <p:spPr bwMode="auto">
            <a:xfrm>
              <a:off x="3248523" y="1580022"/>
              <a:ext cx="128474" cy="84093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56" name="Freeform 80"/>
            <p:cNvSpPr>
              <a:spLocks noEditPoints="1"/>
            </p:cNvSpPr>
            <p:nvPr/>
          </p:nvSpPr>
          <p:spPr bwMode="auto">
            <a:xfrm>
              <a:off x="3243809" y="1576551"/>
              <a:ext cx="137903" cy="849027"/>
            </a:xfrm>
            <a:custGeom>
              <a:avLst/>
              <a:gdLst>
                <a:gd name="T0" fmla="*/ 0 w 1936"/>
                <a:gd name="T1" fmla="*/ 64 h 12240"/>
                <a:gd name="T2" fmla="*/ 64 w 1936"/>
                <a:gd name="T3" fmla="*/ 0 h 12240"/>
                <a:gd name="T4" fmla="*/ 1872 w 1936"/>
                <a:gd name="T5" fmla="*/ 0 h 12240"/>
                <a:gd name="T6" fmla="*/ 1936 w 1936"/>
                <a:gd name="T7" fmla="*/ 64 h 12240"/>
                <a:gd name="T8" fmla="*/ 1936 w 1936"/>
                <a:gd name="T9" fmla="*/ 12176 h 12240"/>
                <a:gd name="T10" fmla="*/ 1872 w 1936"/>
                <a:gd name="T11" fmla="*/ 12240 h 12240"/>
                <a:gd name="T12" fmla="*/ 64 w 1936"/>
                <a:gd name="T13" fmla="*/ 12240 h 12240"/>
                <a:gd name="T14" fmla="*/ 0 w 1936"/>
                <a:gd name="T15" fmla="*/ 12176 h 12240"/>
                <a:gd name="T16" fmla="*/ 0 w 1936"/>
                <a:gd name="T17" fmla="*/ 64 h 12240"/>
                <a:gd name="T18" fmla="*/ 128 w 1936"/>
                <a:gd name="T19" fmla="*/ 12176 h 12240"/>
                <a:gd name="T20" fmla="*/ 64 w 1936"/>
                <a:gd name="T21" fmla="*/ 12112 h 12240"/>
                <a:gd name="T22" fmla="*/ 1872 w 1936"/>
                <a:gd name="T23" fmla="*/ 12112 h 12240"/>
                <a:gd name="T24" fmla="*/ 1808 w 1936"/>
                <a:gd name="T25" fmla="*/ 12176 h 12240"/>
                <a:gd name="T26" fmla="*/ 1808 w 1936"/>
                <a:gd name="T27" fmla="*/ 64 h 12240"/>
                <a:gd name="T28" fmla="*/ 1872 w 1936"/>
                <a:gd name="T29" fmla="*/ 128 h 12240"/>
                <a:gd name="T30" fmla="*/ 64 w 1936"/>
                <a:gd name="T31" fmla="*/ 128 h 12240"/>
                <a:gd name="T32" fmla="*/ 128 w 1936"/>
                <a:gd name="T33" fmla="*/ 64 h 12240"/>
                <a:gd name="T34" fmla="*/ 128 w 1936"/>
                <a:gd name="T35" fmla="*/ 12176 h 12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36" h="12240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72" y="0"/>
                  </a:lnTo>
                  <a:cubicBezTo>
                    <a:pt x="1908" y="0"/>
                    <a:pt x="1936" y="29"/>
                    <a:pt x="1936" y="64"/>
                  </a:cubicBezTo>
                  <a:lnTo>
                    <a:pt x="1936" y="12176"/>
                  </a:lnTo>
                  <a:cubicBezTo>
                    <a:pt x="1936" y="12212"/>
                    <a:pt x="1908" y="12240"/>
                    <a:pt x="1872" y="12240"/>
                  </a:cubicBezTo>
                  <a:lnTo>
                    <a:pt x="64" y="12240"/>
                  </a:lnTo>
                  <a:cubicBezTo>
                    <a:pt x="29" y="12240"/>
                    <a:pt x="0" y="12212"/>
                    <a:pt x="0" y="12176"/>
                  </a:cubicBezTo>
                  <a:lnTo>
                    <a:pt x="0" y="64"/>
                  </a:lnTo>
                  <a:close/>
                  <a:moveTo>
                    <a:pt x="128" y="12176"/>
                  </a:moveTo>
                  <a:lnTo>
                    <a:pt x="64" y="12112"/>
                  </a:lnTo>
                  <a:lnTo>
                    <a:pt x="1872" y="12112"/>
                  </a:lnTo>
                  <a:lnTo>
                    <a:pt x="1808" y="12176"/>
                  </a:lnTo>
                  <a:lnTo>
                    <a:pt x="1808" y="64"/>
                  </a:lnTo>
                  <a:lnTo>
                    <a:pt x="187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2176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57" name="Rectangle 81"/>
            <p:cNvSpPr>
              <a:spLocks noChangeArrowheads="1"/>
            </p:cNvSpPr>
            <p:nvPr/>
          </p:nvSpPr>
          <p:spPr bwMode="auto">
            <a:xfrm>
              <a:off x="3695237" y="1598529"/>
              <a:ext cx="128474" cy="82242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58" name="Freeform 82"/>
            <p:cNvSpPr>
              <a:spLocks noEditPoints="1"/>
            </p:cNvSpPr>
            <p:nvPr/>
          </p:nvSpPr>
          <p:spPr bwMode="auto">
            <a:xfrm>
              <a:off x="3691701" y="1593902"/>
              <a:ext cx="136725" cy="831677"/>
            </a:xfrm>
            <a:custGeom>
              <a:avLst/>
              <a:gdLst>
                <a:gd name="T0" fmla="*/ 0 w 1936"/>
                <a:gd name="T1" fmla="*/ 64 h 11984"/>
                <a:gd name="T2" fmla="*/ 64 w 1936"/>
                <a:gd name="T3" fmla="*/ 0 h 11984"/>
                <a:gd name="T4" fmla="*/ 1872 w 1936"/>
                <a:gd name="T5" fmla="*/ 0 h 11984"/>
                <a:gd name="T6" fmla="*/ 1936 w 1936"/>
                <a:gd name="T7" fmla="*/ 64 h 11984"/>
                <a:gd name="T8" fmla="*/ 1936 w 1936"/>
                <a:gd name="T9" fmla="*/ 11920 h 11984"/>
                <a:gd name="T10" fmla="*/ 1872 w 1936"/>
                <a:gd name="T11" fmla="*/ 11984 h 11984"/>
                <a:gd name="T12" fmla="*/ 64 w 1936"/>
                <a:gd name="T13" fmla="*/ 11984 h 11984"/>
                <a:gd name="T14" fmla="*/ 0 w 1936"/>
                <a:gd name="T15" fmla="*/ 11920 h 11984"/>
                <a:gd name="T16" fmla="*/ 0 w 1936"/>
                <a:gd name="T17" fmla="*/ 64 h 11984"/>
                <a:gd name="T18" fmla="*/ 128 w 1936"/>
                <a:gd name="T19" fmla="*/ 11920 h 11984"/>
                <a:gd name="T20" fmla="*/ 64 w 1936"/>
                <a:gd name="T21" fmla="*/ 11856 h 11984"/>
                <a:gd name="T22" fmla="*/ 1872 w 1936"/>
                <a:gd name="T23" fmla="*/ 11856 h 11984"/>
                <a:gd name="T24" fmla="*/ 1808 w 1936"/>
                <a:gd name="T25" fmla="*/ 11920 h 11984"/>
                <a:gd name="T26" fmla="*/ 1808 w 1936"/>
                <a:gd name="T27" fmla="*/ 64 h 11984"/>
                <a:gd name="T28" fmla="*/ 1872 w 1936"/>
                <a:gd name="T29" fmla="*/ 128 h 11984"/>
                <a:gd name="T30" fmla="*/ 64 w 1936"/>
                <a:gd name="T31" fmla="*/ 128 h 11984"/>
                <a:gd name="T32" fmla="*/ 128 w 1936"/>
                <a:gd name="T33" fmla="*/ 64 h 11984"/>
                <a:gd name="T34" fmla="*/ 128 w 1936"/>
                <a:gd name="T35" fmla="*/ 11920 h 119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36" h="11984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72" y="0"/>
                  </a:lnTo>
                  <a:cubicBezTo>
                    <a:pt x="1908" y="0"/>
                    <a:pt x="1936" y="29"/>
                    <a:pt x="1936" y="64"/>
                  </a:cubicBezTo>
                  <a:lnTo>
                    <a:pt x="1936" y="11920"/>
                  </a:lnTo>
                  <a:cubicBezTo>
                    <a:pt x="1936" y="11956"/>
                    <a:pt x="1908" y="11984"/>
                    <a:pt x="1872" y="11984"/>
                  </a:cubicBezTo>
                  <a:lnTo>
                    <a:pt x="64" y="11984"/>
                  </a:lnTo>
                  <a:cubicBezTo>
                    <a:pt x="29" y="11984"/>
                    <a:pt x="0" y="11956"/>
                    <a:pt x="0" y="11920"/>
                  </a:cubicBezTo>
                  <a:lnTo>
                    <a:pt x="0" y="64"/>
                  </a:lnTo>
                  <a:close/>
                  <a:moveTo>
                    <a:pt x="128" y="11920"/>
                  </a:moveTo>
                  <a:lnTo>
                    <a:pt x="64" y="11856"/>
                  </a:lnTo>
                  <a:lnTo>
                    <a:pt x="1872" y="11856"/>
                  </a:lnTo>
                  <a:lnTo>
                    <a:pt x="1808" y="11920"/>
                  </a:lnTo>
                  <a:lnTo>
                    <a:pt x="1808" y="64"/>
                  </a:lnTo>
                  <a:lnTo>
                    <a:pt x="187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192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59" name="Rectangle 83"/>
            <p:cNvSpPr>
              <a:spLocks noChangeArrowheads="1"/>
            </p:cNvSpPr>
            <p:nvPr/>
          </p:nvSpPr>
          <p:spPr bwMode="auto">
            <a:xfrm>
              <a:off x="4143129" y="1600843"/>
              <a:ext cx="127296" cy="82011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0" name="Freeform 84"/>
            <p:cNvSpPr>
              <a:spLocks noEditPoints="1"/>
            </p:cNvSpPr>
            <p:nvPr/>
          </p:nvSpPr>
          <p:spPr bwMode="auto">
            <a:xfrm>
              <a:off x="4138415" y="1596216"/>
              <a:ext cx="136725" cy="829364"/>
            </a:xfrm>
            <a:custGeom>
              <a:avLst/>
              <a:gdLst>
                <a:gd name="T0" fmla="*/ 0 w 1936"/>
                <a:gd name="T1" fmla="*/ 64 h 11952"/>
                <a:gd name="T2" fmla="*/ 64 w 1936"/>
                <a:gd name="T3" fmla="*/ 0 h 11952"/>
                <a:gd name="T4" fmla="*/ 1872 w 1936"/>
                <a:gd name="T5" fmla="*/ 0 h 11952"/>
                <a:gd name="T6" fmla="*/ 1936 w 1936"/>
                <a:gd name="T7" fmla="*/ 64 h 11952"/>
                <a:gd name="T8" fmla="*/ 1936 w 1936"/>
                <a:gd name="T9" fmla="*/ 11888 h 11952"/>
                <a:gd name="T10" fmla="*/ 1872 w 1936"/>
                <a:gd name="T11" fmla="*/ 11952 h 11952"/>
                <a:gd name="T12" fmla="*/ 64 w 1936"/>
                <a:gd name="T13" fmla="*/ 11952 h 11952"/>
                <a:gd name="T14" fmla="*/ 0 w 1936"/>
                <a:gd name="T15" fmla="*/ 11888 h 11952"/>
                <a:gd name="T16" fmla="*/ 0 w 1936"/>
                <a:gd name="T17" fmla="*/ 64 h 11952"/>
                <a:gd name="T18" fmla="*/ 128 w 1936"/>
                <a:gd name="T19" fmla="*/ 11888 h 11952"/>
                <a:gd name="T20" fmla="*/ 64 w 1936"/>
                <a:gd name="T21" fmla="*/ 11824 h 11952"/>
                <a:gd name="T22" fmla="*/ 1872 w 1936"/>
                <a:gd name="T23" fmla="*/ 11824 h 11952"/>
                <a:gd name="T24" fmla="*/ 1808 w 1936"/>
                <a:gd name="T25" fmla="*/ 11888 h 11952"/>
                <a:gd name="T26" fmla="*/ 1808 w 1936"/>
                <a:gd name="T27" fmla="*/ 64 h 11952"/>
                <a:gd name="T28" fmla="*/ 1872 w 1936"/>
                <a:gd name="T29" fmla="*/ 128 h 11952"/>
                <a:gd name="T30" fmla="*/ 64 w 1936"/>
                <a:gd name="T31" fmla="*/ 128 h 11952"/>
                <a:gd name="T32" fmla="*/ 128 w 1936"/>
                <a:gd name="T33" fmla="*/ 64 h 11952"/>
                <a:gd name="T34" fmla="*/ 128 w 1936"/>
                <a:gd name="T35" fmla="*/ 11888 h 119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36" h="11952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72" y="0"/>
                  </a:lnTo>
                  <a:cubicBezTo>
                    <a:pt x="1908" y="0"/>
                    <a:pt x="1936" y="29"/>
                    <a:pt x="1936" y="64"/>
                  </a:cubicBezTo>
                  <a:lnTo>
                    <a:pt x="1936" y="11888"/>
                  </a:lnTo>
                  <a:cubicBezTo>
                    <a:pt x="1936" y="11924"/>
                    <a:pt x="1908" y="11952"/>
                    <a:pt x="1872" y="11952"/>
                  </a:cubicBezTo>
                  <a:lnTo>
                    <a:pt x="64" y="11952"/>
                  </a:lnTo>
                  <a:cubicBezTo>
                    <a:pt x="29" y="11952"/>
                    <a:pt x="0" y="11924"/>
                    <a:pt x="0" y="11888"/>
                  </a:cubicBezTo>
                  <a:lnTo>
                    <a:pt x="0" y="64"/>
                  </a:lnTo>
                  <a:close/>
                  <a:moveTo>
                    <a:pt x="128" y="11888"/>
                  </a:moveTo>
                  <a:lnTo>
                    <a:pt x="64" y="11824"/>
                  </a:lnTo>
                  <a:lnTo>
                    <a:pt x="1872" y="11824"/>
                  </a:lnTo>
                  <a:lnTo>
                    <a:pt x="1808" y="11888"/>
                  </a:lnTo>
                  <a:lnTo>
                    <a:pt x="1808" y="64"/>
                  </a:lnTo>
                  <a:lnTo>
                    <a:pt x="187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1888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1" name="Rectangle 85"/>
            <p:cNvSpPr>
              <a:spLocks noChangeArrowheads="1"/>
            </p:cNvSpPr>
            <p:nvPr/>
          </p:nvSpPr>
          <p:spPr bwMode="auto">
            <a:xfrm>
              <a:off x="4591022" y="1605469"/>
              <a:ext cx="127296" cy="81548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2" name="Freeform 86"/>
            <p:cNvSpPr>
              <a:spLocks noEditPoints="1"/>
            </p:cNvSpPr>
            <p:nvPr/>
          </p:nvSpPr>
          <p:spPr bwMode="auto">
            <a:xfrm>
              <a:off x="4586307" y="1600843"/>
              <a:ext cx="136725" cy="824737"/>
            </a:xfrm>
            <a:custGeom>
              <a:avLst/>
              <a:gdLst>
                <a:gd name="T0" fmla="*/ 0 w 968"/>
                <a:gd name="T1" fmla="*/ 32 h 5944"/>
                <a:gd name="T2" fmla="*/ 32 w 968"/>
                <a:gd name="T3" fmla="*/ 0 h 5944"/>
                <a:gd name="T4" fmla="*/ 936 w 968"/>
                <a:gd name="T5" fmla="*/ 0 h 5944"/>
                <a:gd name="T6" fmla="*/ 968 w 968"/>
                <a:gd name="T7" fmla="*/ 32 h 5944"/>
                <a:gd name="T8" fmla="*/ 968 w 968"/>
                <a:gd name="T9" fmla="*/ 5912 h 5944"/>
                <a:gd name="T10" fmla="*/ 936 w 968"/>
                <a:gd name="T11" fmla="*/ 5944 h 5944"/>
                <a:gd name="T12" fmla="*/ 32 w 968"/>
                <a:gd name="T13" fmla="*/ 5944 h 5944"/>
                <a:gd name="T14" fmla="*/ 0 w 968"/>
                <a:gd name="T15" fmla="*/ 5912 h 5944"/>
                <a:gd name="T16" fmla="*/ 0 w 968"/>
                <a:gd name="T17" fmla="*/ 32 h 5944"/>
                <a:gd name="T18" fmla="*/ 64 w 968"/>
                <a:gd name="T19" fmla="*/ 5912 h 5944"/>
                <a:gd name="T20" fmla="*/ 32 w 968"/>
                <a:gd name="T21" fmla="*/ 5880 h 5944"/>
                <a:gd name="T22" fmla="*/ 936 w 968"/>
                <a:gd name="T23" fmla="*/ 5880 h 5944"/>
                <a:gd name="T24" fmla="*/ 904 w 968"/>
                <a:gd name="T25" fmla="*/ 5912 h 5944"/>
                <a:gd name="T26" fmla="*/ 904 w 968"/>
                <a:gd name="T27" fmla="*/ 32 h 5944"/>
                <a:gd name="T28" fmla="*/ 936 w 968"/>
                <a:gd name="T29" fmla="*/ 64 h 5944"/>
                <a:gd name="T30" fmla="*/ 32 w 968"/>
                <a:gd name="T31" fmla="*/ 64 h 5944"/>
                <a:gd name="T32" fmla="*/ 64 w 968"/>
                <a:gd name="T33" fmla="*/ 32 h 5944"/>
                <a:gd name="T34" fmla="*/ 64 w 968"/>
                <a:gd name="T35" fmla="*/ 5912 h 59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68" h="5944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936" y="0"/>
                  </a:lnTo>
                  <a:cubicBezTo>
                    <a:pt x="954" y="0"/>
                    <a:pt x="968" y="15"/>
                    <a:pt x="968" y="32"/>
                  </a:cubicBezTo>
                  <a:lnTo>
                    <a:pt x="968" y="5912"/>
                  </a:lnTo>
                  <a:cubicBezTo>
                    <a:pt x="968" y="5930"/>
                    <a:pt x="954" y="5944"/>
                    <a:pt x="936" y="5944"/>
                  </a:cubicBezTo>
                  <a:lnTo>
                    <a:pt x="32" y="5944"/>
                  </a:lnTo>
                  <a:cubicBezTo>
                    <a:pt x="15" y="5944"/>
                    <a:pt x="0" y="5930"/>
                    <a:pt x="0" y="5912"/>
                  </a:cubicBezTo>
                  <a:lnTo>
                    <a:pt x="0" y="32"/>
                  </a:lnTo>
                  <a:close/>
                  <a:moveTo>
                    <a:pt x="64" y="5912"/>
                  </a:moveTo>
                  <a:lnTo>
                    <a:pt x="32" y="5880"/>
                  </a:lnTo>
                  <a:lnTo>
                    <a:pt x="936" y="5880"/>
                  </a:lnTo>
                  <a:lnTo>
                    <a:pt x="904" y="5912"/>
                  </a:lnTo>
                  <a:lnTo>
                    <a:pt x="904" y="32"/>
                  </a:lnTo>
                  <a:lnTo>
                    <a:pt x="936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591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3" name="Rectangle 87"/>
            <p:cNvSpPr>
              <a:spLocks noChangeArrowheads="1"/>
            </p:cNvSpPr>
            <p:nvPr/>
          </p:nvSpPr>
          <p:spPr bwMode="auto">
            <a:xfrm>
              <a:off x="2482392" y="1589275"/>
              <a:ext cx="127296" cy="831677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4" name="Freeform 88"/>
            <p:cNvSpPr>
              <a:spLocks noEditPoints="1"/>
            </p:cNvSpPr>
            <p:nvPr/>
          </p:nvSpPr>
          <p:spPr bwMode="auto">
            <a:xfrm>
              <a:off x="2477677" y="1584649"/>
              <a:ext cx="136725" cy="840931"/>
            </a:xfrm>
            <a:custGeom>
              <a:avLst/>
              <a:gdLst>
                <a:gd name="T0" fmla="*/ 0 w 1920"/>
                <a:gd name="T1" fmla="*/ 64 h 12112"/>
                <a:gd name="T2" fmla="*/ 64 w 1920"/>
                <a:gd name="T3" fmla="*/ 0 h 12112"/>
                <a:gd name="T4" fmla="*/ 1856 w 1920"/>
                <a:gd name="T5" fmla="*/ 0 h 12112"/>
                <a:gd name="T6" fmla="*/ 1920 w 1920"/>
                <a:gd name="T7" fmla="*/ 64 h 12112"/>
                <a:gd name="T8" fmla="*/ 1920 w 1920"/>
                <a:gd name="T9" fmla="*/ 12048 h 12112"/>
                <a:gd name="T10" fmla="*/ 1856 w 1920"/>
                <a:gd name="T11" fmla="*/ 12112 h 12112"/>
                <a:gd name="T12" fmla="*/ 64 w 1920"/>
                <a:gd name="T13" fmla="*/ 12112 h 12112"/>
                <a:gd name="T14" fmla="*/ 0 w 1920"/>
                <a:gd name="T15" fmla="*/ 12048 h 12112"/>
                <a:gd name="T16" fmla="*/ 0 w 1920"/>
                <a:gd name="T17" fmla="*/ 64 h 12112"/>
                <a:gd name="T18" fmla="*/ 128 w 1920"/>
                <a:gd name="T19" fmla="*/ 12048 h 12112"/>
                <a:gd name="T20" fmla="*/ 64 w 1920"/>
                <a:gd name="T21" fmla="*/ 11984 h 12112"/>
                <a:gd name="T22" fmla="*/ 1856 w 1920"/>
                <a:gd name="T23" fmla="*/ 11984 h 12112"/>
                <a:gd name="T24" fmla="*/ 1792 w 1920"/>
                <a:gd name="T25" fmla="*/ 12048 h 12112"/>
                <a:gd name="T26" fmla="*/ 1792 w 1920"/>
                <a:gd name="T27" fmla="*/ 64 h 12112"/>
                <a:gd name="T28" fmla="*/ 1856 w 1920"/>
                <a:gd name="T29" fmla="*/ 128 h 12112"/>
                <a:gd name="T30" fmla="*/ 64 w 1920"/>
                <a:gd name="T31" fmla="*/ 128 h 12112"/>
                <a:gd name="T32" fmla="*/ 128 w 1920"/>
                <a:gd name="T33" fmla="*/ 64 h 12112"/>
                <a:gd name="T34" fmla="*/ 128 w 1920"/>
                <a:gd name="T35" fmla="*/ 12048 h 12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20" h="12112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56" y="0"/>
                  </a:lnTo>
                  <a:cubicBezTo>
                    <a:pt x="1892" y="0"/>
                    <a:pt x="1920" y="29"/>
                    <a:pt x="1920" y="64"/>
                  </a:cubicBezTo>
                  <a:lnTo>
                    <a:pt x="1920" y="12048"/>
                  </a:lnTo>
                  <a:cubicBezTo>
                    <a:pt x="1920" y="12084"/>
                    <a:pt x="1892" y="12112"/>
                    <a:pt x="1856" y="12112"/>
                  </a:cubicBezTo>
                  <a:lnTo>
                    <a:pt x="64" y="12112"/>
                  </a:lnTo>
                  <a:cubicBezTo>
                    <a:pt x="29" y="12112"/>
                    <a:pt x="0" y="12084"/>
                    <a:pt x="0" y="12048"/>
                  </a:cubicBezTo>
                  <a:lnTo>
                    <a:pt x="0" y="64"/>
                  </a:lnTo>
                  <a:close/>
                  <a:moveTo>
                    <a:pt x="128" y="12048"/>
                  </a:moveTo>
                  <a:lnTo>
                    <a:pt x="64" y="11984"/>
                  </a:lnTo>
                  <a:lnTo>
                    <a:pt x="1856" y="11984"/>
                  </a:lnTo>
                  <a:lnTo>
                    <a:pt x="1792" y="12048"/>
                  </a:lnTo>
                  <a:lnTo>
                    <a:pt x="1792" y="64"/>
                  </a:lnTo>
                  <a:lnTo>
                    <a:pt x="1856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2048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5" name="Rectangle 89"/>
            <p:cNvSpPr>
              <a:spLocks noChangeArrowheads="1"/>
            </p:cNvSpPr>
            <p:nvPr/>
          </p:nvSpPr>
          <p:spPr bwMode="auto">
            <a:xfrm>
              <a:off x="2929105" y="1494425"/>
              <a:ext cx="128474" cy="926528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6" name="Freeform 90"/>
            <p:cNvSpPr>
              <a:spLocks noEditPoints="1"/>
            </p:cNvSpPr>
            <p:nvPr/>
          </p:nvSpPr>
          <p:spPr bwMode="auto">
            <a:xfrm>
              <a:off x="2925569" y="1489798"/>
              <a:ext cx="136725" cy="935781"/>
            </a:xfrm>
            <a:custGeom>
              <a:avLst/>
              <a:gdLst>
                <a:gd name="T0" fmla="*/ 0 w 1936"/>
                <a:gd name="T1" fmla="*/ 64 h 13488"/>
                <a:gd name="T2" fmla="*/ 64 w 1936"/>
                <a:gd name="T3" fmla="*/ 0 h 13488"/>
                <a:gd name="T4" fmla="*/ 1872 w 1936"/>
                <a:gd name="T5" fmla="*/ 0 h 13488"/>
                <a:gd name="T6" fmla="*/ 1936 w 1936"/>
                <a:gd name="T7" fmla="*/ 64 h 13488"/>
                <a:gd name="T8" fmla="*/ 1936 w 1936"/>
                <a:gd name="T9" fmla="*/ 13424 h 13488"/>
                <a:gd name="T10" fmla="*/ 1872 w 1936"/>
                <a:gd name="T11" fmla="*/ 13488 h 13488"/>
                <a:gd name="T12" fmla="*/ 64 w 1936"/>
                <a:gd name="T13" fmla="*/ 13488 h 13488"/>
                <a:gd name="T14" fmla="*/ 0 w 1936"/>
                <a:gd name="T15" fmla="*/ 13424 h 13488"/>
                <a:gd name="T16" fmla="*/ 0 w 1936"/>
                <a:gd name="T17" fmla="*/ 64 h 13488"/>
                <a:gd name="T18" fmla="*/ 128 w 1936"/>
                <a:gd name="T19" fmla="*/ 13424 h 13488"/>
                <a:gd name="T20" fmla="*/ 64 w 1936"/>
                <a:gd name="T21" fmla="*/ 13360 h 13488"/>
                <a:gd name="T22" fmla="*/ 1872 w 1936"/>
                <a:gd name="T23" fmla="*/ 13360 h 13488"/>
                <a:gd name="T24" fmla="*/ 1808 w 1936"/>
                <a:gd name="T25" fmla="*/ 13424 h 13488"/>
                <a:gd name="T26" fmla="*/ 1808 w 1936"/>
                <a:gd name="T27" fmla="*/ 64 h 13488"/>
                <a:gd name="T28" fmla="*/ 1872 w 1936"/>
                <a:gd name="T29" fmla="*/ 128 h 13488"/>
                <a:gd name="T30" fmla="*/ 64 w 1936"/>
                <a:gd name="T31" fmla="*/ 128 h 13488"/>
                <a:gd name="T32" fmla="*/ 128 w 1936"/>
                <a:gd name="T33" fmla="*/ 64 h 13488"/>
                <a:gd name="T34" fmla="*/ 128 w 1936"/>
                <a:gd name="T35" fmla="*/ 13424 h 134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36" h="13488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72" y="0"/>
                  </a:lnTo>
                  <a:cubicBezTo>
                    <a:pt x="1908" y="0"/>
                    <a:pt x="1936" y="29"/>
                    <a:pt x="1936" y="64"/>
                  </a:cubicBezTo>
                  <a:lnTo>
                    <a:pt x="1936" y="13424"/>
                  </a:lnTo>
                  <a:cubicBezTo>
                    <a:pt x="1936" y="13460"/>
                    <a:pt x="1908" y="13488"/>
                    <a:pt x="1872" y="13488"/>
                  </a:cubicBezTo>
                  <a:lnTo>
                    <a:pt x="64" y="13488"/>
                  </a:lnTo>
                  <a:cubicBezTo>
                    <a:pt x="29" y="13488"/>
                    <a:pt x="0" y="13460"/>
                    <a:pt x="0" y="13424"/>
                  </a:cubicBezTo>
                  <a:lnTo>
                    <a:pt x="0" y="64"/>
                  </a:lnTo>
                  <a:close/>
                  <a:moveTo>
                    <a:pt x="128" y="13424"/>
                  </a:moveTo>
                  <a:lnTo>
                    <a:pt x="64" y="13360"/>
                  </a:lnTo>
                  <a:lnTo>
                    <a:pt x="1872" y="13360"/>
                  </a:lnTo>
                  <a:lnTo>
                    <a:pt x="1808" y="13424"/>
                  </a:lnTo>
                  <a:lnTo>
                    <a:pt x="1808" y="64"/>
                  </a:lnTo>
                  <a:lnTo>
                    <a:pt x="187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3424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7" name="Rectangle 91"/>
            <p:cNvSpPr>
              <a:spLocks noChangeArrowheads="1"/>
            </p:cNvSpPr>
            <p:nvPr/>
          </p:nvSpPr>
          <p:spPr bwMode="auto">
            <a:xfrm>
              <a:off x="3376997" y="1560357"/>
              <a:ext cx="127296" cy="860595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8" name="Freeform 92"/>
            <p:cNvSpPr>
              <a:spLocks noEditPoints="1"/>
            </p:cNvSpPr>
            <p:nvPr/>
          </p:nvSpPr>
          <p:spPr bwMode="auto">
            <a:xfrm>
              <a:off x="3372283" y="1555730"/>
              <a:ext cx="136725" cy="869848"/>
            </a:xfrm>
            <a:custGeom>
              <a:avLst/>
              <a:gdLst>
                <a:gd name="T0" fmla="*/ 0 w 1936"/>
                <a:gd name="T1" fmla="*/ 64 h 12528"/>
                <a:gd name="T2" fmla="*/ 64 w 1936"/>
                <a:gd name="T3" fmla="*/ 0 h 12528"/>
                <a:gd name="T4" fmla="*/ 1872 w 1936"/>
                <a:gd name="T5" fmla="*/ 0 h 12528"/>
                <a:gd name="T6" fmla="*/ 1936 w 1936"/>
                <a:gd name="T7" fmla="*/ 64 h 12528"/>
                <a:gd name="T8" fmla="*/ 1936 w 1936"/>
                <a:gd name="T9" fmla="*/ 12464 h 12528"/>
                <a:gd name="T10" fmla="*/ 1872 w 1936"/>
                <a:gd name="T11" fmla="*/ 12528 h 12528"/>
                <a:gd name="T12" fmla="*/ 64 w 1936"/>
                <a:gd name="T13" fmla="*/ 12528 h 12528"/>
                <a:gd name="T14" fmla="*/ 0 w 1936"/>
                <a:gd name="T15" fmla="*/ 12464 h 12528"/>
                <a:gd name="T16" fmla="*/ 0 w 1936"/>
                <a:gd name="T17" fmla="*/ 64 h 12528"/>
                <a:gd name="T18" fmla="*/ 128 w 1936"/>
                <a:gd name="T19" fmla="*/ 12464 h 12528"/>
                <a:gd name="T20" fmla="*/ 64 w 1936"/>
                <a:gd name="T21" fmla="*/ 12400 h 12528"/>
                <a:gd name="T22" fmla="*/ 1872 w 1936"/>
                <a:gd name="T23" fmla="*/ 12400 h 12528"/>
                <a:gd name="T24" fmla="*/ 1808 w 1936"/>
                <a:gd name="T25" fmla="*/ 12464 h 12528"/>
                <a:gd name="T26" fmla="*/ 1808 w 1936"/>
                <a:gd name="T27" fmla="*/ 64 h 12528"/>
                <a:gd name="T28" fmla="*/ 1872 w 1936"/>
                <a:gd name="T29" fmla="*/ 128 h 12528"/>
                <a:gd name="T30" fmla="*/ 64 w 1936"/>
                <a:gd name="T31" fmla="*/ 128 h 12528"/>
                <a:gd name="T32" fmla="*/ 128 w 1936"/>
                <a:gd name="T33" fmla="*/ 64 h 12528"/>
                <a:gd name="T34" fmla="*/ 128 w 1936"/>
                <a:gd name="T35" fmla="*/ 12464 h 125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36" h="12528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72" y="0"/>
                  </a:lnTo>
                  <a:cubicBezTo>
                    <a:pt x="1908" y="0"/>
                    <a:pt x="1936" y="29"/>
                    <a:pt x="1936" y="64"/>
                  </a:cubicBezTo>
                  <a:lnTo>
                    <a:pt x="1936" y="12464"/>
                  </a:lnTo>
                  <a:cubicBezTo>
                    <a:pt x="1936" y="12500"/>
                    <a:pt x="1908" y="12528"/>
                    <a:pt x="1872" y="12528"/>
                  </a:cubicBezTo>
                  <a:lnTo>
                    <a:pt x="64" y="12528"/>
                  </a:lnTo>
                  <a:cubicBezTo>
                    <a:pt x="29" y="12528"/>
                    <a:pt x="0" y="12500"/>
                    <a:pt x="0" y="12464"/>
                  </a:cubicBezTo>
                  <a:lnTo>
                    <a:pt x="0" y="64"/>
                  </a:lnTo>
                  <a:close/>
                  <a:moveTo>
                    <a:pt x="128" y="12464"/>
                  </a:moveTo>
                  <a:lnTo>
                    <a:pt x="64" y="12400"/>
                  </a:lnTo>
                  <a:lnTo>
                    <a:pt x="1872" y="12400"/>
                  </a:lnTo>
                  <a:lnTo>
                    <a:pt x="1808" y="12464"/>
                  </a:lnTo>
                  <a:lnTo>
                    <a:pt x="1808" y="64"/>
                  </a:lnTo>
                  <a:lnTo>
                    <a:pt x="187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2464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69" name="Rectangle 93"/>
            <p:cNvSpPr>
              <a:spLocks noChangeArrowheads="1"/>
            </p:cNvSpPr>
            <p:nvPr/>
          </p:nvSpPr>
          <p:spPr bwMode="auto">
            <a:xfrm>
              <a:off x="3823712" y="1745431"/>
              <a:ext cx="127296" cy="675520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0" name="Freeform 94"/>
            <p:cNvSpPr>
              <a:spLocks noEditPoints="1"/>
            </p:cNvSpPr>
            <p:nvPr/>
          </p:nvSpPr>
          <p:spPr bwMode="auto">
            <a:xfrm>
              <a:off x="3818997" y="1741962"/>
              <a:ext cx="136725" cy="683618"/>
            </a:xfrm>
            <a:custGeom>
              <a:avLst/>
              <a:gdLst>
                <a:gd name="T0" fmla="*/ 0 w 1936"/>
                <a:gd name="T1" fmla="*/ 64 h 9856"/>
                <a:gd name="T2" fmla="*/ 64 w 1936"/>
                <a:gd name="T3" fmla="*/ 0 h 9856"/>
                <a:gd name="T4" fmla="*/ 1872 w 1936"/>
                <a:gd name="T5" fmla="*/ 0 h 9856"/>
                <a:gd name="T6" fmla="*/ 1936 w 1936"/>
                <a:gd name="T7" fmla="*/ 64 h 9856"/>
                <a:gd name="T8" fmla="*/ 1936 w 1936"/>
                <a:gd name="T9" fmla="*/ 9792 h 9856"/>
                <a:gd name="T10" fmla="*/ 1872 w 1936"/>
                <a:gd name="T11" fmla="*/ 9856 h 9856"/>
                <a:gd name="T12" fmla="*/ 64 w 1936"/>
                <a:gd name="T13" fmla="*/ 9856 h 9856"/>
                <a:gd name="T14" fmla="*/ 0 w 1936"/>
                <a:gd name="T15" fmla="*/ 9792 h 9856"/>
                <a:gd name="T16" fmla="*/ 0 w 1936"/>
                <a:gd name="T17" fmla="*/ 64 h 9856"/>
                <a:gd name="T18" fmla="*/ 128 w 1936"/>
                <a:gd name="T19" fmla="*/ 9792 h 9856"/>
                <a:gd name="T20" fmla="*/ 64 w 1936"/>
                <a:gd name="T21" fmla="*/ 9728 h 9856"/>
                <a:gd name="T22" fmla="*/ 1872 w 1936"/>
                <a:gd name="T23" fmla="*/ 9728 h 9856"/>
                <a:gd name="T24" fmla="*/ 1808 w 1936"/>
                <a:gd name="T25" fmla="*/ 9792 h 9856"/>
                <a:gd name="T26" fmla="*/ 1808 w 1936"/>
                <a:gd name="T27" fmla="*/ 64 h 9856"/>
                <a:gd name="T28" fmla="*/ 1872 w 1936"/>
                <a:gd name="T29" fmla="*/ 128 h 9856"/>
                <a:gd name="T30" fmla="*/ 64 w 1936"/>
                <a:gd name="T31" fmla="*/ 128 h 9856"/>
                <a:gd name="T32" fmla="*/ 128 w 1936"/>
                <a:gd name="T33" fmla="*/ 64 h 9856"/>
                <a:gd name="T34" fmla="*/ 128 w 1936"/>
                <a:gd name="T35" fmla="*/ 9792 h 98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36" h="9856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72" y="0"/>
                  </a:lnTo>
                  <a:cubicBezTo>
                    <a:pt x="1908" y="0"/>
                    <a:pt x="1936" y="29"/>
                    <a:pt x="1936" y="64"/>
                  </a:cubicBezTo>
                  <a:lnTo>
                    <a:pt x="1936" y="9792"/>
                  </a:lnTo>
                  <a:cubicBezTo>
                    <a:pt x="1936" y="9828"/>
                    <a:pt x="1908" y="9856"/>
                    <a:pt x="1872" y="9856"/>
                  </a:cubicBezTo>
                  <a:lnTo>
                    <a:pt x="64" y="9856"/>
                  </a:lnTo>
                  <a:cubicBezTo>
                    <a:pt x="29" y="9856"/>
                    <a:pt x="0" y="9828"/>
                    <a:pt x="0" y="9792"/>
                  </a:cubicBezTo>
                  <a:lnTo>
                    <a:pt x="0" y="64"/>
                  </a:lnTo>
                  <a:close/>
                  <a:moveTo>
                    <a:pt x="128" y="9792"/>
                  </a:moveTo>
                  <a:lnTo>
                    <a:pt x="64" y="9728"/>
                  </a:lnTo>
                  <a:lnTo>
                    <a:pt x="1872" y="9728"/>
                  </a:lnTo>
                  <a:lnTo>
                    <a:pt x="1808" y="9792"/>
                  </a:lnTo>
                  <a:lnTo>
                    <a:pt x="1808" y="64"/>
                  </a:lnTo>
                  <a:lnTo>
                    <a:pt x="187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979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1" name="Rectangle 95"/>
            <p:cNvSpPr>
              <a:spLocks noChangeArrowheads="1"/>
            </p:cNvSpPr>
            <p:nvPr/>
          </p:nvSpPr>
          <p:spPr bwMode="auto">
            <a:xfrm>
              <a:off x="4270425" y="1775506"/>
              <a:ext cx="128474" cy="645446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2" name="Freeform 96"/>
            <p:cNvSpPr>
              <a:spLocks noEditPoints="1"/>
            </p:cNvSpPr>
            <p:nvPr/>
          </p:nvSpPr>
          <p:spPr bwMode="auto">
            <a:xfrm>
              <a:off x="4265710" y="1772036"/>
              <a:ext cx="136725" cy="653543"/>
            </a:xfrm>
            <a:custGeom>
              <a:avLst/>
              <a:gdLst>
                <a:gd name="T0" fmla="*/ 0 w 968"/>
                <a:gd name="T1" fmla="*/ 32 h 4712"/>
                <a:gd name="T2" fmla="*/ 32 w 968"/>
                <a:gd name="T3" fmla="*/ 0 h 4712"/>
                <a:gd name="T4" fmla="*/ 936 w 968"/>
                <a:gd name="T5" fmla="*/ 0 h 4712"/>
                <a:gd name="T6" fmla="*/ 968 w 968"/>
                <a:gd name="T7" fmla="*/ 32 h 4712"/>
                <a:gd name="T8" fmla="*/ 968 w 968"/>
                <a:gd name="T9" fmla="*/ 4680 h 4712"/>
                <a:gd name="T10" fmla="*/ 936 w 968"/>
                <a:gd name="T11" fmla="*/ 4712 h 4712"/>
                <a:gd name="T12" fmla="*/ 32 w 968"/>
                <a:gd name="T13" fmla="*/ 4712 h 4712"/>
                <a:gd name="T14" fmla="*/ 0 w 968"/>
                <a:gd name="T15" fmla="*/ 4680 h 4712"/>
                <a:gd name="T16" fmla="*/ 0 w 968"/>
                <a:gd name="T17" fmla="*/ 32 h 4712"/>
                <a:gd name="T18" fmla="*/ 64 w 968"/>
                <a:gd name="T19" fmla="*/ 4680 h 4712"/>
                <a:gd name="T20" fmla="*/ 32 w 968"/>
                <a:gd name="T21" fmla="*/ 4648 h 4712"/>
                <a:gd name="T22" fmla="*/ 936 w 968"/>
                <a:gd name="T23" fmla="*/ 4648 h 4712"/>
                <a:gd name="T24" fmla="*/ 904 w 968"/>
                <a:gd name="T25" fmla="*/ 4680 h 4712"/>
                <a:gd name="T26" fmla="*/ 904 w 968"/>
                <a:gd name="T27" fmla="*/ 32 h 4712"/>
                <a:gd name="T28" fmla="*/ 936 w 968"/>
                <a:gd name="T29" fmla="*/ 64 h 4712"/>
                <a:gd name="T30" fmla="*/ 32 w 968"/>
                <a:gd name="T31" fmla="*/ 64 h 4712"/>
                <a:gd name="T32" fmla="*/ 64 w 968"/>
                <a:gd name="T33" fmla="*/ 32 h 4712"/>
                <a:gd name="T34" fmla="*/ 64 w 968"/>
                <a:gd name="T35" fmla="*/ 4680 h 47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68" h="4712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936" y="0"/>
                  </a:lnTo>
                  <a:cubicBezTo>
                    <a:pt x="954" y="0"/>
                    <a:pt x="968" y="15"/>
                    <a:pt x="968" y="32"/>
                  </a:cubicBezTo>
                  <a:lnTo>
                    <a:pt x="968" y="4680"/>
                  </a:lnTo>
                  <a:cubicBezTo>
                    <a:pt x="968" y="4698"/>
                    <a:pt x="954" y="4712"/>
                    <a:pt x="936" y="4712"/>
                  </a:cubicBezTo>
                  <a:lnTo>
                    <a:pt x="32" y="4712"/>
                  </a:lnTo>
                  <a:cubicBezTo>
                    <a:pt x="15" y="4712"/>
                    <a:pt x="0" y="4698"/>
                    <a:pt x="0" y="4680"/>
                  </a:cubicBezTo>
                  <a:lnTo>
                    <a:pt x="0" y="32"/>
                  </a:lnTo>
                  <a:close/>
                  <a:moveTo>
                    <a:pt x="64" y="4680"/>
                  </a:moveTo>
                  <a:lnTo>
                    <a:pt x="32" y="4648"/>
                  </a:lnTo>
                  <a:lnTo>
                    <a:pt x="936" y="4648"/>
                  </a:lnTo>
                  <a:lnTo>
                    <a:pt x="904" y="4680"/>
                  </a:lnTo>
                  <a:lnTo>
                    <a:pt x="904" y="32"/>
                  </a:lnTo>
                  <a:lnTo>
                    <a:pt x="936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468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3" name="Rectangle 97"/>
            <p:cNvSpPr>
              <a:spLocks noChangeArrowheads="1"/>
            </p:cNvSpPr>
            <p:nvPr/>
          </p:nvSpPr>
          <p:spPr bwMode="auto">
            <a:xfrm>
              <a:off x="4718317" y="1703790"/>
              <a:ext cx="127296" cy="717162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4" name="Freeform 98"/>
            <p:cNvSpPr>
              <a:spLocks noEditPoints="1"/>
            </p:cNvSpPr>
            <p:nvPr/>
          </p:nvSpPr>
          <p:spPr bwMode="auto">
            <a:xfrm>
              <a:off x="4713603" y="1699163"/>
              <a:ext cx="136725" cy="726416"/>
            </a:xfrm>
            <a:custGeom>
              <a:avLst/>
              <a:gdLst>
                <a:gd name="T0" fmla="*/ 0 w 960"/>
                <a:gd name="T1" fmla="*/ 32 h 5232"/>
                <a:gd name="T2" fmla="*/ 32 w 960"/>
                <a:gd name="T3" fmla="*/ 0 h 5232"/>
                <a:gd name="T4" fmla="*/ 928 w 960"/>
                <a:gd name="T5" fmla="*/ 0 h 5232"/>
                <a:gd name="T6" fmla="*/ 960 w 960"/>
                <a:gd name="T7" fmla="*/ 32 h 5232"/>
                <a:gd name="T8" fmla="*/ 960 w 960"/>
                <a:gd name="T9" fmla="*/ 5200 h 5232"/>
                <a:gd name="T10" fmla="*/ 928 w 960"/>
                <a:gd name="T11" fmla="*/ 5232 h 5232"/>
                <a:gd name="T12" fmla="*/ 32 w 960"/>
                <a:gd name="T13" fmla="*/ 5232 h 5232"/>
                <a:gd name="T14" fmla="*/ 0 w 960"/>
                <a:gd name="T15" fmla="*/ 5200 h 5232"/>
                <a:gd name="T16" fmla="*/ 0 w 960"/>
                <a:gd name="T17" fmla="*/ 32 h 5232"/>
                <a:gd name="T18" fmla="*/ 64 w 960"/>
                <a:gd name="T19" fmla="*/ 5200 h 5232"/>
                <a:gd name="T20" fmla="*/ 32 w 960"/>
                <a:gd name="T21" fmla="*/ 5168 h 5232"/>
                <a:gd name="T22" fmla="*/ 928 w 960"/>
                <a:gd name="T23" fmla="*/ 5168 h 5232"/>
                <a:gd name="T24" fmla="*/ 896 w 960"/>
                <a:gd name="T25" fmla="*/ 5200 h 5232"/>
                <a:gd name="T26" fmla="*/ 896 w 960"/>
                <a:gd name="T27" fmla="*/ 32 h 5232"/>
                <a:gd name="T28" fmla="*/ 928 w 960"/>
                <a:gd name="T29" fmla="*/ 64 h 5232"/>
                <a:gd name="T30" fmla="*/ 32 w 960"/>
                <a:gd name="T31" fmla="*/ 64 h 5232"/>
                <a:gd name="T32" fmla="*/ 64 w 960"/>
                <a:gd name="T33" fmla="*/ 32 h 5232"/>
                <a:gd name="T34" fmla="*/ 64 w 960"/>
                <a:gd name="T35" fmla="*/ 5200 h 52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60" h="5232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928" y="0"/>
                  </a:lnTo>
                  <a:cubicBezTo>
                    <a:pt x="946" y="0"/>
                    <a:pt x="960" y="15"/>
                    <a:pt x="960" y="32"/>
                  </a:cubicBezTo>
                  <a:lnTo>
                    <a:pt x="960" y="5200"/>
                  </a:lnTo>
                  <a:cubicBezTo>
                    <a:pt x="960" y="5218"/>
                    <a:pt x="946" y="5232"/>
                    <a:pt x="928" y="5232"/>
                  </a:cubicBezTo>
                  <a:lnTo>
                    <a:pt x="32" y="5232"/>
                  </a:lnTo>
                  <a:cubicBezTo>
                    <a:pt x="15" y="5232"/>
                    <a:pt x="0" y="5218"/>
                    <a:pt x="0" y="5200"/>
                  </a:cubicBezTo>
                  <a:lnTo>
                    <a:pt x="0" y="32"/>
                  </a:lnTo>
                  <a:close/>
                  <a:moveTo>
                    <a:pt x="64" y="5200"/>
                  </a:moveTo>
                  <a:lnTo>
                    <a:pt x="32" y="5168"/>
                  </a:lnTo>
                  <a:lnTo>
                    <a:pt x="928" y="5168"/>
                  </a:lnTo>
                  <a:lnTo>
                    <a:pt x="896" y="5200"/>
                  </a:lnTo>
                  <a:lnTo>
                    <a:pt x="896" y="32"/>
                  </a:lnTo>
                  <a:lnTo>
                    <a:pt x="928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520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5" name="Freeform 99"/>
            <p:cNvSpPr>
              <a:spLocks noEditPoints="1"/>
            </p:cNvSpPr>
            <p:nvPr/>
          </p:nvSpPr>
          <p:spPr bwMode="auto">
            <a:xfrm>
              <a:off x="2396349" y="1006292"/>
              <a:ext cx="43610" cy="189701"/>
            </a:xfrm>
            <a:custGeom>
              <a:avLst/>
              <a:gdLst>
                <a:gd name="T0" fmla="*/ 18 w 37"/>
                <a:gd name="T1" fmla="*/ 163 h 164"/>
                <a:gd name="T2" fmla="*/ 18 w 37"/>
                <a:gd name="T3" fmla="*/ 83 h 164"/>
                <a:gd name="T4" fmla="*/ 18 w 37"/>
                <a:gd name="T5" fmla="*/ 1 h 164"/>
                <a:gd name="T6" fmla="*/ 20 w 37"/>
                <a:gd name="T7" fmla="*/ 1 h 164"/>
                <a:gd name="T8" fmla="*/ 20 w 37"/>
                <a:gd name="T9" fmla="*/ 83 h 164"/>
                <a:gd name="T10" fmla="*/ 20 w 37"/>
                <a:gd name="T11" fmla="*/ 163 h 164"/>
                <a:gd name="T12" fmla="*/ 18 w 37"/>
                <a:gd name="T13" fmla="*/ 163 h 164"/>
                <a:gd name="T14" fmla="*/ 0 w 37"/>
                <a:gd name="T15" fmla="*/ 162 h 164"/>
                <a:gd name="T16" fmla="*/ 37 w 37"/>
                <a:gd name="T17" fmla="*/ 162 h 164"/>
                <a:gd name="T18" fmla="*/ 37 w 37"/>
                <a:gd name="T19" fmla="*/ 164 h 164"/>
                <a:gd name="T20" fmla="*/ 0 w 37"/>
                <a:gd name="T21" fmla="*/ 164 h 164"/>
                <a:gd name="T22" fmla="*/ 0 w 37"/>
                <a:gd name="T23" fmla="*/ 162 h 164"/>
                <a:gd name="T24" fmla="*/ 0 w 37"/>
                <a:gd name="T25" fmla="*/ 0 h 164"/>
                <a:gd name="T26" fmla="*/ 37 w 37"/>
                <a:gd name="T27" fmla="*/ 0 h 164"/>
                <a:gd name="T28" fmla="*/ 37 w 37"/>
                <a:gd name="T29" fmla="*/ 2 h 164"/>
                <a:gd name="T30" fmla="*/ 0 w 37"/>
                <a:gd name="T31" fmla="*/ 2 h 164"/>
                <a:gd name="T32" fmla="*/ 0 w 37"/>
                <a:gd name="T33" fmla="*/ 0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" h="164">
                  <a:moveTo>
                    <a:pt x="18" y="163"/>
                  </a:moveTo>
                  <a:lnTo>
                    <a:pt x="18" y="83"/>
                  </a:lnTo>
                  <a:lnTo>
                    <a:pt x="18" y="1"/>
                  </a:lnTo>
                  <a:lnTo>
                    <a:pt x="20" y="1"/>
                  </a:lnTo>
                  <a:lnTo>
                    <a:pt x="20" y="83"/>
                  </a:lnTo>
                  <a:lnTo>
                    <a:pt x="20" y="163"/>
                  </a:lnTo>
                  <a:lnTo>
                    <a:pt x="18" y="163"/>
                  </a:lnTo>
                  <a:close/>
                  <a:moveTo>
                    <a:pt x="0" y="162"/>
                  </a:moveTo>
                  <a:lnTo>
                    <a:pt x="37" y="162"/>
                  </a:lnTo>
                  <a:lnTo>
                    <a:pt x="37" y="164"/>
                  </a:lnTo>
                  <a:lnTo>
                    <a:pt x="0" y="164"/>
                  </a:lnTo>
                  <a:lnTo>
                    <a:pt x="0" y="162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6" name="Freeform 100"/>
            <p:cNvSpPr>
              <a:spLocks noEditPoints="1"/>
            </p:cNvSpPr>
            <p:nvPr/>
          </p:nvSpPr>
          <p:spPr bwMode="auto">
            <a:xfrm>
              <a:off x="2844241" y="1397261"/>
              <a:ext cx="42432" cy="131865"/>
            </a:xfrm>
            <a:custGeom>
              <a:avLst/>
              <a:gdLst>
                <a:gd name="T0" fmla="*/ 17 w 36"/>
                <a:gd name="T1" fmla="*/ 113 h 114"/>
                <a:gd name="T2" fmla="*/ 17 w 36"/>
                <a:gd name="T3" fmla="*/ 57 h 114"/>
                <a:gd name="T4" fmla="*/ 17 w 36"/>
                <a:gd name="T5" fmla="*/ 1 h 114"/>
                <a:gd name="T6" fmla="*/ 19 w 36"/>
                <a:gd name="T7" fmla="*/ 1 h 114"/>
                <a:gd name="T8" fmla="*/ 19 w 36"/>
                <a:gd name="T9" fmla="*/ 57 h 114"/>
                <a:gd name="T10" fmla="*/ 19 w 36"/>
                <a:gd name="T11" fmla="*/ 113 h 114"/>
                <a:gd name="T12" fmla="*/ 17 w 36"/>
                <a:gd name="T13" fmla="*/ 113 h 114"/>
                <a:gd name="T14" fmla="*/ 0 w 36"/>
                <a:gd name="T15" fmla="*/ 112 h 114"/>
                <a:gd name="T16" fmla="*/ 36 w 36"/>
                <a:gd name="T17" fmla="*/ 112 h 114"/>
                <a:gd name="T18" fmla="*/ 36 w 36"/>
                <a:gd name="T19" fmla="*/ 114 h 114"/>
                <a:gd name="T20" fmla="*/ 0 w 36"/>
                <a:gd name="T21" fmla="*/ 114 h 114"/>
                <a:gd name="T22" fmla="*/ 0 w 36"/>
                <a:gd name="T23" fmla="*/ 112 h 114"/>
                <a:gd name="T24" fmla="*/ 0 w 36"/>
                <a:gd name="T25" fmla="*/ 0 h 114"/>
                <a:gd name="T26" fmla="*/ 36 w 36"/>
                <a:gd name="T27" fmla="*/ 0 h 114"/>
                <a:gd name="T28" fmla="*/ 36 w 36"/>
                <a:gd name="T29" fmla="*/ 2 h 114"/>
                <a:gd name="T30" fmla="*/ 0 w 36"/>
                <a:gd name="T31" fmla="*/ 2 h 114"/>
                <a:gd name="T32" fmla="*/ 0 w 36"/>
                <a:gd name="T33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114">
                  <a:moveTo>
                    <a:pt x="17" y="113"/>
                  </a:moveTo>
                  <a:lnTo>
                    <a:pt x="17" y="57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57"/>
                  </a:lnTo>
                  <a:lnTo>
                    <a:pt x="19" y="113"/>
                  </a:lnTo>
                  <a:lnTo>
                    <a:pt x="17" y="113"/>
                  </a:lnTo>
                  <a:close/>
                  <a:moveTo>
                    <a:pt x="0" y="112"/>
                  </a:moveTo>
                  <a:lnTo>
                    <a:pt x="36" y="112"/>
                  </a:lnTo>
                  <a:lnTo>
                    <a:pt x="36" y="114"/>
                  </a:lnTo>
                  <a:lnTo>
                    <a:pt x="0" y="114"/>
                  </a:lnTo>
                  <a:lnTo>
                    <a:pt x="0" y="11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7" name="Freeform 101"/>
            <p:cNvSpPr>
              <a:spLocks noEditPoints="1"/>
            </p:cNvSpPr>
            <p:nvPr/>
          </p:nvSpPr>
          <p:spPr bwMode="auto">
            <a:xfrm>
              <a:off x="3292134" y="1524499"/>
              <a:ext cx="41253" cy="111044"/>
            </a:xfrm>
            <a:custGeom>
              <a:avLst/>
              <a:gdLst>
                <a:gd name="T0" fmla="*/ 16 w 35"/>
                <a:gd name="T1" fmla="*/ 95 h 96"/>
                <a:gd name="T2" fmla="*/ 16 w 35"/>
                <a:gd name="T3" fmla="*/ 48 h 96"/>
                <a:gd name="T4" fmla="*/ 16 w 35"/>
                <a:gd name="T5" fmla="*/ 1 h 96"/>
                <a:gd name="T6" fmla="*/ 18 w 35"/>
                <a:gd name="T7" fmla="*/ 1 h 96"/>
                <a:gd name="T8" fmla="*/ 18 w 35"/>
                <a:gd name="T9" fmla="*/ 48 h 96"/>
                <a:gd name="T10" fmla="*/ 18 w 35"/>
                <a:gd name="T11" fmla="*/ 95 h 96"/>
                <a:gd name="T12" fmla="*/ 16 w 35"/>
                <a:gd name="T13" fmla="*/ 95 h 96"/>
                <a:gd name="T14" fmla="*/ 0 w 35"/>
                <a:gd name="T15" fmla="*/ 95 h 96"/>
                <a:gd name="T16" fmla="*/ 35 w 35"/>
                <a:gd name="T17" fmla="*/ 95 h 96"/>
                <a:gd name="T18" fmla="*/ 35 w 35"/>
                <a:gd name="T19" fmla="*/ 96 h 96"/>
                <a:gd name="T20" fmla="*/ 0 w 35"/>
                <a:gd name="T21" fmla="*/ 96 h 96"/>
                <a:gd name="T22" fmla="*/ 0 w 35"/>
                <a:gd name="T23" fmla="*/ 95 h 96"/>
                <a:gd name="T24" fmla="*/ 0 w 35"/>
                <a:gd name="T25" fmla="*/ 0 h 96"/>
                <a:gd name="T26" fmla="*/ 35 w 35"/>
                <a:gd name="T27" fmla="*/ 0 h 96"/>
                <a:gd name="T28" fmla="*/ 35 w 35"/>
                <a:gd name="T29" fmla="*/ 2 h 96"/>
                <a:gd name="T30" fmla="*/ 0 w 35"/>
                <a:gd name="T31" fmla="*/ 2 h 96"/>
                <a:gd name="T32" fmla="*/ 0 w 35"/>
                <a:gd name="T33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5" h="96">
                  <a:moveTo>
                    <a:pt x="16" y="95"/>
                  </a:moveTo>
                  <a:lnTo>
                    <a:pt x="16" y="48"/>
                  </a:lnTo>
                  <a:lnTo>
                    <a:pt x="16" y="1"/>
                  </a:lnTo>
                  <a:lnTo>
                    <a:pt x="18" y="1"/>
                  </a:lnTo>
                  <a:lnTo>
                    <a:pt x="18" y="48"/>
                  </a:lnTo>
                  <a:lnTo>
                    <a:pt x="18" y="95"/>
                  </a:lnTo>
                  <a:lnTo>
                    <a:pt x="16" y="95"/>
                  </a:lnTo>
                  <a:close/>
                  <a:moveTo>
                    <a:pt x="0" y="95"/>
                  </a:moveTo>
                  <a:lnTo>
                    <a:pt x="35" y="95"/>
                  </a:lnTo>
                  <a:lnTo>
                    <a:pt x="35" y="96"/>
                  </a:lnTo>
                  <a:lnTo>
                    <a:pt x="0" y="96"/>
                  </a:lnTo>
                  <a:lnTo>
                    <a:pt x="0" y="9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8" name="Freeform 102"/>
            <p:cNvSpPr>
              <a:spLocks noEditPoints="1"/>
            </p:cNvSpPr>
            <p:nvPr/>
          </p:nvSpPr>
          <p:spPr bwMode="auto">
            <a:xfrm>
              <a:off x="3738848" y="1549947"/>
              <a:ext cx="41253" cy="97164"/>
            </a:xfrm>
            <a:custGeom>
              <a:avLst/>
              <a:gdLst>
                <a:gd name="T0" fmla="*/ 17 w 35"/>
                <a:gd name="T1" fmla="*/ 83 h 84"/>
                <a:gd name="T2" fmla="*/ 17 w 35"/>
                <a:gd name="T3" fmla="*/ 42 h 84"/>
                <a:gd name="T4" fmla="*/ 17 w 35"/>
                <a:gd name="T5" fmla="*/ 1 h 84"/>
                <a:gd name="T6" fmla="*/ 19 w 35"/>
                <a:gd name="T7" fmla="*/ 1 h 84"/>
                <a:gd name="T8" fmla="*/ 19 w 35"/>
                <a:gd name="T9" fmla="*/ 42 h 84"/>
                <a:gd name="T10" fmla="*/ 19 w 35"/>
                <a:gd name="T11" fmla="*/ 83 h 84"/>
                <a:gd name="T12" fmla="*/ 17 w 35"/>
                <a:gd name="T13" fmla="*/ 83 h 84"/>
                <a:gd name="T14" fmla="*/ 0 w 35"/>
                <a:gd name="T15" fmla="*/ 82 h 84"/>
                <a:gd name="T16" fmla="*/ 35 w 35"/>
                <a:gd name="T17" fmla="*/ 82 h 84"/>
                <a:gd name="T18" fmla="*/ 35 w 35"/>
                <a:gd name="T19" fmla="*/ 84 h 84"/>
                <a:gd name="T20" fmla="*/ 0 w 35"/>
                <a:gd name="T21" fmla="*/ 84 h 84"/>
                <a:gd name="T22" fmla="*/ 0 w 35"/>
                <a:gd name="T23" fmla="*/ 82 h 84"/>
                <a:gd name="T24" fmla="*/ 0 w 35"/>
                <a:gd name="T25" fmla="*/ 0 h 84"/>
                <a:gd name="T26" fmla="*/ 35 w 35"/>
                <a:gd name="T27" fmla="*/ 0 h 84"/>
                <a:gd name="T28" fmla="*/ 35 w 35"/>
                <a:gd name="T29" fmla="*/ 2 h 84"/>
                <a:gd name="T30" fmla="*/ 0 w 35"/>
                <a:gd name="T31" fmla="*/ 2 h 84"/>
                <a:gd name="T32" fmla="*/ 0 w 35"/>
                <a:gd name="T33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5" h="84">
                  <a:moveTo>
                    <a:pt x="17" y="83"/>
                  </a:moveTo>
                  <a:lnTo>
                    <a:pt x="17" y="42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42"/>
                  </a:lnTo>
                  <a:lnTo>
                    <a:pt x="19" y="83"/>
                  </a:lnTo>
                  <a:lnTo>
                    <a:pt x="17" y="83"/>
                  </a:lnTo>
                  <a:close/>
                  <a:moveTo>
                    <a:pt x="0" y="82"/>
                  </a:moveTo>
                  <a:lnTo>
                    <a:pt x="35" y="82"/>
                  </a:lnTo>
                  <a:lnTo>
                    <a:pt x="35" y="84"/>
                  </a:lnTo>
                  <a:lnTo>
                    <a:pt x="0" y="84"/>
                  </a:lnTo>
                  <a:lnTo>
                    <a:pt x="0" y="82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79" name="Freeform 103"/>
            <p:cNvSpPr>
              <a:spLocks noEditPoints="1"/>
            </p:cNvSpPr>
            <p:nvPr/>
          </p:nvSpPr>
          <p:spPr bwMode="auto">
            <a:xfrm>
              <a:off x="4185561" y="1523342"/>
              <a:ext cx="43610" cy="155000"/>
            </a:xfrm>
            <a:custGeom>
              <a:avLst/>
              <a:gdLst>
                <a:gd name="T0" fmla="*/ 17 w 37"/>
                <a:gd name="T1" fmla="*/ 133 h 134"/>
                <a:gd name="T2" fmla="*/ 17 w 37"/>
                <a:gd name="T3" fmla="*/ 67 h 134"/>
                <a:gd name="T4" fmla="*/ 17 w 37"/>
                <a:gd name="T5" fmla="*/ 1 h 134"/>
                <a:gd name="T6" fmla="*/ 19 w 37"/>
                <a:gd name="T7" fmla="*/ 1 h 134"/>
                <a:gd name="T8" fmla="*/ 19 w 37"/>
                <a:gd name="T9" fmla="*/ 67 h 134"/>
                <a:gd name="T10" fmla="*/ 19 w 37"/>
                <a:gd name="T11" fmla="*/ 133 h 134"/>
                <a:gd name="T12" fmla="*/ 17 w 37"/>
                <a:gd name="T13" fmla="*/ 133 h 134"/>
                <a:gd name="T14" fmla="*/ 0 w 37"/>
                <a:gd name="T15" fmla="*/ 132 h 134"/>
                <a:gd name="T16" fmla="*/ 37 w 37"/>
                <a:gd name="T17" fmla="*/ 132 h 134"/>
                <a:gd name="T18" fmla="*/ 37 w 37"/>
                <a:gd name="T19" fmla="*/ 134 h 134"/>
                <a:gd name="T20" fmla="*/ 0 w 37"/>
                <a:gd name="T21" fmla="*/ 134 h 134"/>
                <a:gd name="T22" fmla="*/ 0 w 37"/>
                <a:gd name="T23" fmla="*/ 132 h 134"/>
                <a:gd name="T24" fmla="*/ 0 w 37"/>
                <a:gd name="T25" fmla="*/ 0 h 134"/>
                <a:gd name="T26" fmla="*/ 37 w 37"/>
                <a:gd name="T27" fmla="*/ 0 h 134"/>
                <a:gd name="T28" fmla="*/ 37 w 37"/>
                <a:gd name="T29" fmla="*/ 1 h 134"/>
                <a:gd name="T30" fmla="*/ 0 w 37"/>
                <a:gd name="T31" fmla="*/ 1 h 134"/>
                <a:gd name="T32" fmla="*/ 0 w 37"/>
                <a:gd name="T33" fmla="*/ 0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" h="134">
                  <a:moveTo>
                    <a:pt x="17" y="133"/>
                  </a:moveTo>
                  <a:lnTo>
                    <a:pt x="17" y="67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67"/>
                  </a:lnTo>
                  <a:lnTo>
                    <a:pt x="19" y="133"/>
                  </a:lnTo>
                  <a:lnTo>
                    <a:pt x="17" y="133"/>
                  </a:lnTo>
                  <a:close/>
                  <a:moveTo>
                    <a:pt x="0" y="132"/>
                  </a:moveTo>
                  <a:lnTo>
                    <a:pt x="37" y="132"/>
                  </a:lnTo>
                  <a:lnTo>
                    <a:pt x="37" y="134"/>
                  </a:lnTo>
                  <a:lnTo>
                    <a:pt x="0" y="134"/>
                  </a:lnTo>
                  <a:lnTo>
                    <a:pt x="0" y="132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1"/>
                  </a:lnTo>
                  <a:lnTo>
                    <a:pt x="0" y="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0" name="Freeform 104"/>
            <p:cNvSpPr>
              <a:spLocks noEditPoints="1"/>
            </p:cNvSpPr>
            <p:nvPr/>
          </p:nvSpPr>
          <p:spPr bwMode="auto">
            <a:xfrm>
              <a:off x="4632275" y="1561514"/>
              <a:ext cx="43610" cy="87910"/>
            </a:xfrm>
            <a:custGeom>
              <a:avLst/>
              <a:gdLst>
                <a:gd name="T0" fmla="*/ 18 w 37"/>
                <a:gd name="T1" fmla="*/ 75 h 76"/>
                <a:gd name="T2" fmla="*/ 18 w 37"/>
                <a:gd name="T3" fmla="*/ 38 h 76"/>
                <a:gd name="T4" fmla="*/ 18 w 37"/>
                <a:gd name="T5" fmla="*/ 1 h 76"/>
                <a:gd name="T6" fmla="*/ 19 w 37"/>
                <a:gd name="T7" fmla="*/ 1 h 76"/>
                <a:gd name="T8" fmla="*/ 19 w 37"/>
                <a:gd name="T9" fmla="*/ 38 h 76"/>
                <a:gd name="T10" fmla="*/ 19 w 37"/>
                <a:gd name="T11" fmla="*/ 75 h 76"/>
                <a:gd name="T12" fmla="*/ 18 w 37"/>
                <a:gd name="T13" fmla="*/ 75 h 76"/>
                <a:gd name="T14" fmla="*/ 0 w 37"/>
                <a:gd name="T15" fmla="*/ 74 h 76"/>
                <a:gd name="T16" fmla="*/ 37 w 37"/>
                <a:gd name="T17" fmla="*/ 74 h 76"/>
                <a:gd name="T18" fmla="*/ 37 w 37"/>
                <a:gd name="T19" fmla="*/ 76 h 76"/>
                <a:gd name="T20" fmla="*/ 0 w 37"/>
                <a:gd name="T21" fmla="*/ 76 h 76"/>
                <a:gd name="T22" fmla="*/ 0 w 37"/>
                <a:gd name="T23" fmla="*/ 74 h 76"/>
                <a:gd name="T24" fmla="*/ 0 w 37"/>
                <a:gd name="T25" fmla="*/ 0 h 76"/>
                <a:gd name="T26" fmla="*/ 37 w 37"/>
                <a:gd name="T27" fmla="*/ 0 h 76"/>
                <a:gd name="T28" fmla="*/ 37 w 37"/>
                <a:gd name="T29" fmla="*/ 2 h 76"/>
                <a:gd name="T30" fmla="*/ 0 w 37"/>
                <a:gd name="T31" fmla="*/ 2 h 76"/>
                <a:gd name="T32" fmla="*/ 0 w 37"/>
                <a:gd name="T33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" h="76">
                  <a:moveTo>
                    <a:pt x="18" y="75"/>
                  </a:moveTo>
                  <a:lnTo>
                    <a:pt x="18" y="38"/>
                  </a:lnTo>
                  <a:lnTo>
                    <a:pt x="18" y="1"/>
                  </a:lnTo>
                  <a:lnTo>
                    <a:pt x="19" y="1"/>
                  </a:lnTo>
                  <a:lnTo>
                    <a:pt x="19" y="38"/>
                  </a:lnTo>
                  <a:lnTo>
                    <a:pt x="19" y="75"/>
                  </a:lnTo>
                  <a:lnTo>
                    <a:pt x="18" y="75"/>
                  </a:lnTo>
                  <a:close/>
                  <a:moveTo>
                    <a:pt x="0" y="74"/>
                  </a:moveTo>
                  <a:lnTo>
                    <a:pt x="37" y="74"/>
                  </a:lnTo>
                  <a:lnTo>
                    <a:pt x="37" y="76"/>
                  </a:lnTo>
                  <a:lnTo>
                    <a:pt x="0" y="76"/>
                  </a:lnTo>
                  <a:lnTo>
                    <a:pt x="0" y="74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1" name="Freeform 105"/>
            <p:cNvSpPr>
              <a:spLocks noEditPoints="1"/>
            </p:cNvSpPr>
            <p:nvPr/>
          </p:nvSpPr>
          <p:spPr bwMode="auto">
            <a:xfrm>
              <a:off x="2524823" y="1524499"/>
              <a:ext cx="42432" cy="129552"/>
            </a:xfrm>
            <a:custGeom>
              <a:avLst/>
              <a:gdLst>
                <a:gd name="T0" fmla="*/ 17 w 36"/>
                <a:gd name="T1" fmla="*/ 111 h 112"/>
                <a:gd name="T2" fmla="*/ 17 w 36"/>
                <a:gd name="T3" fmla="*/ 56 h 112"/>
                <a:gd name="T4" fmla="*/ 17 w 36"/>
                <a:gd name="T5" fmla="*/ 1 h 112"/>
                <a:gd name="T6" fmla="*/ 19 w 36"/>
                <a:gd name="T7" fmla="*/ 1 h 112"/>
                <a:gd name="T8" fmla="*/ 19 w 36"/>
                <a:gd name="T9" fmla="*/ 56 h 112"/>
                <a:gd name="T10" fmla="*/ 19 w 36"/>
                <a:gd name="T11" fmla="*/ 111 h 112"/>
                <a:gd name="T12" fmla="*/ 17 w 36"/>
                <a:gd name="T13" fmla="*/ 111 h 112"/>
                <a:gd name="T14" fmla="*/ 0 w 36"/>
                <a:gd name="T15" fmla="*/ 110 h 112"/>
                <a:gd name="T16" fmla="*/ 36 w 36"/>
                <a:gd name="T17" fmla="*/ 110 h 112"/>
                <a:gd name="T18" fmla="*/ 36 w 36"/>
                <a:gd name="T19" fmla="*/ 112 h 112"/>
                <a:gd name="T20" fmla="*/ 0 w 36"/>
                <a:gd name="T21" fmla="*/ 112 h 112"/>
                <a:gd name="T22" fmla="*/ 0 w 36"/>
                <a:gd name="T23" fmla="*/ 110 h 112"/>
                <a:gd name="T24" fmla="*/ 0 w 36"/>
                <a:gd name="T25" fmla="*/ 0 h 112"/>
                <a:gd name="T26" fmla="*/ 36 w 36"/>
                <a:gd name="T27" fmla="*/ 0 h 112"/>
                <a:gd name="T28" fmla="*/ 36 w 36"/>
                <a:gd name="T29" fmla="*/ 2 h 112"/>
                <a:gd name="T30" fmla="*/ 0 w 36"/>
                <a:gd name="T31" fmla="*/ 2 h 112"/>
                <a:gd name="T32" fmla="*/ 0 w 36"/>
                <a:gd name="T33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112">
                  <a:moveTo>
                    <a:pt x="17" y="111"/>
                  </a:moveTo>
                  <a:lnTo>
                    <a:pt x="17" y="56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56"/>
                  </a:lnTo>
                  <a:lnTo>
                    <a:pt x="19" y="111"/>
                  </a:lnTo>
                  <a:lnTo>
                    <a:pt x="17" y="111"/>
                  </a:lnTo>
                  <a:close/>
                  <a:moveTo>
                    <a:pt x="0" y="110"/>
                  </a:moveTo>
                  <a:lnTo>
                    <a:pt x="36" y="110"/>
                  </a:lnTo>
                  <a:lnTo>
                    <a:pt x="36" y="112"/>
                  </a:lnTo>
                  <a:lnTo>
                    <a:pt x="0" y="112"/>
                  </a:lnTo>
                  <a:lnTo>
                    <a:pt x="0" y="11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2" name="Freeform 106"/>
            <p:cNvSpPr>
              <a:spLocks noEditPoints="1"/>
            </p:cNvSpPr>
            <p:nvPr/>
          </p:nvSpPr>
          <p:spPr bwMode="auto">
            <a:xfrm>
              <a:off x="2971537" y="1441216"/>
              <a:ext cx="42432" cy="106418"/>
            </a:xfrm>
            <a:custGeom>
              <a:avLst/>
              <a:gdLst>
                <a:gd name="T0" fmla="*/ 17 w 36"/>
                <a:gd name="T1" fmla="*/ 91 h 92"/>
                <a:gd name="T2" fmla="*/ 17 w 36"/>
                <a:gd name="T3" fmla="*/ 46 h 92"/>
                <a:gd name="T4" fmla="*/ 17 w 36"/>
                <a:gd name="T5" fmla="*/ 1 h 92"/>
                <a:gd name="T6" fmla="*/ 19 w 36"/>
                <a:gd name="T7" fmla="*/ 1 h 92"/>
                <a:gd name="T8" fmla="*/ 19 w 36"/>
                <a:gd name="T9" fmla="*/ 46 h 92"/>
                <a:gd name="T10" fmla="*/ 19 w 36"/>
                <a:gd name="T11" fmla="*/ 91 h 92"/>
                <a:gd name="T12" fmla="*/ 17 w 36"/>
                <a:gd name="T13" fmla="*/ 91 h 92"/>
                <a:gd name="T14" fmla="*/ 0 w 36"/>
                <a:gd name="T15" fmla="*/ 90 h 92"/>
                <a:gd name="T16" fmla="*/ 36 w 36"/>
                <a:gd name="T17" fmla="*/ 90 h 92"/>
                <a:gd name="T18" fmla="*/ 36 w 36"/>
                <a:gd name="T19" fmla="*/ 92 h 92"/>
                <a:gd name="T20" fmla="*/ 0 w 36"/>
                <a:gd name="T21" fmla="*/ 92 h 92"/>
                <a:gd name="T22" fmla="*/ 0 w 36"/>
                <a:gd name="T23" fmla="*/ 90 h 92"/>
                <a:gd name="T24" fmla="*/ 0 w 36"/>
                <a:gd name="T25" fmla="*/ 0 h 92"/>
                <a:gd name="T26" fmla="*/ 36 w 36"/>
                <a:gd name="T27" fmla="*/ 0 h 92"/>
                <a:gd name="T28" fmla="*/ 36 w 36"/>
                <a:gd name="T29" fmla="*/ 2 h 92"/>
                <a:gd name="T30" fmla="*/ 0 w 36"/>
                <a:gd name="T31" fmla="*/ 2 h 92"/>
                <a:gd name="T32" fmla="*/ 0 w 36"/>
                <a:gd name="T33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92">
                  <a:moveTo>
                    <a:pt x="17" y="91"/>
                  </a:moveTo>
                  <a:lnTo>
                    <a:pt x="17" y="46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46"/>
                  </a:lnTo>
                  <a:lnTo>
                    <a:pt x="19" y="91"/>
                  </a:lnTo>
                  <a:lnTo>
                    <a:pt x="17" y="91"/>
                  </a:lnTo>
                  <a:close/>
                  <a:moveTo>
                    <a:pt x="0" y="90"/>
                  </a:moveTo>
                  <a:lnTo>
                    <a:pt x="36" y="90"/>
                  </a:lnTo>
                  <a:lnTo>
                    <a:pt x="36" y="92"/>
                  </a:lnTo>
                  <a:lnTo>
                    <a:pt x="0" y="92"/>
                  </a:lnTo>
                  <a:lnTo>
                    <a:pt x="0" y="9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3" name="Freeform 107"/>
            <p:cNvSpPr>
              <a:spLocks noEditPoints="1"/>
            </p:cNvSpPr>
            <p:nvPr/>
          </p:nvSpPr>
          <p:spPr bwMode="auto">
            <a:xfrm>
              <a:off x="3419429" y="1444686"/>
              <a:ext cx="42432" cy="231343"/>
            </a:xfrm>
            <a:custGeom>
              <a:avLst/>
              <a:gdLst>
                <a:gd name="T0" fmla="*/ 16 w 36"/>
                <a:gd name="T1" fmla="*/ 199 h 200"/>
                <a:gd name="T2" fmla="*/ 16 w 36"/>
                <a:gd name="T3" fmla="*/ 100 h 200"/>
                <a:gd name="T4" fmla="*/ 16 w 36"/>
                <a:gd name="T5" fmla="*/ 1 h 200"/>
                <a:gd name="T6" fmla="*/ 18 w 36"/>
                <a:gd name="T7" fmla="*/ 1 h 200"/>
                <a:gd name="T8" fmla="*/ 18 w 36"/>
                <a:gd name="T9" fmla="*/ 100 h 200"/>
                <a:gd name="T10" fmla="*/ 18 w 36"/>
                <a:gd name="T11" fmla="*/ 199 h 200"/>
                <a:gd name="T12" fmla="*/ 16 w 36"/>
                <a:gd name="T13" fmla="*/ 199 h 200"/>
                <a:gd name="T14" fmla="*/ 0 w 36"/>
                <a:gd name="T15" fmla="*/ 198 h 200"/>
                <a:gd name="T16" fmla="*/ 36 w 36"/>
                <a:gd name="T17" fmla="*/ 198 h 200"/>
                <a:gd name="T18" fmla="*/ 36 w 36"/>
                <a:gd name="T19" fmla="*/ 200 h 200"/>
                <a:gd name="T20" fmla="*/ 0 w 36"/>
                <a:gd name="T21" fmla="*/ 200 h 200"/>
                <a:gd name="T22" fmla="*/ 0 w 36"/>
                <a:gd name="T23" fmla="*/ 198 h 200"/>
                <a:gd name="T24" fmla="*/ 0 w 36"/>
                <a:gd name="T25" fmla="*/ 0 h 200"/>
                <a:gd name="T26" fmla="*/ 36 w 36"/>
                <a:gd name="T27" fmla="*/ 0 h 200"/>
                <a:gd name="T28" fmla="*/ 36 w 36"/>
                <a:gd name="T29" fmla="*/ 2 h 200"/>
                <a:gd name="T30" fmla="*/ 0 w 36"/>
                <a:gd name="T31" fmla="*/ 2 h 200"/>
                <a:gd name="T32" fmla="*/ 0 w 36"/>
                <a:gd name="T33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200">
                  <a:moveTo>
                    <a:pt x="16" y="199"/>
                  </a:moveTo>
                  <a:lnTo>
                    <a:pt x="16" y="100"/>
                  </a:lnTo>
                  <a:lnTo>
                    <a:pt x="16" y="1"/>
                  </a:lnTo>
                  <a:lnTo>
                    <a:pt x="18" y="1"/>
                  </a:lnTo>
                  <a:lnTo>
                    <a:pt x="18" y="100"/>
                  </a:lnTo>
                  <a:lnTo>
                    <a:pt x="18" y="199"/>
                  </a:lnTo>
                  <a:lnTo>
                    <a:pt x="16" y="199"/>
                  </a:lnTo>
                  <a:close/>
                  <a:moveTo>
                    <a:pt x="0" y="198"/>
                  </a:moveTo>
                  <a:lnTo>
                    <a:pt x="36" y="198"/>
                  </a:lnTo>
                  <a:lnTo>
                    <a:pt x="36" y="200"/>
                  </a:lnTo>
                  <a:lnTo>
                    <a:pt x="0" y="200"/>
                  </a:lnTo>
                  <a:lnTo>
                    <a:pt x="0" y="19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4" name="Freeform 108"/>
            <p:cNvSpPr>
              <a:spLocks noEditPoints="1"/>
            </p:cNvSpPr>
            <p:nvPr/>
          </p:nvSpPr>
          <p:spPr bwMode="auto">
            <a:xfrm>
              <a:off x="3866143" y="1692223"/>
              <a:ext cx="42432" cy="106418"/>
            </a:xfrm>
            <a:custGeom>
              <a:avLst/>
              <a:gdLst>
                <a:gd name="T0" fmla="*/ 18 w 36"/>
                <a:gd name="T1" fmla="*/ 91 h 92"/>
                <a:gd name="T2" fmla="*/ 18 w 36"/>
                <a:gd name="T3" fmla="*/ 46 h 92"/>
                <a:gd name="T4" fmla="*/ 18 w 36"/>
                <a:gd name="T5" fmla="*/ 1 h 92"/>
                <a:gd name="T6" fmla="*/ 20 w 36"/>
                <a:gd name="T7" fmla="*/ 1 h 92"/>
                <a:gd name="T8" fmla="*/ 20 w 36"/>
                <a:gd name="T9" fmla="*/ 46 h 92"/>
                <a:gd name="T10" fmla="*/ 20 w 36"/>
                <a:gd name="T11" fmla="*/ 91 h 92"/>
                <a:gd name="T12" fmla="*/ 18 w 36"/>
                <a:gd name="T13" fmla="*/ 91 h 92"/>
                <a:gd name="T14" fmla="*/ 0 w 36"/>
                <a:gd name="T15" fmla="*/ 90 h 92"/>
                <a:gd name="T16" fmla="*/ 36 w 36"/>
                <a:gd name="T17" fmla="*/ 90 h 92"/>
                <a:gd name="T18" fmla="*/ 36 w 36"/>
                <a:gd name="T19" fmla="*/ 92 h 92"/>
                <a:gd name="T20" fmla="*/ 0 w 36"/>
                <a:gd name="T21" fmla="*/ 92 h 92"/>
                <a:gd name="T22" fmla="*/ 0 w 36"/>
                <a:gd name="T23" fmla="*/ 90 h 92"/>
                <a:gd name="T24" fmla="*/ 0 w 36"/>
                <a:gd name="T25" fmla="*/ 0 h 92"/>
                <a:gd name="T26" fmla="*/ 36 w 36"/>
                <a:gd name="T27" fmla="*/ 0 h 92"/>
                <a:gd name="T28" fmla="*/ 36 w 36"/>
                <a:gd name="T29" fmla="*/ 2 h 92"/>
                <a:gd name="T30" fmla="*/ 0 w 36"/>
                <a:gd name="T31" fmla="*/ 2 h 92"/>
                <a:gd name="T32" fmla="*/ 0 w 36"/>
                <a:gd name="T33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92">
                  <a:moveTo>
                    <a:pt x="18" y="91"/>
                  </a:moveTo>
                  <a:lnTo>
                    <a:pt x="18" y="46"/>
                  </a:lnTo>
                  <a:lnTo>
                    <a:pt x="18" y="1"/>
                  </a:lnTo>
                  <a:lnTo>
                    <a:pt x="20" y="1"/>
                  </a:lnTo>
                  <a:lnTo>
                    <a:pt x="20" y="46"/>
                  </a:lnTo>
                  <a:lnTo>
                    <a:pt x="20" y="91"/>
                  </a:lnTo>
                  <a:lnTo>
                    <a:pt x="18" y="91"/>
                  </a:lnTo>
                  <a:close/>
                  <a:moveTo>
                    <a:pt x="0" y="90"/>
                  </a:moveTo>
                  <a:lnTo>
                    <a:pt x="36" y="90"/>
                  </a:lnTo>
                  <a:lnTo>
                    <a:pt x="36" y="92"/>
                  </a:lnTo>
                  <a:lnTo>
                    <a:pt x="0" y="92"/>
                  </a:lnTo>
                  <a:lnTo>
                    <a:pt x="0" y="9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5" name="Freeform 109"/>
            <p:cNvSpPr>
              <a:spLocks noEditPoints="1"/>
            </p:cNvSpPr>
            <p:nvPr/>
          </p:nvSpPr>
          <p:spPr bwMode="auto">
            <a:xfrm>
              <a:off x="4314036" y="1715357"/>
              <a:ext cx="42432" cy="121455"/>
            </a:xfrm>
            <a:custGeom>
              <a:avLst/>
              <a:gdLst>
                <a:gd name="T0" fmla="*/ 17 w 36"/>
                <a:gd name="T1" fmla="*/ 104 h 105"/>
                <a:gd name="T2" fmla="*/ 17 w 36"/>
                <a:gd name="T3" fmla="*/ 52 h 105"/>
                <a:gd name="T4" fmla="*/ 17 w 36"/>
                <a:gd name="T5" fmla="*/ 1 h 105"/>
                <a:gd name="T6" fmla="*/ 19 w 36"/>
                <a:gd name="T7" fmla="*/ 1 h 105"/>
                <a:gd name="T8" fmla="*/ 19 w 36"/>
                <a:gd name="T9" fmla="*/ 52 h 105"/>
                <a:gd name="T10" fmla="*/ 19 w 36"/>
                <a:gd name="T11" fmla="*/ 104 h 105"/>
                <a:gd name="T12" fmla="*/ 17 w 36"/>
                <a:gd name="T13" fmla="*/ 104 h 105"/>
                <a:gd name="T14" fmla="*/ 0 w 36"/>
                <a:gd name="T15" fmla="*/ 103 h 105"/>
                <a:gd name="T16" fmla="*/ 36 w 36"/>
                <a:gd name="T17" fmla="*/ 103 h 105"/>
                <a:gd name="T18" fmla="*/ 36 w 36"/>
                <a:gd name="T19" fmla="*/ 105 h 105"/>
                <a:gd name="T20" fmla="*/ 0 w 36"/>
                <a:gd name="T21" fmla="*/ 105 h 105"/>
                <a:gd name="T22" fmla="*/ 0 w 36"/>
                <a:gd name="T23" fmla="*/ 103 h 105"/>
                <a:gd name="T24" fmla="*/ 0 w 36"/>
                <a:gd name="T25" fmla="*/ 0 h 105"/>
                <a:gd name="T26" fmla="*/ 36 w 36"/>
                <a:gd name="T27" fmla="*/ 0 h 105"/>
                <a:gd name="T28" fmla="*/ 36 w 36"/>
                <a:gd name="T29" fmla="*/ 2 h 105"/>
                <a:gd name="T30" fmla="*/ 0 w 36"/>
                <a:gd name="T31" fmla="*/ 2 h 105"/>
                <a:gd name="T32" fmla="*/ 0 w 36"/>
                <a:gd name="T33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105">
                  <a:moveTo>
                    <a:pt x="17" y="104"/>
                  </a:moveTo>
                  <a:lnTo>
                    <a:pt x="17" y="52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52"/>
                  </a:lnTo>
                  <a:lnTo>
                    <a:pt x="19" y="104"/>
                  </a:lnTo>
                  <a:lnTo>
                    <a:pt x="17" y="104"/>
                  </a:lnTo>
                  <a:close/>
                  <a:moveTo>
                    <a:pt x="0" y="103"/>
                  </a:moveTo>
                  <a:lnTo>
                    <a:pt x="36" y="103"/>
                  </a:lnTo>
                  <a:lnTo>
                    <a:pt x="36" y="105"/>
                  </a:lnTo>
                  <a:lnTo>
                    <a:pt x="0" y="105"/>
                  </a:lnTo>
                  <a:lnTo>
                    <a:pt x="0" y="10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6" name="Freeform 110"/>
            <p:cNvSpPr>
              <a:spLocks noEditPoints="1"/>
            </p:cNvSpPr>
            <p:nvPr/>
          </p:nvSpPr>
          <p:spPr bwMode="auto">
            <a:xfrm>
              <a:off x="4760749" y="1660992"/>
              <a:ext cx="42432" cy="85597"/>
            </a:xfrm>
            <a:custGeom>
              <a:avLst/>
              <a:gdLst>
                <a:gd name="T0" fmla="*/ 17 w 36"/>
                <a:gd name="T1" fmla="*/ 73 h 74"/>
                <a:gd name="T2" fmla="*/ 17 w 36"/>
                <a:gd name="T3" fmla="*/ 37 h 74"/>
                <a:gd name="T4" fmla="*/ 17 w 36"/>
                <a:gd name="T5" fmla="*/ 1 h 74"/>
                <a:gd name="T6" fmla="*/ 19 w 36"/>
                <a:gd name="T7" fmla="*/ 1 h 74"/>
                <a:gd name="T8" fmla="*/ 19 w 36"/>
                <a:gd name="T9" fmla="*/ 37 h 74"/>
                <a:gd name="T10" fmla="*/ 19 w 36"/>
                <a:gd name="T11" fmla="*/ 73 h 74"/>
                <a:gd name="T12" fmla="*/ 17 w 36"/>
                <a:gd name="T13" fmla="*/ 73 h 74"/>
                <a:gd name="T14" fmla="*/ 0 w 36"/>
                <a:gd name="T15" fmla="*/ 73 h 74"/>
                <a:gd name="T16" fmla="*/ 36 w 36"/>
                <a:gd name="T17" fmla="*/ 73 h 74"/>
                <a:gd name="T18" fmla="*/ 36 w 36"/>
                <a:gd name="T19" fmla="*/ 74 h 74"/>
                <a:gd name="T20" fmla="*/ 0 w 36"/>
                <a:gd name="T21" fmla="*/ 74 h 74"/>
                <a:gd name="T22" fmla="*/ 0 w 36"/>
                <a:gd name="T23" fmla="*/ 73 h 74"/>
                <a:gd name="T24" fmla="*/ 0 w 36"/>
                <a:gd name="T25" fmla="*/ 0 h 74"/>
                <a:gd name="T26" fmla="*/ 36 w 36"/>
                <a:gd name="T27" fmla="*/ 0 h 74"/>
                <a:gd name="T28" fmla="*/ 36 w 36"/>
                <a:gd name="T29" fmla="*/ 1 h 74"/>
                <a:gd name="T30" fmla="*/ 0 w 36"/>
                <a:gd name="T31" fmla="*/ 1 h 74"/>
                <a:gd name="T32" fmla="*/ 0 w 36"/>
                <a:gd name="T33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74">
                  <a:moveTo>
                    <a:pt x="17" y="73"/>
                  </a:moveTo>
                  <a:lnTo>
                    <a:pt x="17" y="37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37"/>
                  </a:lnTo>
                  <a:lnTo>
                    <a:pt x="19" y="73"/>
                  </a:lnTo>
                  <a:lnTo>
                    <a:pt x="17" y="73"/>
                  </a:lnTo>
                  <a:close/>
                  <a:moveTo>
                    <a:pt x="0" y="73"/>
                  </a:moveTo>
                  <a:lnTo>
                    <a:pt x="36" y="73"/>
                  </a:lnTo>
                  <a:lnTo>
                    <a:pt x="36" y="74"/>
                  </a:lnTo>
                  <a:lnTo>
                    <a:pt x="0" y="74"/>
                  </a:lnTo>
                  <a:lnTo>
                    <a:pt x="0" y="7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1"/>
                  </a:lnTo>
                  <a:lnTo>
                    <a:pt x="0" y="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7" name="Freeform 112"/>
            <p:cNvSpPr>
              <a:spLocks noEditPoints="1"/>
            </p:cNvSpPr>
            <p:nvPr/>
          </p:nvSpPr>
          <p:spPr bwMode="auto">
            <a:xfrm>
              <a:off x="2227800" y="721741"/>
              <a:ext cx="30645" cy="1700368"/>
            </a:xfrm>
            <a:custGeom>
              <a:avLst/>
              <a:gdLst>
                <a:gd name="T0" fmla="*/ 0 w 26"/>
                <a:gd name="T1" fmla="*/ 1468 h 1470"/>
                <a:gd name="T2" fmla="*/ 26 w 26"/>
                <a:gd name="T3" fmla="*/ 1468 h 1470"/>
                <a:gd name="T4" fmla="*/ 26 w 26"/>
                <a:gd name="T5" fmla="*/ 1470 h 1470"/>
                <a:gd name="T6" fmla="*/ 0 w 26"/>
                <a:gd name="T7" fmla="*/ 1470 h 1470"/>
                <a:gd name="T8" fmla="*/ 0 w 26"/>
                <a:gd name="T9" fmla="*/ 1468 h 1470"/>
                <a:gd name="T10" fmla="*/ 0 w 26"/>
                <a:gd name="T11" fmla="*/ 1223 h 1470"/>
                <a:gd name="T12" fmla="*/ 26 w 26"/>
                <a:gd name="T13" fmla="*/ 1223 h 1470"/>
                <a:gd name="T14" fmla="*/ 26 w 26"/>
                <a:gd name="T15" fmla="*/ 1225 h 1470"/>
                <a:gd name="T16" fmla="*/ 0 w 26"/>
                <a:gd name="T17" fmla="*/ 1225 h 1470"/>
                <a:gd name="T18" fmla="*/ 0 w 26"/>
                <a:gd name="T19" fmla="*/ 1223 h 1470"/>
                <a:gd name="T20" fmla="*/ 0 w 26"/>
                <a:gd name="T21" fmla="*/ 979 h 1470"/>
                <a:gd name="T22" fmla="*/ 26 w 26"/>
                <a:gd name="T23" fmla="*/ 979 h 1470"/>
                <a:gd name="T24" fmla="*/ 26 w 26"/>
                <a:gd name="T25" fmla="*/ 980 h 1470"/>
                <a:gd name="T26" fmla="*/ 0 w 26"/>
                <a:gd name="T27" fmla="*/ 980 h 1470"/>
                <a:gd name="T28" fmla="*/ 0 w 26"/>
                <a:gd name="T29" fmla="*/ 979 h 1470"/>
                <a:gd name="T30" fmla="*/ 0 w 26"/>
                <a:gd name="T31" fmla="*/ 734 h 1470"/>
                <a:gd name="T32" fmla="*/ 26 w 26"/>
                <a:gd name="T33" fmla="*/ 734 h 1470"/>
                <a:gd name="T34" fmla="*/ 26 w 26"/>
                <a:gd name="T35" fmla="*/ 736 h 1470"/>
                <a:gd name="T36" fmla="*/ 0 w 26"/>
                <a:gd name="T37" fmla="*/ 736 h 1470"/>
                <a:gd name="T38" fmla="*/ 0 w 26"/>
                <a:gd name="T39" fmla="*/ 734 h 1470"/>
                <a:gd name="T40" fmla="*/ 0 w 26"/>
                <a:gd name="T41" fmla="*/ 489 h 1470"/>
                <a:gd name="T42" fmla="*/ 26 w 26"/>
                <a:gd name="T43" fmla="*/ 489 h 1470"/>
                <a:gd name="T44" fmla="*/ 26 w 26"/>
                <a:gd name="T45" fmla="*/ 491 h 1470"/>
                <a:gd name="T46" fmla="*/ 0 w 26"/>
                <a:gd name="T47" fmla="*/ 491 h 1470"/>
                <a:gd name="T48" fmla="*/ 0 w 26"/>
                <a:gd name="T49" fmla="*/ 489 h 1470"/>
                <a:gd name="T50" fmla="*/ 0 w 26"/>
                <a:gd name="T51" fmla="*/ 244 h 1470"/>
                <a:gd name="T52" fmla="*/ 26 w 26"/>
                <a:gd name="T53" fmla="*/ 244 h 1470"/>
                <a:gd name="T54" fmla="*/ 26 w 26"/>
                <a:gd name="T55" fmla="*/ 246 h 1470"/>
                <a:gd name="T56" fmla="*/ 0 w 26"/>
                <a:gd name="T57" fmla="*/ 246 h 1470"/>
                <a:gd name="T58" fmla="*/ 0 w 26"/>
                <a:gd name="T59" fmla="*/ 244 h 1470"/>
                <a:gd name="T60" fmla="*/ 0 w 26"/>
                <a:gd name="T61" fmla="*/ 0 h 1470"/>
                <a:gd name="T62" fmla="*/ 26 w 26"/>
                <a:gd name="T63" fmla="*/ 0 h 1470"/>
                <a:gd name="T64" fmla="*/ 26 w 26"/>
                <a:gd name="T65" fmla="*/ 2 h 1470"/>
                <a:gd name="T66" fmla="*/ 0 w 26"/>
                <a:gd name="T67" fmla="*/ 2 h 1470"/>
                <a:gd name="T68" fmla="*/ 0 w 26"/>
                <a:gd name="T69" fmla="*/ 0 h 1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26" h="1470">
                  <a:moveTo>
                    <a:pt x="0" y="1468"/>
                  </a:moveTo>
                  <a:lnTo>
                    <a:pt x="26" y="1468"/>
                  </a:lnTo>
                  <a:lnTo>
                    <a:pt x="26" y="1470"/>
                  </a:lnTo>
                  <a:lnTo>
                    <a:pt x="0" y="1470"/>
                  </a:lnTo>
                  <a:lnTo>
                    <a:pt x="0" y="1468"/>
                  </a:lnTo>
                  <a:close/>
                  <a:moveTo>
                    <a:pt x="0" y="1223"/>
                  </a:moveTo>
                  <a:lnTo>
                    <a:pt x="26" y="1223"/>
                  </a:lnTo>
                  <a:lnTo>
                    <a:pt x="26" y="1225"/>
                  </a:lnTo>
                  <a:lnTo>
                    <a:pt x="0" y="1225"/>
                  </a:lnTo>
                  <a:lnTo>
                    <a:pt x="0" y="1223"/>
                  </a:lnTo>
                  <a:close/>
                  <a:moveTo>
                    <a:pt x="0" y="979"/>
                  </a:moveTo>
                  <a:lnTo>
                    <a:pt x="26" y="979"/>
                  </a:lnTo>
                  <a:lnTo>
                    <a:pt x="26" y="980"/>
                  </a:lnTo>
                  <a:lnTo>
                    <a:pt x="0" y="980"/>
                  </a:lnTo>
                  <a:lnTo>
                    <a:pt x="0" y="979"/>
                  </a:lnTo>
                  <a:close/>
                  <a:moveTo>
                    <a:pt x="0" y="734"/>
                  </a:moveTo>
                  <a:lnTo>
                    <a:pt x="26" y="734"/>
                  </a:lnTo>
                  <a:lnTo>
                    <a:pt x="26" y="736"/>
                  </a:lnTo>
                  <a:lnTo>
                    <a:pt x="0" y="736"/>
                  </a:lnTo>
                  <a:lnTo>
                    <a:pt x="0" y="734"/>
                  </a:lnTo>
                  <a:close/>
                  <a:moveTo>
                    <a:pt x="0" y="489"/>
                  </a:moveTo>
                  <a:lnTo>
                    <a:pt x="26" y="489"/>
                  </a:lnTo>
                  <a:lnTo>
                    <a:pt x="26" y="491"/>
                  </a:lnTo>
                  <a:lnTo>
                    <a:pt x="0" y="491"/>
                  </a:lnTo>
                  <a:lnTo>
                    <a:pt x="0" y="489"/>
                  </a:lnTo>
                  <a:close/>
                  <a:moveTo>
                    <a:pt x="0" y="244"/>
                  </a:moveTo>
                  <a:lnTo>
                    <a:pt x="26" y="244"/>
                  </a:lnTo>
                  <a:lnTo>
                    <a:pt x="26" y="246"/>
                  </a:lnTo>
                  <a:lnTo>
                    <a:pt x="0" y="246"/>
                  </a:lnTo>
                  <a:lnTo>
                    <a:pt x="0" y="244"/>
                  </a:lnTo>
                  <a:close/>
                  <a:moveTo>
                    <a:pt x="0" y="0"/>
                  </a:moveTo>
                  <a:lnTo>
                    <a:pt x="26" y="0"/>
                  </a:lnTo>
                  <a:lnTo>
                    <a:pt x="2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8" name="Freeform 114"/>
            <p:cNvSpPr>
              <a:spLocks noEditPoints="1"/>
            </p:cNvSpPr>
            <p:nvPr/>
          </p:nvSpPr>
          <p:spPr bwMode="auto">
            <a:xfrm>
              <a:off x="2257266" y="2420952"/>
              <a:ext cx="2684997" cy="28918"/>
            </a:xfrm>
            <a:custGeom>
              <a:avLst/>
              <a:gdLst>
                <a:gd name="T0" fmla="*/ 2 w 2278"/>
                <a:gd name="T1" fmla="*/ 0 h 25"/>
                <a:gd name="T2" fmla="*/ 2 w 2278"/>
                <a:gd name="T3" fmla="*/ 25 h 25"/>
                <a:gd name="T4" fmla="*/ 0 w 2278"/>
                <a:gd name="T5" fmla="*/ 25 h 25"/>
                <a:gd name="T6" fmla="*/ 0 w 2278"/>
                <a:gd name="T7" fmla="*/ 0 h 25"/>
                <a:gd name="T8" fmla="*/ 2 w 2278"/>
                <a:gd name="T9" fmla="*/ 0 h 25"/>
                <a:gd name="T10" fmla="*/ 381 w 2278"/>
                <a:gd name="T11" fmla="*/ 0 h 25"/>
                <a:gd name="T12" fmla="*/ 381 w 2278"/>
                <a:gd name="T13" fmla="*/ 25 h 25"/>
                <a:gd name="T14" fmla="*/ 379 w 2278"/>
                <a:gd name="T15" fmla="*/ 25 h 25"/>
                <a:gd name="T16" fmla="*/ 379 w 2278"/>
                <a:gd name="T17" fmla="*/ 0 h 25"/>
                <a:gd name="T18" fmla="*/ 381 w 2278"/>
                <a:gd name="T19" fmla="*/ 0 h 25"/>
                <a:gd name="T20" fmla="*/ 761 w 2278"/>
                <a:gd name="T21" fmla="*/ 0 h 25"/>
                <a:gd name="T22" fmla="*/ 761 w 2278"/>
                <a:gd name="T23" fmla="*/ 25 h 25"/>
                <a:gd name="T24" fmla="*/ 759 w 2278"/>
                <a:gd name="T25" fmla="*/ 25 h 25"/>
                <a:gd name="T26" fmla="*/ 759 w 2278"/>
                <a:gd name="T27" fmla="*/ 0 h 25"/>
                <a:gd name="T28" fmla="*/ 761 w 2278"/>
                <a:gd name="T29" fmla="*/ 0 h 25"/>
                <a:gd name="T30" fmla="*/ 1141 w 2278"/>
                <a:gd name="T31" fmla="*/ 0 h 25"/>
                <a:gd name="T32" fmla="*/ 1141 w 2278"/>
                <a:gd name="T33" fmla="*/ 25 h 25"/>
                <a:gd name="T34" fmla="*/ 1139 w 2278"/>
                <a:gd name="T35" fmla="*/ 25 h 25"/>
                <a:gd name="T36" fmla="*/ 1139 w 2278"/>
                <a:gd name="T37" fmla="*/ 0 h 25"/>
                <a:gd name="T38" fmla="*/ 1141 w 2278"/>
                <a:gd name="T39" fmla="*/ 0 h 25"/>
                <a:gd name="T40" fmla="*/ 1520 w 2278"/>
                <a:gd name="T41" fmla="*/ 0 h 25"/>
                <a:gd name="T42" fmla="*/ 1520 w 2278"/>
                <a:gd name="T43" fmla="*/ 25 h 25"/>
                <a:gd name="T44" fmla="*/ 1518 w 2278"/>
                <a:gd name="T45" fmla="*/ 25 h 25"/>
                <a:gd name="T46" fmla="*/ 1518 w 2278"/>
                <a:gd name="T47" fmla="*/ 0 h 25"/>
                <a:gd name="T48" fmla="*/ 1520 w 2278"/>
                <a:gd name="T49" fmla="*/ 0 h 25"/>
                <a:gd name="T50" fmla="*/ 1899 w 2278"/>
                <a:gd name="T51" fmla="*/ 0 h 25"/>
                <a:gd name="T52" fmla="*/ 1899 w 2278"/>
                <a:gd name="T53" fmla="*/ 25 h 25"/>
                <a:gd name="T54" fmla="*/ 1897 w 2278"/>
                <a:gd name="T55" fmla="*/ 25 h 25"/>
                <a:gd name="T56" fmla="*/ 1897 w 2278"/>
                <a:gd name="T57" fmla="*/ 0 h 25"/>
                <a:gd name="T58" fmla="*/ 1899 w 2278"/>
                <a:gd name="T59" fmla="*/ 0 h 25"/>
                <a:gd name="T60" fmla="*/ 2278 w 2278"/>
                <a:gd name="T61" fmla="*/ 0 h 25"/>
                <a:gd name="T62" fmla="*/ 2278 w 2278"/>
                <a:gd name="T63" fmla="*/ 25 h 25"/>
                <a:gd name="T64" fmla="*/ 2276 w 2278"/>
                <a:gd name="T65" fmla="*/ 25 h 25"/>
                <a:gd name="T66" fmla="*/ 2276 w 2278"/>
                <a:gd name="T67" fmla="*/ 0 h 25"/>
                <a:gd name="T68" fmla="*/ 2278 w 2278"/>
                <a:gd name="T69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2278" h="25">
                  <a:moveTo>
                    <a:pt x="2" y="0"/>
                  </a:moveTo>
                  <a:lnTo>
                    <a:pt x="2" y="25"/>
                  </a:lnTo>
                  <a:lnTo>
                    <a:pt x="0" y="25"/>
                  </a:lnTo>
                  <a:lnTo>
                    <a:pt x="0" y="0"/>
                  </a:lnTo>
                  <a:lnTo>
                    <a:pt x="2" y="0"/>
                  </a:lnTo>
                  <a:close/>
                  <a:moveTo>
                    <a:pt x="381" y="0"/>
                  </a:moveTo>
                  <a:lnTo>
                    <a:pt x="381" y="25"/>
                  </a:lnTo>
                  <a:lnTo>
                    <a:pt x="379" y="25"/>
                  </a:lnTo>
                  <a:lnTo>
                    <a:pt x="379" y="0"/>
                  </a:lnTo>
                  <a:lnTo>
                    <a:pt x="381" y="0"/>
                  </a:lnTo>
                  <a:close/>
                  <a:moveTo>
                    <a:pt x="761" y="0"/>
                  </a:moveTo>
                  <a:lnTo>
                    <a:pt x="761" y="25"/>
                  </a:lnTo>
                  <a:lnTo>
                    <a:pt x="759" y="25"/>
                  </a:lnTo>
                  <a:lnTo>
                    <a:pt x="759" y="0"/>
                  </a:lnTo>
                  <a:lnTo>
                    <a:pt x="761" y="0"/>
                  </a:lnTo>
                  <a:close/>
                  <a:moveTo>
                    <a:pt x="1141" y="0"/>
                  </a:moveTo>
                  <a:lnTo>
                    <a:pt x="1141" y="25"/>
                  </a:lnTo>
                  <a:lnTo>
                    <a:pt x="1139" y="25"/>
                  </a:lnTo>
                  <a:lnTo>
                    <a:pt x="1139" y="0"/>
                  </a:lnTo>
                  <a:lnTo>
                    <a:pt x="1141" y="0"/>
                  </a:lnTo>
                  <a:close/>
                  <a:moveTo>
                    <a:pt x="1520" y="0"/>
                  </a:moveTo>
                  <a:lnTo>
                    <a:pt x="1520" y="25"/>
                  </a:lnTo>
                  <a:lnTo>
                    <a:pt x="1518" y="25"/>
                  </a:lnTo>
                  <a:lnTo>
                    <a:pt x="1518" y="0"/>
                  </a:lnTo>
                  <a:lnTo>
                    <a:pt x="1520" y="0"/>
                  </a:lnTo>
                  <a:close/>
                  <a:moveTo>
                    <a:pt x="1899" y="0"/>
                  </a:moveTo>
                  <a:lnTo>
                    <a:pt x="1899" y="25"/>
                  </a:lnTo>
                  <a:lnTo>
                    <a:pt x="1897" y="25"/>
                  </a:lnTo>
                  <a:lnTo>
                    <a:pt x="1897" y="0"/>
                  </a:lnTo>
                  <a:lnTo>
                    <a:pt x="1899" y="0"/>
                  </a:lnTo>
                  <a:close/>
                  <a:moveTo>
                    <a:pt x="2278" y="0"/>
                  </a:moveTo>
                  <a:lnTo>
                    <a:pt x="2278" y="25"/>
                  </a:lnTo>
                  <a:lnTo>
                    <a:pt x="2276" y="25"/>
                  </a:lnTo>
                  <a:lnTo>
                    <a:pt x="2276" y="0"/>
                  </a:lnTo>
                  <a:lnTo>
                    <a:pt x="2278" y="0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289" name="Rectangle 288"/>
            <p:cNvSpPr/>
            <p:nvPr/>
          </p:nvSpPr>
          <p:spPr>
            <a:xfrm>
              <a:off x="2255400" y="720045"/>
              <a:ext cx="2691609" cy="170484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noProof="1"/>
            </a:p>
          </p:txBody>
        </p:sp>
        <p:grpSp>
          <p:nvGrpSpPr>
            <p:cNvPr id="6" name="Grouper 307"/>
            <p:cNvGrpSpPr/>
            <p:nvPr/>
          </p:nvGrpSpPr>
          <p:grpSpPr>
            <a:xfrm>
              <a:off x="4138383" y="874013"/>
              <a:ext cx="635649" cy="330280"/>
              <a:chOff x="457200" y="1088231"/>
              <a:chExt cx="635649" cy="330280"/>
            </a:xfrm>
          </p:grpSpPr>
          <p:sp>
            <p:nvSpPr>
              <p:cNvPr id="309" name="Rectangle 126"/>
              <p:cNvSpPr>
                <a:spLocks noChangeArrowheads="1"/>
              </p:cNvSpPr>
              <p:nvPr/>
            </p:nvSpPr>
            <p:spPr bwMode="auto">
              <a:xfrm>
                <a:off x="533400" y="1088231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AVG</a:t>
                </a:r>
                <a:endParaRPr kumimoji="0" lang="en-GB" sz="1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310" name="Rectangle 129"/>
              <p:cNvSpPr>
                <a:spLocks noChangeArrowheads="1"/>
              </p:cNvSpPr>
              <p:nvPr/>
            </p:nvSpPr>
            <p:spPr bwMode="auto">
              <a:xfrm>
                <a:off x="533400" y="1295400"/>
                <a:ext cx="55944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AVG + GLU</a:t>
                </a:r>
                <a:endParaRPr kumimoji="0" lang="en-GB" sz="1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grpSp>
            <p:nvGrpSpPr>
              <p:cNvPr id="7" name="Grouper 162"/>
              <p:cNvGrpSpPr/>
              <p:nvPr/>
            </p:nvGrpSpPr>
            <p:grpSpPr>
              <a:xfrm>
                <a:off x="457200" y="1143000"/>
                <a:ext cx="47079" cy="244828"/>
                <a:chOff x="3644401" y="3162154"/>
                <a:chExt cx="47079" cy="244828"/>
              </a:xfrm>
            </p:grpSpPr>
            <p:sp>
              <p:nvSpPr>
                <p:cNvPr id="312" name="Rectangle 195"/>
                <p:cNvSpPr>
                  <a:spLocks noChangeArrowheads="1"/>
                </p:cNvSpPr>
                <p:nvPr/>
              </p:nvSpPr>
              <p:spPr bwMode="auto">
                <a:xfrm>
                  <a:off x="3645640" y="3163491"/>
                  <a:ext cx="44601" cy="49501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noProof="1"/>
                </a:p>
              </p:txBody>
            </p:sp>
            <p:sp>
              <p:nvSpPr>
                <p:cNvPr id="313" name="Freeform 196"/>
                <p:cNvSpPr>
                  <a:spLocks noEditPoints="1"/>
                </p:cNvSpPr>
                <p:nvPr/>
              </p:nvSpPr>
              <p:spPr bwMode="auto">
                <a:xfrm>
                  <a:off x="3644401" y="3162154"/>
                  <a:ext cx="47079" cy="52177"/>
                </a:xfrm>
                <a:custGeom>
                  <a:avLst/>
                  <a:gdLst>
                    <a:gd name="T0" fmla="*/ 0 w 640"/>
                    <a:gd name="T1" fmla="*/ 16 h 656"/>
                    <a:gd name="T2" fmla="*/ 16 w 640"/>
                    <a:gd name="T3" fmla="*/ 0 h 656"/>
                    <a:gd name="T4" fmla="*/ 624 w 640"/>
                    <a:gd name="T5" fmla="*/ 0 h 656"/>
                    <a:gd name="T6" fmla="*/ 640 w 640"/>
                    <a:gd name="T7" fmla="*/ 16 h 656"/>
                    <a:gd name="T8" fmla="*/ 640 w 640"/>
                    <a:gd name="T9" fmla="*/ 640 h 656"/>
                    <a:gd name="T10" fmla="*/ 624 w 640"/>
                    <a:gd name="T11" fmla="*/ 656 h 656"/>
                    <a:gd name="T12" fmla="*/ 16 w 640"/>
                    <a:gd name="T13" fmla="*/ 656 h 656"/>
                    <a:gd name="T14" fmla="*/ 0 w 640"/>
                    <a:gd name="T15" fmla="*/ 640 h 656"/>
                    <a:gd name="T16" fmla="*/ 0 w 640"/>
                    <a:gd name="T17" fmla="*/ 16 h 656"/>
                    <a:gd name="T18" fmla="*/ 32 w 640"/>
                    <a:gd name="T19" fmla="*/ 640 h 656"/>
                    <a:gd name="T20" fmla="*/ 16 w 640"/>
                    <a:gd name="T21" fmla="*/ 624 h 656"/>
                    <a:gd name="T22" fmla="*/ 624 w 640"/>
                    <a:gd name="T23" fmla="*/ 624 h 656"/>
                    <a:gd name="T24" fmla="*/ 608 w 640"/>
                    <a:gd name="T25" fmla="*/ 640 h 656"/>
                    <a:gd name="T26" fmla="*/ 608 w 640"/>
                    <a:gd name="T27" fmla="*/ 16 h 656"/>
                    <a:gd name="T28" fmla="*/ 624 w 640"/>
                    <a:gd name="T29" fmla="*/ 32 h 656"/>
                    <a:gd name="T30" fmla="*/ 16 w 640"/>
                    <a:gd name="T31" fmla="*/ 32 h 656"/>
                    <a:gd name="T32" fmla="*/ 32 w 640"/>
                    <a:gd name="T33" fmla="*/ 16 h 656"/>
                    <a:gd name="T34" fmla="*/ 32 w 640"/>
                    <a:gd name="T35" fmla="*/ 640 h 6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640" h="656">
                      <a:moveTo>
                        <a:pt x="0" y="16"/>
                      </a:moveTo>
                      <a:cubicBezTo>
                        <a:pt x="0" y="8"/>
                        <a:pt x="8" y="0"/>
                        <a:pt x="16" y="0"/>
                      </a:cubicBezTo>
                      <a:lnTo>
                        <a:pt x="624" y="0"/>
                      </a:lnTo>
                      <a:cubicBezTo>
                        <a:pt x="633" y="0"/>
                        <a:pt x="640" y="8"/>
                        <a:pt x="640" y="16"/>
                      </a:cubicBezTo>
                      <a:lnTo>
                        <a:pt x="640" y="640"/>
                      </a:lnTo>
                      <a:cubicBezTo>
                        <a:pt x="640" y="649"/>
                        <a:pt x="633" y="656"/>
                        <a:pt x="624" y="656"/>
                      </a:cubicBezTo>
                      <a:lnTo>
                        <a:pt x="16" y="656"/>
                      </a:lnTo>
                      <a:cubicBezTo>
                        <a:pt x="8" y="656"/>
                        <a:pt x="0" y="649"/>
                        <a:pt x="0" y="640"/>
                      </a:cubicBezTo>
                      <a:lnTo>
                        <a:pt x="0" y="16"/>
                      </a:lnTo>
                      <a:close/>
                      <a:moveTo>
                        <a:pt x="32" y="640"/>
                      </a:moveTo>
                      <a:lnTo>
                        <a:pt x="16" y="624"/>
                      </a:lnTo>
                      <a:lnTo>
                        <a:pt x="624" y="624"/>
                      </a:lnTo>
                      <a:lnTo>
                        <a:pt x="608" y="640"/>
                      </a:lnTo>
                      <a:lnTo>
                        <a:pt x="608" y="16"/>
                      </a:lnTo>
                      <a:lnTo>
                        <a:pt x="624" y="32"/>
                      </a:lnTo>
                      <a:lnTo>
                        <a:pt x="16" y="32"/>
                      </a:lnTo>
                      <a:lnTo>
                        <a:pt x="32" y="16"/>
                      </a:lnTo>
                      <a:lnTo>
                        <a:pt x="32" y="64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noProof="1"/>
                </a:p>
              </p:txBody>
            </p:sp>
            <p:sp>
              <p:nvSpPr>
                <p:cNvPr id="314" name="Rectangle 198"/>
                <p:cNvSpPr>
                  <a:spLocks noChangeArrowheads="1"/>
                </p:cNvSpPr>
                <p:nvPr/>
              </p:nvSpPr>
              <p:spPr bwMode="auto">
                <a:xfrm>
                  <a:off x="3645640" y="3356143"/>
                  <a:ext cx="44601" cy="49501"/>
                </a:xfrm>
                <a:prstGeom prst="rect">
                  <a:avLst/>
                </a:prstGeom>
                <a:solidFill>
                  <a:srgbClr val="D9D9D9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noProof="1"/>
                </a:p>
              </p:txBody>
            </p:sp>
            <p:sp>
              <p:nvSpPr>
                <p:cNvPr id="315" name="Freeform 199"/>
                <p:cNvSpPr>
                  <a:spLocks noEditPoints="1"/>
                </p:cNvSpPr>
                <p:nvPr/>
              </p:nvSpPr>
              <p:spPr bwMode="auto">
                <a:xfrm>
                  <a:off x="3644401" y="3354805"/>
                  <a:ext cx="47079" cy="52177"/>
                </a:xfrm>
                <a:custGeom>
                  <a:avLst/>
                  <a:gdLst>
                    <a:gd name="T0" fmla="*/ 0 w 640"/>
                    <a:gd name="T1" fmla="*/ 16 h 656"/>
                    <a:gd name="T2" fmla="*/ 16 w 640"/>
                    <a:gd name="T3" fmla="*/ 0 h 656"/>
                    <a:gd name="T4" fmla="*/ 624 w 640"/>
                    <a:gd name="T5" fmla="*/ 0 h 656"/>
                    <a:gd name="T6" fmla="*/ 640 w 640"/>
                    <a:gd name="T7" fmla="*/ 16 h 656"/>
                    <a:gd name="T8" fmla="*/ 640 w 640"/>
                    <a:gd name="T9" fmla="*/ 640 h 656"/>
                    <a:gd name="T10" fmla="*/ 624 w 640"/>
                    <a:gd name="T11" fmla="*/ 656 h 656"/>
                    <a:gd name="T12" fmla="*/ 16 w 640"/>
                    <a:gd name="T13" fmla="*/ 656 h 656"/>
                    <a:gd name="T14" fmla="*/ 0 w 640"/>
                    <a:gd name="T15" fmla="*/ 640 h 656"/>
                    <a:gd name="T16" fmla="*/ 0 w 640"/>
                    <a:gd name="T17" fmla="*/ 16 h 656"/>
                    <a:gd name="T18" fmla="*/ 32 w 640"/>
                    <a:gd name="T19" fmla="*/ 640 h 656"/>
                    <a:gd name="T20" fmla="*/ 16 w 640"/>
                    <a:gd name="T21" fmla="*/ 624 h 656"/>
                    <a:gd name="T22" fmla="*/ 624 w 640"/>
                    <a:gd name="T23" fmla="*/ 624 h 656"/>
                    <a:gd name="T24" fmla="*/ 608 w 640"/>
                    <a:gd name="T25" fmla="*/ 640 h 656"/>
                    <a:gd name="T26" fmla="*/ 608 w 640"/>
                    <a:gd name="T27" fmla="*/ 16 h 656"/>
                    <a:gd name="T28" fmla="*/ 624 w 640"/>
                    <a:gd name="T29" fmla="*/ 32 h 656"/>
                    <a:gd name="T30" fmla="*/ 16 w 640"/>
                    <a:gd name="T31" fmla="*/ 32 h 656"/>
                    <a:gd name="T32" fmla="*/ 32 w 640"/>
                    <a:gd name="T33" fmla="*/ 16 h 656"/>
                    <a:gd name="T34" fmla="*/ 32 w 640"/>
                    <a:gd name="T35" fmla="*/ 640 h 6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640" h="656">
                      <a:moveTo>
                        <a:pt x="0" y="16"/>
                      </a:moveTo>
                      <a:cubicBezTo>
                        <a:pt x="0" y="8"/>
                        <a:pt x="8" y="0"/>
                        <a:pt x="16" y="0"/>
                      </a:cubicBezTo>
                      <a:lnTo>
                        <a:pt x="624" y="0"/>
                      </a:lnTo>
                      <a:cubicBezTo>
                        <a:pt x="633" y="0"/>
                        <a:pt x="640" y="8"/>
                        <a:pt x="640" y="16"/>
                      </a:cubicBezTo>
                      <a:lnTo>
                        <a:pt x="640" y="640"/>
                      </a:lnTo>
                      <a:cubicBezTo>
                        <a:pt x="640" y="649"/>
                        <a:pt x="633" y="656"/>
                        <a:pt x="624" y="656"/>
                      </a:cubicBezTo>
                      <a:lnTo>
                        <a:pt x="16" y="656"/>
                      </a:lnTo>
                      <a:cubicBezTo>
                        <a:pt x="8" y="656"/>
                        <a:pt x="0" y="649"/>
                        <a:pt x="0" y="640"/>
                      </a:cubicBezTo>
                      <a:lnTo>
                        <a:pt x="0" y="16"/>
                      </a:lnTo>
                      <a:close/>
                      <a:moveTo>
                        <a:pt x="32" y="640"/>
                      </a:moveTo>
                      <a:lnTo>
                        <a:pt x="16" y="624"/>
                      </a:lnTo>
                      <a:lnTo>
                        <a:pt x="624" y="624"/>
                      </a:lnTo>
                      <a:lnTo>
                        <a:pt x="608" y="640"/>
                      </a:lnTo>
                      <a:lnTo>
                        <a:pt x="608" y="16"/>
                      </a:lnTo>
                      <a:lnTo>
                        <a:pt x="624" y="32"/>
                      </a:lnTo>
                      <a:lnTo>
                        <a:pt x="16" y="32"/>
                      </a:lnTo>
                      <a:lnTo>
                        <a:pt x="32" y="16"/>
                      </a:lnTo>
                      <a:lnTo>
                        <a:pt x="32" y="64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noProof="1"/>
                </a:p>
              </p:txBody>
            </p:sp>
          </p:grpSp>
        </p:grpSp>
        <p:sp>
          <p:nvSpPr>
            <p:cNvPr id="316" name="Rectangle 315"/>
            <p:cNvSpPr/>
            <p:nvPr/>
          </p:nvSpPr>
          <p:spPr>
            <a:xfrm>
              <a:off x="3123597" y="735513"/>
              <a:ext cx="56082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Roots</a:t>
              </a:r>
              <a:endParaRPr lang="en-GB" sz="1200" noProof="1"/>
            </a:p>
          </p:txBody>
        </p:sp>
        <p:sp>
          <p:nvSpPr>
            <p:cNvPr id="318" name="Rectangle 317"/>
            <p:cNvSpPr/>
            <p:nvPr/>
          </p:nvSpPr>
          <p:spPr>
            <a:xfrm>
              <a:off x="4638679" y="721146"/>
              <a:ext cx="31432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400" b="1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A</a:t>
              </a:r>
              <a:endParaRPr lang="en-GB" sz="1400" noProof="1"/>
            </a:p>
          </p:txBody>
        </p:sp>
        <p:sp>
          <p:nvSpPr>
            <p:cNvPr id="320" name="Freeform 202"/>
            <p:cNvSpPr>
              <a:spLocks noEditPoints="1"/>
            </p:cNvSpPr>
            <p:nvPr/>
          </p:nvSpPr>
          <p:spPr bwMode="auto">
            <a:xfrm>
              <a:off x="2251800" y="1851981"/>
              <a:ext cx="2685981" cy="6690"/>
            </a:xfrm>
            <a:custGeom>
              <a:avLst/>
              <a:gdLst>
                <a:gd name="T0" fmla="*/ 42 w 2168"/>
                <a:gd name="T1" fmla="*/ 0 h 5"/>
                <a:gd name="T2" fmla="*/ 61 w 2168"/>
                <a:gd name="T3" fmla="*/ 4 h 5"/>
                <a:gd name="T4" fmla="*/ 107 w 2168"/>
                <a:gd name="T5" fmla="*/ 0 h 5"/>
                <a:gd name="T6" fmla="*/ 150 w 2168"/>
                <a:gd name="T7" fmla="*/ 4 h 5"/>
                <a:gd name="T8" fmla="*/ 169 w 2168"/>
                <a:gd name="T9" fmla="*/ 0 h 5"/>
                <a:gd name="T10" fmla="*/ 226 w 2168"/>
                <a:gd name="T11" fmla="*/ 0 h 5"/>
                <a:gd name="T12" fmla="*/ 246 w 2168"/>
                <a:gd name="T13" fmla="*/ 4 h 5"/>
                <a:gd name="T14" fmla="*/ 292 w 2168"/>
                <a:gd name="T15" fmla="*/ 0 h 5"/>
                <a:gd name="T16" fmla="*/ 334 w 2168"/>
                <a:gd name="T17" fmla="*/ 4 h 5"/>
                <a:gd name="T18" fmla="*/ 353 w 2168"/>
                <a:gd name="T19" fmla="*/ 0 h 5"/>
                <a:gd name="T20" fmla="*/ 411 w 2168"/>
                <a:gd name="T21" fmla="*/ 0 h 5"/>
                <a:gd name="T22" fmla="*/ 430 w 2168"/>
                <a:gd name="T23" fmla="*/ 4 h 5"/>
                <a:gd name="T24" fmla="*/ 476 w 2168"/>
                <a:gd name="T25" fmla="*/ 0 h 5"/>
                <a:gd name="T26" fmla="*/ 518 w 2168"/>
                <a:gd name="T27" fmla="*/ 4 h 5"/>
                <a:gd name="T28" fmla="*/ 537 w 2168"/>
                <a:gd name="T29" fmla="*/ 0 h 5"/>
                <a:gd name="T30" fmla="*/ 595 w 2168"/>
                <a:gd name="T31" fmla="*/ 0 h 5"/>
                <a:gd name="T32" fmla="*/ 614 w 2168"/>
                <a:gd name="T33" fmla="*/ 4 h 5"/>
                <a:gd name="T34" fmla="*/ 660 w 2168"/>
                <a:gd name="T35" fmla="*/ 0 h 5"/>
                <a:gd name="T36" fmla="*/ 703 w 2168"/>
                <a:gd name="T37" fmla="*/ 4 h 5"/>
                <a:gd name="T38" fmla="*/ 722 w 2168"/>
                <a:gd name="T39" fmla="*/ 0 h 5"/>
                <a:gd name="T40" fmla="*/ 779 w 2168"/>
                <a:gd name="T41" fmla="*/ 0 h 5"/>
                <a:gd name="T42" fmla="*/ 799 w 2168"/>
                <a:gd name="T43" fmla="*/ 4 h 5"/>
                <a:gd name="T44" fmla="*/ 845 w 2168"/>
                <a:gd name="T45" fmla="*/ 0 h 5"/>
                <a:gd name="T46" fmla="*/ 887 w 2168"/>
                <a:gd name="T47" fmla="*/ 4 h 5"/>
                <a:gd name="T48" fmla="*/ 906 w 2168"/>
                <a:gd name="T49" fmla="*/ 0 h 5"/>
                <a:gd name="T50" fmla="*/ 964 w 2168"/>
                <a:gd name="T51" fmla="*/ 0 h 5"/>
                <a:gd name="T52" fmla="*/ 983 w 2168"/>
                <a:gd name="T53" fmla="*/ 4 h 5"/>
                <a:gd name="T54" fmla="*/ 1029 w 2168"/>
                <a:gd name="T55" fmla="*/ 0 h 5"/>
                <a:gd name="T56" fmla="*/ 1071 w 2168"/>
                <a:gd name="T57" fmla="*/ 4 h 5"/>
                <a:gd name="T58" fmla="*/ 1090 w 2168"/>
                <a:gd name="T59" fmla="*/ 0 h 5"/>
                <a:gd name="T60" fmla="*/ 1148 w 2168"/>
                <a:gd name="T61" fmla="*/ 1 h 5"/>
                <a:gd name="T62" fmla="*/ 1167 w 2168"/>
                <a:gd name="T63" fmla="*/ 4 h 5"/>
                <a:gd name="T64" fmla="*/ 1213 w 2168"/>
                <a:gd name="T65" fmla="*/ 1 h 5"/>
                <a:gd name="T66" fmla="*/ 1256 w 2168"/>
                <a:gd name="T67" fmla="*/ 4 h 5"/>
                <a:gd name="T68" fmla="*/ 1275 w 2168"/>
                <a:gd name="T69" fmla="*/ 1 h 5"/>
                <a:gd name="T70" fmla="*/ 1332 w 2168"/>
                <a:gd name="T71" fmla="*/ 1 h 5"/>
                <a:gd name="T72" fmla="*/ 1352 w 2168"/>
                <a:gd name="T73" fmla="*/ 4 h 5"/>
                <a:gd name="T74" fmla="*/ 1398 w 2168"/>
                <a:gd name="T75" fmla="*/ 1 h 5"/>
                <a:gd name="T76" fmla="*/ 1440 w 2168"/>
                <a:gd name="T77" fmla="*/ 4 h 5"/>
                <a:gd name="T78" fmla="*/ 1459 w 2168"/>
                <a:gd name="T79" fmla="*/ 1 h 5"/>
                <a:gd name="T80" fmla="*/ 1517 w 2168"/>
                <a:gd name="T81" fmla="*/ 1 h 5"/>
                <a:gd name="T82" fmla="*/ 1536 w 2168"/>
                <a:gd name="T83" fmla="*/ 4 h 5"/>
                <a:gd name="T84" fmla="*/ 1582 w 2168"/>
                <a:gd name="T85" fmla="*/ 1 h 5"/>
                <a:gd name="T86" fmla="*/ 1624 w 2168"/>
                <a:gd name="T87" fmla="*/ 4 h 5"/>
                <a:gd name="T88" fmla="*/ 1643 w 2168"/>
                <a:gd name="T89" fmla="*/ 1 h 5"/>
                <a:gd name="T90" fmla="*/ 1701 w 2168"/>
                <a:gd name="T91" fmla="*/ 1 h 5"/>
                <a:gd name="T92" fmla="*/ 1720 w 2168"/>
                <a:gd name="T93" fmla="*/ 5 h 5"/>
                <a:gd name="T94" fmla="*/ 1766 w 2168"/>
                <a:gd name="T95" fmla="*/ 1 h 5"/>
                <a:gd name="T96" fmla="*/ 1808 w 2168"/>
                <a:gd name="T97" fmla="*/ 5 h 5"/>
                <a:gd name="T98" fmla="*/ 1828 w 2168"/>
                <a:gd name="T99" fmla="*/ 1 h 5"/>
                <a:gd name="T100" fmla="*/ 1885 w 2168"/>
                <a:gd name="T101" fmla="*/ 1 h 5"/>
                <a:gd name="T102" fmla="*/ 1904 w 2168"/>
                <a:gd name="T103" fmla="*/ 5 h 5"/>
                <a:gd name="T104" fmla="*/ 1951 w 2168"/>
                <a:gd name="T105" fmla="*/ 1 h 5"/>
                <a:gd name="T106" fmla="*/ 1993 w 2168"/>
                <a:gd name="T107" fmla="*/ 5 h 5"/>
                <a:gd name="T108" fmla="*/ 2012 w 2168"/>
                <a:gd name="T109" fmla="*/ 1 h 5"/>
                <a:gd name="T110" fmla="*/ 2070 w 2168"/>
                <a:gd name="T111" fmla="*/ 1 h 5"/>
                <a:gd name="T112" fmla="*/ 2089 w 2168"/>
                <a:gd name="T113" fmla="*/ 5 h 5"/>
                <a:gd name="T114" fmla="*/ 2135 w 2168"/>
                <a:gd name="T115" fmla="*/ 1 h 5"/>
                <a:gd name="T116" fmla="*/ 2168 w 2168"/>
                <a:gd name="T117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168" h="5">
                  <a:moveTo>
                    <a:pt x="0" y="0"/>
                  </a:moveTo>
                  <a:lnTo>
                    <a:pt x="11" y="0"/>
                  </a:lnTo>
                  <a:lnTo>
                    <a:pt x="11" y="4"/>
                  </a:lnTo>
                  <a:lnTo>
                    <a:pt x="0" y="4"/>
                  </a:lnTo>
                  <a:lnTo>
                    <a:pt x="0" y="0"/>
                  </a:lnTo>
                  <a:close/>
                  <a:moveTo>
                    <a:pt x="15" y="0"/>
                  </a:moveTo>
                  <a:lnTo>
                    <a:pt x="27" y="0"/>
                  </a:lnTo>
                  <a:lnTo>
                    <a:pt x="27" y="4"/>
                  </a:lnTo>
                  <a:lnTo>
                    <a:pt x="15" y="4"/>
                  </a:lnTo>
                  <a:lnTo>
                    <a:pt x="15" y="0"/>
                  </a:lnTo>
                  <a:close/>
                  <a:moveTo>
                    <a:pt x="31" y="0"/>
                  </a:moveTo>
                  <a:lnTo>
                    <a:pt x="42" y="0"/>
                  </a:lnTo>
                  <a:lnTo>
                    <a:pt x="42" y="4"/>
                  </a:lnTo>
                  <a:lnTo>
                    <a:pt x="31" y="4"/>
                  </a:lnTo>
                  <a:lnTo>
                    <a:pt x="31" y="0"/>
                  </a:lnTo>
                  <a:close/>
                  <a:moveTo>
                    <a:pt x="46" y="0"/>
                  </a:moveTo>
                  <a:lnTo>
                    <a:pt x="58" y="0"/>
                  </a:lnTo>
                  <a:lnTo>
                    <a:pt x="58" y="4"/>
                  </a:lnTo>
                  <a:lnTo>
                    <a:pt x="46" y="4"/>
                  </a:lnTo>
                  <a:lnTo>
                    <a:pt x="46" y="0"/>
                  </a:lnTo>
                  <a:close/>
                  <a:moveTo>
                    <a:pt x="61" y="0"/>
                  </a:moveTo>
                  <a:lnTo>
                    <a:pt x="73" y="0"/>
                  </a:lnTo>
                  <a:lnTo>
                    <a:pt x="73" y="4"/>
                  </a:lnTo>
                  <a:lnTo>
                    <a:pt x="61" y="4"/>
                  </a:lnTo>
                  <a:lnTo>
                    <a:pt x="61" y="0"/>
                  </a:lnTo>
                  <a:close/>
                  <a:moveTo>
                    <a:pt x="77" y="0"/>
                  </a:moveTo>
                  <a:lnTo>
                    <a:pt x="88" y="0"/>
                  </a:lnTo>
                  <a:lnTo>
                    <a:pt x="88" y="4"/>
                  </a:lnTo>
                  <a:lnTo>
                    <a:pt x="77" y="4"/>
                  </a:lnTo>
                  <a:lnTo>
                    <a:pt x="77" y="0"/>
                  </a:lnTo>
                  <a:close/>
                  <a:moveTo>
                    <a:pt x="92" y="0"/>
                  </a:moveTo>
                  <a:lnTo>
                    <a:pt x="104" y="0"/>
                  </a:lnTo>
                  <a:lnTo>
                    <a:pt x="104" y="4"/>
                  </a:lnTo>
                  <a:lnTo>
                    <a:pt x="92" y="4"/>
                  </a:lnTo>
                  <a:lnTo>
                    <a:pt x="92" y="0"/>
                  </a:lnTo>
                  <a:close/>
                  <a:moveTo>
                    <a:pt x="107" y="0"/>
                  </a:moveTo>
                  <a:lnTo>
                    <a:pt x="119" y="0"/>
                  </a:lnTo>
                  <a:lnTo>
                    <a:pt x="119" y="4"/>
                  </a:lnTo>
                  <a:lnTo>
                    <a:pt x="107" y="4"/>
                  </a:lnTo>
                  <a:lnTo>
                    <a:pt x="107" y="0"/>
                  </a:lnTo>
                  <a:close/>
                  <a:moveTo>
                    <a:pt x="123" y="0"/>
                  </a:moveTo>
                  <a:lnTo>
                    <a:pt x="134" y="0"/>
                  </a:lnTo>
                  <a:lnTo>
                    <a:pt x="134" y="4"/>
                  </a:lnTo>
                  <a:lnTo>
                    <a:pt x="123" y="4"/>
                  </a:lnTo>
                  <a:lnTo>
                    <a:pt x="123" y="0"/>
                  </a:lnTo>
                  <a:close/>
                  <a:moveTo>
                    <a:pt x="138" y="0"/>
                  </a:moveTo>
                  <a:lnTo>
                    <a:pt x="150" y="0"/>
                  </a:lnTo>
                  <a:lnTo>
                    <a:pt x="150" y="4"/>
                  </a:lnTo>
                  <a:lnTo>
                    <a:pt x="138" y="4"/>
                  </a:lnTo>
                  <a:lnTo>
                    <a:pt x="138" y="0"/>
                  </a:lnTo>
                  <a:close/>
                  <a:moveTo>
                    <a:pt x="154" y="0"/>
                  </a:moveTo>
                  <a:lnTo>
                    <a:pt x="165" y="0"/>
                  </a:lnTo>
                  <a:lnTo>
                    <a:pt x="165" y="4"/>
                  </a:lnTo>
                  <a:lnTo>
                    <a:pt x="154" y="4"/>
                  </a:lnTo>
                  <a:lnTo>
                    <a:pt x="154" y="0"/>
                  </a:lnTo>
                  <a:close/>
                  <a:moveTo>
                    <a:pt x="169" y="0"/>
                  </a:moveTo>
                  <a:lnTo>
                    <a:pt x="180" y="0"/>
                  </a:lnTo>
                  <a:lnTo>
                    <a:pt x="180" y="4"/>
                  </a:lnTo>
                  <a:lnTo>
                    <a:pt x="169" y="4"/>
                  </a:lnTo>
                  <a:lnTo>
                    <a:pt x="169" y="0"/>
                  </a:lnTo>
                  <a:close/>
                  <a:moveTo>
                    <a:pt x="184" y="0"/>
                  </a:moveTo>
                  <a:lnTo>
                    <a:pt x="196" y="0"/>
                  </a:lnTo>
                  <a:lnTo>
                    <a:pt x="196" y="4"/>
                  </a:lnTo>
                  <a:lnTo>
                    <a:pt x="184" y="4"/>
                  </a:lnTo>
                  <a:lnTo>
                    <a:pt x="184" y="0"/>
                  </a:lnTo>
                  <a:close/>
                  <a:moveTo>
                    <a:pt x="200" y="0"/>
                  </a:moveTo>
                  <a:lnTo>
                    <a:pt x="211" y="0"/>
                  </a:lnTo>
                  <a:lnTo>
                    <a:pt x="211" y="4"/>
                  </a:lnTo>
                  <a:lnTo>
                    <a:pt x="200" y="4"/>
                  </a:lnTo>
                  <a:lnTo>
                    <a:pt x="200" y="0"/>
                  </a:lnTo>
                  <a:close/>
                  <a:moveTo>
                    <a:pt x="215" y="0"/>
                  </a:moveTo>
                  <a:lnTo>
                    <a:pt x="226" y="0"/>
                  </a:lnTo>
                  <a:lnTo>
                    <a:pt x="226" y="4"/>
                  </a:lnTo>
                  <a:lnTo>
                    <a:pt x="215" y="4"/>
                  </a:lnTo>
                  <a:lnTo>
                    <a:pt x="215" y="0"/>
                  </a:lnTo>
                  <a:close/>
                  <a:moveTo>
                    <a:pt x="230" y="0"/>
                  </a:moveTo>
                  <a:lnTo>
                    <a:pt x="242" y="0"/>
                  </a:lnTo>
                  <a:lnTo>
                    <a:pt x="242" y="4"/>
                  </a:lnTo>
                  <a:lnTo>
                    <a:pt x="230" y="4"/>
                  </a:lnTo>
                  <a:lnTo>
                    <a:pt x="230" y="0"/>
                  </a:lnTo>
                  <a:close/>
                  <a:moveTo>
                    <a:pt x="246" y="0"/>
                  </a:moveTo>
                  <a:lnTo>
                    <a:pt x="257" y="0"/>
                  </a:lnTo>
                  <a:lnTo>
                    <a:pt x="257" y="4"/>
                  </a:lnTo>
                  <a:lnTo>
                    <a:pt x="246" y="4"/>
                  </a:lnTo>
                  <a:lnTo>
                    <a:pt x="246" y="0"/>
                  </a:lnTo>
                  <a:close/>
                  <a:moveTo>
                    <a:pt x="261" y="0"/>
                  </a:moveTo>
                  <a:lnTo>
                    <a:pt x="273" y="0"/>
                  </a:lnTo>
                  <a:lnTo>
                    <a:pt x="273" y="4"/>
                  </a:lnTo>
                  <a:lnTo>
                    <a:pt x="261" y="4"/>
                  </a:lnTo>
                  <a:lnTo>
                    <a:pt x="261" y="0"/>
                  </a:lnTo>
                  <a:close/>
                  <a:moveTo>
                    <a:pt x="276" y="0"/>
                  </a:moveTo>
                  <a:lnTo>
                    <a:pt x="288" y="0"/>
                  </a:lnTo>
                  <a:lnTo>
                    <a:pt x="288" y="4"/>
                  </a:lnTo>
                  <a:lnTo>
                    <a:pt x="276" y="4"/>
                  </a:lnTo>
                  <a:lnTo>
                    <a:pt x="276" y="0"/>
                  </a:lnTo>
                  <a:close/>
                  <a:moveTo>
                    <a:pt x="292" y="0"/>
                  </a:moveTo>
                  <a:lnTo>
                    <a:pt x="303" y="0"/>
                  </a:lnTo>
                  <a:lnTo>
                    <a:pt x="303" y="4"/>
                  </a:lnTo>
                  <a:lnTo>
                    <a:pt x="292" y="4"/>
                  </a:lnTo>
                  <a:lnTo>
                    <a:pt x="292" y="0"/>
                  </a:lnTo>
                  <a:close/>
                  <a:moveTo>
                    <a:pt x="307" y="0"/>
                  </a:moveTo>
                  <a:lnTo>
                    <a:pt x="319" y="0"/>
                  </a:lnTo>
                  <a:lnTo>
                    <a:pt x="319" y="4"/>
                  </a:lnTo>
                  <a:lnTo>
                    <a:pt x="307" y="4"/>
                  </a:lnTo>
                  <a:lnTo>
                    <a:pt x="307" y="0"/>
                  </a:lnTo>
                  <a:close/>
                  <a:moveTo>
                    <a:pt x="322" y="0"/>
                  </a:moveTo>
                  <a:lnTo>
                    <a:pt x="334" y="0"/>
                  </a:lnTo>
                  <a:lnTo>
                    <a:pt x="334" y="4"/>
                  </a:lnTo>
                  <a:lnTo>
                    <a:pt x="322" y="4"/>
                  </a:lnTo>
                  <a:lnTo>
                    <a:pt x="322" y="0"/>
                  </a:lnTo>
                  <a:close/>
                  <a:moveTo>
                    <a:pt x="338" y="0"/>
                  </a:moveTo>
                  <a:lnTo>
                    <a:pt x="349" y="0"/>
                  </a:lnTo>
                  <a:lnTo>
                    <a:pt x="349" y="4"/>
                  </a:lnTo>
                  <a:lnTo>
                    <a:pt x="338" y="4"/>
                  </a:lnTo>
                  <a:lnTo>
                    <a:pt x="338" y="0"/>
                  </a:lnTo>
                  <a:close/>
                  <a:moveTo>
                    <a:pt x="353" y="0"/>
                  </a:moveTo>
                  <a:lnTo>
                    <a:pt x="365" y="0"/>
                  </a:lnTo>
                  <a:lnTo>
                    <a:pt x="365" y="4"/>
                  </a:lnTo>
                  <a:lnTo>
                    <a:pt x="353" y="4"/>
                  </a:lnTo>
                  <a:lnTo>
                    <a:pt x="353" y="0"/>
                  </a:lnTo>
                  <a:close/>
                  <a:moveTo>
                    <a:pt x="369" y="0"/>
                  </a:moveTo>
                  <a:lnTo>
                    <a:pt x="380" y="0"/>
                  </a:lnTo>
                  <a:lnTo>
                    <a:pt x="380" y="4"/>
                  </a:lnTo>
                  <a:lnTo>
                    <a:pt x="369" y="4"/>
                  </a:lnTo>
                  <a:lnTo>
                    <a:pt x="369" y="0"/>
                  </a:lnTo>
                  <a:close/>
                  <a:moveTo>
                    <a:pt x="384" y="0"/>
                  </a:moveTo>
                  <a:lnTo>
                    <a:pt x="395" y="0"/>
                  </a:lnTo>
                  <a:lnTo>
                    <a:pt x="395" y="4"/>
                  </a:lnTo>
                  <a:lnTo>
                    <a:pt x="384" y="4"/>
                  </a:lnTo>
                  <a:lnTo>
                    <a:pt x="384" y="0"/>
                  </a:lnTo>
                  <a:close/>
                  <a:moveTo>
                    <a:pt x="399" y="0"/>
                  </a:moveTo>
                  <a:lnTo>
                    <a:pt x="411" y="0"/>
                  </a:lnTo>
                  <a:lnTo>
                    <a:pt x="411" y="4"/>
                  </a:lnTo>
                  <a:lnTo>
                    <a:pt x="399" y="4"/>
                  </a:lnTo>
                  <a:lnTo>
                    <a:pt x="399" y="0"/>
                  </a:lnTo>
                  <a:close/>
                  <a:moveTo>
                    <a:pt x="415" y="0"/>
                  </a:moveTo>
                  <a:lnTo>
                    <a:pt x="426" y="0"/>
                  </a:lnTo>
                  <a:lnTo>
                    <a:pt x="426" y="4"/>
                  </a:lnTo>
                  <a:lnTo>
                    <a:pt x="415" y="4"/>
                  </a:lnTo>
                  <a:lnTo>
                    <a:pt x="415" y="0"/>
                  </a:lnTo>
                  <a:close/>
                  <a:moveTo>
                    <a:pt x="430" y="0"/>
                  </a:moveTo>
                  <a:lnTo>
                    <a:pt x="442" y="0"/>
                  </a:lnTo>
                  <a:lnTo>
                    <a:pt x="442" y="4"/>
                  </a:lnTo>
                  <a:lnTo>
                    <a:pt x="430" y="4"/>
                  </a:lnTo>
                  <a:lnTo>
                    <a:pt x="430" y="0"/>
                  </a:lnTo>
                  <a:close/>
                  <a:moveTo>
                    <a:pt x="445" y="0"/>
                  </a:moveTo>
                  <a:lnTo>
                    <a:pt x="457" y="0"/>
                  </a:lnTo>
                  <a:lnTo>
                    <a:pt x="457" y="4"/>
                  </a:lnTo>
                  <a:lnTo>
                    <a:pt x="445" y="4"/>
                  </a:lnTo>
                  <a:lnTo>
                    <a:pt x="445" y="0"/>
                  </a:lnTo>
                  <a:close/>
                  <a:moveTo>
                    <a:pt x="461" y="0"/>
                  </a:moveTo>
                  <a:lnTo>
                    <a:pt x="472" y="0"/>
                  </a:lnTo>
                  <a:lnTo>
                    <a:pt x="472" y="4"/>
                  </a:lnTo>
                  <a:lnTo>
                    <a:pt x="461" y="4"/>
                  </a:lnTo>
                  <a:lnTo>
                    <a:pt x="461" y="0"/>
                  </a:lnTo>
                  <a:close/>
                  <a:moveTo>
                    <a:pt x="476" y="0"/>
                  </a:moveTo>
                  <a:lnTo>
                    <a:pt x="488" y="0"/>
                  </a:lnTo>
                  <a:lnTo>
                    <a:pt x="488" y="4"/>
                  </a:lnTo>
                  <a:lnTo>
                    <a:pt x="476" y="4"/>
                  </a:lnTo>
                  <a:lnTo>
                    <a:pt x="476" y="0"/>
                  </a:lnTo>
                  <a:close/>
                  <a:moveTo>
                    <a:pt x="491" y="0"/>
                  </a:moveTo>
                  <a:lnTo>
                    <a:pt x="503" y="0"/>
                  </a:lnTo>
                  <a:lnTo>
                    <a:pt x="503" y="4"/>
                  </a:lnTo>
                  <a:lnTo>
                    <a:pt x="491" y="4"/>
                  </a:lnTo>
                  <a:lnTo>
                    <a:pt x="491" y="0"/>
                  </a:lnTo>
                  <a:close/>
                  <a:moveTo>
                    <a:pt x="507" y="0"/>
                  </a:moveTo>
                  <a:lnTo>
                    <a:pt x="518" y="0"/>
                  </a:lnTo>
                  <a:lnTo>
                    <a:pt x="518" y="4"/>
                  </a:lnTo>
                  <a:lnTo>
                    <a:pt x="507" y="4"/>
                  </a:lnTo>
                  <a:lnTo>
                    <a:pt x="507" y="0"/>
                  </a:lnTo>
                  <a:close/>
                  <a:moveTo>
                    <a:pt x="522" y="0"/>
                  </a:moveTo>
                  <a:lnTo>
                    <a:pt x="534" y="0"/>
                  </a:lnTo>
                  <a:lnTo>
                    <a:pt x="534" y="4"/>
                  </a:lnTo>
                  <a:lnTo>
                    <a:pt x="522" y="4"/>
                  </a:lnTo>
                  <a:lnTo>
                    <a:pt x="522" y="0"/>
                  </a:lnTo>
                  <a:close/>
                  <a:moveTo>
                    <a:pt x="537" y="0"/>
                  </a:moveTo>
                  <a:lnTo>
                    <a:pt x="549" y="0"/>
                  </a:lnTo>
                  <a:lnTo>
                    <a:pt x="549" y="4"/>
                  </a:lnTo>
                  <a:lnTo>
                    <a:pt x="537" y="4"/>
                  </a:lnTo>
                  <a:lnTo>
                    <a:pt x="537" y="0"/>
                  </a:lnTo>
                  <a:close/>
                  <a:moveTo>
                    <a:pt x="553" y="0"/>
                  </a:moveTo>
                  <a:lnTo>
                    <a:pt x="564" y="0"/>
                  </a:lnTo>
                  <a:lnTo>
                    <a:pt x="564" y="4"/>
                  </a:lnTo>
                  <a:lnTo>
                    <a:pt x="553" y="4"/>
                  </a:lnTo>
                  <a:lnTo>
                    <a:pt x="553" y="0"/>
                  </a:lnTo>
                  <a:close/>
                  <a:moveTo>
                    <a:pt x="568" y="0"/>
                  </a:moveTo>
                  <a:lnTo>
                    <a:pt x="580" y="0"/>
                  </a:lnTo>
                  <a:lnTo>
                    <a:pt x="580" y="4"/>
                  </a:lnTo>
                  <a:lnTo>
                    <a:pt x="568" y="4"/>
                  </a:lnTo>
                  <a:lnTo>
                    <a:pt x="568" y="0"/>
                  </a:lnTo>
                  <a:close/>
                  <a:moveTo>
                    <a:pt x="584" y="0"/>
                  </a:moveTo>
                  <a:lnTo>
                    <a:pt x="595" y="0"/>
                  </a:lnTo>
                  <a:lnTo>
                    <a:pt x="595" y="4"/>
                  </a:lnTo>
                  <a:lnTo>
                    <a:pt x="584" y="4"/>
                  </a:lnTo>
                  <a:lnTo>
                    <a:pt x="584" y="0"/>
                  </a:lnTo>
                  <a:close/>
                  <a:moveTo>
                    <a:pt x="599" y="0"/>
                  </a:moveTo>
                  <a:lnTo>
                    <a:pt x="610" y="0"/>
                  </a:lnTo>
                  <a:lnTo>
                    <a:pt x="610" y="4"/>
                  </a:lnTo>
                  <a:lnTo>
                    <a:pt x="599" y="4"/>
                  </a:lnTo>
                  <a:lnTo>
                    <a:pt x="599" y="0"/>
                  </a:lnTo>
                  <a:close/>
                  <a:moveTo>
                    <a:pt x="614" y="0"/>
                  </a:moveTo>
                  <a:lnTo>
                    <a:pt x="626" y="0"/>
                  </a:lnTo>
                  <a:lnTo>
                    <a:pt x="626" y="4"/>
                  </a:lnTo>
                  <a:lnTo>
                    <a:pt x="614" y="4"/>
                  </a:lnTo>
                  <a:lnTo>
                    <a:pt x="614" y="0"/>
                  </a:lnTo>
                  <a:close/>
                  <a:moveTo>
                    <a:pt x="630" y="0"/>
                  </a:moveTo>
                  <a:lnTo>
                    <a:pt x="641" y="0"/>
                  </a:lnTo>
                  <a:lnTo>
                    <a:pt x="641" y="4"/>
                  </a:lnTo>
                  <a:lnTo>
                    <a:pt x="630" y="4"/>
                  </a:lnTo>
                  <a:lnTo>
                    <a:pt x="630" y="0"/>
                  </a:lnTo>
                  <a:close/>
                  <a:moveTo>
                    <a:pt x="645" y="0"/>
                  </a:moveTo>
                  <a:lnTo>
                    <a:pt x="657" y="0"/>
                  </a:lnTo>
                  <a:lnTo>
                    <a:pt x="657" y="4"/>
                  </a:lnTo>
                  <a:lnTo>
                    <a:pt x="645" y="4"/>
                  </a:lnTo>
                  <a:lnTo>
                    <a:pt x="645" y="0"/>
                  </a:lnTo>
                  <a:close/>
                  <a:moveTo>
                    <a:pt x="660" y="0"/>
                  </a:moveTo>
                  <a:lnTo>
                    <a:pt x="672" y="0"/>
                  </a:lnTo>
                  <a:lnTo>
                    <a:pt x="672" y="4"/>
                  </a:lnTo>
                  <a:lnTo>
                    <a:pt x="660" y="4"/>
                  </a:lnTo>
                  <a:lnTo>
                    <a:pt x="660" y="0"/>
                  </a:lnTo>
                  <a:close/>
                  <a:moveTo>
                    <a:pt x="676" y="0"/>
                  </a:moveTo>
                  <a:lnTo>
                    <a:pt x="687" y="0"/>
                  </a:lnTo>
                  <a:lnTo>
                    <a:pt x="687" y="4"/>
                  </a:lnTo>
                  <a:lnTo>
                    <a:pt x="676" y="4"/>
                  </a:lnTo>
                  <a:lnTo>
                    <a:pt x="676" y="0"/>
                  </a:lnTo>
                  <a:close/>
                  <a:moveTo>
                    <a:pt x="691" y="0"/>
                  </a:moveTo>
                  <a:lnTo>
                    <a:pt x="703" y="0"/>
                  </a:lnTo>
                  <a:lnTo>
                    <a:pt x="703" y="4"/>
                  </a:lnTo>
                  <a:lnTo>
                    <a:pt x="691" y="4"/>
                  </a:lnTo>
                  <a:lnTo>
                    <a:pt x="691" y="0"/>
                  </a:lnTo>
                  <a:close/>
                  <a:moveTo>
                    <a:pt x="706" y="0"/>
                  </a:moveTo>
                  <a:lnTo>
                    <a:pt x="718" y="0"/>
                  </a:lnTo>
                  <a:lnTo>
                    <a:pt x="718" y="4"/>
                  </a:lnTo>
                  <a:lnTo>
                    <a:pt x="706" y="4"/>
                  </a:lnTo>
                  <a:lnTo>
                    <a:pt x="706" y="0"/>
                  </a:lnTo>
                  <a:close/>
                  <a:moveTo>
                    <a:pt x="722" y="0"/>
                  </a:moveTo>
                  <a:lnTo>
                    <a:pt x="733" y="0"/>
                  </a:lnTo>
                  <a:lnTo>
                    <a:pt x="733" y="4"/>
                  </a:lnTo>
                  <a:lnTo>
                    <a:pt x="722" y="4"/>
                  </a:lnTo>
                  <a:lnTo>
                    <a:pt x="722" y="0"/>
                  </a:lnTo>
                  <a:close/>
                  <a:moveTo>
                    <a:pt x="737" y="0"/>
                  </a:moveTo>
                  <a:lnTo>
                    <a:pt x="749" y="0"/>
                  </a:lnTo>
                  <a:lnTo>
                    <a:pt x="749" y="4"/>
                  </a:lnTo>
                  <a:lnTo>
                    <a:pt x="737" y="4"/>
                  </a:lnTo>
                  <a:lnTo>
                    <a:pt x="737" y="0"/>
                  </a:lnTo>
                  <a:close/>
                  <a:moveTo>
                    <a:pt x="753" y="0"/>
                  </a:moveTo>
                  <a:lnTo>
                    <a:pt x="764" y="0"/>
                  </a:lnTo>
                  <a:lnTo>
                    <a:pt x="764" y="4"/>
                  </a:lnTo>
                  <a:lnTo>
                    <a:pt x="753" y="4"/>
                  </a:lnTo>
                  <a:lnTo>
                    <a:pt x="753" y="0"/>
                  </a:lnTo>
                  <a:close/>
                  <a:moveTo>
                    <a:pt x="768" y="0"/>
                  </a:moveTo>
                  <a:lnTo>
                    <a:pt x="779" y="0"/>
                  </a:lnTo>
                  <a:lnTo>
                    <a:pt x="779" y="4"/>
                  </a:lnTo>
                  <a:lnTo>
                    <a:pt x="768" y="4"/>
                  </a:lnTo>
                  <a:lnTo>
                    <a:pt x="768" y="0"/>
                  </a:lnTo>
                  <a:close/>
                  <a:moveTo>
                    <a:pt x="783" y="0"/>
                  </a:moveTo>
                  <a:lnTo>
                    <a:pt x="795" y="0"/>
                  </a:lnTo>
                  <a:lnTo>
                    <a:pt x="795" y="4"/>
                  </a:lnTo>
                  <a:lnTo>
                    <a:pt x="783" y="4"/>
                  </a:lnTo>
                  <a:lnTo>
                    <a:pt x="783" y="0"/>
                  </a:lnTo>
                  <a:close/>
                  <a:moveTo>
                    <a:pt x="799" y="0"/>
                  </a:moveTo>
                  <a:lnTo>
                    <a:pt x="810" y="0"/>
                  </a:lnTo>
                  <a:lnTo>
                    <a:pt x="810" y="4"/>
                  </a:lnTo>
                  <a:lnTo>
                    <a:pt x="799" y="4"/>
                  </a:lnTo>
                  <a:lnTo>
                    <a:pt x="799" y="0"/>
                  </a:lnTo>
                  <a:close/>
                  <a:moveTo>
                    <a:pt x="814" y="0"/>
                  </a:moveTo>
                  <a:lnTo>
                    <a:pt x="825" y="0"/>
                  </a:lnTo>
                  <a:lnTo>
                    <a:pt x="825" y="4"/>
                  </a:lnTo>
                  <a:lnTo>
                    <a:pt x="814" y="4"/>
                  </a:lnTo>
                  <a:lnTo>
                    <a:pt x="814" y="0"/>
                  </a:lnTo>
                  <a:close/>
                  <a:moveTo>
                    <a:pt x="829" y="0"/>
                  </a:moveTo>
                  <a:lnTo>
                    <a:pt x="841" y="0"/>
                  </a:lnTo>
                  <a:lnTo>
                    <a:pt x="841" y="4"/>
                  </a:lnTo>
                  <a:lnTo>
                    <a:pt x="829" y="4"/>
                  </a:lnTo>
                  <a:lnTo>
                    <a:pt x="829" y="0"/>
                  </a:lnTo>
                  <a:close/>
                  <a:moveTo>
                    <a:pt x="845" y="0"/>
                  </a:moveTo>
                  <a:lnTo>
                    <a:pt x="856" y="0"/>
                  </a:lnTo>
                  <a:lnTo>
                    <a:pt x="856" y="4"/>
                  </a:lnTo>
                  <a:lnTo>
                    <a:pt x="845" y="4"/>
                  </a:lnTo>
                  <a:lnTo>
                    <a:pt x="845" y="0"/>
                  </a:lnTo>
                  <a:close/>
                  <a:moveTo>
                    <a:pt x="860" y="0"/>
                  </a:moveTo>
                  <a:lnTo>
                    <a:pt x="872" y="0"/>
                  </a:lnTo>
                  <a:lnTo>
                    <a:pt x="872" y="4"/>
                  </a:lnTo>
                  <a:lnTo>
                    <a:pt x="860" y="4"/>
                  </a:lnTo>
                  <a:lnTo>
                    <a:pt x="860" y="0"/>
                  </a:lnTo>
                  <a:close/>
                  <a:moveTo>
                    <a:pt x="875" y="0"/>
                  </a:moveTo>
                  <a:lnTo>
                    <a:pt x="887" y="0"/>
                  </a:lnTo>
                  <a:lnTo>
                    <a:pt x="887" y="4"/>
                  </a:lnTo>
                  <a:lnTo>
                    <a:pt x="875" y="4"/>
                  </a:lnTo>
                  <a:lnTo>
                    <a:pt x="875" y="0"/>
                  </a:lnTo>
                  <a:close/>
                  <a:moveTo>
                    <a:pt x="891" y="0"/>
                  </a:moveTo>
                  <a:lnTo>
                    <a:pt x="902" y="0"/>
                  </a:lnTo>
                  <a:lnTo>
                    <a:pt x="902" y="4"/>
                  </a:lnTo>
                  <a:lnTo>
                    <a:pt x="891" y="4"/>
                  </a:lnTo>
                  <a:lnTo>
                    <a:pt x="891" y="0"/>
                  </a:lnTo>
                  <a:close/>
                  <a:moveTo>
                    <a:pt x="906" y="0"/>
                  </a:moveTo>
                  <a:lnTo>
                    <a:pt x="918" y="0"/>
                  </a:lnTo>
                  <a:lnTo>
                    <a:pt x="918" y="4"/>
                  </a:lnTo>
                  <a:lnTo>
                    <a:pt x="906" y="4"/>
                  </a:lnTo>
                  <a:lnTo>
                    <a:pt x="906" y="0"/>
                  </a:lnTo>
                  <a:close/>
                  <a:moveTo>
                    <a:pt x="921" y="0"/>
                  </a:moveTo>
                  <a:lnTo>
                    <a:pt x="933" y="0"/>
                  </a:lnTo>
                  <a:lnTo>
                    <a:pt x="933" y="4"/>
                  </a:lnTo>
                  <a:lnTo>
                    <a:pt x="921" y="4"/>
                  </a:lnTo>
                  <a:lnTo>
                    <a:pt x="921" y="0"/>
                  </a:lnTo>
                  <a:close/>
                  <a:moveTo>
                    <a:pt x="937" y="0"/>
                  </a:moveTo>
                  <a:lnTo>
                    <a:pt x="948" y="0"/>
                  </a:lnTo>
                  <a:lnTo>
                    <a:pt x="948" y="4"/>
                  </a:lnTo>
                  <a:lnTo>
                    <a:pt x="937" y="4"/>
                  </a:lnTo>
                  <a:lnTo>
                    <a:pt x="937" y="0"/>
                  </a:lnTo>
                  <a:close/>
                  <a:moveTo>
                    <a:pt x="952" y="0"/>
                  </a:moveTo>
                  <a:lnTo>
                    <a:pt x="964" y="0"/>
                  </a:lnTo>
                  <a:lnTo>
                    <a:pt x="964" y="4"/>
                  </a:lnTo>
                  <a:lnTo>
                    <a:pt x="952" y="4"/>
                  </a:lnTo>
                  <a:lnTo>
                    <a:pt x="952" y="0"/>
                  </a:lnTo>
                  <a:close/>
                  <a:moveTo>
                    <a:pt x="968" y="0"/>
                  </a:moveTo>
                  <a:lnTo>
                    <a:pt x="979" y="0"/>
                  </a:lnTo>
                  <a:lnTo>
                    <a:pt x="979" y="4"/>
                  </a:lnTo>
                  <a:lnTo>
                    <a:pt x="968" y="4"/>
                  </a:lnTo>
                  <a:lnTo>
                    <a:pt x="968" y="0"/>
                  </a:lnTo>
                  <a:close/>
                  <a:moveTo>
                    <a:pt x="983" y="0"/>
                  </a:moveTo>
                  <a:lnTo>
                    <a:pt x="994" y="0"/>
                  </a:lnTo>
                  <a:lnTo>
                    <a:pt x="994" y="4"/>
                  </a:lnTo>
                  <a:lnTo>
                    <a:pt x="983" y="4"/>
                  </a:lnTo>
                  <a:lnTo>
                    <a:pt x="983" y="0"/>
                  </a:lnTo>
                  <a:close/>
                  <a:moveTo>
                    <a:pt x="998" y="0"/>
                  </a:moveTo>
                  <a:lnTo>
                    <a:pt x="1010" y="0"/>
                  </a:lnTo>
                  <a:lnTo>
                    <a:pt x="1010" y="4"/>
                  </a:lnTo>
                  <a:lnTo>
                    <a:pt x="998" y="4"/>
                  </a:lnTo>
                  <a:lnTo>
                    <a:pt x="998" y="0"/>
                  </a:lnTo>
                  <a:close/>
                  <a:moveTo>
                    <a:pt x="1014" y="0"/>
                  </a:moveTo>
                  <a:lnTo>
                    <a:pt x="1025" y="0"/>
                  </a:lnTo>
                  <a:lnTo>
                    <a:pt x="1025" y="4"/>
                  </a:lnTo>
                  <a:lnTo>
                    <a:pt x="1014" y="4"/>
                  </a:lnTo>
                  <a:lnTo>
                    <a:pt x="1014" y="0"/>
                  </a:lnTo>
                  <a:close/>
                  <a:moveTo>
                    <a:pt x="1029" y="0"/>
                  </a:moveTo>
                  <a:lnTo>
                    <a:pt x="1041" y="0"/>
                  </a:lnTo>
                  <a:lnTo>
                    <a:pt x="1041" y="4"/>
                  </a:lnTo>
                  <a:lnTo>
                    <a:pt x="1029" y="4"/>
                  </a:lnTo>
                  <a:lnTo>
                    <a:pt x="1029" y="0"/>
                  </a:lnTo>
                  <a:close/>
                  <a:moveTo>
                    <a:pt x="1044" y="0"/>
                  </a:moveTo>
                  <a:lnTo>
                    <a:pt x="1056" y="0"/>
                  </a:lnTo>
                  <a:lnTo>
                    <a:pt x="1056" y="4"/>
                  </a:lnTo>
                  <a:lnTo>
                    <a:pt x="1044" y="4"/>
                  </a:lnTo>
                  <a:lnTo>
                    <a:pt x="1044" y="0"/>
                  </a:lnTo>
                  <a:close/>
                  <a:moveTo>
                    <a:pt x="1060" y="0"/>
                  </a:moveTo>
                  <a:lnTo>
                    <a:pt x="1071" y="0"/>
                  </a:lnTo>
                  <a:lnTo>
                    <a:pt x="1071" y="4"/>
                  </a:lnTo>
                  <a:lnTo>
                    <a:pt x="1060" y="4"/>
                  </a:lnTo>
                  <a:lnTo>
                    <a:pt x="1060" y="0"/>
                  </a:lnTo>
                  <a:close/>
                  <a:moveTo>
                    <a:pt x="1075" y="0"/>
                  </a:moveTo>
                  <a:lnTo>
                    <a:pt x="1087" y="0"/>
                  </a:lnTo>
                  <a:lnTo>
                    <a:pt x="1087" y="4"/>
                  </a:lnTo>
                  <a:lnTo>
                    <a:pt x="1075" y="4"/>
                  </a:lnTo>
                  <a:lnTo>
                    <a:pt x="1075" y="0"/>
                  </a:lnTo>
                  <a:close/>
                  <a:moveTo>
                    <a:pt x="1090" y="0"/>
                  </a:moveTo>
                  <a:lnTo>
                    <a:pt x="1102" y="1"/>
                  </a:lnTo>
                  <a:lnTo>
                    <a:pt x="1102" y="4"/>
                  </a:lnTo>
                  <a:lnTo>
                    <a:pt x="1090" y="4"/>
                  </a:lnTo>
                  <a:lnTo>
                    <a:pt x="1090" y="0"/>
                  </a:lnTo>
                  <a:close/>
                  <a:moveTo>
                    <a:pt x="1106" y="1"/>
                  </a:moveTo>
                  <a:lnTo>
                    <a:pt x="1117" y="1"/>
                  </a:lnTo>
                  <a:lnTo>
                    <a:pt x="1117" y="4"/>
                  </a:lnTo>
                  <a:lnTo>
                    <a:pt x="1106" y="4"/>
                  </a:lnTo>
                  <a:lnTo>
                    <a:pt x="1106" y="1"/>
                  </a:lnTo>
                  <a:close/>
                  <a:moveTo>
                    <a:pt x="1121" y="1"/>
                  </a:moveTo>
                  <a:lnTo>
                    <a:pt x="1133" y="1"/>
                  </a:lnTo>
                  <a:lnTo>
                    <a:pt x="1133" y="4"/>
                  </a:lnTo>
                  <a:lnTo>
                    <a:pt x="1121" y="4"/>
                  </a:lnTo>
                  <a:lnTo>
                    <a:pt x="1121" y="1"/>
                  </a:lnTo>
                  <a:close/>
                  <a:moveTo>
                    <a:pt x="1136" y="1"/>
                  </a:moveTo>
                  <a:lnTo>
                    <a:pt x="1148" y="1"/>
                  </a:lnTo>
                  <a:lnTo>
                    <a:pt x="1148" y="4"/>
                  </a:lnTo>
                  <a:lnTo>
                    <a:pt x="1136" y="4"/>
                  </a:lnTo>
                  <a:lnTo>
                    <a:pt x="1136" y="1"/>
                  </a:lnTo>
                  <a:close/>
                  <a:moveTo>
                    <a:pt x="1152" y="1"/>
                  </a:moveTo>
                  <a:lnTo>
                    <a:pt x="1163" y="1"/>
                  </a:lnTo>
                  <a:lnTo>
                    <a:pt x="1163" y="4"/>
                  </a:lnTo>
                  <a:lnTo>
                    <a:pt x="1152" y="4"/>
                  </a:lnTo>
                  <a:lnTo>
                    <a:pt x="1152" y="1"/>
                  </a:lnTo>
                  <a:close/>
                  <a:moveTo>
                    <a:pt x="1167" y="1"/>
                  </a:moveTo>
                  <a:lnTo>
                    <a:pt x="1179" y="1"/>
                  </a:lnTo>
                  <a:lnTo>
                    <a:pt x="1179" y="4"/>
                  </a:lnTo>
                  <a:lnTo>
                    <a:pt x="1167" y="4"/>
                  </a:lnTo>
                  <a:lnTo>
                    <a:pt x="1167" y="1"/>
                  </a:lnTo>
                  <a:close/>
                  <a:moveTo>
                    <a:pt x="1183" y="1"/>
                  </a:moveTo>
                  <a:lnTo>
                    <a:pt x="1194" y="1"/>
                  </a:lnTo>
                  <a:lnTo>
                    <a:pt x="1194" y="4"/>
                  </a:lnTo>
                  <a:lnTo>
                    <a:pt x="1183" y="4"/>
                  </a:lnTo>
                  <a:lnTo>
                    <a:pt x="1183" y="1"/>
                  </a:lnTo>
                  <a:close/>
                  <a:moveTo>
                    <a:pt x="1198" y="1"/>
                  </a:moveTo>
                  <a:lnTo>
                    <a:pt x="1209" y="1"/>
                  </a:lnTo>
                  <a:lnTo>
                    <a:pt x="1209" y="4"/>
                  </a:lnTo>
                  <a:lnTo>
                    <a:pt x="1198" y="4"/>
                  </a:lnTo>
                  <a:lnTo>
                    <a:pt x="1198" y="1"/>
                  </a:lnTo>
                  <a:close/>
                  <a:moveTo>
                    <a:pt x="1213" y="1"/>
                  </a:moveTo>
                  <a:lnTo>
                    <a:pt x="1225" y="1"/>
                  </a:lnTo>
                  <a:lnTo>
                    <a:pt x="1225" y="4"/>
                  </a:lnTo>
                  <a:lnTo>
                    <a:pt x="1213" y="4"/>
                  </a:lnTo>
                  <a:lnTo>
                    <a:pt x="1213" y="1"/>
                  </a:lnTo>
                  <a:close/>
                  <a:moveTo>
                    <a:pt x="1229" y="1"/>
                  </a:moveTo>
                  <a:lnTo>
                    <a:pt x="1240" y="1"/>
                  </a:lnTo>
                  <a:lnTo>
                    <a:pt x="1240" y="4"/>
                  </a:lnTo>
                  <a:lnTo>
                    <a:pt x="1229" y="4"/>
                  </a:lnTo>
                  <a:lnTo>
                    <a:pt x="1229" y="1"/>
                  </a:lnTo>
                  <a:close/>
                  <a:moveTo>
                    <a:pt x="1244" y="1"/>
                  </a:moveTo>
                  <a:lnTo>
                    <a:pt x="1256" y="1"/>
                  </a:lnTo>
                  <a:lnTo>
                    <a:pt x="1256" y="4"/>
                  </a:lnTo>
                  <a:lnTo>
                    <a:pt x="1244" y="4"/>
                  </a:lnTo>
                  <a:lnTo>
                    <a:pt x="1244" y="1"/>
                  </a:lnTo>
                  <a:close/>
                  <a:moveTo>
                    <a:pt x="1259" y="1"/>
                  </a:moveTo>
                  <a:lnTo>
                    <a:pt x="1271" y="1"/>
                  </a:lnTo>
                  <a:lnTo>
                    <a:pt x="1271" y="4"/>
                  </a:lnTo>
                  <a:lnTo>
                    <a:pt x="1259" y="4"/>
                  </a:lnTo>
                  <a:lnTo>
                    <a:pt x="1259" y="1"/>
                  </a:lnTo>
                  <a:close/>
                  <a:moveTo>
                    <a:pt x="1275" y="1"/>
                  </a:moveTo>
                  <a:lnTo>
                    <a:pt x="1286" y="1"/>
                  </a:lnTo>
                  <a:lnTo>
                    <a:pt x="1286" y="4"/>
                  </a:lnTo>
                  <a:lnTo>
                    <a:pt x="1275" y="4"/>
                  </a:lnTo>
                  <a:lnTo>
                    <a:pt x="1275" y="1"/>
                  </a:lnTo>
                  <a:close/>
                  <a:moveTo>
                    <a:pt x="1290" y="1"/>
                  </a:moveTo>
                  <a:lnTo>
                    <a:pt x="1302" y="1"/>
                  </a:lnTo>
                  <a:lnTo>
                    <a:pt x="1302" y="4"/>
                  </a:lnTo>
                  <a:lnTo>
                    <a:pt x="1290" y="4"/>
                  </a:lnTo>
                  <a:lnTo>
                    <a:pt x="1290" y="1"/>
                  </a:lnTo>
                  <a:close/>
                  <a:moveTo>
                    <a:pt x="1305" y="1"/>
                  </a:moveTo>
                  <a:lnTo>
                    <a:pt x="1317" y="1"/>
                  </a:lnTo>
                  <a:lnTo>
                    <a:pt x="1317" y="4"/>
                  </a:lnTo>
                  <a:lnTo>
                    <a:pt x="1305" y="4"/>
                  </a:lnTo>
                  <a:lnTo>
                    <a:pt x="1305" y="1"/>
                  </a:lnTo>
                  <a:close/>
                  <a:moveTo>
                    <a:pt x="1321" y="1"/>
                  </a:moveTo>
                  <a:lnTo>
                    <a:pt x="1332" y="1"/>
                  </a:lnTo>
                  <a:lnTo>
                    <a:pt x="1332" y="4"/>
                  </a:lnTo>
                  <a:lnTo>
                    <a:pt x="1321" y="4"/>
                  </a:lnTo>
                  <a:lnTo>
                    <a:pt x="1321" y="1"/>
                  </a:lnTo>
                  <a:close/>
                  <a:moveTo>
                    <a:pt x="1336" y="1"/>
                  </a:moveTo>
                  <a:lnTo>
                    <a:pt x="1348" y="1"/>
                  </a:lnTo>
                  <a:lnTo>
                    <a:pt x="1348" y="4"/>
                  </a:lnTo>
                  <a:lnTo>
                    <a:pt x="1336" y="4"/>
                  </a:lnTo>
                  <a:lnTo>
                    <a:pt x="1336" y="1"/>
                  </a:lnTo>
                  <a:close/>
                  <a:moveTo>
                    <a:pt x="1352" y="1"/>
                  </a:moveTo>
                  <a:lnTo>
                    <a:pt x="1363" y="1"/>
                  </a:lnTo>
                  <a:lnTo>
                    <a:pt x="1363" y="4"/>
                  </a:lnTo>
                  <a:lnTo>
                    <a:pt x="1352" y="4"/>
                  </a:lnTo>
                  <a:lnTo>
                    <a:pt x="1352" y="1"/>
                  </a:lnTo>
                  <a:close/>
                  <a:moveTo>
                    <a:pt x="1367" y="1"/>
                  </a:moveTo>
                  <a:lnTo>
                    <a:pt x="1378" y="1"/>
                  </a:lnTo>
                  <a:lnTo>
                    <a:pt x="1378" y="4"/>
                  </a:lnTo>
                  <a:lnTo>
                    <a:pt x="1367" y="4"/>
                  </a:lnTo>
                  <a:lnTo>
                    <a:pt x="1367" y="1"/>
                  </a:lnTo>
                  <a:close/>
                  <a:moveTo>
                    <a:pt x="1382" y="1"/>
                  </a:moveTo>
                  <a:lnTo>
                    <a:pt x="1394" y="1"/>
                  </a:lnTo>
                  <a:lnTo>
                    <a:pt x="1394" y="4"/>
                  </a:lnTo>
                  <a:lnTo>
                    <a:pt x="1382" y="4"/>
                  </a:lnTo>
                  <a:lnTo>
                    <a:pt x="1382" y="1"/>
                  </a:lnTo>
                  <a:close/>
                  <a:moveTo>
                    <a:pt x="1398" y="1"/>
                  </a:moveTo>
                  <a:lnTo>
                    <a:pt x="1409" y="1"/>
                  </a:lnTo>
                  <a:lnTo>
                    <a:pt x="1409" y="4"/>
                  </a:lnTo>
                  <a:lnTo>
                    <a:pt x="1398" y="4"/>
                  </a:lnTo>
                  <a:lnTo>
                    <a:pt x="1398" y="1"/>
                  </a:lnTo>
                  <a:close/>
                  <a:moveTo>
                    <a:pt x="1413" y="1"/>
                  </a:moveTo>
                  <a:lnTo>
                    <a:pt x="1424" y="1"/>
                  </a:lnTo>
                  <a:lnTo>
                    <a:pt x="1424" y="4"/>
                  </a:lnTo>
                  <a:lnTo>
                    <a:pt x="1413" y="4"/>
                  </a:lnTo>
                  <a:lnTo>
                    <a:pt x="1413" y="1"/>
                  </a:lnTo>
                  <a:close/>
                  <a:moveTo>
                    <a:pt x="1428" y="1"/>
                  </a:moveTo>
                  <a:lnTo>
                    <a:pt x="1440" y="1"/>
                  </a:lnTo>
                  <a:lnTo>
                    <a:pt x="1440" y="4"/>
                  </a:lnTo>
                  <a:lnTo>
                    <a:pt x="1428" y="4"/>
                  </a:lnTo>
                  <a:lnTo>
                    <a:pt x="1428" y="1"/>
                  </a:lnTo>
                  <a:close/>
                  <a:moveTo>
                    <a:pt x="1444" y="1"/>
                  </a:moveTo>
                  <a:lnTo>
                    <a:pt x="1455" y="1"/>
                  </a:lnTo>
                  <a:lnTo>
                    <a:pt x="1455" y="4"/>
                  </a:lnTo>
                  <a:lnTo>
                    <a:pt x="1444" y="4"/>
                  </a:lnTo>
                  <a:lnTo>
                    <a:pt x="1444" y="1"/>
                  </a:lnTo>
                  <a:close/>
                  <a:moveTo>
                    <a:pt x="1459" y="1"/>
                  </a:moveTo>
                  <a:lnTo>
                    <a:pt x="1471" y="1"/>
                  </a:lnTo>
                  <a:lnTo>
                    <a:pt x="1471" y="4"/>
                  </a:lnTo>
                  <a:lnTo>
                    <a:pt x="1459" y="4"/>
                  </a:lnTo>
                  <a:lnTo>
                    <a:pt x="1459" y="1"/>
                  </a:lnTo>
                  <a:close/>
                  <a:moveTo>
                    <a:pt x="1474" y="1"/>
                  </a:moveTo>
                  <a:lnTo>
                    <a:pt x="1486" y="1"/>
                  </a:lnTo>
                  <a:lnTo>
                    <a:pt x="1486" y="4"/>
                  </a:lnTo>
                  <a:lnTo>
                    <a:pt x="1474" y="4"/>
                  </a:lnTo>
                  <a:lnTo>
                    <a:pt x="1474" y="1"/>
                  </a:lnTo>
                  <a:close/>
                  <a:moveTo>
                    <a:pt x="1490" y="1"/>
                  </a:moveTo>
                  <a:lnTo>
                    <a:pt x="1501" y="1"/>
                  </a:lnTo>
                  <a:lnTo>
                    <a:pt x="1501" y="4"/>
                  </a:lnTo>
                  <a:lnTo>
                    <a:pt x="1490" y="4"/>
                  </a:lnTo>
                  <a:lnTo>
                    <a:pt x="1490" y="1"/>
                  </a:lnTo>
                  <a:close/>
                  <a:moveTo>
                    <a:pt x="1505" y="1"/>
                  </a:moveTo>
                  <a:lnTo>
                    <a:pt x="1517" y="1"/>
                  </a:lnTo>
                  <a:lnTo>
                    <a:pt x="1517" y="4"/>
                  </a:lnTo>
                  <a:lnTo>
                    <a:pt x="1505" y="4"/>
                  </a:lnTo>
                  <a:lnTo>
                    <a:pt x="1505" y="1"/>
                  </a:lnTo>
                  <a:close/>
                  <a:moveTo>
                    <a:pt x="1520" y="1"/>
                  </a:moveTo>
                  <a:lnTo>
                    <a:pt x="1532" y="1"/>
                  </a:lnTo>
                  <a:lnTo>
                    <a:pt x="1532" y="4"/>
                  </a:lnTo>
                  <a:lnTo>
                    <a:pt x="1520" y="4"/>
                  </a:lnTo>
                  <a:lnTo>
                    <a:pt x="1520" y="1"/>
                  </a:lnTo>
                  <a:close/>
                  <a:moveTo>
                    <a:pt x="1536" y="1"/>
                  </a:moveTo>
                  <a:lnTo>
                    <a:pt x="1547" y="1"/>
                  </a:lnTo>
                  <a:lnTo>
                    <a:pt x="1547" y="4"/>
                  </a:lnTo>
                  <a:lnTo>
                    <a:pt x="1536" y="4"/>
                  </a:lnTo>
                  <a:lnTo>
                    <a:pt x="1536" y="1"/>
                  </a:lnTo>
                  <a:close/>
                  <a:moveTo>
                    <a:pt x="1551" y="1"/>
                  </a:moveTo>
                  <a:lnTo>
                    <a:pt x="1563" y="1"/>
                  </a:lnTo>
                  <a:lnTo>
                    <a:pt x="1563" y="4"/>
                  </a:lnTo>
                  <a:lnTo>
                    <a:pt x="1551" y="4"/>
                  </a:lnTo>
                  <a:lnTo>
                    <a:pt x="1551" y="1"/>
                  </a:lnTo>
                  <a:close/>
                  <a:moveTo>
                    <a:pt x="1567" y="1"/>
                  </a:moveTo>
                  <a:lnTo>
                    <a:pt x="1578" y="1"/>
                  </a:lnTo>
                  <a:lnTo>
                    <a:pt x="1578" y="4"/>
                  </a:lnTo>
                  <a:lnTo>
                    <a:pt x="1567" y="4"/>
                  </a:lnTo>
                  <a:lnTo>
                    <a:pt x="1567" y="1"/>
                  </a:lnTo>
                  <a:close/>
                  <a:moveTo>
                    <a:pt x="1582" y="1"/>
                  </a:moveTo>
                  <a:lnTo>
                    <a:pt x="1593" y="1"/>
                  </a:lnTo>
                  <a:lnTo>
                    <a:pt x="1593" y="4"/>
                  </a:lnTo>
                  <a:lnTo>
                    <a:pt x="1582" y="4"/>
                  </a:lnTo>
                  <a:lnTo>
                    <a:pt x="1582" y="1"/>
                  </a:lnTo>
                  <a:close/>
                  <a:moveTo>
                    <a:pt x="1597" y="1"/>
                  </a:moveTo>
                  <a:lnTo>
                    <a:pt x="1609" y="1"/>
                  </a:lnTo>
                  <a:lnTo>
                    <a:pt x="1609" y="4"/>
                  </a:lnTo>
                  <a:lnTo>
                    <a:pt x="1597" y="4"/>
                  </a:lnTo>
                  <a:lnTo>
                    <a:pt x="1597" y="1"/>
                  </a:lnTo>
                  <a:close/>
                  <a:moveTo>
                    <a:pt x="1613" y="1"/>
                  </a:moveTo>
                  <a:lnTo>
                    <a:pt x="1624" y="1"/>
                  </a:lnTo>
                  <a:lnTo>
                    <a:pt x="1624" y="4"/>
                  </a:lnTo>
                  <a:lnTo>
                    <a:pt x="1613" y="4"/>
                  </a:lnTo>
                  <a:lnTo>
                    <a:pt x="1613" y="1"/>
                  </a:lnTo>
                  <a:close/>
                  <a:moveTo>
                    <a:pt x="1628" y="1"/>
                  </a:moveTo>
                  <a:lnTo>
                    <a:pt x="1640" y="1"/>
                  </a:lnTo>
                  <a:lnTo>
                    <a:pt x="1640" y="5"/>
                  </a:lnTo>
                  <a:lnTo>
                    <a:pt x="1628" y="4"/>
                  </a:lnTo>
                  <a:lnTo>
                    <a:pt x="1628" y="1"/>
                  </a:lnTo>
                  <a:close/>
                  <a:moveTo>
                    <a:pt x="1643" y="1"/>
                  </a:moveTo>
                  <a:lnTo>
                    <a:pt x="1655" y="1"/>
                  </a:lnTo>
                  <a:lnTo>
                    <a:pt x="1655" y="5"/>
                  </a:lnTo>
                  <a:lnTo>
                    <a:pt x="1643" y="5"/>
                  </a:lnTo>
                  <a:lnTo>
                    <a:pt x="1643" y="1"/>
                  </a:lnTo>
                  <a:close/>
                  <a:moveTo>
                    <a:pt x="1659" y="1"/>
                  </a:moveTo>
                  <a:lnTo>
                    <a:pt x="1670" y="1"/>
                  </a:lnTo>
                  <a:lnTo>
                    <a:pt x="1670" y="5"/>
                  </a:lnTo>
                  <a:lnTo>
                    <a:pt x="1659" y="5"/>
                  </a:lnTo>
                  <a:lnTo>
                    <a:pt x="1659" y="1"/>
                  </a:lnTo>
                  <a:close/>
                  <a:moveTo>
                    <a:pt x="1674" y="1"/>
                  </a:moveTo>
                  <a:lnTo>
                    <a:pt x="1686" y="1"/>
                  </a:lnTo>
                  <a:lnTo>
                    <a:pt x="1686" y="5"/>
                  </a:lnTo>
                  <a:lnTo>
                    <a:pt x="1674" y="5"/>
                  </a:lnTo>
                  <a:lnTo>
                    <a:pt x="1674" y="1"/>
                  </a:lnTo>
                  <a:close/>
                  <a:moveTo>
                    <a:pt x="1689" y="1"/>
                  </a:moveTo>
                  <a:lnTo>
                    <a:pt x="1701" y="1"/>
                  </a:lnTo>
                  <a:lnTo>
                    <a:pt x="1701" y="5"/>
                  </a:lnTo>
                  <a:lnTo>
                    <a:pt x="1689" y="5"/>
                  </a:lnTo>
                  <a:lnTo>
                    <a:pt x="1689" y="1"/>
                  </a:lnTo>
                  <a:close/>
                  <a:moveTo>
                    <a:pt x="1705" y="1"/>
                  </a:moveTo>
                  <a:lnTo>
                    <a:pt x="1716" y="1"/>
                  </a:lnTo>
                  <a:lnTo>
                    <a:pt x="1716" y="5"/>
                  </a:lnTo>
                  <a:lnTo>
                    <a:pt x="1705" y="5"/>
                  </a:lnTo>
                  <a:lnTo>
                    <a:pt x="1705" y="1"/>
                  </a:lnTo>
                  <a:close/>
                  <a:moveTo>
                    <a:pt x="1720" y="1"/>
                  </a:moveTo>
                  <a:lnTo>
                    <a:pt x="1732" y="1"/>
                  </a:lnTo>
                  <a:lnTo>
                    <a:pt x="1732" y="5"/>
                  </a:lnTo>
                  <a:lnTo>
                    <a:pt x="1720" y="5"/>
                  </a:lnTo>
                  <a:lnTo>
                    <a:pt x="1720" y="1"/>
                  </a:lnTo>
                  <a:close/>
                  <a:moveTo>
                    <a:pt x="1735" y="1"/>
                  </a:moveTo>
                  <a:lnTo>
                    <a:pt x="1747" y="1"/>
                  </a:lnTo>
                  <a:lnTo>
                    <a:pt x="1747" y="5"/>
                  </a:lnTo>
                  <a:lnTo>
                    <a:pt x="1735" y="5"/>
                  </a:lnTo>
                  <a:lnTo>
                    <a:pt x="1735" y="1"/>
                  </a:lnTo>
                  <a:close/>
                  <a:moveTo>
                    <a:pt x="1751" y="1"/>
                  </a:moveTo>
                  <a:lnTo>
                    <a:pt x="1762" y="1"/>
                  </a:lnTo>
                  <a:lnTo>
                    <a:pt x="1762" y="5"/>
                  </a:lnTo>
                  <a:lnTo>
                    <a:pt x="1751" y="5"/>
                  </a:lnTo>
                  <a:lnTo>
                    <a:pt x="1751" y="1"/>
                  </a:lnTo>
                  <a:close/>
                  <a:moveTo>
                    <a:pt x="1766" y="1"/>
                  </a:moveTo>
                  <a:lnTo>
                    <a:pt x="1778" y="1"/>
                  </a:lnTo>
                  <a:lnTo>
                    <a:pt x="1778" y="5"/>
                  </a:lnTo>
                  <a:lnTo>
                    <a:pt x="1766" y="5"/>
                  </a:lnTo>
                  <a:lnTo>
                    <a:pt x="1766" y="1"/>
                  </a:lnTo>
                  <a:close/>
                  <a:moveTo>
                    <a:pt x="1782" y="1"/>
                  </a:moveTo>
                  <a:lnTo>
                    <a:pt x="1793" y="1"/>
                  </a:lnTo>
                  <a:lnTo>
                    <a:pt x="1793" y="5"/>
                  </a:lnTo>
                  <a:lnTo>
                    <a:pt x="1782" y="5"/>
                  </a:lnTo>
                  <a:lnTo>
                    <a:pt x="1782" y="1"/>
                  </a:lnTo>
                  <a:close/>
                  <a:moveTo>
                    <a:pt x="1797" y="1"/>
                  </a:moveTo>
                  <a:lnTo>
                    <a:pt x="1808" y="1"/>
                  </a:lnTo>
                  <a:lnTo>
                    <a:pt x="1808" y="5"/>
                  </a:lnTo>
                  <a:lnTo>
                    <a:pt x="1797" y="5"/>
                  </a:lnTo>
                  <a:lnTo>
                    <a:pt x="1797" y="1"/>
                  </a:lnTo>
                  <a:close/>
                  <a:moveTo>
                    <a:pt x="1812" y="1"/>
                  </a:moveTo>
                  <a:lnTo>
                    <a:pt x="1824" y="1"/>
                  </a:lnTo>
                  <a:lnTo>
                    <a:pt x="1824" y="5"/>
                  </a:lnTo>
                  <a:lnTo>
                    <a:pt x="1812" y="5"/>
                  </a:lnTo>
                  <a:lnTo>
                    <a:pt x="1812" y="1"/>
                  </a:lnTo>
                  <a:close/>
                  <a:moveTo>
                    <a:pt x="1828" y="1"/>
                  </a:moveTo>
                  <a:lnTo>
                    <a:pt x="1839" y="1"/>
                  </a:lnTo>
                  <a:lnTo>
                    <a:pt x="1839" y="5"/>
                  </a:lnTo>
                  <a:lnTo>
                    <a:pt x="1828" y="5"/>
                  </a:lnTo>
                  <a:lnTo>
                    <a:pt x="1828" y="1"/>
                  </a:lnTo>
                  <a:close/>
                  <a:moveTo>
                    <a:pt x="1843" y="1"/>
                  </a:moveTo>
                  <a:lnTo>
                    <a:pt x="1855" y="1"/>
                  </a:lnTo>
                  <a:lnTo>
                    <a:pt x="1855" y="5"/>
                  </a:lnTo>
                  <a:lnTo>
                    <a:pt x="1843" y="5"/>
                  </a:lnTo>
                  <a:lnTo>
                    <a:pt x="1843" y="1"/>
                  </a:lnTo>
                  <a:close/>
                  <a:moveTo>
                    <a:pt x="1858" y="1"/>
                  </a:moveTo>
                  <a:lnTo>
                    <a:pt x="1870" y="1"/>
                  </a:lnTo>
                  <a:lnTo>
                    <a:pt x="1870" y="5"/>
                  </a:lnTo>
                  <a:lnTo>
                    <a:pt x="1858" y="5"/>
                  </a:lnTo>
                  <a:lnTo>
                    <a:pt x="1858" y="1"/>
                  </a:lnTo>
                  <a:close/>
                  <a:moveTo>
                    <a:pt x="1874" y="1"/>
                  </a:moveTo>
                  <a:lnTo>
                    <a:pt x="1885" y="1"/>
                  </a:lnTo>
                  <a:lnTo>
                    <a:pt x="1885" y="5"/>
                  </a:lnTo>
                  <a:lnTo>
                    <a:pt x="1874" y="5"/>
                  </a:lnTo>
                  <a:lnTo>
                    <a:pt x="1874" y="1"/>
                  </a:lnTo>
                  <a:close/>
                  <a:moveTo>
                    <a:pt x="1889" y="1"/>
                  </a:moveTo>
                  <a:lnTo>
                    <a:pt x="1901" y="1"/>
                  </a:lnTo>
                  <a:lnTo>
                    <a:pt x="1901" y="5"/>
                  </a:lnTo>
                  <a:lnTo>
                    <a:pt x="1889" y="5"/>
                  </a:lnTo>
                  <a:lnTo>
                    <a:pt x="1889" y="1"/>
                  </a:lnTo>
                  <a:close/>
                  <a:moveTo>
                    <a:pt x="1904" y="1"/>
                  </a:moveTo>
                  <a:lnTo>
                    <a:pt x="1916" y="1"/>
                  </a:lnTo>
                  <a:lnTo>
                    <a:pt x="1916" y="5"/>
                  </a:lnTo>
                  <a:lnTo>
                    <a:pt x="1904" y="5"/>
                  </a:lnTo>
                  <a:lnTo>
                    <a:pt x="1904" y="1"/>
                  </a:lnTo>
                  <a:close/>
                  <a:moveTo>
                    <a:pt x="1920" y="1"/>
                  </a:moveTo>
                  <a:lnTo>
                    <a:pt x="1931" y="1"/>
                  </a:lnTo>
                  <a:lnTo>
                    <a:pt x="1931" y="5"/>
                  </a:lnTo>
                  <a:lnTo>
                    <a:pt x="1920" y="5"/>
                  </a:lnTo>
                  <a:lnTo>
                    <a:pt x="1920" y="1"/>
                  </a:lnTo>
                  <a:close/>
                  <a:moveTo>
                    <a:pt x="1935" y="1"/>
                  </a:moveTo>
                  <a:lnTo>
                    <a:pt x="1947" y="1"/>
                  </a:lnTo>
                  <a:lnTo>
                    <a:pt x="1947" y="5"/>
                  </a:lnTo>
                  <a:lnTo>
                    <a:pt x="1935" y="5"/>
                  </a:lnTo>
                  <a:lnTo>
                    <a:pt x="1935" y="1"/>
                  </a:lnTo>
                  <a:close/>
                  <a:moveTo>
                    <a:pt x="1951" y="1"/>
                  </a:moveTo>
                  <a:lnTo>
                    <a:pt x="1962" y="1"/>
                  </a:lnTo>
                  <a:lnTo>
                    <a:pt x="1962" y="5"/>
                  </a:lnTo>
                  <a:lnTo>
                    <a:pt x="1951" y="5"/>
                  </a:lnTo>
                  <a:lnTo>
                    <a:pt x="1951" y="1"/>
                  </a:lnTo>
                  <a:close/>
                  <a:moveTo>
                    <a:pt x="1966" y="1"/>
                  </a:moveTo>
                  <a:lnTo>
                    <a:pt x="1977" y="1"/>
                  </a:lnTo>
                  <a:lnTo>
                    <a:pt x="1977" y="5"/>
                  </a:lnTo>
                  <a:lnTo>
                    <a:pt x="1966" y="5"/>
                  </a:lnTo>
                  <a:lnTo>
                    <a:pt x="1966" y="1"/>
                  </a:lnTo>
                  <a:close/>
                  <a:moveTo>
                    <a:pt x="1981" y="1"/>
                  </a:moveTo>
                  <a:lnTo>
                    <a:pt x="1993" y="1"/>
                  </a:lnTo>
                  <a:lnTo>
                    <a:pt x="1993" y="5"/>
                  </a:lnTo>
                  <a:lnTo>
                    <a:pt x="1981" y="5"/>
                  </a:lnTo>
                  <a:lnTo>
                    <a:pt x="1981" y="1"/>
                  </a:lnTo>
                  <a:close/>
                  <a:moveTo>
                    <a:pt x="1997" y="1"/>
                  </a:moveTo>
                  <a:lnTo>
                    <a:pt x="2008" y="1"/>
                  </a:lnTo>
                  <a:lnTo>
                    <a:pt x="2008" y="5"/>
                  </a:lnTo>
                  <a:lnTo>
                    <a:pt x="1997" y="5"/>
                  </a:lnTo>
                  <a:lnTo>
                    <a:pt x="1997" y="1"/>
                  </a:lnTo>
                  <a:close/>
                  <a:moveTo>
                    <a:pt x="2012" y="1"/>
                  </a:moveTo>
                  <a:lnTo>
                    <a:pt x="2023" y="1"/>
                  </a:lnTo>
                  <a:lnTo>
                    <a:pt x="2023" y="5"/>
                  </a:lnTo>
                  <a:lnTo>
                    <a:pt x="2012" y="5"/>
                  </a:lnTo>
                  <a:lnTo>
                    <a:pt x="2012" y="1"/>
                  </a:lnTo>
                  <a:close/>
                  <a:moveTo>
                    <a:pt x="2027" y="1"/>
                  </a:moveTo>
                  <a:lnTo>
                    <a:pt x="2039" y="1"/>
                  </a:lnTo>
                  <a:lnTo>
                    <a:pt x="2039" y="5"/>
                  </a:lnTo>
                  <a:lnTo>
                    <a:pt x="2027" y="5"/>
                  </a:lnTo>
                  <a:lnTo>
                    <a:pt x="2027" y="1"/>
                  </a:lnTo>
                  <a:close/>
                  <a:moveTo>
                    <a:pt x="2043" y="1"/>
                  </a:moveTo>
                  <a:lnTo>
                    <a:pt x="2054" y="1"/>
                  </a:lnTo>
                  <a:lnTo>
                    <a:pt x="2054" y="5"/>
                  </a:lnTo>
                  <a:lnTo>
                    <a:pt x="2043" y="5"/>
                  </a:lnTo>
                  <a:lnTo>
                    <a:pt x="2043" y="1"/>
                  </a:lnTo>
                  <a:close/>
                  <a:moveTo>
                    <a:pt x="2058" y="1"/>
                  </a:moveTo>
                  <a:lnTo>
                    <a:pt x="2070" y="1"/>
                  </a:lnTo>
                  <a:lnTo>
                    <a:pt x="2070" y="5"/>
                  </a:lnTo>
                  <a:lnTo>
                    <a:pt x="2058" y="5"/>
                  </a:lnTo>
                  <a:lnTo>
                    <a:pt x="2058" y="1"/>
                  </a:lnTo>
                  <a:close/>
                  <a:moveTo>
                    <a:pt x="2073" y="1"/>
                  </a:moveTo>
                  <a:lnTo>
                    <a:pt x="2085" y="1"/>
                  </a:lnTo>
                  <a:lnTo>
                    <a:pt x="2085" y="5"/>
                  </a:lnTo>
                  <a:lnTo>
                    <a:pt x="2073" y="5"/>
                  </a:lnTo>
                  <a:lnTo>
                    <a:pt x="2073" y="1"/>
                  </a:lnTo>
                  <a:close/>
                  <a:moveTo>
                    <a:pt x="2089" y="1"/>
                  </a:moveTo>
                  <a:lnTo>
                    <a:pt x="2100" y="1"/>
                  </a:lnTo>
                  <a:lnTo>
                    <a:pt x="2100" y="5"/>
                  </a:lnTo>
                  <a:lnTo>
                    <a:pt x="2089" y="5"/>
                  </a:lnTo>
                  <a:lnTo>
                    <a:pt x="2089" y="1"/>
                  </a:lnTo>
                  <a:close/>
                  <a:moveTo>
                    <a:pt x="2104" y="1"/>
                  </a:moveTo>
                  <a:lnTo>
                    <a:pt x="2116" y="1"/>
                  </a:lnTo>
                  <a:lnTo>
                    <a:pt x="2116" y="5"/>
                  </a:lnTo>
                  <a:lnTo>
                    <a:pt x="2104" y="5"/>
                  </a:lnTo>
                  <a:lnTo>
                    <a:pt x="2104" y="1"/>
                  </a:lnTo>
                  <a:close/>
                  <a:moveTo>
                    <a:pt x="2119" y="1"/>
                  </a:moveTo>
                  <a:lnTo>
                    <a:pt x="2131" y="1"/>
                  </a:lnTo>
                  <a:lnTo>
                    <a:pt x="2131" y="5"/>
                  </a:lnTo>
                  <a:lnTo>
                    <a:pt x="2119" y="5"/>
                  </a:lnTo>
                  <a:lnTo>
                    <a:pt x="2119" y="1"/>
                  </a:lnTo>
                  <a:close/>
                  <a:moveTo>
                    <a:pt x="2135" y="1"/>
                  </a:moveTo>
                  <a:lnTo>
                    <a:pt x="2146" y="1"/>
                  </a:lnTo>
                  <a:lnTo>
                    <a:pt x="2146" y="5"/>
                  </a:lnTo>
                  <a:lnTo>
                    <a:pt x="2135" y="5"/>
                  </a:lnTo>
                  <a:lnTo>
                    <a:pt x="2135" y="1"/>
                  </a:lnTo>
                  <a:close/>
                  <a:moveTo>
                    <a:pt x="2150" y="1"/>
                  </a:moveTo>
                  <a:lnTo>
                    <a:pt x="2162" y="1"/>
                  </a:lnTo>
                  <a:lnTo>
                    <a:pt x="2162" y="5"/>
                  </a:lnTo>
                  <a:lnTo>
                    <a:pt x="2150" y="5"/>
                  </a:lnTo>
                  <a:lnTo>
                    <a:pt x="2150" y="1"/>
                  </a:lnTo>
                  <a:close/>
                  <a:moveTo>
                    <a:pt x="2166" y="1"/>
                  </a:moveTo>
                  <a:lnTo>
                    <a:pt x="2168" y="1"/>
                  </a:lnTo>
                  <a:lnTo>
                    <a:pt x="2168" y="5"/>
                  </a:lnTo>
                  <a:lnTo>
                    <a:pt x="2166" y="5"/>
                  </a:lnTo>
                  <a:lnTo>
                    <a:pt x="2166" y="1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321" name="Rectangle 278"/>
            <p:cNvSpPr>
              <a:spLocks noChangeArrowheads="1"/>
            </p:cNvSpPr>
            <p:nvPr/>
          </p:nvSpPr>
          <p:spPr bwMode="auto">
            <a:xfrm rot="16200000">
              <a:off x="552422" y="1477069"/>
              <a:ext cx="258055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GB" sz="1000" b="1" noProof="1" smtClean="0">
                  <a:latin typeface="Times New Roman"/>
                  <a:cs typeface="Times New Roman"/>
                </a:rPr>
                <a:t>Mean of ratios </a:t>
              </a:r>
              <a:r>
                <a:rPr lang="en-GB" sz="1000" noProof="1" smtClean="0"/>
                <a:t> </a:t>
              </a:r>
              <a:r>
                <a:rPr lang="en-GB" sz="1000" b="1" noProof="1" smtClean="0">
                  <a:latin typeface="Times New Roman"/>
                  <a:cs typeface="Times New Roman"/>
                </a:rPr>
                <a:t>[AA]</a:t>
              </a:r>
              <a:r>
                <a:rPr lang="en-GB" sz="800" b="1" baseline="-25000" noProof="1" smtClean="0">
                  <a:latin typeface="Times New Roman"/>
                  <a:cs typeface="Times New Roman"/>
                </a:rPr>
                <a:t>AVG or AVG + Glu </a:t>
              </a:r>
              <a:r>
                <a:rPr lang="en-GB" sz="1000" b="1" noProof="1" smtClean="0">
                  <a:latin typeface="Times New Roman"/>
                  <a:cs typeface="Times New Roman"/>
                </a:rPr>
                <a:t>/</a:t>
              </a:r>
              <a:r>
                <a:rPr lang="en-GB" sz="1000" noProof="1" smtClean="0"/>
                <a:t> </a:t>
              </a:r>
              <a:r>
                <a:rPr lang="en-GB" sz="1000" b="1" noProof="1" smtClean="0">
                  <a:latin typeface="Times New Roman"/>
                  <a:cs typeface="Times New Roman"/>
                </a:rPr>
                <a:t>[AA]</a:t>
              </a:r>
              <a:r>
                <a:rPr lang="en-GB" sz="800" b="1" baseline="-25000" noProof="1" smtClean="0">
                  <a:latin typeface="Times New Roman"/>
                  <a:cs typeface="Times New Roman"/>
                </a:rPr>
                <a:t>KNO3</a:t>
              </a:r>
              <a:r>
                <a:rPr lang="en-GB" sz="1000" b="1" baseline="-25000" noProof="1" smtClean="0">
                  <a:latin typeface="Times New Roman"/>
                  <a:cs typeface="Times New Roman"/>
                </a:rPr>
                <a:t> </a:t>
              </a:r>
              <a:endParaRPr lang="en-GB" sz="1000" b="1" noProof="1" smtClean="0">
                <a:latin typeface="Times New Roman"/>
                <a:cs typeface="Times New Roman"/>
              </a:endParaRPr>
            </a:p>
            <a:p>
              <a:pPr lvl="0" algn="ctr"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sz="800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(</a:t>
              </a:r>
              <a:r>
                <a:rPr kumimoji="0" lang="en-GB" sz="800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ymbol" charset="2"/>
                  <a:cs typeface="Symbol" charset="2"/>
                </a:rPr>
                <a:t>m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m</a:t>
              </a:r>
              <a:r>
                <a:rPr kumimoji="0" lang="en-GB" sz="800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oles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. g</a:t>
              </a:r>
              <a:r>
                <a:rPr lang="en-GB" sz="800" baseline="300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-1 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DW</a:t>
              </a:r>
              <a:r>
                <a:rPr kumimoji="0" lang="en-GB" sz="800" i="0" u="none" strike="noStrike" cap="none" normalizeH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/ </a:t>
              </a:r>
              <a:r>
                <a:rPr lang="en-GB" sz="800" noProof="1" smtClean="0">
                  <a:solidFill>
                    <a:srgbClr val="000000"/>
                  </a:solidFill>
                  <a:latin typeface="Symbol" charset="2"/>
                  <a:cs typeface="Symbol" charset="2"/>
                </a:rPr>
                <a:t>m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moles. g</a:t>
              </a:r>
              <a:r>
                <a:rPr lang="en-GB" sz="800" baseline="300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-1 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DW)</a:t>
              </a:r>
              <a:endParaRPr kumimoji="0" lang="en-GB" sz="800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grpSp>
        <p:nvGrpSpPr>
          <p:cNvPr id="8" name="Grouper 323"/>
          <p:cNvGrpSpPr/>
          <p:nvPr/>
        </p:nvGrpSpPr>
        <p:grpSpPr>
          <a:xfrm>
            <a:off x="1704201" y="2829645"/>
            <a:ext cx="3248799" cy="2580555"/>
            <a:chOff x="1704201" y="2829645"/>
            <a:chExt cx="3248799" cy="2580555"/>
          </a:xfrm>
        </p:grpSpPr>
        <p:sp>
          <p:nvSpPr>
            <p:cNvPr id="160" name="Rectangle 55"/>
            <p:cNvSpPr>
              <a:spLocks noChangeArrowheads="1"/>
            </p:cNvSpPr>
            <p:nvPr/>
          </p:nvSpPr>
          <p:spPr bwMode="auto">
            <a:xfrm>
              <a:off x="2320751" y="4963245"/>
              <a:ext cx="34624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Pentose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61" name="Rectangle 56"/>
            <p:cNvSpPr>
              <a:spLocks noChangeArrowheads="1"/>
            </p:cNvSpPr>
            <p:nvPr/>
          </p:nvSpPr>
          <p:spPr bwMode="auto">
            <a:xfrm>
              <a:off x="2819400" y="4963245"/>
              <a:ext cx="19236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PEP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62" name="Rectangle 57"/>
            <p:cNvSpPr>
              <a:spLocks noChangeArrowheads="1"/>
            </p:cNvSpPr>
            <p:nvPr/>
          </p:nvSpPr>
          <p:spPr bwMode="auto">
            <a:xfrm>
              <a:off x="3145383" y="4963245"/>
              <a:ext cx="4360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Aspartate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80" name="Rectangle 58"/>
            <p:cNvSpPr>
              <a:spLocks noChangeArrowheads="1"/>
            </p:cNvSpPr>
            <p:nvPr/>
          </p:nvSpPr>
          <p:spPr bwMode="auto">
            <a:xfrm>
              <a:off x="3729608" y="4963245"/>
              <a:ext cx="21079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Keto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84" name="Rectangle 59"/>
            <p:cNvSpPr>
              <a:spLocks noChangeArrowheads="1"/>
            </p:cNvSpPr>
            <p:nvPr/>
          </p:nvSpPr>
          <p:spPr bwMode="auto">
            <a:xfrm>
              <a:off x="4114800" y="4963245"/>
              <a:ext cx="2693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GA3P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85" name="Rectangle 60"/>
            <p:cNvSpPr>
              <a:spLocks noChangeArrowheads="1"/>
            </p:cNvSpPr>
            <p:nvPr/>
          </p:nvSpPr>
          <p:spPr bwMode="auto">
            <a:xfrm>
              <a:off x="4542631" y="4963245"/>
              <a:ext cx="41036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Pyruvate</a:t>
              </a:r>
              <a:endParaRPr kumimoji="0" lang="en-GB" sz="800" b="1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  <p:sp>
          <p:nvSpPr>
            <p:cNvPr id="189" name="Rectangle 8"/>
            <p:cNvSpPr>
              <a:spLocks noChangeArrowheads="1"/>
            </p:cNvSpPr>
            <p:nvPr/>
          </p:nvSpPr>
          <p:spPr bwMode="auto">
            <a:xfrm>
              <a:off x="2354248" y="3709993"/>
              <a:ext cx="126585" cy="124319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191" name="Freeform 9"/>
            <p:cNvSpPr>
              <a:spLocks noEditPoints="1"/>
            </p:cNvSpPr>
            <p:nvPr/>
          </p:nvSpPr>
          <p:spPr bwMode="auto">
            <a:xfrm>
              <a:off x="2349471" y="3705376"/>
              <a:ext cx="136139" cy="1252425"/>
            </a:xfrm>
            <a:custGeom>
              <a:avLst/>
              <a:gdLst>
                <a:gd name="T0" fmla="*/ 0 w 1904"/>
                <a:gd name="T1" fmla="*/ 64 h 18080"/>
                <a:gd name="T2" fmla="*/ 64 w 1904"/>
                <a:gd name="T3" fmla="*/ 0 h 18080"/>
                <a:gd name="T4" fmla="*/ 1840 w 1904"/>
                <a:gd name="T5" fmla="*/ 0 h 18080"/>
                <a:gd name="T6" fmla="*/ 1904 w 1904"/>
                <a:gd name="T7" fmla="*/ 64 h 18080"/>
                <a:gd name="T8" fmla="*/ 1904 w 1904"/>
                <a:gd name="T9" fmla="*/ 18016 h 18080"/>
                <a:gd name="T10" fmla="*/ 1840 w 1904"/>
                <a:gd name="T11" fmla="*/ 18080 h 18080"/>
                <a:gd name="T12" fmla="*/ 64 w 1904"/>
                <a:gd name="T13" fmla="*/ 18080 h 18080"/>
                <a:gd name="T14" fmla="*/ 0 w 1904"/>
                <a:gd name="T15" fmla="*/ 18016 h 18080"/>
                <a:gd name="T16" fmla="*/ 0 w 1904"/>
                <a:gd name="T17" fmla="*/ 64 h 18080"/>
                <a:gd name="T18" fmla="*/ 128 w 1904"/>
                <a:gd name="T19" fmla="*/ 18016 h 18080"/>
                <a:gd name="T20" fmla="*/ 64 w 1904"/>
                <a:gd name="T21" fmla="*/ 17952 h 18080"/>
                <a:gd name="T22" fmla="*/ 1840 w 1904"/>
                <a:gd name="T23" fmla="*/ 17952 h 18080"/>
                <a:gd name="T24" fmla="*/ 1776 w 1904"/>
                <a:gd name="T25" fmla="*/ 18016 h 18080"/>
                <a:gd name="T26" fmla="*/ 1776 w 1904"/>
                <a:gd name="T27" fmla="*/ 64 h 18080"/>
                <a:gd name="T28" fmla="*/ 1840 w 1904"/>
                <a:gd name="T29" fmla="*/ 128 h 18080"/>
                <a:gd name="T30" fmla="*/ 64 w 1904"/>
                <a:gd name="T31" fmla="*/ 128 h 18080"/>
                <a:gd name="T32" fmla="*/ 128 w 1904"/>
                <a:gd name="T33" fmla="*/ 64 h 18080"/>
                <a:gd name="T34" fmla="*/ 128 w 1904"/>
                <a:gd name="T35" fmla="*/ 18016 h 180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04" h="18080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40" y="0"/>
                  </a:lnTo>
                  <a:cubicBezTo>
                    <a:pt x="1876" y="0"/>
                    <a:pt x="1904" y="29"/>
                    <a:pt x="1904" y="64"/>
                  </a:cubicBezTo>
                  <a:lnTo>
                    <a:pt x="1904" y="18016"/>
                  </a:lnTo>
                  <a:cubicBezTo>
                    <a:pt x="1904" y="18052"/>
                    <a:pt x="1876" y="18080"/>
                    <a:pt x="1840" y="18080"/>
                  </a:cubicBezTo>
                  <a:lnTo>
                    <a:pt x="64" y="18080"/>
                  </a:lnTo>
                  <a:cubicBezTo>
                    <a:pt x="29" y="18080"/>
                    <a:pt x="0" y="18052"/>
                    <a:pt x="0" y="18016"/>
                  </a:cubicBezTo>
                  <a:lnTo>
                    <a:pt x="0" y="64"/>
                  </a:lnTo>
                  <a:close/>
                  <a:moveTo>
                    <a:pt x="128" y="18016"/>
                  </a:moveTo>
                  <a:lnTo>
                    <a:pt x="64" y="17952"/>
                  </a:lnTo>
                  <a:lnTo>
                    <a:pt x="1840" y="17952"/>
                  </a:lnTo>
                  <a:lnTo>
                    <a:pt x="1776" y="18016"/>
                  </a:lnTo>
                  <a:lnTo>
                    <a:pt x="1776" y="64"/>
                  </a:lnTo>
                  <a:lnTo>
                    <a:pt x="184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8016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192" name="Rectangle 10"/>
            <p:cNvSpPr>
              <a:spLocks noChangeArrowheads="1"/>
            </p:cNvSpPr>
            <p:nvPr/>
          </p:nvSpPr>
          <p:spPr bwMode="auto">
            <a:xfrm>
              <a:off x="2800879" y="4252518"/>
              <a:ext cx="127780" cy="70066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193" name="Freeform 11"/>
            <p:cNvSpPr>
              <a:spLocks noEditPoints="1"/>
            </p:cNvSpPr>
            <p:nvPr/>
          </p:nvSpPr>
          <p:spPr bwMode="auto">
            <a:xfrm>
              <a:off x="2796102" y="4249055"/>
              <a:ext cx="137333" cy="708745"/>
            </a:xfrm>
            <a:custGeom>
              <a:avLst/>
              <a:gdLst>
                <a:gd name="T0" fmla="*/ 0 w 1904"/>
                <a:gd name="T1" fmla="*/ 64 h 10240"/>
                <a:gd name="T2" fmla="*/ 64 w 1904"/>
                <a:gd name="T3" fmla="*/ 0 h 10240"/>
                <a:gd name="T4" fmla="*/ 1840 w 1904"/>
                <a:gd name="T5" fmla="*/ 0 h 10240"/>
                <a:gd name="T6" fmla="*/ 1904 w 1904"/>
                <a:gd name="T7" fmla="*/ 64 h 10240"/>
                <a:gd name="T8" fmla="*/ 1904 w 1904"/>
                <a:gd name="T9" fmla="*/ 10176 h 10240"/>
                <a:gd name="T10" fmla="*/ 1840 w 1904"/>
                <a:gd name="T11" fmla="*/ 10240 h 10240"/>
                <a:gd name="T12" fmla="*/ 64 w 1904"/>
                <a:gd name="T13" fmla="*/ 10240 h 10240"/>
                <a:gd name="T14" fmla="*/ 0 w 1904"/>
                <a:gd name="T15" fmla="*/ 10176 h 10240"/>
                <a:gd name="T16" fmla="*/ 0 w 1904"/>
                <a:gd name="T17" fmla="*/ 64 h 10240"/>
                <a:gd name="T18" fmla="*/ 128 w 1904"/>
                <a:gd name="T19" fmla="*/ 10176 h 10240"/>
                <a:gd name="T20" fmla="*/ 64 w 1904"/>
                <a:gd name="T21" fmla="*/ 10112 h 10240"/>
                <a:gd name="T22" fmla="*/ 1840 w 1904"/>
                <a:gd name="T23" fmla="*/ 10112 h 10240"/>
                <a:gd name="T24" fmla="*/ 1776 w 1904"/>
                <a:gd name="T25" fmla="*/ 10176 h 10240"/>
                <a:gd name="T26" fmla="*/ 1776 w 1904"/>
                <a:gd name="T27" fmla="*/ 64 h 10240"/>
                <a:gd name="T28" fmla="*/ 1840 w 1904"/>
                <a:gd name="T29" fmla="*/ 128 h 10240"/>
                <a:gd name="T30" fmla="*/ 64 w 1904"/>
                <a:gd name="T31" fmla="*/ 128 h 10240"/>
                <a:gd name="T32" fmla="*/ 128 w 1904"/>
                <a:gd name="T33" fmla="*/ 64 h 10240"/>
                <a:gd name="T34" fmla="*/ 128 w 1904"/>
                <a:gd name="T35" fmla="*/ 10176 h 10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04" h="10240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40" y="0"/>
                  </a:lnTo>
                  <a:cubicBezTo>
                    <a:pt x="1876" y="0"/>
                    <a:pt x="1904" y="29"/>
                    <a:pt x="1904" y="64"/>
                  </a:cubicBezTo>
                  <a:lnTo>
                    <a:pt x="1904" y="10176"/>
                  </a:lnTo>
                  <a:cubicBezTo>
                    <a:pt x="1904" y="10212"/>
                    <a:pt x="1876" y="10240"/>
                    <a:pt x="1840" y="10240"/>
                  </a:cubicBezTo>
                  <a:lnTo>
                    <a:pt x="64" y="10240"/>
                  </a:lnTo>
                  <a:cubicBezTo>
                    <a:pt x="29" y="10240"/>
                    <a:pt x="0" y="10212"/>
                    <a:pt x="0" y="10176"/>
                  </a:cubicBezTo>
                  <a:lnTo>
                    <a:pt x="0" y="64"/>
                  </a:lnTo>
                  <a:close/>
                  <a:moveTo>
                    <a:pt x="128" y="10176"/>
                  </a:moveTo>
                  <a:lnTo>
                    <a:pt x="64" y="10112"/>
                  </a:lnTo>
                  <a:lnTo>
                    <a:pt x="1840" y="10112"/>
                  </a:lnTo>
                  <a:lnTo>
                    <a:pt x="1776" y="10176"/>
                  </a:lnTo>
                  <a:lnTo>
                    <a:pt x="1776" y="64"/>
                  </a:lnTo>
                  <a:lnTo>
                    <a:pt x="184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0176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194" name="Rectangle 12"/>
            <p:cNvSpPr>
              <a:spLocks noChangeArrowheads="1"/>
            </p:cNvSpPr>
            <p:nvPr/>
          </p:nvSpPr>
          <p:spPr bwMode="auto">
            <a:xfrm>
              <a:off x="3248703" y="4479916"/>
              <a:ext cx="126585" cy="47326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04" name="Freeform 13"/>
            <p:cNvSpPr>
              <a:spLocks noEditPoints="1"/>
            </p:cNvSpPr>
            <p:nvPr/>
          </p:nvSpPr>
          <p:spPr bwMode="auto">
            <a:xfrm>
              <a:off x="3243927" y="4475299"/>
              <a:ext cx="136139" cy="482501"/>
            </a:xfrm>
            <a:custGeom>
              <a:avLst/>
              <a:gdLst>
                <a:gd name="T0" fmla="*/ 0 w 1904"/>
                <a:gd name="T1" fmla="*/ 64 h 6960"/>
                <a:gd name="T2" fmla="*/ 64 w 1904"/>
                <a:gd name="T3" fmla="*/ 0 h 6960"/>
                <a:gd name="T4" fmla="*/ 1840 w 1904"/>
                <a:gd name="T5" fmla="*/ 0 h 6960"/>
                <a:gd name="T6" fmla="*/ 1904 w 1904"/>
                <a:gd name="T7" fmla="*/ 64 h 6960"/>
                <a:gd name="T8" fmla="*/ 1904 w 1904"/>
                <a:gd name="T9" fmla="*/ 6896 h 6960"/>
                <a:gd name="T10" fmla="*/ 1840 w 1904"/>
                <a:gd name="T11" fmla="*/ 6960 h 6960"/>
                <a:gd name="T12" fmla="*/ 64 w 1904"/>
                <a:gd name="T13" fmla="*/ 6960 h 6960"/>
                <a:gd name="T14" fmla="*/ 0 w 1904"/>
                <a:gd name="T15" fmla="*/ 6896 h 6960"/>
                <a:gd name="T16" fmla="*/ 0 w 1904"/>
                <a:gd name="T17" fmla="*/ 64 h 6960"/>
                <a:gd name="T18" fmla="*/ 128 w 1904"/>
                <a:gd name="T19" fmla="*/ 6896 h 6960"/>
                <a:gd name="T20" fmla="*/ 64 w 1904"/>
                <a:gd name="T21" fmla="*/ 6832 h 6960"/>
                <a:gd name="T22" fmla="*/ 1840 w 1904"/>
                <a:gd name="T23" fmla="*/ 6832 h 6960"/>
                <a:gd name="T24" fmla="*/ 1776 w 1904"/>
                <a:gd name="T25" fmla="*/ 6896 h 6960"/>
                <a:gd name="T26" fmla="*/ 1776 w 1904"/>
                <a:gd name="T27" fmla="*/ 64 h 6960"/>
                <a:gd name="T28" fmla="*/ 1840 w 1904"/>
                <a:gd name="T29" fmla="*/ 128 h 6960"/>
                <a:gd name="T30" fmla="*/ 64 w 1904"/>
                <a:gd name="T31" fmla="*/ 128 h 6960"/>
                <a:gd name="T32" fmla="*/ 128 w 1904"/>
                <a:gd name="T33" fmla="*/ 64 h 6960"/>
                <a:gd name="T34" fmla="*/ 128 w 1904"/>
                <a:gd name="T35" fmla="*/ 6896 h 69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04" h="6960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40" y="0"/>
                  </a:lnTo>
                  <a:cubicBezTo>
                    <a:pt x="1876" y="0"/>
                    <a:pt x="1904" y="29"/>
                    <a:pt x="1904" y="64"/>
                  </a:cubicBezTo>
                  <a:lnTo>
                    <a:pt x="1904" y="6896"/>
                  </a:lnTo>
                  <a:cubicBezTo>
                    <a:pt x="1904" y="6932"/>
                    <a:pt x="1876" y="6960"/>
                    <a:pt x="1840" y="6960"/>
                  </a:cubicBezTo>
                  <a:lnTo>
                    <a:pt x="64" y="6960"/>
                  </a:lnTo>
                  <a:cubicBezTo>
                    <a:pt x="29" y="6960"/>
                    <a:pt x="0" y="6932"/>
                    <a:pt x="0" y="6896"/>
                  </a:cubicBezTo>
                  <a:lnTo>
                    <a:pt x="0" y="64"/>
                  </a:lnTo>
                  <a:close/>
                  <a:moveTo>
                    <a:pt x="128" y="6896"/>
                  </a:moveTo>
                  <a:lnTo>
                    <a:pt x="64" y="6832"/>
                  </a:lnTo>
                  <a:lnTo>
                    <a:pt x="1840" y="6832"/>
                  </a:lnTo>
                  <a:lnTo>
                    <a:pt x="1776" y="6896"/>
                  </a:lnTo>
                  <a:lnTo>
                    <a:pt x="1776" y="64"/>
                  </a:lnTo>
                  <a:lnTo>
                    <a:pt x="184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6896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05" name="Rectangle 14"/>
            <p:cNvSpPr>
              <a:spLocks noChangeArrowheads="1"/>
            </p:cNvSpPr>
            <p:nvPr/>
          </p:nvSpPr>
          <p:spPr bwMode="auto">
            <a:xfrm>
              <a:off x="3695334" y="4523780"/>
              <a:ext cx="127780" cy="42940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06" name="Freeform 15"/>
            <p:cNvSpPr>
              <a:spLocks noEditPoints="1"/>
            </p:cNvSpPr>
            <p:nvPr/>
          </p:nvSpPr>
          <p:spPr bwMode="auto">
            <a:xfrm>
              <a:off x="3690557" y="4519163"/>
              <a:ext cx="136139" cy="438637"/>
            </a:xfrm>
            <a:custGeom>
              <a:avLst/>
              <a:gdLst>
                <a:gd name="T0" fmla="*/ 0 w 1904"/>
                <a:gd name="T1" fmla="*/ 64 h 6336"/>
                <a:gd name="T2" fmla="*/ 64 w 1904"/>
                <a:gd name="T3" fmla="*/ 0 h 6336"/>
                <a:gd name="T4" fmla="*/ 1840 w 1904"/>
                <a:gd name="T5" fmla="*/ 0 h 6336"/>
                <a:gd name="T6" fmla="*/ 1904 w 1904"/>
                <a:gd name="T7" fmla="*/ 64 h 6336"/>
                <a:gd name="T8" fmla="*/ 1904 w 1904"/>
                <a:gd name="T9" fmla="*/ 6272 h 6336"/>
                <a:gd name="T10" fmla="*/ 1840 w 1904"/>
                <a:gd name="T11" fmla="*/ 6336 h 6336"/>
                <a:gd name="T12" fmla="*/ 64 w 1904"/>
                <a:gd name="T13" fmla="*/ 6336 h 6336"/>
                <a:gd name="T14" fmla="*/ 0 w 1904"/>
                <a:gd name="T15" fmla="*/ 6272 h 6336"/>
                <a:gd name="T16" fmla="*/ 0 w 1904"/>
                <a:gd name="T17" fmla="*/ 64 h 6336"/>
                <a:gd name="T18" fmla="*/ 128 w 1904"/>
                <a:gd name="T19" fmla="*/ 6272 h 6336"/>
                <a:gd name="T20" fmla="*/ 64 w 1904"/>
                <a:gd name="T21" fmla="*/ 6208 h 6336"/>
                <a:gd name="T22" fmla="*/ 1840 w 1904"/>
                <a:gd name="T23" fmla="*/ 6208 h 6336"/>
                <a:gd name="T24" fmla="*/ 1776 w 1904"/>
                <a:gd name="T25" fmla="*/ 6272 h 6336"/>
                <a:gd name="T26" fmla="*/ 1776 w 1904"/>
                <a:gd name="T27" fmla="*/ 64 h 6336"/>
                <a:gd name="T28" fmla="*/ 1840 w 1904"/>
                <a:gd name="T29" fmla="*/ 128 h 6336"/>
                <a:gd name="T30" fmla="*/ 64 w 1904"/>
                <a:gd name="T31" fmla="*/ 128 h 6336"/>
                <a:gd name="T32" fmla="*/ 128 w 1904"/>
                <a:gd name="T33" fmla="*/ 64 h 6336"/>
                <a:gd name="T34" fmla="*/ 128 w 1904"/>
                <a:gd name="T35" fmla="*/ 6272 h 6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04" h="6336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40" y="0"/>
                  </a:lnTo>
                  <a:cubicBezTo>
                    <a:pt x="1876" y="0"/>
                    <a:pt x="1904" y="29"/>
                    <a:pt x="1904" y="64"/>
                  </a:cubicBezTo>
                  <a:lnTo>
                    <a:pt x="1904" y="6272"/>
                  </a:lnTo>
                  <a:cubicBezTo>
                    <a:pt x="1904" y="6308"/>
                    <a:pt x="1876" y="6336"/>
                    <a:pt x="1840" y="6336"/>
                  </a:cubicBezTo>
                  <a:lnTo>
                    <a:pt x="64" y="6336"/>
                  </a:lnTo>
                  <a:cubicBezTo>
                    <a:pt x="29" y="6336"/>
                    <a:pt x="0" y="6308"/>
                    <a:pt x="0" y="6272"/>
                  </a:cubicBezTo>
                  <a:lnTo>
                    <a:pt x="0" y="64"/>
                  </a:lnTo>
                  <a:close/>
                  <a:moveTo>
                    <a:pt x="128" y="6272"/>
                  </a:moveTo>
                  <a:lnTo>
                    <a:pt x="64" y="6208"/>
                  </a:lnTo>
                  <a:lnTo>
                    <a:pt x="1840" y="6208"/>
                  </a:lnTo>
                  <a:lnTo>
                    <a:pt x="1776" y="6272"/>
                  </a:lnTo>
                  <a:lnTo>
                    <a:pt x="1776" y="64"/>
                  </a:lnTo>
                  <a:lnTo>
                    <a:pt x="184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627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07" name="Rectangle 16"/>
            <p:cNvSpPr>
              <a:spLocks noChangeArrowheads="1"/>
            </p:cNvSpPr>
            <p:nvPr/>
          </p:nvSpPr>
          <p:spPr bwMode="auto">
            <a:xfrm>
              <a:off x="4141965" y="4556101"/>
              <a:ext cx="127780" cy="39708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08" name="Freeform 17"/>
            <p:cNvSpPr>
              <a:spLocks noEditPoints="1"/>
            </p:cNvSpPr>
            <p:nvPr/>
          </p:nvSpPr>
          <p:spPr bwMode="auto">
            <a:xfrm>
              <a:off x="4138383" y="4552638"/>
              <a:ext cx="136139" cy="405163"/>
            </a:xfrm>
            <a:custGeom>
              <a:avLst/>
              <a:gdLst>
                <a:gd name="T0" fmla="*/ 0 w 1904"/>
                <a:gd name="T1" fmla="*/ 64 h 5856"/>
                <a:gd name="T2" fmla="*/ 64 w 1904"/>
                <a:gd name="T3" fmla="*/ 0 h 5856"/>
                <a:gd name="T4" fmla="*/ 1840 w 1904"/>
                <a:gd name="T5" fmla="*/ 0 h 5856"/>
                <a:gd name="T6" fmla="*/ 1904 w 1904"/>
                <a:gd name="T7" fmla="*/ 64 h 5856"/>
                <a:gd name="T8" fmla="*/ 1904 w 1904"/>
                <a:gd name="T9" fmla="*/ 5792 h 5856"/>
                <a:gd name="T10" fmla="*/ 1840 w 1904"/>
                <a:gd name="T11" fmla="*/ 5856 h 5856"/>
                <a:gd name="T12" fmla="*/ 64 w 1904"/>
                <a:gd name="T13" fmla="*/ 5856 h 5856"/>
                <a:gd name="T14" fmla="*/ 0 w 1904"/>
                <a:gd name="T15" fmla="*/ 5792 h 5856"/>
                <a:gd name="T16" fmla="*/ 0 w 1904"/>
                <a:gd name="T17" fmla="*/ 64 h 5856"/>
                <a:gd name="T18" fmla="*/ 128 w 1904"/>
                <a:gd name="T19" fmla="*/ 5792 h 5856"/>
                <a:gd name="T20" fmla="*/ 64 w 1904"/>
                <a:gd name="T21" fmla="*/ 5728 h 5856"/>
                <a:gd name="T22" fmla="*/ 1840 w 1904"/>
                <a:gd name="T23" fmla="*/ 5728 h 5856"/>
                <a:gd name="T24" fmla="*/ 1776 w 1904"/>
                <a:gd name="T25" fmla="*/ 5792 h 5856"/>
                <a:gd name="T26" fmla="*/ 1776 w 1904"/>
                <a:gd name="T27" fmla="*/ 64 h 5856"/>
                <a:gd name="T28" fmla="*/ 1840 w 1904"/>
                <a:gd name="T29" fmla="*/ 128 h 5856"/>
                <a:gd name="T30" fmla="*/ 64 w 1904"/>
                <a:gd name="T31" fmla="*/ 128 h 5856"/>
                <a:gd name="T32" fmla="*/ 128 w 1904"/>
                <a:gd name="T33" fmla="*/ 64 h 5856"/>
                <a:gd name="T34" fmla="*/ 128 w 1904"/>
                <a:gd name="T35" fmla="*/ 5792 h 58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04" h="5856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40" y="0"/>
                  </a:lnTo>
                  <a:cubicBezTo>
                    <a:pt x="1876" y="0"/>
                    <a:pt x="1904" y="29"/>
                    <a:pt x="1904" y="64"/>
                  </a:cubicBezTo>
                  <a:lnTo>
                    <a:pt x="1904" y="5792"/>
                  </a:lnTo>
                  <a:cubicBezTo>
                    <a:pt x="1904" y="5828"/>
                    <a:pt x="1876" y="5856"/>
                    <a:pt x="1840" y="5856"/>
                  </a:cubicBezTo>
                  <a:lnTo>
                    <a:pt x="64" y="5856"/>
                  </a:lnTo>
                  <a:cubicBezTo>
                    <a:pt x="29" y="5856"/>
                    <a:pt x="0" y="5828"/>
                    <a:pt x="0" y="5792"/>
                  </a:cubicBezTo>
                  <a:lnTo>
                    <a:pt x="0" y="64"/>
                  </a:lnTo>
                  <a:close/>
                  <a:moveTo>
                    <a:pt x="128" y="5792"/>
                  </a:moveTo>
                  <a:lnTo>
                    <a:pt x="64" y="5728"/>
                  </a:lnTo>
                  <a:lnTo>
                    <a:pt x="1840" y="5728"/>
                  </a:lnTo>
                  <a:lnTo>
                    <a:pt x="1776" y="5792"/>
                  </a:lnTo>
                  <a:lnTo>
                    <a:pt x="1776" y="64"/>
                  </a:lnTo>
                  <a:lnTo>
                    <a:pt x="184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579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09" name="Rectangle 18"/>
            <p:cNvSpPr>
              <a:spLocks noChangeArrowheads="1"/>
            </p:cNvSpPr>
            <p:nvPr/>
          </p:nvSpPr>
          <p:spPr bwMode="auto">
            <a:xfrm>
              <a:off x="4589791" y="4626514"/>
              <a:ext cx="126585" cy="32667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0" name="Freeform 19"/>
            <p:cNvSpPr>
              <a:spLocks noEditPoints="1"/>
            </p:cNvSpPr>
            <p:nvPr/>
          </p:nvSpPr>
          <p:spPr bwMode="auto">
            <a:xfrm>
              <a:off x="4585014" y="4621897"/>
              <a:ext cx="136139" cy="335904"/>
            </a:xfrm>
            <a:custGeom>
              <a:avLst/>
              <a:gdLst>
                <a:gd name="T0" fmla="*/ 0 w 952"/>
                <a:gd name="T1" fmla="*/ 32 h 2424"/>
                <a:gd name="T2" fmla="*/ 32 w 952"/>
                <a:gd name="T3" fmla="*/ 0 h 2424"/>
                <a:gd name="T4" fmla="*/ 920 w 952"/>
                <a:gd name="T5" fmla="*/ 0 h 2424"/>
                <a:gd name="T6" fmla="*/ 952 w 952"/>
                <a:gd name="T7" fmla="*/ 32 h 2424"/>
                <a:gd name="T8" fmla="*/ 952 w 952"/>
                <a:gd name="T9" fmla="*/ 2392 h 2424"/>
                <a:gd name="T10" fmla="*/ 920 w 952"/>
                <a:gd name="T11" fmla="*/ 2424 h 2424"/>
                <a:gd name="T12" fmla="*/ 32 w 952"/>
                <a:gd name="T13" fmla="*/ 2424 h 2424"/>
                <a:gd name="T14" fmla="*/ 0 w 952"/>
                <a:gd name="T15" fmla="*/ 2392 h 2424"/>
                <a:gd name="T16" fmla="*/ 0 w 952"/>
                <a:gd name="T17" fmla="*/ 32 h 2424"/>
                <a:gd name="T18" fmla="*/ 64 w 952"/>
                <a:gd name="T19" fmla="*/ 2392 h 2424"/>
                <a:gd name="T20" fmla="*/ 32 w 952"/>
                <a:gd name="T21" fmla="*/ 2360 h 2424"/>
                <a:gd name="T22" fmla="*/ 920 w 952"/>
                <a:gd name="T23" fmla="*/ 2360 h 2424"/>
                <a:gd name="T24" fmla="*/ 888 w 952"/>
                <a:gd name="T25" fmla="*/ 2392 h 2424"/>
                <a:gd name="T26" fmla="*/ 888 w 952"/>
                <a:gd name="T27" fmla="*/ 32 h 2424"/>
                <a:gd name="T28" fmla="*/ 920 w 952"/>
                <a:gd name="T29" fmla="*/ 64 h 2424"/>
                <a:gd name="T30" fmla="*/ 32 w 952"/>
                <a:gd name="T31" fmla="*/ 64 h 2424"/>
                <a:gd name="T32" fmla="*/ 64 w 952"/>
                <a:gd name="T33" fmla="*/ 32 h 2424"/>
                <a:gd name="T34" fmla="*/ 64 w 952"/>
                <a:gd name="T35" fmla="*/ 2392 h 24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52" h="2424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920" y="0"/>
                  </a:lnTo>
                  <a:cubicBezTo>
                    <a:pt x="938" y="0"/>
                    <a:pt x="952" y="15"/>
                    <a:pt x="952" y="32"/>
                  </a:cubicBezTo>
                  <a:lnTo>
                    <a:pt x="952" y="2392"/>
                  </a:lnTo>
                  <a:cubicBezTo>
                    <a:pt x="952" y="2410"/>
                    <a:pt x="938" y="2424"/>
                    <a:pt x="920" y="2424"/>
                  </a:cubicBezTo>
                  <a:lnTo>
                    <a:pt x="32" y="2424"/>
                  </a:lnTo>
                  <a:cubicBezTo>
                    <a:pt x="15" y="2424"/>
                    <a:pt x="0" y="2410"/>
                    <a:pt x="0" y="2392"/>
                  </a:cubicBezTo>
                  <a:lnTo>
                    <a:pt x="0" y="32"/>
                  </a:lnTo>
                  <a:close/>
                  <a:moveTo>
                    <a:pt x="64" y="2392"/>
                  </a:moveTo>
                  <a:lnTo>
                    <a:pt x="32" y="2360"/>
                  </a:lnTo>
                  <a:lnTo>
                    <a:pt x="920" y="2360"/>
                  </a:lnTo>
                  <a:lnTo>
                    <a:pt x="888" y="2392"/>
                  </a:lnTo>
                  <a:lnTo>
                    <a:pt x="888" y="32"/>
                  </a:lnTo>
                  <a:lnTo>
                    <a:pt x="920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239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1" name="Rectangle 20"/>
            <p:cNvSpPr>
              <a:spLocks noChangeArrowheads="1"/>
            </p:cNvSpPr>
            <p:nvPr/>
          </p:nvSpPr>
          <p:spPr bwMode="auto">
            <a:xfrm>
              <a:off x="2480833" y="3589945"/>
              <a:ext cx="127780" cy="1363239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2" name="Freeform 21"/>
            <p:cNvSpPr>
              <a:spLocks noEditPoints="1"/>
            </p:cNvSpPr>
            <p:nvPr/>
          </p:nvSpPr>
          <p:spPr bwMode="auto">
            <a:xfrm>
              <a:off x="2477250" y="3585328"/>
              <a:ext cx="136139" cy="1372473"/>
            </a:xfrm>
            <a:custGeom>
              <a:avLst/>
              <a:gdLst>
                <a:gd name="T0" fmla="*/ 0 w 1904"/>
                <a:gd name="T1" fmla="*/ 64 h 19824"/>
                <a:gd name="T2" fmla="*/ 64 w 1904"/>
                <a:gd name="T3" fmla="*/ 0 h 19824"/>
                <a:gd name="T4" fmla="*/ 1840 w 1904"/>
                <a:gd name="T5" fmla="*/ 0 h 19824"/>
                <a:gd name="T6" fmla="*/ 1904 w 1904"/>
                <a:gd name="T7" fmla="*/ 64 h 19824"/>
                <a:gd name="T8" fmla="*/ 1904 w 1904"/>
                <a:gd name="T9" fmla="*/ 19760 h 19824"/>
                <a:gd name="T10" fmla="*/ 1840 w 1904"/>
                <a:gd name="T11" fmla="*/ 19824 h 19824"/>
                <a:gd name="T12" fmla="*/ 64 w 1904"/>
                <a:gd name="T13" fmla="*/ 19824 h 19824"/>
                <a:gd name="T14" fmla="*/ 0 w 1904"/>
                <a:gd name="T15" fmla="*/ 19760 h 19824"/>
                <a:gd name="T16" fmla="*/ 0 w 1904"/>
                <a:gd name="T17" fmla="*/ 64 h 19824"/>
                <a:gd name="T18" fmla="*/ 128 w 1904"/>
                <a:gd name="T19" fmla="*/ 19760 h 19824"/>
                <a:gd name="T20" fmla="*/ 64 w 1904"/>
                <a:gd name="T21" fmla="*/ 19696 h 19824"/>
                <a:gd name="T22" fmla="*/ 1840 w 1904"/>
                <a:gd name="T23" fmla="*/ 19696 h 19824"/>
                <a:gd name="T24" fmla="*/ 1776 w 1904"/>
                <a:gd name="T25" fmla="*/ 19760 h 19824"/>
                <a:gd name="T26" fmla="*/ 1776 w 1904"/>
                <a:gd name="T27" fmla="*/ 64 h 19824"/>
                <a:gd name="T28" fmla="*/ 1840 w 1904"/>
                <a:gd name="T29" fmla="*/ 128 h 19824"/>
                <a:gd name="T30" fmla="*/ 64 w 1904"/>
                <a:gd name="T31" fmla="*/ 128 h 19824"/>
                <a:gd name="T32" fmla="*/ 128 w 1904"/>
                <a:gd name="T33" fmla="*/ 64 h 19824"/>
                <a:gd name="T34" fmla="*/ 128 w 1904"/>
                <a:gd name="T35" fmla="*/ 19760 h 198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04" h="19824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40" y="0"/>
                  </a:lnTo>
                  <a:cubicBezTo>
                    <a:pt x="1876" y="0"/>
                    <a:pt x="1904" y="29"/>
                    <a:pt x="1904" y="64"/>
                  </a:cubicBezTo>
                  <a:lnTo>
                    <a:pt x="1904" y="19760"/>
                  </a:lnTo>
                  <a:cubicBezTo>
                    <a:pt x="1904" y="19796"/>
                    <a:pt x="1876" y="19824"/>
                    <a:pt x="1840" y="19824"/>
                  </a:cubicBezTo>
                  <a:lnTo>
                    <a:pt x="64" y="19824"/>
                  </a:lnTo>
                  <a:cubicBezTo>
                    <a:pt x="29" y="19824"/>
                    <a:pt x="0" y="19796"/>
                    <a:pt x="0" y="19760"/>
                  </a:cubicBezTo>
                  <a:lnTo>
                    <a:pt x="0" y="64"/>
                  </a:lnTo>
                  <a:close/>
                  <a:moveTo>
                    <a:pt x="128" y="19760"/>
                  </a:moveTo>
                  <a:lnTo>
                    <a:pt x="64" y="19696"/>
                  </a:lnTo>
                  <a:lnTo>
                    <a:pt x="1840" y="19696"/>
                  </a:lnTo>
                  <a:lnTo>
                    <a:pt x="1776" y="19760"/>
                  </a:lnTo>
                  <a:lnTo>
                    <a:pt x="1776" y="64"/>
                  </a:lnTo>
                  <a:lnTo>
                    <a:pt x="184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976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3" name="Rectangle 22"/>
            <p:cNvSpPr>
              <a:spLocks noChangeArrowheads="1"/>
            </p:cNvSpPr>
            <p:nvPr/>
          </p:nvSpPr>
          <p:spPr bwMode="auto">
            <a:xfrm>
              <a:off x="2928658" y="4043588"/>
              <a:ext cx="126585" cy="909595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4" name="Freeform 23"/>
            <p:cNvSpPr>
              <a:spLocks noEditPoints="1"/>
            </p:cNvSpPr>
            <p:nvPr/>
          </p:nvSpPr>
          <p:spPr bwMode="auto">
            <a:xfrm>
              <a:off x="2923881" y="4038971"/>
              <a:ext cx="136139" cy="918830"/>
            </a:xfrm>
            <a:custGeom>
              <a:avLst/>
              <a:gdLst>
                <a:gd name="T0" fmla="*/ 0 w 1904"/>
                <a:gd name="T1" fmla="*/ 64 h 13264"/>
                <a:gd name="T2" fmla="*/ 64 w 1904"/>
                <a:gd name="T3" fmla="*/ 0 h 13264"/>
                <a:gd name="T4" fmla="*/ 1840 w 1904"/>
                <a:gd name="T5" fmla="*/ 0 h 13264"/>
                <a:gd name="T6" fmla="*/ 1904 w 1904"/>
                <a:gd name="T7" fmla="*/ 64 h 13264"/>
                <a:gd name="T8" fmla="*/ 1904 w 1904"/>
                <a:gd name="T9" fmla="*/ 13200 h 13264"/>
                <a:gd name="T10" fmla="*/ 1840 w 1904"/>
                <a:gd name="T11" fmla="*/ 13264 h 13264"/>
                <a:gd name="T12" fmla="*/ 64 w 1904"/>
                <a:gd name="T13" fmla="*/ 13264 h 13264"/>
                <a:gd name="T14" fmla="*/ 0 w 1904"/>
                <a:gd name="T15" fmla="*/ 13200 h 13264"/>
                <a:gd name="T16" fmla="*/ 0 w 1904"/>
                <a:gd name="T17" fmla="*/ 64 h 13264"/>
                <a:gd name="T18" fmla="*/ 128 w 1904"/>
                <a:gd name="T19" fmla="*/ 13200 h 13264"/>
                <a:gd name="T20" fmla="*/ 64 w 1904"/>
                <a:gd name="T21" fmla="*/ 13136 h 13264"/>
                <a:gd name="T22" fmla="*/ 1840 w 1904"/>
                <a:gd name="T23" fmla="*/ 13136 h 13264"/>
                <a:gd name="T24" fmla="*/ 1776 w 1904"/>
                <a:gd name="T25" fmla="*/ 13200 h 13264"/>
                <a:gd name="T26" fmla="*/ 1776 w 1904"/>
                <a:gd name="T27" fmla="*/ 64 h 13264"/>
                <a:gd name="T28" fmla="*/ 1840 w 1904"/>
                <a:gd name="T29" fmla="*/ 128 h 13264"/>
                <a:gd name="T30" fmla="*/ 64 w 1904"/>
                <a:gd name="T31" fmla="*/ 128 h 13264"/>
                <a:gd name="T32" fmla="*/ 128 w 1904"/>
                <a:gd name="T33" fmla="*/ 64 h 13264"/>
                <a:gd name="T34" fmla="*/ 128 w 1904"/>
                <a:gd name="T35" fmla="*/ 13200 h 132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04" h="13264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40" y="0"/>
                  </a:lnTo>
                  <a:cubicBezTo>
                    <a:pt x="1876" y="0"/>
                    <a:pt x="1904" y="29"/>
                    <a:pt x="1904" y="64"/>
                  </a:cubicBezTo>
                  <a:lnTo>
                    <a:pt x="1904" y="13200"/>
                  </a:lnTo>
                  <a:cubicBezTo>
                    <a:pt x="1904" y="13236"/>
                    <a:pt x="1876" y="13264"/>
                    <a:pt x="1840" y="13264"/>
                  </a:cubicBezTo>
                  <a:lnTo>
                    <a:pt x="64" y="13264"/>
                  </a:lnTo>
                  <a:cubicBezTo>
                    <a:pt x="29" y="13264"/>
                    <a:pt x="0" y="13236"/>
                    <a:pt x="0" y="13200"/>
                  </a:cubicBezTo>
                  <a:lnTo>
                    <a:pt x="0" y="64"/>
                  </a:lnTo>
                  <a:close/>
                  <a:moveTo>
                    <a:pt x="128" y="13200"/>
                  </a:moveTo>
                  <a:lnTo>
                    <a:pt x="64" y="13136"/>
                  </a:lnTo>
                  <a:lnTo>
                    <a:pt x="1840" y="13136"/>
                  </a:lnTo>
                  <a:lnTo>
                    <a:pt x="1776" y="13200"/>
                  </a:lnTo>
                  <a:lnTo>
                    <a:pt x="1776" y="64"/>
                  </a:lnTo>
                  <a:lnTo>
                    <a:pt x="184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320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5" name="Rectangle 24"/>
            <p:cNvSpPr>
              <a:spLocks noChangeArrowheads="1"/>
            </p:cNvSpPr>
            <p:nvPr/>
          </p:nvSpPr>
          <p:spPr bwMode="auto">
            <a:xfrm>
              <a:off x="3375289" y="4157865"/>
              <a:ext cx="128974" cy="795319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6" name="Freeform 25"/>
            <p:cNvSpPr>
              <a:spLocks noEditPoints="1"/>
            </p:cNvSpPr>
            <p:nvPr/>
          </p:nvSpPr>
          <p:spPr bwMode="auto">
            <a:xfrm>
              <a:off x="3370512" y="4153247"/>
              <a:ext cx="138527" cy="804553"/>
            </a:xfrm>
            <a:custGeom>
              <a:avLst/>
              <a:gdLst>
                <a:gd name="T0" fmla="*/ 0 w 1920"/>
                <a:gd name="T1" fmla="*/ 64 h 11616"/>
                <a:gd name="T2" fmla="*/ 64 w 1920"/>
                <a:gd name="T3" fmla="*/ 0 h 11616"/>
                <a:gd name="T4" fmla="*/ 1856 w 1920"/>
                <a:gd name="T5" fmla="*/ 0 h 11616"/>
                <a:gd name="T6" fmla="*/ 1920 w 1920"/>
                <a:gd name="T7" fmla="*/ 64 h 11616"/>
                <a:gd name="T8" fmla="*/ 1920 w 1920"/>
                <a:gd name="T9" fmla="*/ 11552 h 11616"/>
                <a:gd name="T10" fmla="*/ 1856 w 1920"/>
                <a:gd name="T11" fmla="*/ 11616 h 11616"/>
                <a:gd name="T12" fmla="*/ 64 w 1920"/>
                <a:gd name="T13" fmla="*/ 11616 h 11616"/>
                <a:gd name="T14" fmla="*/ 0 w 1920"/>
                <a:gd name="T15" fmla="*/ 11552 h 11616"/>
                <a:gd name="T16" fmla="*/ 0 w 1920"/>
                <a:gd name="T17" fmla="*/ 64 h 11616"/>
                <a:gd name="T18" fmla="*/ 128 w 1920"/>
                <a:gd name="T19" fmla="*/ 11552 h 11616"/>
                <a:gd name="T20" fmla="*/ 64 w 1920"/>
                <a:gd name="T21" fmla="*/ 11488 h 11616"/>
                <a:gd name="T22" fmla="*/ 1856 w 1920"/>
                <a:gd name="T23" fmla="*/ 11488 h 11616"/>
                <a:gd name="T24" fmla="*/ 1792 w 1920"/>
                <a:gd name="T25" fmla="*/ 11552 h 11616"/>
                <a:gd name="T26" fmla="*/ 1792 w 1920"/>
                <a:gd name="T27" fmla="*/ 64 h 11616"/>
                <a:gd name="T28" fmla="*/ 1856 w 1920"/>
                <a:gd name="T29" fmla="*/ 128 h 11616"/>
                <a:gd name="T30" fmla="*/ 64 w 1920"/>
                <a:gd name="T31" fmla="*/ 128 h 11616"/>
                <a:gd name="T32" fmla="*/ 128 w 1920"/>
                <a:gd name="T33" fmla="*/ 64 h 11616"/>
                <a:gd name="T34" fmla="*/ 128 w 1920"/>
                <a:gd name="T35" fmla="*/ 11552 h 116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20" h="11616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56" y="0"/>
                  </a:lnTo>
                  <a:cubicBezTo>
                    <a:pt x="1892" y="0"/>
                    <a:pt x="1920" y="29"/>
                    <a:pt x="1920" y="64"/>
                  </a:cubicBezTo>
                  <a:lnTo>
                    <a:pt x="1920" y="11552"/>
                  </a:lnTo>
                  <a:cubicBezTo>
                    <a:pt x="1920" y="11588"/>
                    <a:pt x="1892" y="11616"/>
                    <a:pt x="1856" y="11616"/>
                  </a:cubicBezTo>
                  <a:lnTo>
                    <a:pt x="64" y="11616"/>
                  </a:lnTo>
                  <a:cubicBezTo>
                    <a:pt x="29" y="11616"/>
                    <a:pt x="0" y="11588"/>
                    <a:pt x="0" y="11552"/>
                  </a:cubicBezTo>
                  <a:lnTo>
                    <a:pt x="0" y="64"/>
                  </a:lnTo>
                  <a:close/>
                  <a:moveTo>
                    <a:pt x="128" y="11552"/>
                  </a:moveTo>
                  <a:lnTo>
                    <a:pt x="64" y="11488"/>
                  </a:lnTo>
                  <a:lnTo>
                    <a:pt x="1856" y="11488"/>
                  </a:lnTo>
                  <a:lnTo>
                    <a:pt x="1792" y="11552"/>
                  </a:lnTo>
                  <a:lnTo>
                    <a:pt x="1792" y="64"/>
                  </a:lnTo>
                  <a:lnTo>
                    <a:pt x="1856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155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7" name="Rectangle 26"/>
            <p:cNvSpPr>
              <a:spLocks noChangeArrowheads="1"/>
            </p:cNvSpPr>
            <p:nvPr/>
          </p:nvSpPr>
          <p:spPr bwMode="auto">
            <a:xfrm>
              <a:off x="3823114" y="4282530"/>
              <a:ext cx="127780" cy="670654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8" name="Freeform 27"/>
            <p:cNvSpPr>
              <a:spLocks noEditPoints="1"/>
            </p:cNvSpPr>
            <p:nvPr/>
          </p:nvSpPr>
          <p:spPr bwMode="auto">
            <a:xfrm>
              <a:off x="3818337" y="4279067"/>
              <a:ext cx="137333" cy="678733"/>
            </a:xfrm>
            <a:custGeom>
              <a:avLst/>
              <a:gdLst>
                <a:gd name="T0" fmla="*/ 0 w 1920"/>
                <a:gd name="T1" fmla="*/ 64 h 9808"/>
                <a:gd name="T2" fmla="*/ 64 w 1920"/>
                <a:gd name="T3" fmla="*/ 0 h 9808"/>
                <a:gd name="T4" fmla="*/ 1856 w 1920"/>
                <a:gd name="T5" fmla="*/ 0 h 9808"/>
                <a:gd name="T6" fmla="*/ 1920 w 1920"/>
                <a:gd name="T7" fmla="*/ 64 h 9808"/>
                <a:gd name="T8" fmla="*/ 1920 w 1920"/>
                <a:gd name="T9" fmla="*/ 9744 h 9808"/>
                <a:gd name="T10" fmla="*/ 1856 w 1920"/>
                <a:gd name="T11" fmla="*/ 9808 h 9808"/>
                <a:gd name="T12" fmla="*/ 64 w 1920"/>
                <a:gd name="T13" fmla="*/ 9808 h 9808"/>
                <a:gd name="T14" fmla="*/ 0 w 1920"/>
                <a:gd name="T15" fmla="*/ 9744 h 9808"/>
                <a:gd name="T16" fmla="*/ 0 w 1920"/>
                <a:gd name="T17" fmla="*/ 64 h 9808"/>
                <a:gd name="T18" fmla="*/ 128 w 1920"/>
                <a:gd name="T19" fmla="*/ 9744 h 9808"/>
                <a:gd name="T20" fmla="*/ 64 w 1920"/>
                <a:gd name="T21" fmla="*/ 9680 h 9808"/>
                <a:gd name="T22" fmla="*/ 1856 w 1920"/>
                <a:gd name="T23" fmla="*/ 9680 h 9808"/>
                <a:gd name="T24" fmla="*/ 1792 w 1920"/>
                <a:gd name="T25" fmla="*/ 9744 h 9808"/>
                <a:gd name="T26" fmla="*/ 1792 w 1920"/>
                <a:gd name="T27" fmla="*/ 64 h 9808"/>
                <a:gd name="T28" fmla="*/ 1856 w 1920"/>
                <a:gd name="T29" fmla="*/ 128 h 9808"/>
                <a:gd name="T30" fmla="*/ 64 w 1920"/>
                <a:gd name="T31" fmla="*/ 128 h 9808"/>
                <a:gd name="T32" fmla="*/ 128 w 1920"/>
                <a:gd name="T33" fmla="*/ 64 h 9808"/>
                <a:gd name="T34" fmla="*/ 128 w 1920"/>
                <a:gd name="T35" fmla="*/ 9744 h 98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920" h="9808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1856" y="0"/>
                  </a:lnTo>
                  <a:cubicBezTo>
                    <a:pt x="1892" y="0"/>
                    <a:pt x="1920" y="29"/>
                    <a:pt x="1920" y="64"/>
                  </a:cubicBezTo>
                  <a:lnTo>
                    <a:pt x="1920" y="9744"/>
                  </a:lnTo>
                  <a:cubicBezTo>
                    <a:pt x="1920" y="9780"/>
                    <a:pt x="1892" y="9808"/>
                    <a:pt x="1856" y="9808"/>
                  </a:cubicBezTo>
                  <a:lnTo>
                    <a:pt x="64" y="9808"/>
                  </a:lnTo>
                  <a:cubicBezTo>
                    <a:pt x="29" y="9808"/>
                    <a:pt x="0" y="9780"/>
                    <a:pt x="0" y="9744"/>
                  </a:cubicBezTo>
                  <a:lnTo>
                    <a:pt x="0" y="64"/>
                  </a:lnTo>
                  <a:close/>
                  <a:moveTo>
                    <a:pt x="128" y="9744"/>
                  </a:moveTo>
                  <a:lnTo>
                    <a:pt x="64" y="9680"/>
                  </a:lnTo>
                  <a:lnTo>
                    <a:pt x="1856" y="9680"/>
                  </a:lnTo>
                  <a:lnTo>
                    <a:pt x="1792" y="9744"/>
                  </a:lnTo>
                  <a:lnTo>
                    <a:pt x="1792" y="64"/>
                  </a:lnTo>
                  <a:lnTo>
                    <a:pt x="1856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9744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19" name="Rectangle 28"/>
            <p:cNvSpPr>
              <a:spLocks noChangeArrowheads="1"/>
            </p:cNvSpPr>
            <p:nvPr/>
          </p:nvSpPr>
          <p:spPr bwMode="auto">
            <a:xfrm>
              <a:off x="4269745" y="4235203"/>
              <a:ext cx="127780" cy="717980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0" name="Freeform 29"/>
            <p:cNvSpPr>
              <a:spLocks noEditPoints="1"/>
            </p:cNvSpPr>
            <p:nvPr/>
          </p:nvSpPr>
          <p:spPr bwMode="auto">
            <a:xfrm>
              <a:off x="4264968" y="4230586"/>
              <a:ext cx="137333" cy="727214"/>
            </a:xfrm>
            <a:custGeom>
              <a:avLst/>
              <a:gdLst>
                <a:gd name="T0" fmla="*/ 0 w 960"/>
                <a:gd name="T1" fmla="*/ 32 h 5248"/>
                <a:gd name="T2" fmla="*/ 32 w 960"/>
                <a:gd name="T3" fmla="*/ 0 h 5248"/>
                <a:gd name="T4" fmla="*/ 928 w 960"/>
                <a:gd name="T5" fmla="*/ 0 h 5248"/>
                <a:gd name="T6" fmla="*/ 960 w 960"/>
                <a:gd name="T7" fmla="*/ 32 h 5248"/>
                <a:gd name="T8" fmla="*/ 960 w 960"/>
                <a:gd name="T9" fmla="*/ 5216 h 5248"/>
                <a:gd name="T10" fmla="*/ 928 w 960"/>
                <a:gd name="T11" fmla="*/ 5248 h 5248"/>
                <a:gd name="T12" fmla="*/ 32 w 960"/>
                <a:gd name="T13" fmla="*/ 5248 h 5248"/>
                <a:gd name="T14" fmla="*/ 0 w 960"/>
                <a:gd name="T15" fmla="*/ 5216 h 5248"/>
                <a:gd name="T16" fmla="*/ 0 w 960"/>
                <a:gd name="T17" fmla="*/ 32 h 5248"/>
                <a:gd name="T18" fmla="*/ 64 w 960"/>
                <a:gd name="T19" fmla="*/ 5216 h 5248"/>
                <a:gd name="T20" fmla="*/ 32 w 960"/>
                <a:gd name="T21" fmla="*/ 5184 h 5248"/>
                <a:gd name="T22" fmla="*/ 928 w 960"/>
                <a:gd name="T23" fmla="*/ 5184 h 5248"/>
                <a:gd name="T24" fmla="*/ 896 w 960"/>
                <a:gd name="T25" fmla="*/ 5216 h 5248"/>
                <a:gd name="T26" fmla="*/ 896 w 960"/>
                <a:gd name="T27" fmla="*/ 32 h 5248"/>
                <a:gd name="T28" fmla="*/ 928 w 960"/>
                <a:gd name="T29" fmla="*/ 64 h 5248"/>
                <a:gd name="T30" fmla="*/ 32 w 960"/>
                <a:gd name="T31" fmla="*/ 64 h 5248"/>
                <a:gd name="T32" fmla="*/ 64 w 960"/>
                <a:gd name="T33" fmla="*/ 32 h 5248"/>
                <a:gd name="T34" fmla="*/ 64 w 960"/>
                <a:gd name="T35" fmla="*/ 5216 h 52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60" h="5248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928" y="0"/>
                  </a:lnTo>
                  <a:cubicBezTo>
                    <a:pt x="946" y="0"/>
                    <a:pt x="960" y="15"/>
                    <a:pt x="960" y="32"/>
                  </a:cubicBezTo>
                  <a:lnTo>
                    <a:pt x="960" y="5216"/>
                  </a:lnTo>
                  <a:cubicBezTo>
                    <a:pt x="960" y="5234"/>
                    <a:pt x="946" y="5248"/>
                    <a:pt x="928" y="5248"/>
                  </a:cubicBezTo>
                  <a:lnTo>
                    <a:pt x="32" y="5248"/>
                  </a:lnTo>
                  <a:cubicBezTo>
                    <a:pt x="15" y="5248"/>
                    <a:pt x="0" y="5234"/>
                    <a:pt x="0" y="5216"/>
                  </a:cubicBezTo>
                  <a:lnTo>
                    <a:pt x="0" y="32"/>
                  </a:lnTo>
                  <a:close/>
                  <a:moveTo>
                    <a:pt x="64" y="5216"/>
                  </a:moveTo>
                  <a:lnTo>
                    <a:pt x="32" y="5184"/>
                  </a:lnTo>
                  <a:lnTo>
                    <a:pt x="928" y="5184"/>
                  </a:lnTo>
                  <a:lnTo>
                    <a:pt x="896" y="5216"/>
                  </a:lnTo>
                  <a:lnTo>
                    <a:pt x="896" y="32"/>
                  </a:lnTo>
                  <a:lnTo>
                    <a:pt x="928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5216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1" name="Rectangle 30"/>
            <p:cNvSpPr>
              <a:spLocks noChangeArrowheads="1"/>
            </p:cNvSpPr>
            <p:nvPr/>
          </p:nvSpPr>
          <p:spPr bwMode="auto">
            <a:xfrm>
              <a:off x="4716376" y="4350634"/>
              <a:ext cx="128974" cy="602549"/>
            </a:xfrm>
            <a:prstGeom prst="rect">
              <a:avLst/>
            </a:prstGeom>
            <a:solidFill>
              <a:srgbClr val="BFBFB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2" name="Freeform 31"/>
            <p:cNvSpPr>
              <a:spLocks noEditPoints="1"/>
            </p:cNvSpPr>
            <p:nvPr/>
          </p:nvSpPr>
          <p:spPr bwMode="auto">
            <a:xfrm>
              <a:off x="4712793" y="4346017"/>
              <a:ext cx="137333" cy="611784"/>
            </a:xfrm>
            <a:custGeom>
              <a:avLst/>
              <a:gdLst>
                <a:gd name="T0" fmla="*/ 0 w 960"/>
                <a:gd name="T1" fmla="*/ 32 h 4416"/>
                <a:gd name="T2" fmla="*/ 32 w 960"/>
                <a:gd name="T3" fmla="*/ 0 h 4416"/>
                <a:gd name="T4" fmla="*/ 928 w 960"/>
                <a:gd name="T5" fmla="*/ 0 h 4416"/>
                <a:gd name="T6" fmla="*/ 960 w 960"/>
                <a:gd name="T7" fmla="*/ 32 h 4416"/>
                <a:gd name="T8" fmla="*/ 960 w 960"/>
                <a:gd name="T9" fmla="*/ 4384 h 4416"/>
                <a:gd name="T10" fmla="*/ 928 w 960"/>
                <a:gd name="T11" fmla="*/ 4416 h 4416"/>
                <a:gd name="T12" fmla="*/ 32 w 960"/>
                <a:gd name="T13" fmla="*/ 4416 h 4416"/>
                <a:gd name="T14" fmla="*/ 0 w 960"/>
                <a:gd name="T15" fmla="*/ 4384 h 4416"/>
                <a:gd name="T16" fmla="*/ 0 w 960"/>
                <a:gd name="T17" fmla="*/ 32 h 4416"/>
                <a:gd name="T18" fmla="*/ 64 w 960"/>
                <a:gd name="T19" fmla="*/ 4384 h 4416"/>
                <a:gd name="T20" fmla="*/ 32 w 960"/>
                <a:gd name="T21" fmla="*/ 4352 h 4416"/>
                <a:gd name="T22" fmla="*/ 928 w 960"/>
                <a:gd name="T23" fmla="*/ 4352 h 4416"/>
                <a:gd name="T24" fmla="*/ 896 w 960"/>
                <a:gd name="T25" fmla="*/ 4384 h 4416"/>
                <a:gd name="T26" fmla="*/ 896 w 960"/>
                <a:gd name="T27" fmla="*/ 32 h 4416"/>
                <a:gd name="T28" fmla="*/ 928 w 960"/>
                <a:gd name="T29" fmla="*/ 64 h 4416"/>
                <a:gd name="T30" fmla="*/ 32 w 960"/>
                <a:gd name="T31" fmla="*/ 64 h 4416"/>
                <a:gd name="T32" fmla="*/ 64 w 960"/>
                <a:gd name="T33" fmla="*/ 32 h 4416"/>
                <a:gd name="T34" fmla="*/ 64 w 960"/>
                <a:gd name="T35" fmla="*/ 4384 h 4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960" h="4416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928" y="0"/>
                  </a:lnTo>
                  <a:cubicBezTo>
                    <a:pt x="946" y="0"/>
                    <a:pt x="960" y="15"/>
                    <a:pt x="960" y="32"/>
                  </a:cubicBezTo>
                  <a:lnTo>
                    <a:pt x="960" y="4384"/>
                  </a:lnTo>
                  <a:cubicBezTo>
                    <a:pt x="960" y="4402"/>
                    <a:pt x="946" y="4416"/>
                    <a:pt x="928" y="4416"/>
                  </a:cubicBezTo>
                  <a:lnTo>
                    <a:pt x="32" y="4416"/>
                  </a:lnTo>
                  <a:cubicBezTo>
                    <a:pt x="15" y="4416"/>
                    <a:pt x="0" y="4402"/>
                    <a:pt x="0" y="4384"/>
                  </a:cubicBezTo>
                  <a:lnTo>
                    <a:pt x="0" y="32"/>
                  </a:lnTo>
                  <a:close/>
                  <a:moveTo>
                    <a:pt x="64" y="4384"/>
                  </a:moveTo>
                  <a:lnTo>
                    <a:pt x="32" y="4352"/>
                  </a:lnTo>
                  <a:lnTo>
                    <a:pt x="928" y="4352"/>
                  </a:lnTo>
                  <a:lnTo>
                    <a:pt x="896" y="4384"/>
                  </a:lnTo>
                  <a:lnTo>
                    <a:pt x="896" y="32"/>
                  </a:lnTo>
                  <a:lnTo>
                    <a:pt x="928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4384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3" name="Freeform 32"/>
            <p:cNvSpPr>
              <a:spLocks noEditPoints="1"/>
            </p:cNvSpPr>
            <p:nvPr/>
          </p:nvSpPr>
          <p:spPr bwMode="auto">
            <a:xfrm>
              <a:off x="2394851" y="3593407"/>
              <a:ext cx="44186" cy="234325"/>
            </a:xfrm>
            <a:custGeom>
              <a:avLst/>
              <a:gdLst>
                <a:gd name="T0" fmla="*/ 18 w 37"/>
                <a:gd name="T1" fmla="*/ 202 h 203"/>
                <a:gd name="T2" fmla="*/ 18 w 37"/>
                <a:gd name="T3" fmla="*/ 101 h 203"/>
                <a:gd name="T4" fmla="*/ 18 w 37"/>
                <a:gd name="T5" fmla="*/ 1 h 203"/>
                <a:gd name="T6" fmla="*/ 20 w 37"/>
                <a:gd name="T7" fmla="*/ 1 h 203"/>
                <a:gd name="T8" fmla="*/ 20 w 37"/>
                <a:gd name="T9" fmla="*/ 101 h 203"/>
                <a:gd name="T10" fmla="*/ 20 w 37"/>
                <a:gd name="T11" fmla="*/ 202 h 203"/>
                <a:gd name="T12" fmla="*/ 18 w 37"/>
                <a:gd name="T13" fmla="*/ 202 h 203"/>
                <a:gd name="T14" fmla="*/ 0 w 37"/>
                <a:gd name="T15" fmla="*/ 201 h 203"/>
                <a:gd name="T16" fmla="*/ 37 w 37"/>
                <a:gd name="T17" fmla="*/ 201 h 203"/>
                <a:gd name="T18" fmla="*/ 37 w 37"/>
                <a:gd name="T19" fmla="*/ 203 h 203"/>
                <a:gd name="T20" fmla="*/ 0 w 37"/>
                <a:gd name="T21" fmla="*/ 203 h 203"/>
                <a:gd name="T22" fmla="*/ 0 w 37"/>
                <a:gd name="T23" fmla="*/ 201 h 203"/>
                <a:gd name="T24" fmla="*/ 0 w 37"/>
                <a:gd name="T25" fmla="*/ 0 h 203"/>
                <a:gd name="T26" fmla="*/ 37 w 37"/>
                <a:gd name="T27" fmla="*/ 0 h 203"/>
                <a:gd name="T28" fmla="*/ 37 w 37"/>
                <a:gd name="T29" fmla="*/ 2 h 203"/>
                <a:gd name="T30" fmla="*/ 0 w 37"/>
                <a:gd name="T31" fmla="*/ 2 h 203"/>
                <a:gd name="T32" fmla="*/ 0 w 37"/>
                <a:gd name="T33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" h="203">
                  <a:moveTo>
                    <a:pt x="18" y="202"/>
                  </a:moveTo>
                  <a:lnTo>
                    <a:pt x="18" y="101"/>
                  </a:lnTo>
                  <a:lnTo>
                    <a:pt x="18" y="1"/>
                  </a:lnTo>
                  <a:lnTo>
                    <a:pt x="20" y="1"/>
                  </a:lnTo>
                  <a:lnTo>
                    <a:pt x="20" y="101"/>
                  </a:lnTo>
                  <a:lnTo>
                    <a:pt x="20" y="202"/>
                  </a:lnTo>
                  <a:lnTo>
                    <a:pt x="18" y="202"/>
                  </a:lnTo>
                  <a:close/>
                  <a:moveTo>
                    <a:pt x="0" y="201"/>
                  </a:moveTo>
                  <a:lnTo>
                    <a:pt x="37" y="201"/>
                  </a:lnTo>
                  <a:lnTo>
                    <a:pt x="37" y="203"/>
                  </a:lnTo>
                  <a:lnTo>
                    <a:pt x="0" y="203"/>
                  </a:lnTo>
                  <a:lnTo>
                    <a:pt x="0" y="201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4" name="Freeform 33"/>
            <p:cNvSpPr>
              <a:spLocks noEditPoints="1"/>
            </p:cNvSpPr>
            <p:nvPr/>
          </p:nvSpPr>
          <p:spPr bwMode="auto">
            <a:xfrm>
              <a:off x="2843870" y="4189031"/>
              <a:ext cx="41797" cy="126974"/>
            </a:xfrm>
            <a:custGeom>
              <a:avLst/>
              <a:gdLst>
                <a:gd name="T0" fmla="*/ 16 w 35"/>
                <a:gd name="T1" fmla="*/ 109 h 110"/>
                <a:gd name="T2" fmla="*/ 16 w 35"/>
                <a:gd name="T3" fmla="*/ 55 h 110"/>
                <a:gd name="T4" fmla="*/ 16 w 35"/>
                <a:gd name="T5" fmla="*/ 1 h 110"/>
                <a:gd name="T6" fmla="*/ 18 w 35"/>
                <a:gd name="T7" fmla="*/ 1 h 110"/>
                <a:gd name="T8" fmla="*/ 18 w 35"/>
                <a:gd name="T9" fmla="*/ 55 h 110"/>
                <a:gd name="T10" fmla="*/ 18 w 35"/>
                <a:gd name="T11" fmla="*/ 109 h 110"/>
                <a:gd name="T12" fmla="*/ 16 w 35"/>
                <a:gd name="T13" fmla="*/ 109 h 110"/>
                <a:gd name="T14" fmla="*/ 0 w 35"/>
                <a:gd name="T15" fmla="*/ 108 h 110"/>
                <a:gd name="T16" fmla="*/ 35 w 35"/>
                <a:gd name="T17" fmla="*/ 108 h 110"/>
                <a:gd name="T18" fmla="*/ 35 w 35"/>
                <a:gd name="T19" fmla="*/ 110 h 110"/>
                <a:gd name="T20" fmla="*/ 0 w 35"/>
                <a:gd name="T21" fmla="*/ 110 h 110"/>
                <a:gd name="T22" fmla="*/ 0 w 35"/>
                <a:gd name="T23" fmla="*/ 108 h 110"/>
                <a:gd name="T24" fmla="*/ 0 w 35"/>
                <a:gd name="T25" fmla="*/ 0 h 110"/>
                <a:gd name="T26" fmla="*/ 35 w 35"/>
                <a:gd name="T27" fmla="*/ 0 h 110"/>
                <a:gd name="T28" fmla="*/ 35 w 35"/>
                <a:gd name="T29" fmla="*/ 2 h 110"/>
                <a:gd name="T30" fmla="*/ 0 w 35"/>
                <a:gd name="T31" fmla="*/ 2 h 110"/>
                <a:gd name="T32" fmla="*/ 0 w 35"/>
                <a:gd name="T33" fmla="*/ 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5" h="110">
                  <a:moveTo>
                    <a:pt x="16" y="109"/>
                  </a:moveTo>
                  <a:lnTo>
                    <a:pt x="16" y="55"/>
                  </a:lnTo>
                  <a:lnTo>
                    <a:pt x="16" y="1"/>
                  </a:lnTo>
                  <a:lnTo>
                    <a:pt x="18" y="1"/>
                  </a:lnTo>
                  <a:lnTo>
                    <a:pt x="18" y="55"/>
                  </a:lnTo>
                  <a:lnTo>
                    <a:pt x="18" y="109"/>
                  </a:lnTo>
                  <a:lnTo>
                    <a:pt x="16" y="109"/>
                  </a:lnTo>
                  <a:close/>
                  <a:moveTo>
                    <a:pt x="0" y="108"/>
                  </a:moveTo>
                  <a:lnTo>
                    <a:pt x="35" y="108"/>
                  </a:lnTo>
                  <a:lnTo>
                    <a:pt x="35" y="110"/>
                  </a:lnTo>
                  <a:lnTo>
                    <a:pt x="0" y="110"/>
                  </a:lnTo>
                  <a:lnTo>
                    <a:pt x="0" y="108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5" name="Freeform 34"/>
            <p:cNvSpPr>
              <a:spLocks noEditPoints="1"/>
            </p:cNvSpPr>
            <p:nvPr/>
          </p:nvSpPr>
          <p:spPr bwMode="auto">
            <a:xfrm>
              <a:off x="3290501" y="4431435"/>
              <a:ext cx="42991" cy="96962"/>
            </a:xfrm>
            <a:custGeom>
              <a:avLst/>
              <a:gdLst>
                <a:gd name="T0" fmla="*/ 16 w 36"/>
                <a:gd name="T1" fmla="*/ 83 h 84"/>
                <a:gd name="T2" fmla="*/ 16 w 36"/>
                <a:gd name="T3" fmla="*/ 42 h 84"/>
                <a:gd name="T4" fmla="*/ 16 w 36"/>
                <a:gd name="T5" fmla="*/ 1 h 84"/>
                <a:gd name="T6" fmla="*/ 18 w 36"/>
                <a:gd name="T7" fmla="*/ 1 h 84"/>
                <a:gd name="T8" fmla="*/ 18 w 36"/>
                <a:gd name="T9" fmla="*/ 42 h 84"/>
                <a:gd name="T10" fmla="*/ 18 w 36"/>
                <a:gd name="T11" fmla="*/ 83 h 84"/>
                <a:gd name="T12" fmla="*/ 16 w 36"/>
                <a:gd name="T13" fmla="*/ 83 h 84"/>
                <a:gd name="T14" fmla="*/ 0 w 36"/>
                <a:gd name="T15" fmla="*/ 82 h 84"/>
                <a:gd name="T16" fmla="*/ 36 w 36"/>
                <a:gd name="T17" fmla="*/ 82 h 84"/>
                <a:gd name="T18" fmla="*/ 36 w 36"/>
                <a:gd name="T19" fmla="*/ 84 h 84"/>
                <a:gd name="T20" fmla="*/ 0 w 36"/>
                <a:gd name="T21" fmla="*/ 84 h 84"/>
                <a:gd name="T22" fmla="*/ 0 w 36"/>
                <a:gd name="T23" fmla="*/ 82 h 84"/>
                <a:gd name="T24" fmla="*/ 0 w 36"/>
                <a:gd name="T25" fmla="*/ 0 h 84"/>
                <a:gd name="T26" fmla="*/ 36 w 36"/>
                <a:gd name="T27" fmla="*/ 0 h 84"/>
                <a:gd name="T28" fmla="*/ 36 w 36"/>
                <a:gd name="T29" fmla="*/ 2 h 84"/>
                <a:gd name="T30" fmla="*/ 0 w 36"/>
                <a:gd name="T31" fmla="*/ 2 h 84"/>
                <a:gd name="T32" fmla="*/ 0 w 36"/>
                <a:gd name="T33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84">
                  <a:moveTo>
                    <a:pt x="16" y="83"/>
                  </a:moveTo>
                  <a:lnTo>
                    <a:pt x="16" y="42"/>
                  </a:lnTo>
                  <a:lnTo>
                    <a:pt x="16" y="1"/>
                  </a:lnTo>
                  <a:lnTo>
                    <a:pt x="18" y="1"/>
                  </a:lnTo>
                  <a:lnTo>
                    <a:pt x="18" y="42"/>
                  </a:lnTo>
                  <a:lnTo>
                    <a:pt x="18" y="83"/>
                  </a:lnTo>
                  <a:lnTo>
                    <a:pt x="16" y="83"/>
                  </a:lnTo>
                  <a:close/>
                  <a:moveTo>
                    <a:pt x="0" y="82"/>
                  </a:moveTo>
                  <a:lnTo>
                    <a:pt x="36" y="82"/>
                  </a:lnTo>
                  <a:lnTo>
                    <a:pt x="36" y="84"/>
                  </a:lnTo>
                  <a:lnTo>
                    <a:pt x="0" y="84"/>
                  </a:lnTo>
                  <a:lnTo>
                    <a:pt x="0" y="8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6" name="Freeform 35"/>
            <p:cNvSpPr>
              <a:spLocks noEditPoints="1"/>
            </p:cNvSpPr>
            <p:nvPr/>
          </p:nvSpPr>
          <p:spPr bwMode="auto">
            <a:xfrm>
              <a:off x="3738325" y="4489151"/>
              <a:ext cx="41797" cy="68105"/>
            </a:xfrm>
            <a:custGeom>
              <a:avLst/>
              <a:gdLst>
                <a:gd name="T0" fmla="*/ 16 w 35"/>
                <a:gd name="T1" fmla="*/ 58 h 59"/>
                <a:gd name="T2" fmla="*/ 16 w 35"/>
                <a:gd name="T3" fmla="*/ 30 h 59"/>
                <a:gd name="T4" fmla="*/ 16 w 35"/>
                <a:gd name="T5" fmla="*/ 1 h 59"/>
                <a:gd name="T6" fmla="*/ 18 w 35"/>
                <a:gd name="T7" fmla="*/ 1 h 59"/>
                <a:gd name="T8" fmla="*/ 18 w 35"/>
                <a:gd name="T9" fmla="*/ 30 h 59"/>
                <a:gd name="T10" fmla="*/ 18 w 35"/>
                <a:gd name="T11" fmla="*/ 58 h 59"/>
                <a:gd name="T12" fmla="*/ 16 w 35"/>
                <a:gd name="T13" fmla="*/ 58 h 59"/>
                <a:gd name="T14" fmla="*/ 0 w 35"/>
                <a:gd name="T15" fmla="*/ 57 h 59"/>
                <a:gd name="T16" fmla="*/ 35 w 35"/>
                <a:gd name="T17" fmla="*/ 57 h 59"/>
                <a:gd name="T18" fmla="*/ 35 w 35"/>
                <a:gd name="T19" fmla="*/ 59 h 59"/>
                <a:gd name="T20" fmla="*/ 0 w 35"/>
                <a:gd name="T21" fmla="*/ 59 h 59"/>
                <a:gd name="T22" fmla="*/ 0 w 35"/>
                <a:gd name="T23" fmla="*/ 57 h 59"/>
                <a:gd name="T24" fmla="*/ 0 w 35"/>
                <a:gd name="T25" fmla="*/ 0 h 59"/>
                <a:gd name="T26" fmla="*/ 35 w 35"/>
                <a:gd name="T27" fmla="*/ 0 h 59"/>
                <a:gd name="T28" fmla="*/ 35 w 35"/>
                <a:gd name="T29" fmla="*/ 2 h 59"/>
                <a:gd name="T30" fmla="*/ 0 w 35"/>
                <a:gd name="T31" fmla="*/ 2 h 59"/>
                <a:gd name="T32" fmla="*/ 0 w 35"/>
                <a:gd name="T33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5" h="59">
                  <a:moveTo>
                    <a:pt x="16" y="58"/>
                  </a:moveTo>
                  <a:lnTo>
                    <a:pt x="16" y="30"/>
                  </a:lnTo>
                  <a:lnTo>
                    <a:pt x="16" y="1"/>
                  </a:lnTo>
                  <a:lnTo>
                    <a:pt x="18" y="1"/>
                  </a:lnTo>
                  <a:lnTo>
                    <a:pt x="18" y="30"/>
                  </a:lnTo>
                  <a:lnTo>
                    <a:pt x="18" y="58"/>
                  </a:lnTo>
                  <a:lnTo>
                    <a:pt x="16" y="58"/>
                  </a:lnTo>
                  <a:close/>
                  <a:moveTo>
                    <a:pt x="0" y="57"/>
                  </a:moveTo>
                  <a:lnTo>
                    <a:pt x="35" y="57"/>
                  </a:lnTo>
                  <a:lnTo>
                    <a:pt x="35" y="59"/>
                  </a:lnTo>
                  <a:lnTo>
                    <a:pt x="0" y="59"/>
                  </a:lnTo>
                  <a:lnTo>
                    <a:pt x="0" y="57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7" name="Freeform 36"/>
            <p:cNvSpPr>
              <a:spLocks noEditPoints="1"/>
            </p:cNvSpPr>
            <p:nvPr/>
          </p:nvSpPr>
          <p:spPr bwMode="auto">
            <a:xfrm>
              <a:off x="4184956" y="4518009"/>
              <a:ext cx="41797" cy="77339"/>
            </a:xfrm>
            <a:custGeom>
              <a:avLst/>
              <a:gdLst>
                <a:gd name="T0" fmla="*/ 17 w 35"/>
                <a:gd name="T1" fmla="*/ 66 h 67"/>
                <a:gd name="T2" fmla="*/ 17 w 35"/>
                <a:gd name="T3" fmla="*/ 33 h 67"/>
                <a:gd name="T4" fmla="*/ 17 w 35"/>
                <a:gd name="T5" fmla="*/ 1 h 67"/>
                <a:gd name="T6" fmla="*/ 19 w 35"/>
                <a:gd name="T7" fmla="*/ 1 h 67"/>
                <a:gd name="T8" fmla="*/ 19 w 35"/>
                <a:gd name="T9" fmla="*/ 33 h 67"/>
                <a:gd name="T10" fmla="*/ 19 w 35"/>
                <a:gd name="T11" fmla="*/ 66 h 67"/>
                <a:gd name="T12" fmla="*/ 17 w 35"/>
                <a:gd name="T13" fmla="*/ 66 h 67"/>
                <a:gd name="T14" fmla="*/ 0 w 35"/>
                <a:gd name="T15" fmla="*/ 65 h 67"/>
                <a:gd name="T16" fmla="*/ 35 w 35"/>
                <a:gd name="T17" fmla="*/ 65 h 67"/>
                <a:gd name="T18" fmla="*/ 35 w 35"/>
                <a:gd name="T19" fmla="*/ 67 h 67"/>
                <a:gd name="T20" fmla="*/ 0 w 35"/>
                <a:gd name="T21" fmla="*/ 67 h 67"/>
                <a:gd name="T22" fmla="*/ 0 w 35"/>
                <a:gd name="T23" fmla="*/ 65 h 67"/>
                <a:gd name="T24" fmla="*/ 0 w 35"/>
                <a:gd name="T25" fmla="*/ 0 h 67"/>
                <a:gd name="T26" fmla="*/ 35 w 35"/>
                <a:gd name="T27" fmla="*/ 0 h 67"/>
                <a:gd name="T28" fmla="*/ 35 w 35"/>
                <a:gd name="T29" fmla="*/ 2 h 67"/>
                <a:gd name="T30" fmla="*/ 0 w 35"/>
                <a:gd name="T31" fmla="*/ 2 h 67"/>
                <a:gd name="T32" fmla="*/ 0 w 35"/>
                <a:gd name="T33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5" h="67">
                  <a:moveTo>
                    <a:pt x="17" y="66"/>
                  </a:moveTo>
                  <a:lnTo>
                    <a:pt x="17" y="33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33"/>
                  </a:lnTo>
                  <a:lnTo>
                    <a:pt x="19" y="66"/>
                  </a:lnTo>
                  <a:lnTo>
                    <a:pt x="17" y="66"/>
                  </a:lnTo>
                  <a:close/>
                  <a:moveTo>
                    <a:pt x="0" y="65"/>
                  </a:moveTo>
                  <a:lnTo>
                    <a:pt x="35" y="65"/>
                  </a:lnTo>
                  <a:lnTo>
                    <a:pt x="35" y="67"/>
                  </a:lnTo>
                  <a:lnTo>
                    <a:pt x="0" y="67"/>
                  </a:lnTo>
                  <a:lnTo>
                    <a:pt x="0" y="6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8" name="Freeform 37"/>
            <p:cNvSpPr>
              <a:spLocks noEditPoints="1"/>
            </p:cNvSpPr>
            <p:nvPr/>
          </p:nvSpPr>
          <p:spPr bwMode="auto">
            <a:xfrm>
              <a:off x="4631587" y="4596502"/>
              <a:ext cx="42991" cy="60024"/>
            </a:xfrm>
            <a:custGeom>
              <a:avLst/>
              <a:gdLst>
                <a:gd name="T0" fmla="*/ 18 w 36"/>
                <a:gd name="T1" fmla="*/ 51 h 52"/>
                <a:gd name="T2" fmla="*/ 18 w 36"/>
                <a:gd name="T3" fmla="*/ 26 h 52"/>
                <a:gd name="T4" fmla="*/ 18 w 36"/>
                <a:gd name="T5" fmla="*/ 1 h 52"/>
                <a:gd name="T6" fmla="*/ 20 w 36"/>
                <a:gd name="T7" fmla="*/ 1 h 52"/>
                <a:gd name="T8" fmla="*/ 20 w 36"/>
                <a:gd name="T9" fmla="*/ 26 h 52"/>
                <a:gd name="T10" fmla="*/ 20 w 36"/>
                <a:gd name="T11" fmla="*/ 51 h 52"/>
                <a:gd name="T12" fmla="*/ 18 w 36"/>
                <a:gd name="T13" fmla="*/ 51 h 52"/>
                <a:gd name="T14" fmla="*/ 0 w 36"/>
                <a:gd name="T15" fmla="*/ 50 h 52"/>
                <a:gd name="T16" fmla="*/ 36 w 36"/>
                <a:gd name="T17" fmla="*/ 50 h 52"/>
                <a:gd name="T18" fmla="*/ 36 w 36"/>
                <a:gd name="T19" fmla="*/ 52 h 52"/>
                <a:gd name="T20" fmla="*/ 0 w 36"/>
                <a:gd name="T21" fmla="*/ 52 h 52"/>
                <a:gd name="T22" fmla="*/ 0 w 36"/>
                <a:gd name="T23" fmla="*/ 50 h 52"/>
                <a:gd name="T24" fmla="*/ 0 w 36"/>
                <a:gd name="T25" fmla="*/ 0 h 52"/>
                <a:gd name="T26" fmla="*/ 36 w 36"/>
                <a:gd name="T27" fmla="*/ 0 h 52"/>
                <a:gd name="T28" fmla="*/ 36 w 36"/>
                <a:gd name="T29" fmla="*/ 2 h 52"/>
                <a:gd name="T30" fmla="*/ 0 w 36"/>
                <a:gd name="T31" fmla="*/ 2 h 52"/>
                <a:gd name="T32" fmla="*/ 0 w 36"/>
                <a:gd name="T33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52">
                  <a:moveTo>
                    <a:pt x="18" y="51"/>
                  </a:moveTo>
                  <a:lnTo>
                    <a:pt x="18" y="26"/>
                  </a:lnTo>
                  <a:lnTo>
                    <a:pt x="18" y="1"/>
                  </a:lnTo>
                  <a:lnTo>
                    <a:pt x="20" y="1"/>
                  </a:lnTo>
                  <a:lnTo>
                    <a:pt x="20" y="26"/>
                  </a:lnTo>
                  <a:lnTo>
                    <a:pt x="20" y="51"/>
                  </a:lnTo>
                  <a:lnTo>
                    <a:pt x="18" y="51"/>
                  </a:lnTo>
                  <a:close/>
                  <a:moveTo>
                    <a:pt x="0" y="50"/>
                  </a:moveTo>
                  <a:lnTo>
                    <a:pt x="36" y="50"/>
                  </a:lnTo>
                  <a:lnTo>
                    <a:pt x="36" y="52"/>
                  </a:lnTo>
                  <a:lnTo>
                    <a:pt x="0" y="52"/>
                  </a:lnTo>
                  <a:lnTo>
                    <a:pt x="0" y="5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29" name="Freeform 38"/>
            <p:cNvSpPr>
              <a:spLocks noEditPoints="1"/>
            </p:cNvSpPr>
            <p:nvPr/>
          </p:nvSpPr>
          <p:spPr bwMode="auto">
            <a:xfrm>
              <a:off x="2523824" y="3372935"/>
              <a:ext cx="41797" cy="431711"/>
            </a:xfrm>
            <a:custGeom>
              <a:avLst/>
              <a:gdLst>
                <a:gd name="T0" fmla="*/ 17 w 35"/>
                <a:gd name="T1" fmla="*/ 373 h 374"/>
                <a:gd name="T2" fmla="*/ 17 w 35"/>
                <a:gd name="T3" fmla="*/ 188 h 374"/>
                <a:gd name="T4" fmla="*/ 17 w 35"/>
                <a:gd name="T5" fmla="*/ 1 h 374"/>
                <a:gd name="T6" fmla="*/ 19 w 35"/>
                <a:gd name="T7" fmla="*/ 1 h 374"/>
                <a:gd name="T8" fmla="*/ 19 w 35"/>
                <a:gd name="T9" fmla="*/ 188 h 374"/>
                <a:gd name="T10" fmla="*/ 19 w 35"/>
                <a:gd name="T11" fmla="*/ 373 h 374"/>
                <a:gd name="T12" fmla="*/ 17 w 35"/>
                <a:gd name="T13" fmla="*/ 373 h 374"/>
                <a:gd name="T14" fmla="*/ 0 w 35"/>
                <a:gd name="T15" fmla="*/ 372 h 374"/>
                <a:gd name="T16" fmla="*/ 35 w 35"/>
                <a:gd name="T17" fmla="*/ 372 h 374"/>
                <a:gd name="T18" fmla="*/ 35 w 35"/>
                <a:gd name="T19" fmla="*/ 374 h 374"/>
                <a:gd name="T20" fmla="*/ 0 w 35"/>
                <a:gd name="T21" fmla="*/ 374 h 374"/>
                <a:gd name="T22" fmla="*/ 0 w 35"/>
                <a:gd name="T23" fmla="*/ 372 h 374"/>
                <a:gd name="T24" fmla="*/ 0 w 35"/>
                <a:gd name="T25" fmla="*/ 0 h 374"/>
                <a:gd name="T26" fmla="*/ 35 w 35"/>
                <a:gd name="T27" fmla="*/ 0 h 374"/>
                <a:gd name="T28" fmla="*/ 35 w 35"/>
                <a:gd name="T29" fmla="*/ 2 h 374"/>
                <a:gd name="T30" fmla="*/ 0 w 35"/>
                <a:gd name="T31" fmla="*/ 2 h 374"/>
                <a:gd name="T32" fmla="*/ 0 w 35"/>
                <a:gd name="T33" fmla="*/ 0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5" h="374">
                  <a:moveTo>
                    <a:pt x="17" y="373"/>
                  </a:moveTo>
                  <a:lnTo>
                    <a:pt x="17" y="188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188"/>
                  </a:lnTo>
                  <a:lnTo>
                    <a:pt x="19" y="373"/>
                  </a:lnTo>
                  <a:lnTo>
                    <a:pt x="17" y="373"/>
                  </a:lnTo>
                  <a:close/>
                  <a:moveTo>
                    <a:pt x="0" y="372"/>
                  </a:moveTo>
                  <a:lnTo>
                    <a:pt x="35" y="372"/>
                  </a:lnTo>
                  <a:lnTo>
                    <a:pt x="35" y="374"/>
                  </a:lnTo>
                  <a:lnTo>
                    <a:pt x="0" y="374"/>
                  </a:lnTo>
                  <a:lnTo>
                    <a:pt x="0" y="372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30" name="Freeform 39"/>
            <p:cNvSpPr>
              <a:spLocks noEditPoints="1"/>
            </p:cNvSpPr>
            <p:nvPr/>
          </p:nvSpPr>
          <p:spPr bwMode="auto">
            <a:xfrm>
              <a:off x="2970455" y="4000879"/>
              <a:ext cx="44186" cy="85419"/>
            </a:xfrm>
            <a:custGeom>
              <a:avLst/>
              <a:gdLst>
                <a:gd name="T0" fmla="*/ 18 w 37"/>
                <a:gd name="T1" fmla="*/ 74 h 74"/>
                <a:gd name="T2" fmla="*/ 18 w 37"/>
                <a:gd name="T3" fmla="*/ 37 h 74"/>
                <a:gd name="T4" fmla="*/ 18 w 37"/>
                <a:gd name="T5" fmla="*/ 1 h 74"/>
                <a:gd name="T6" fmla="*/ 20 w 37"/>
                <a:gd name="T7" fmla="*/ 1 h 74"/>
                <a:gd name="T8" fmla="*/ 20 w 37"/>
                <a:gd name="T9" fmla="*/ 37 h 74"/>
                <a:gd name="T10" fmla="*/ 20 w 37"/>
                <a:gd name="T11" fmla="*/ 74 h 74"/>
                <a:gd name="T12" fmla="*/ 18 w 37"/>
                <a:gd name="T13" fmla="*/ 74 h 74"/>
                <a:gd name="T14" fmla="*/ 0 w 37"/>
                <a:gd name="T15" fmla="*/ 73 h 74"/>
                <a:gd name="T16" fmla="*/ 37 w 37"/>
                <a:gd name="T17" fmla="*/ 73 h 74"/>
                <a:gd name="T18" fmla="*/ 37 w 37"/>
                <a:gd name="T19" fmla="*/ 74 h 74"/>
                <a:gd name="T20" fmla="*/ 0 w 37"/>
                <a:gd name="T21" fmla="*/ 74 h 74"/>
                <a:gd name="T22" fmla="*/ 0 w 37"/>
                <a:gd name="T23" fmla="*/ 73 h 74"/>
                <a:gd name="T24" fmla="*/ 0 w 37"/>
                <a:gd name="T25" fmla="*/ 0 h 74"/>
                <a:gd name="T26" fmla="*/ 37 w 37"/>
                <a:gd name="T27" fmla="*/ 0 h 74"/>
                <a:gd name="T28" fmla="*/ 37 w 37"/>
                <a:gd name="T29" fmla="*/ 2 h 74"/>
                <a:gd name="T30" fmla="*/ 0 w 37"/>
                <a:gd name="T31" fmla="*/ 2 h 74"/>
                <a:gd name="T32" fmla="*/ 0 w 37"/>
                <a:gd name="T33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" h="74">
                  <a:moveTo>
                    <a:pt x="18" y="74"/>
                  </a:moveTo>
                  <a:lnTo>
                    <a:pt x="18" y="37"/>
                  </a:lnTo>
                  <a:lnTo>
                    <a:pt x="18" y="1"/>
                  </a:lnTo>
                  <a:lnTo>
                    <a:pt x="20" y="1"/>
                  </a:lnTo>
                  <a:lnTo>
                    <a:pt x="20" y="37"/>
                  </a:lnTo>
                  <a:lnTo>
                    <a:pt x="20" y="74"/>
                  </a:lnTo>
                  <a:lnTo>
                    <a:pt x="18" y="74"/>
                  </a:lnTo>
                  <a:close/>
                  <a:moveTo>
                    <a:pt x="0" y="73"/>
                  </a:moveTo>
                  <a:lnTo>
                    <a:pt x="37" y="73"/>
                  </a:lnTo>
                  <a:lnTo>
                    <a:pt x="37" y="74"/>
                  </a:lnTo>
                  <a:lnTo>
                    <a:pt x="0" y="74"/>
                  </a:lnTo>
                  <a:lnTo>
                    <a:pt x="0" y="73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31" name="Freeform 40"/>
            <p:cNvSpPr>
              <a:spLocks noEditPoints="1"/>
            </p:cNvSpPr>
            <p:nvPr/>
          </p:nvSpPr>
          <p:spPr bwMode="auto">
            <a:xfrm>
              <a:off x="3418280" y="4108229"/>
              <a:ext cx="42991" cy="100425"/>
            </a:xfrm>
            <a:custGeom>
              <a:avLst/>
              <a:gdLst>
                <a:gd name="T0" fmla="*/ 17 w 36"/>
                <a:gd name="T1" fmla="*/ 86 h 87"/>
                <a:gd name="T2" fmla="*/ 17 w 36"/>
                <a:gd name="T3" fmla="*/ 43 h 87"/>
                <a:gd name="T4" fmla="*/ 17 w 36"/>
                <a:gd name="T5" fmla="*/ 1 h 87"/>
                <a:gd name="T6" fmla="*/ 19 w 36"/>
                <a:gd name="T7" fmla="*/ 1 h 87"/>
                <a:gd name="T8" fmla="*/ 19 w 36"/>
                <a:gd name="T9" fmla="*/ 43 h 87"/>
                <a:gd name="T10" fmla="*/ 19 w 36"/>
                <a:gd name="T11" fmla="*/ 86 h 87"/>
                <a:gd name="T12" fmla="*/ 17 w 36"/>
                <a:gd name="T13" fmla="*/ 86 h 87"/>
                <a:gd name="T14" fmla="*/ 0 w 36"/>
                <a:gd name="T15" fmla="*/ 85 h 87"/>
                <a:gd name="T16" fmla="*/ 36 w 36"/>
                <a:gd name="T17" fmla="*/ 85 h 87"/>
                <a:gd name="T18" fmla="*/ 36 w 36"/>
                <a:gd name="T19" fmla="*/ 87 h 87"/>
                <a:gd name="T20" fmla="*/ 0 w 36"/>
                <a:gd name="T21" fmla="*/ 87 h 87"/>
                <a:gd name="T22" fmla="*/ 0 w 36"/>
                <a:gd name="T23" fmla="*/ 85 h 87"/>
                <a:gd name="T24" fmla="*/ 0 w 36"/>
                <a:gd name="T25" fmla="*/ 0 h 87"/>
                <a:gd name="T26" fmla="*/ 36 w 36"/>
                <a:gd name="T27" fmla="*/ 0 h 87"/>
                <a:gd name="T28" fmla="*/ 36 w 36"/>
                <a:gd name="T29" fmla="*/ 2 h 87"/>
                <a:gd name="T30" fmla="*/ 0 w 36"/>
                <a:gd name="T31" fmla="*/ 2 h 87"/>
                <a:gd name="T32" fmla="*/ 0 w 36"/>
                <a:gd name="T33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87">
                  <a:moveTo>
                    <a:pt x="17" y="86"/>
                  </a:moveTo>
                  <a:lnTo>
                    <a:pt x="17" y="43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43"/>
                  </a:lnTo>
                  <a:lnTo>
                    <a:pt x="19" y="86"/>
                  </a:lnTo>
                  <a:lnTo>
                    <a:pt x="17" y="86"/>
                  </a:lnTo>
                  <a:close/>
                  <a:moveTo>
                    <a:pt x="0" y="85"/>
                  </a:moveTo>
                  <a:lnTo>
                    <a:pt x="36" y="85"/>
                  </a:lnTo>
                  <a:lnTo>
                    <a:pt x="36" y="87"/>
                  </a:lnTo>
                  <a:lnTo>
                    <a:pt x="0" y="87"/>
                  </a:lnTo>
                  <a:lnTo>
                    <a:pt x="0" y="85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32" name="Freeform 41"/>
            <p:cNvSpPr>
              <a:spLocks noEditPoints="1"/>
            </p:cNvSpPr>
            <p:nvPr/>
          </p:nvSpPr>
          <p:spPr bwMode="auto">
            <a:xfrm>
              <a:off x="3864911" y="4225969"/>
              <a:ext cx="44186" cy="113122"/>
            </a:xfrm>
            <a:custGeom>
              <a:avLst/>
              <a:gdLst>
                <a:gd name="T0" fmla="*/ 17 w 37"/>
                <a:gd name="T1" fmla="*/ 97 h 98"/>
                <a:gd name="T2" fmla="*/ 17 w 37"/>
                <a:gd name="T3" fmla="*/ 49 h 98"/>
                <a:gd name="T4" fmla="*/ 17 w 37"/>
                <a:gd name="T5" fmla="*/ 1 h 98"/>
                <a:gd name="T6" fmla="*/ 19 w 37"/>
                <a:gd name="T7" fmla="*/ 1 h 98"/>
                <a:gd name="T8" fmla="*/ 19 w 37"/>
                <a:gd name="T9" fmla="*/ 49 h 98"/>
                <a:gd name="T10" fmla="*/ 19 w 37"/>
                <a:gd name="T11" fmla="*/ 97 h 98"/>
                <a:gd name="T12" fmla="*/ 17 w 37"/>
                <a:gd name="T13" fmla="*/ 97 h 98"/>
                <a:gd name="T14" fmla="*/ 0 w 37"/>
                <a:gd name="T15" fmla="*/ 96 h 98"/>
                <a:gd name="T16" fmla="*/ 37 w 37"/>
                <a:gd name="T17" fmla="*/ 96 h 98"/>
                <a:gd name="T18" fmla="*/ 37 w 37"/>
                <a:gd name="T19" fmla="*/ 98 h 98"/>
                <a:gd name="T20" fmla="*/ 0 w 37"/>
                <a:gd name="T21" fmla="*/ 98 h 98"/>
                <a:gd name="T22" fmla="*/ 0 w 37"/>
                <a:gd name="T23" fmla="*/ 96 h 98"/>
                <a:gd name="T24" fmla="*/ 0 w 37"/>
                <a:gd name="T25" fmla="*/ 0 h 98"/>
                <a:gd name="T26" fmla="*/ 37 w 37"/>
                <a:gd name="T27" fmla="*/ 0 h 98"/>
                <a:gd name="T28" fmla="*/ 37 w 37"/>
                <a:gd name="T29" fmla="*/ 2 h 98"/>
                <a:gd name="T30" fmla="*/ 0 w 37"/>
                <a:gd name="T31" fmla="*/ 2 h 98"/>
                <a:gd name="T32" fmla="*/ 0 w 37"/>
                <a:gd name="T33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" h="98">
                  <a:moveTo>
                    <a:pt x="17" y="97"/>
                  </a:moveTo>
                  <a:lnTo>
                    <a:pt x="17" y="49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49"/>
                  </a:lnTo>
                  <a:lnTo>
                    <a:pt x="19" y="97"/>
                  </a:lnTo>
                  <a:lnTo>
                    <a:pt x="17" y="97"/>
                  </a:lnTo>
                  <a:close/>
                  <a:moveTo>
                    <a:pt x="0" y="96"/>
                  </a:moveTo>
                  <a:lnTo>
                    <a:pt x="37" y="96"/>
                  </a:lnTo>
                  <a:lnTo>
                    <a:pt x="37" y="98"/>
                  </a:lnTo>
                  <a:lnTo>
                    <a:pt x="0" y="98"/>
                  </a:lnTo>
                  <a:lnTo>
                    <a:pt x="0" y="96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33" name="Freeform 42"/>
            <p:cNvSpPr>
              <a:spLocks noEditPoints="1"/>
            </p:cNvSpPr>
            <p:nvPr/>
          </p:nvSpPr>
          <p:spPr bwMode="auto">
            <a:xfrm>
              <a:off x="4311542" y="4189031"/>
              <a:ext cx="44186" cy="92345"/>
            </a:xfrm>
            <a:custGeom>
              <a:avLst/>
              <a:gdLst>
                <a:gd name="T0" fmla="*/ 18 w 37"/>
                <a:gd name="T1" fmla="*/ 79 h 80"/>
                <a:gd name="T2" fmla="*/ 18 w 37"/>
                <a:gd name="T3" fmla="*/ 40 h 80"/>
                <a:gd name="T4" fmla="*/ 18 w 37"/>
                <a:gd name="T5" fmla="*/ 1 h 80"/>
                <a:gd name="T6" fmla="*/ 20 w 37"/>
                <a:gd name="T7" fmla="*/ 1 h 80"/>
                <a:gd name="T8" fmla="*/ 20 w 37"/>
                <a:gd name="T9" fmla="*/ 40 h 80"/>
                <a:gd name="T10" fmla="*/ 20 w 37"/>
                <a:gd name="T11" fmla="*/ 79 h 80"/>
                <a:gd name="T12" fmla="*/ 18 w 37"/>
                <a:gd name="T13" fmla="*/ 79 h 80"/>
                <a:gd name="T14" fmla="*/ 0 w 37"/>
                <a:gd name="T15" fmla="*/ 78 h 80"/>
                <a:gd name="T16" fmla="*/ 37 w 37"/>
                <a:gd name="T17" fmla="*/ 78 h 80"/>
                <a:gd name="T18" fmla="*/ 37 w 37"/>
                <a:gd name="T19" fmla="*/ 80 h 80"/>
                <a:gd name="T20" fmla="*/ 0 w 37"/>
                <a:gd name="T21" fmla="*/ 80 h 80"/>
                <a:gd name="T22" fmla="*/ 0 w 37"/>
                <a:gd name="T23" fmla="*/ 78 h 80"/>
                <a:gd name="T24" fmla="*/ 0 w 37"/>
                <a:gd name="T25" fmla="*/ 0 h 80"/>
                <a:gd name="T26" fmla="*/ 37 w 37"/>
                <a:gd name="T27" fmla="*/ 0 h 80"/>
                <a:gd name="T28" fmla="*/ 37 w 37"/>
                <a:gd name="T29" fmla="*/ 2 h 80"/>
                <a:gd name="T30" fmla="*/ 0 w 37"/>
                <a:gd name="T31" fmla="*/ 2 h 80"/>
                <a:gd name="T32" fmla="*/ 0 w 37"/>
                <a:gd name="T33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" h="80">
                  <a:moveTo>
                    <a:pt x="18" y="79"/>
                  </a:moveTo>
                  <a:lnTo>
                    <a:pt x="18" y="40"/>
                  </a:lnTo>
                  <a:lnTo>
                    <a:pt x="18" y="1"/>
                  </a:lnTo>
                  <a:lnTo>
                    <a:pt x="20" y="1"/>
                  </a:lnTo>
                  <a:lnTo>
                    <a:pt x="20" y="40"/>
                  </a:lnTo>
                  <a:lnTo>
                    <a:pt x="20" y="79"/>
                  </a:lnTo>
                  <a:lnTo>
                    <a:pt x="18" y="79"/>
                  </a:lnTo>
                  <a:close/>
                  <a:moveTo>
                    <a:pt x="0" y="78"/>
                  </a:moveTo>
                  <a:lnTo>
                    <a:pt x="37" y="78"/>
                  </a:lnTo>
                  <a:lnTo>
                    <a:pt x="37" y="80"/>
                  </a:lnTo>
                  <a:lnTo>
                    <a:pt x="0" y="80"/>
                  </a:lnTo>
                  <a:lnTo>
                    <a:pt x="0" y="78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34" name="Freeform 43"/>
            <p:cNvSpPr>
              <a:spLocks noEditPoints="1"/>
            </p:cNvSpPr>
            <p:nvPr/>
          </p:nvSpPr>
          <p:spPr bwMode="auto">
            <a:xfrm>
              <a:off x="4759367" y="4305616"/>
              <a:ext cx="42991" cy="90036"/>
            </a:xfrm>
            <a:custGeom>
              <a:avLst/>
              <a:gdLst>
                <a:gd name="T0" fmla="*/ 17 w 36"/>
                <a:gd name="T1" fmla="*/ 77 h 78"/>
                <a:gd name="T2" fmla="*/ 17 w 36"/>
                <a:gd name="T3" fmla="*/ 39 h 78"/>
                <a:gd name="T4" fmla="*/ 17 w 36"/>
                <a:gd name="T5" fmla="*/ 1 h 78"/>
                <a:gd name="T6" fmla="*/ 19 w 36"/>
                <a:gd name="T7" fmla="*/ 1 h 78"/>
                <a:gd name="T8" fmla="*/ 19 w 36"/>
                <a:gd name="T9" fmla="*/ 39 h 78"/>
                <a:gd name="T10" fmla="*/ 19 w 36"/>
                <a:gd name="T11" fmla="*/ 77 h 78"/>
                <a:gd name="T12" fmla="*/ 17 w 36"/>
                <a:gd name="T13" fmla="*/ 77 h 78"/>
                <a:gd name="T14" fmla="*/ 0 w 36"/>
                <a:gd name="T15" fmla="*/ 76 h 78"/>
                <a:gd name="T16" fmla="*/ 36 w 36"/>
                <a:gd name="T17" fmla="*/ 76 h 78"/>
                <a:gd name="T18" fmla="*/ 36 w 36"/>
                <a:gd name="T19" fmla="*/ 78 h 78"/>
                <a:gd name="T20" fmla="*/ 0 w 36"/>
                <a:gd name="T21" fmla="*/ 78 h 78"/>
                <a:gd name="T22" fmla="*/ 0 w 36"/>
                <a:gd name="T23" fmla="*/ 76 h 78"/>
                <a:gd name="T24" fmla="*/ 0 w 36"/>
                <a:gd name="T25" fmla="*/ 0 h 78"/>
                <a:gd name="T26" fmla="*/ 36 w 36"/>
                <a:gd name="T27" fmla="*/ 0 h 78"/>
                <a:gd name="T28" fmla="*/ 36 w 36"/>
                <a:gd name="T29" fmla="*/ 1 h 78"/>
                <a:gd name="T30" fmla="*/ 0 w 36"/>
                <a:gd name="T31" fmla="*/ 1 h 78"/>
                <a:gd name="T32" fmla="*/ 0 w 36"/>
                <a:gd name="T33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78">
                  <a:moveTo>
                    <a:pt x="17" y="77"/>
                  </a:moveTo>
                  <a:lnTo>
                    <a:pt x="17" y="39"/>
                  </a:lnTo>
                  <a:lnTo>
                    <a:pt x="17" y="1"/>
                  </a:lnTo>
                  <a:lnTo>
                    <a:pt x="19" y="1"/>
                  </a:lnTo>
                  <a:lnTo>
                    <a:pt x="19" y="39"/>
                  </a:lnTo>
                  <a:lnTo>
                    <a:pt x="19" y="77"/>
                  </a:lnTo>
                  <a:lnTo>
                    <a:pt x="17" y="77"/>
                  </a:lnTo>
                  <a:close/>
                  <a:moveTo>
                    <a:pt x="0" y="76"/>
                  </a:moveTo>
                  <a:lnTo>
                    <a:pt x="36" y="76"/>
                  </a:lnTo>
                  <a:lnTo>
                    <a:pt x="36" y="78"/>
                  </a:lnTo>
                  <a:lnTo>
                    <a:pt x="0" y="78"/>
                  </a:lnTo>
                  <a:lnTo>
                    <a:pt x="0" y="7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1"/>
                  </a:lnTo>
                  <a:lnTo>
                    <a:pt x="0" y="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35" name="Freeform 45"/>
            <p:cNvSpPr>
              <a:spLocks noEditPoints="1"/>
            </p:cNvSpPr>
            <p:nvPr/>
          </p:nvSpPr>
          <p:spPr bwMode="auto">
            <a:xfrm>
              <a:off x="2226468" y="3257504"/>
              <a:ext cx="31049" cy="1696834"/>
            </a:xfrm>
            <a:custGeom>
              <a:avLst/>
              <a:gdLst>
                <a:gd name="T0" fmla="*/ 0 w 26"/>
                <a:gd name="T1" fmla="*/ 1468 h 1470"/>
                <a:gd name="T2" fmla="*/ 26 w 26"/>
                <a:gd name="T3" fmla="*/ 1468 h 1470"/>
                <a:gd name="T4" fmla="*/ 26 w 26"/>
                <a:gd name="T5" fmla="*/ 1470 h 1470"/>
                <a:gd name="T6" fmla="*/ 0 w 26"/>
                <a:gd name="T7" fmla="*/ 1470 h 1470"/>
                <a:gd name="T8" fmla="*/ 0 w 26"/>
                <a:gd name="T9" fmla="*/ 1468 h 1470"/>
                <a:gd name="T10" fmla="*/ 0 w 26"/>
                <a:gd name="T11" fmla="*/ 1223 h 1470"/>
                <a:gd name="T12" fmla="*/ 26 w 26"/>
                <a:gd name="T13" fmla="*/ 1223 h 1470"/>
                <a:gd name="T14" fmla="*/ 26 w 26"/>
                <a:gd name="T15" fmla="*/ 1225 h 1470"/>
                <a:gd name="T16" fmla="*/ 0 w 26"/>
                <a:gd name="T17" fmla="*/ 1225 h 1470"/>
                <a:gd name="T18" fmla="*/ 0 w 26"/>
                <a:gd name="T19" fmla="*/ 1223 h 1470"/>
                <a:gd name="T20" fmla="*/ 0 w 26"/>
                <a:gd name="T21" fmla="*/ 979 h 1470"/>
                <a:gd name="T22" fmla="*/ 26 w 26"/>
                <a:gd name="T23" fmla="*/ 979 h 1470"/>
                <a:gd name="T24" fmla="*/ 26 w 26"/>
                <a:gd name="T25" fmla="*/ 980 h 1470"/>
                <a:gd name="T26" fmla="*/ 0 w 26"/>
                <a:gd name="T27" fmla="*/ 980 h 1470"/>
                <a:gd name="T28" fmla="*/ 0 w 26"/>
                <a:gd name="T29" fmla="*/ 979 h 1470"/>
                <a:gd name="T30" fmla="*/ 0 w 26"/>
                <a:gd name="T31" fmla="*/ 734 h 1470"/>
                <a:gd name="T32" fmla="*/ 26 w 26"/>
                <a:gd name="T33" fmla="*/ 734 h 1470"/>
                <a:gd name="T34" fmla="*/ 26 w 26"/>
                <a:gd name="T35" fmla="*/ 736 h 1470"/>
                <a:gd name="T36" fmla="*/ 0 w 26"/>
                <a:gd name="T37" fmla="*/ 736 h 1470"/>
                <a:gd name="T38" fmla="*/ 0 w 26"/>
                <a:gd name="T39" fmla="*/ 734 h 1470"/>
                <a:gd name="T40" fmla="*/ 0 w 26"/>
                <a:gd name="T41" fmla="*/ 489 h 1470"/>
                <a:gd name="T42" fmla="*/ 26 w 26"/>
                <a:gd name="T43" fmla="*/ 489 h 1470"/>
                <a:gd name="T44" fmla="*/ 26 w 26"/>
                <a:gd name="T45" fmla="*/ 491 h 1470"/>
                <a:gd name="T46" fmla="*/ 0 w 26"/>
                <a:gd name="T47" fmla="*/ 491 h 1470"/>
                <a:gd name="T48" fmla="*/ 0 w 26"/>
                <a:gd name="T49" fmla="*/ 489 h 1470"/>
                <a:gd name="T50" fmla="*/ 0 w 26"/>
                <a:gd name="T51" fmla="*/ 244 h 1470"/>
                <a:gd name="T52" fmla="*/ 26 w 26"/>
                <a:gd name="T53" fmla="*/ 244 h 1470"/>
                <a:gd name="T54" fmla="*/ 26 w 26"/>
                <a:gd name="T55" fmla="*/ 246 h 1470"/>
                <a:gd name="T56" fmla="*/ 0 w 26"/>
                <a:gd name="T57" fmla="*/ 246 h 1470"/>
                <a:gd name="T58" fmla="*/ 0 w 26"/>
                <a:gd name="T59" fmla="*/ 244 h 1470"/>
                <a:gd name="T60" fmla="*/ 0 w 26"/>
                <a:gd name="T61" fmla="*/ 0 h 1470"/>
                <a:gd name="T62" fmla="*/ 26 w 26"/>
                <a:gd name="T63" fmla="*/ 0 h 1470"/>
                <a:gd name="T64" fmla="*/ 26 w 26"/>
                <a:gd name="T65" fmla="*/ 2 h 1470"/>
                <a:gd name="T66" fmla="*/ 0 w 26"/>
                <a:gd name="T67" fmla="*/ 2 h 1470"/>
                <a:gd name="T68" fmla="*/ 0 w 26"/>
                <a:gd name="T69" fmla="*/ 0 h 14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26" h="1470">
                  <a:moveTo>
                    <a:pt x="0" y="1468"/>
                  </a:moveTo>
                  <a:lnTo>
                    <a:pt x="26" y="1468"/>
                  </a:lnTo>
                  <a:lnTo>
                    <a:pt x="26" y="1470"/>
                  </a:lnTo>
                  <a:lnTo>
                    <a:pt x="0" y="1470"/>
                  </a:lnTo>
                  <a:lnTo>
                    <a:pt x="0" y="1468"/>
                  </a:lnTo>
                  <a:close/>
                  <a:moveTo>
                    <a:pt x="0" y="1223"/>
                  </a:moveTo>
                  <a:lnTo>
                    <a:pt x="26" y="1223"/>
                  </a:lnTo>
                  <a:lnTo>
                    <a:pt x="26" y="1225"/>
                  </a:lnTo>
                  <a:lnTo>
                    <a:pt x="0" y="1225"/>
                  </a:lnTo>
                  <a:lnTo>
                    <a:pt x="0" y="1223"/>
                  </a:lnTo>
                  <a:close/>
                  <a:moveTo>
                    <a:pt x="0" y="979"/>
                  </a:moveTo>
                  <a:lnTo>
                    <a:pt x="26" y="979"/>
                  </a:lnTo>
                  <a:lnTo>
                    <a:pt x="26" y="980"/>
                  </a:lnTo>
                  <a:lnTo>
                    <a:pt x="0" y="980"/>
                  </a:lnTo>
                  <a:lnTo>
                    <a:pt x="0" y="979"/>
                  </a:lnTo>
                  <a:close/>
                  <a:moveTo>
                    <a:pt x="0" y="734"/>
                  </a:moveTo>
                  <a:lnTo>
                    <a:pt x="26" y="734"/>
                  </a:lnTo>
                  <a:lnTo>
                    <a:pt x="26" y="736"/>
                  </a:lnTo>
                  <a:lnTo>
                    <a:pt x="0" y="736"/>
                  </a:lnTo>
                  <a:lnTo>
                    <a:pt x="0" y="734"/>
                  </a:lnTo>
                  <a:close/>
                  <a:moveTo>
                    <a:pt x="0" y="489"/>
                  </a:moveTo>
                  <a:lnTo>
                    <a:pt x="26" y="489"/>
                  </a:lnTo>
                  <a:lnTo>
                    <a:pt x="26" y="491"/>
                  </a:lnTo>
                  <a:lnTo>
                    <a:pt x="0" y="491"/>
                  </a:lnTo>
                  <a:lnTo>
                    <a:pt x="0" y="489"/>
                  </a:lnTo>
                  <a:close/>
                  <a:moveTo>
                    <a:pt x="0" y="244"/>
                  </a:moveTo>
                  <a:lnTo>
                    <a:pt x="26" y="244"/>
                  </a:lnTo>
                  <a:lnTo>
                    <a:pt x="26" y="246"/>
                  </a:lnTo>
                  <a:lnTo>
                    <a:pt x="0" y="246"/>
                  </a:lnTo>
                  <a:lnTo>
                    <a:pt x="0" y="244"/>
                  </a:lnTo>
                  <a:close/>
                  <a:moveTo>
                    <a:pt x="0" y="0"/>
                  </a:moveTo>
                  <a:lnTo>
                    <a:pt x="26" y="0"/>
                  </a:lnTo>
                  <a:lnTo>
                    <a:pt x="2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36" name="Freeform 47"/>
            <p:cNvSpPr>
              <a:spLocks noEditPoints="1"/>
            </p:cNvSpPr>
            <p:nvPr/>
          </p:nvSpPr>
          <p:spPr bwMode="auto">
            <a:xfrm>
              <a:off x="2256323" y="4953183"/>
              <a:ext cx="2685757" cy="28858"/>
            </a:xfrm>
            <a:custGeom>
              <a:avLst/>
              <a:gdLst>
                <a:gd name="T0" fmla="*/ 2 w 2249"/>
                <a:gd name="T1" fmla="*/ 0 h 25"/>
                <a:gd name="T2" fmla="*/ 2 w 2249"/>
                <a:gd name="T3" fmla="*/ 25 h 25"/>
                <a:gd name="T4" fmla="*/ 0 w 2249"/>
                <a:gd name="T5" fmla="*/ 25 h 25"/>
                <a:gd name="T6" fmla="*/ 0 w 2249"/>
                <a:gd name="T7" fmla="*/ 0 h 25"/>
                <a:gd name="T8" fmla="*/ 2 w 2249"/>
                <a:gd name="T9" fmla="*/ 0 h 25"/>
                <a:gd name="T10" fmla="*/ 377 w 2249"/>
                <a:gd name="T11" fmla="*/ 0 h 25"/>
                <a:gd name="T12" fmla="*/ 377 w 2249"/>
                <a:gd name="T13" fmla="*/ 25 h 25"/>
                <a:gd name="T14" fmla="*/ 375 w 2249"/>
                <a:gd name="T15" fmla="*/ 25 h 25"/>
                <a:gd name="T16" fmla="*/ 375 w 2249"/>
                <a:gd name="T17" fmla="*/ 0 h 25"/>
                <a:gd name="T18" fmla="*/ 377 w 2249"/>
                <a:gd name="T19" fmla="*/ 0 h 25"/>
                <a:gd name="T20" fmla="*/ 751 w 2249"/>
                <a:gd name="T21" fmla="*/ 0 h 25"/>
                <a:gd name="T22" fmla="*/ 751 w 2249"/>
                <a:gd name="T23" fmla="*/ 25 h 25"/>
                <a:gd name="T24" fmla="*/ 749 w 2249"/>
                <a:gd name="T25" fmla="*/ 25 h 25"/>
                <a:gd name="T26" fmla="*/ 749 w 2249"/>
                <a:gd name="T27" fmla="*/ 0 h 25"/>
                <a:gd name="T28" fmla="*/ 751 w 2249"/>
                <a:gd name="T29" fmla="*/ 0 h 25"/>
                <a:gd name="T30" fmla="*/ 1125 w 2249"/>
                <a:gd name="T31" fmla="*/ 0 h 25"/>
                <a:gd name="T32" fmla="*/ 1125 w 2249"/>
                <a:gd name="T33" fmla="*/ 25 h 25"/>
                <a:gd name="T34" fmla="*/ 1123 w 2249"/>
                <a:gd name="T35" fmla="*/ 25 h 25"/>
                <a:gd name="T36" fmla="*/ 1123 w 2249"/>
                <a:gd name="T37" fmla="*/ 0 h 25"/>
                <a:gd name="T38" fmla="*/ 1125 w 2249"/>
                <a:gd name="T39" fmla="*/ 0 h 25"/>
                <a:gd name="T40" fmla="*/ 1500 w 2249"/>
                <a:gd name="T41" fmla="*/ 0 h 25"/>
                <a:gd name="T42" fmla="*/ 1500 w 2249"/>
                <a:gd name="T43" fmla="*/ 25 h 25"/>
                <a:gd name="T44" fmla="*/ 1498 w 2249"/>
                <a:gd name="T45" fmla="*/ 25 h 25"/>
                <a:gd name="T46" fmla="*/ 1498 w 2249"/>
                <a:gd name="T47" fmla="*/ 0 h 25"/>
                <a:gd name="T48" fmla="*/ 1500 w 2249"/>
                <a:gd name="T49" fmla="*/ 0 h 25"/>
                <a:gd name="T50" fmla="*/ 1874 w 2249"/>
                <a:gd name="T51" fmla="*/ 0 h 25"/>
                <a:gd name="T52" fmla="*/ 1874 w 2249"/>
                <a:gd name="T53" fmla="*/ 25 h 25"/>
                <a:gd name="T54" fmla="*/ 1872 w 2249"/>
                <a:gd name="T55" fmla="*/ 25 h 25"/>
                <a:gd name="T56" fmla="*/ 1872 w 2249"/>
                <a:gd name="T57" fmla="*/ 0 h 25"/>
                <a:gd name="T58" fmla="*/ 1874 w 2249"/>
                <a:gd name="T59" fmla="*/ 0 h 25"/>
                <a:gd name="T60" fmla="*/ 2249 w 2249"/>
                <a:gd name="T61" fmla="*/ 0 h 25"/>
                <a:gd name="T62" fmla="*/ 2249 w 2249"/>
                <a:gd name="T63" fmla="*/ 25 h 25"/>
                <a:gd name="T64" fmla="*/ 2247 w 2249"/>
                <a:gd name="T65" fmla="*/ 25 h 25"/>
                <a:gd name="T66" fmla="*/ 2247 w 2249"/>
                <a:gd name="T67" fmla="*/ 0 h 25"/>
                <a:gd name="T68" fmla="*/ 2249 w 2249"/>
                <a:gd name="T69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2249" h="25">
                  <a:moveTo>
                    <a:pt x="2" y="0"/>
                  </a:moveTo>
                  <a:lnTo>
                    <a:pt x="2" y="25"/>
                  </a:lnTo>
                  <a:lnTo>
                    <a:pt x="0" y="25"/>
                  </a:lnTo>
                  <a:lnTo>
                    <a:pt x="0" y="0"/>
                  </a:lnTo>
                  <a:lnTo>
                    <a:pt x="2" y="0"/>
                  </a:lnTo>
                  <a:close/>
                  <a:moveTo>
                    <a:pt x="377" y="0"/>
                  </a:moveTo>
                  <a:lnTo>
                    <a:pt x="377" y="25"/>
                  </a:lnTo>
                  <a:lnTo>
                    <a:pt x="375" y="25"/>
                  </a:lnTo>
                  <a:lnTo>
                    <a:pt x="375" y="0"/>
                  </a:lnTo>
                  <a:lnTo>
                    <a:pt x="377" y="0"/>
                  </a:lnTo>
                  <a:close/>
                  <a:moveTo>
                    <a:pt x="751" y="0"/>
                  </a:moveTo>
                  <a:lnTo>
                    <a:pt x="751" y="25"/>
                  </a:lnTo>
                  <a:lnTo>
                    <a:pt x="749" y="25"/>
                  </a:lnTo>
                  <a:lnTo>
                    <a:pt x="749" y="0"/>
                  </a:lnTo>
                  <a:lnTo>
                    <a:pt x="751" y="0"/>
                  </a:lnTo>
                  <a:close/>
                  <a:moveTo>
                    <a:pt x="1125" y="0"/>
                  </a:moveTo>
                  <a:lnTo>
                    <a:pt x="1125" y="25"/>
                  </a:lnTo>
                  <a:lnTo>
                    <a:pt x="1123" y="25"/>
                  </a:lnTo>
                  <a:lnTo>
                    <a:pt x="1123" y="0"/>
                  </a:lnTo>
                  <a:lnTo>
                    <a:pt x="1125" y="0"/>
                  </a:lnTo>
                  <a:close/>
                  <a:moveTo>
                    <a:pt x="1500" y="0"/>
                  </a:moveTo>
                  <a:lnTo>
                    <a:pt x="1500" y="25"/>
                  </a:lnTo>
                  <a:lnTo>
                    <a:pt x="1498" y="25"/>
                  </a:lnTo>
                  <a:lnTo>
                    <a:pt x="1498" y="0"/>
                  </a:lnTo>
                  <a:lnTo>
                    <a:pt x="1500" y="0"/>
                  </a:lnTo>
                  <a:close/>
                  <a:moveTo>
                    <a:pt x="1874" y="0"/>
                  </a:moveTo>
                  <a:lnTo>
                    <a:pt x="1874" y="25"/>
                  </a:lnTo>
                  <a:lnTo>
                    <a:pt x="1872" y="25"/>
                  </a:lnTo>
                  <a:lnTo>
                    <a:pt x="1872" y="0"/>
                  </a:lnTo>
                  <a:lnTo>
                    <a:pt x="1874" y="0"/>
                  </a:lnTo>
                  <a:close/>
                  <a:moveTo>
                    <a:pt x="2249" y="0"/>
                  </a:moveTo>
                  <a:lnTo>
                    <a:pt x="2249" y="25"/>
                  </a:lnTo>
                  <a:lnTo>
                    <a:pt x="2247" y="25"/>
                  </a:lnTo>
                  <a:lnTo>
                    <a:pt x="2247" y="0"/>
                  </a:lnTo>
                  <a:lnTo>
                    <a:pt x="2249" y="0"/>
                  </a:lnTo>
                  <a:close/>
                </a:path>
              </a:pathLst>
            </a:custGeom>
            <a:solidFill>
              <a:schemeClr val="tx1"/>
            </a:solidFill>
            <a:ln w="1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baseline="-25000" noProof="1"/>
            </a:p>
          </p:txBody>
        </p:sp>
        <p:sp>
          <p:nvSpPr>
            <p:cNvPr id="290" name="Rectangle 289"/>
            <p:cNvSpPr/>
            <p:nvPr/>
          </p:nvSpPr>
          <p:spPr>
            <a:xfrm>
              <a:off x="2253118" y="3248527"/>
              <a:ext cx="2691609" cy="170484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noProof="1"/>
            </a:p>
          </p:txBody>
        </p:sp>
        <p:grpSp>
          <p:nvGrpSpPr>
            <p:cNvPr id="9" name="Grouper 290"/>
            <p:cNvGrpSpPr/>
            <p:nvPr/>
          </p:nvGrpSpPr>
          <p:grpSpPr>
            <a:xfrm>
              <a:off x="2051838" y="3200040"/>
              <a:ext cx="128240" cy="1815697"/>
              <a:chOff x="1608138" y="1468438"/>
              <a:chExt cx="100577" cy="2499957"/>
            </a:xfrm>
          </p:grpSpPr>
          <p:sp>
            <p:nvSpPr>
              <p:cNvPr id="292" name="Rectangle 115"/>
              <p:cNvSpPr>
                <a:spLocks noChangeArrowheads="1"/>
              </p:cNvSpPr>
              <p:nvPr/>
            </p:nvSpPr>
            <p:spPr bwMode="auto">
              <a:xfrm>
                <a:off x="1608138" y="3798889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0.0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93" name="Rectangle 116"/>
              <p:cNvSpPr>
                <a:spLocks noChangeArrowheads="1"/>
              </p:cNvSpPr>
              <p:nvPr/>
            </p:nvSpPr>
            <p:spPr bwMode="auto">
              <a:xfrm>
                <a:off x="1608138" y="3409950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0.5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94" name="Rectangle 117"/>
              <p:cNvSpPr>
                <a:spLocks noChangeArrowheads="1"/>
              </p:cNvSpPr>
              <p:nvPr/>
            </p:nvSpPr>
            <p:spPr bwMode="auto">
              <a:xfrm>
                <a:off x="1608138" y="3022600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1.0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95" name="Rectangle 118"/>
              <p:cNvSpPr>
                <a:spLocks noChangeArrowheads="1"/>
              </p:cNvSpPr>
              <p:nvPr/>
            </p:nvSpPr>
            <p:spPr bwMode="auto">
              <a:xfrm>
                <a:off x="1608138" y="2633663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1.5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96" name="Rectangle 119"/>
              <p:cNvSpPr>
                <a:spLocks noChangeArrowheads="1"/>
              </p:cNvSpPr>
              <p:nvPr/>
            </p:nvSpPr>
            <p:spPr bwMode="auto">
              <a:xfrm>
                <a:off x="1608138" y="2244724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2.0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97" name="Rectangle 120"/>
              <p:cNvSpPr>
                <a:spLocks noChangeArrowheads="1"/>
              </p:cNvSpPr>
              <p:nvPr/>
            </p:nvSpPr>
            <p:spPr bwMode="auto">
              <a:xfrm>
                <a:off x="1608138" y="1857376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2.5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298" name="Rectangle 121"/>
              <p:cNvSpPr>
                <a:spLocks noChangeArrowheads="1"/>
              </p:cNvSpPr>
              <p:nvPr/>
            </p:nvSpPr>
            <p:spPr bwMode="auto">
              <a:xfrm>
                <a:off x="1608138" y="1468438"/>
                <a:ext cx="100577" cy="1695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3.0</a:t>
                </a:r>
                <a:endParaRPr kumimoji="0" lang="en-GB" sz="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</p:grpSp>
        <p:grpSp>
          <p:nvGrpSpPr>
            <p:cNvPr id="10" name="Grouper 298"/>
            <p:cNvGrpSpPr/>
            <p:nvPr/>
          </p:nvGrpSpPr>
          <p:grpSpPr>
            <a:xfrm>
              <a:off x="4122256" y="3489965"/>
              <a:ext cx="635649" cy="330280"/>
              <a:chOff x="457200" y="1088231"/>
              <a:chExt cx="635649" cy="330280"/>
            </a:xfrm>
          </p:grpSpPr>
          <p:sp>
            <p:nvSpPr>
              <p:cNvPr id="300" name="Rectangle 126"/>
              <p:cNvSpPr>
                <a:spLocks noChangeArrowheads="1"/>
              </p:cNvSpPr>
              <p:nvPr/>
            </p:nvSpPr>
            <p:spPr bwMode="auto">
              <a:xfrm>
                <a:off x="533400" y="1088231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AVG</a:t>
                </a:r>
                <a:endParaRPr kumimoji="0" lang="en-GB" sz="1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sp>
            <p:nvSpPr>
              <p:cNvPr id="301" name="Rectangle 129"/>
              <p:cNvSpPr>
                <a:spLocks noChangeArrowheads="1"/>
              </p:cNvSpPr>
              <p:nvPr/>
            </p:nvSpPr>
            <p:spPr bwMode="auto">
              <a:xfrm>
                <a:off x="533400" y="1295400"/>
                <a:ext cx="55944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800" b="1" i="0" u="none" strike="noStrike" cap="none" normalizeH="0" baseline="0" noProof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/>
                    <a:cs typeface="Times New Roman"/>
                  </a:rPr>
                  <a:t>AVG + GLU</a:t>
                </a:r>
                <a:endParaRPr kumimoji="0" lang="en-GB" sz="1800" b="1" i="0" u="none" strike="noStrike" cap="none" normalizeH="0" baseline="0" noProof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/>
                  <a:cs typeface="Times New Roman"/>
                </a:endParaRPr>
              </a:p>
            </p:txBody>
          </p:sp>
          <p:grpSp>
            <p:nvGrpSpPr>
              <p:cNvPr id="11" name="Grouper 162"/>
              <p:cNvGrpSpPr/>
              <p:nvPr/>
            </p:nvGrpSpPr>
            <p:grpSpPr>
              <a:xfrm>
                <a:off x="457200" y="1143000"/>
                <a:ext cx="47079" cy="244828"/>
                <a:chOff x="3644401" y="3162154"/>
                <a:chExt cx="47079" cy="244828"/>
              </a:xfrm>
            </p:grpSpPr>
            <p:sp>
              <p:nvSpPr>
                <p:cNvPr id="303" name="Rectangle 195"/>
                <p:cNvSpPr>
                  <a:spLocks noChangeArrowheads="1"/>
                </p:cNvSpPr>
                <p:nvPr/>
              </p:nvSpPr>
              <p:spPr bwMode="auto">
                <a:xfrm>
                  <a:off x="3645640" y="3163491"/>
                  <a:ext cx="44601" cy="49501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noProof="1"/>
                </a:p>
              </p:txBody>
            </p:sp>
            <p:sp>
              <p:nvSpPr>
                <p:cNvPr id="304" name="Freeform 196"/>
                <p:cNvSpPr>
                  <a:spLocks noEditPoints="1"/>
                </p:cNvSpPr>
                <p:nvPr/>
              </p:nvSpPr>
              <p:spPr bwMode="auto">
                <a:xfrm>
                  <a:off x="3644401" y="3162154"/>
                  <a:ext cx="47079" cy="52177"/>
                </a:xfrm>
                <a:custGeom>
                  <a:avLst/>
                  <a:gdLst>
                    <a:gd name="T0" fmla="*/ 0 w 640"/>
                    <a:gd name="T1" fmla="*/ 16 h 656"/>
                    <a:gd name="T2" fmla="*/ 16 w 640"/>
                    <a:gd name="T3" fmla="*/ 0 h 656"/>
                    <a:gd name="T4" fmla="*/ 624 w 640"/>
                    <a:gd name="T5" fmla="*/ 0 h 656"/>
                    <a:gd name="T6" fmla="*/ 640 w 640"/>
                    <a:gd name="T7" fmla="*/ 16 h 656"/>
                    <a:gd name="T8" fmla="*/ 640 w 640"/>
                    <a:gd name="T9" fmla="*/ 640 h 656"/>
                    <a:gd name="T10" fmla="*/ 624 w 640"/>
                    <a:gd name="T11" fmla="*/ 656 h 656"/>
                    <a:gd name="T12" fmla="*/ 16 w 640"/>
                    <a:gd name="T13" fmla="*/ 656 h 656"/>
                    <a:gd name="T14" fmla="*/ 0 w 640"/>
                    <a:gd name="T15" fmla="*/ 640 h 656"/>
                    <a:gd name="T16" fmla="*/ 0 w 640"/>
                    <a:gd name="T17" fmla="*/ 16 h 656"/>
                    <a:gd name="T18" fmla="*/ 32 w 640"/>
                    <a:gd name="T19" fmla="*/ 640 h 656"/>
                    <a:gd name="T20" fmla="*/ 16 w 640"/>
                    <a:gd name="T21" fmla="*/ 624 h 656"/>
                    <a:gd name="T22" fmla="*/ 624 w 640"/>
                    <a:gd name="T23" fmla="*/ 624 h 656"/>
                    <a:gd name="T24" fmla="*/ 608 w 640"/>
                    <a:gd name="T25" fmla="*/ 640 h 656"/>
                    <a:gd name="T26" fmla="*/ 608 w 640"/>
                    <a:gd name="T27" fmla="*/ 16 h 656"/>
                    <a:gd name="T28" fmla="*/ 624 w 640"/>
                    <a:gd name="T29" fmla="*/ 32 h 656"/>
                    <a:gd name="T30" fmla="*/ 16 w 640"/>
                    <a:gd name="T31" fmla="*/ 32 h 656"/>
                    <a:gd name="T32" fmla="*/ 32 w 640"/>
                    <a:gd name="T33" fmla="*/ 16 h 656"/>
                    <a:gd name="T34" fmla="*/ 32 w 640"/>
                    <a:gd name="T35" fmla="*/ 640 h 6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640" h="656">
                      <a:moveTo>
                        <a:pt x="0" y="16"/>
                      </a:moveTo>
                      <a:cubicBezTo>
                        <a:pt x="0" y="8"/>
                        <a:pt x="8" y="0"/>
                        <a:pt x="16" y="0"/>
                      </a:cubicBezTo>
                      <a:lnTo>
                        <a:pt x="624" y="0"/>
                      </a:lnTo>
                      <a:cubicBezTo>
                        <a:pt x="633" y="0"/>
                        <a:pt x="640" y="8"/>
                        <a:pt x="640" y="16"/>
                      </a:cubicBezTo>
                      <a:lnTo>
                        <a:pt x="640" y="640"/>
                      </a:lnTo>
                      <a:cubicBezTo>
                        <a:pt x="640" y="649"/>
                        <a:pt x="633" y="656"/>
                        <a:pt x="624" y="656"/>
                      </a:cubicBezTo>
                      <a:lnTo>
                        <a:pt x="16" y="656"/>
                      </a:lnTo>
                      <a:cubicBezTo>
                        <a:pt x="8" y="656"/>
                        <a:pt x="0" y="649"/>
                        <a:pt x="0" y="640"/>
                      </a:cubicBezTo>
                      <a:lnTo>
                        <a:pt x="0" y="16"/>
                      </a:lnTo>
                      <a:close/>
                      <a:moveTo>
                        <a:pt x="32" y="640"/>
                      </a:moveTo>
                      <a:lnTo>
                        <a:pt x="16" y="624"/>
                      </a:lnTo>
                      <a:lnTo>
                        <a:pt x="624" y="624"/>
                      </a:lnTo>
                      <a:lnTo>
                        <a:pt x="608" y="640"/>
                      </a:lnTo>
                      <a:lnTo>
                        <a:pt x="608" y="16"/>
                      </a:lnTo>
                      <a:lnTo>
                        <a:pt x="624" y="32"/>
                      </a:lnTo>
                      <a:lnTo>
                        <a:pt x="16" y="32"/>
                      </a:lnTo>
                      <a:lnTo>
                        <a:pt x="32" y="16"/>
                      </a:lnTo>
                      <a:lnTo>
                        <a:pt x="32" y="64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noProof="1"/>
                </a:p>
              </p:txBody>
            </p:sp>
            <p:sp>
              <p:nvSpPr>
                <p:cNvPr id="305" name="Rectangle 198"/>
                <p:cNvSpPr>
                  <a:spLocks noChangeArrowheads="1"/>
                </p:cNvSpPr>
                <p:nvPr/>
              </p:nvSpPr>
              <p:spPr bwMode="auto">
                <a:xfrm>
                  <a:off x="3645640" y="3356143"/>
                  <a:ext cx="44601" cy="49501"/>
                </a:xfrm>
                <a:prstGeom prst="rect">
                  <a:avLst/>
                </a:prstGeom>
                <a:solidFill>
                  <a:srgbClr val="D9D9D9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noProof="1"/>
                </a:p>
              </p:txBody>
            </p:sp>
            <p:sp>
              <p:nvSpPr>
                <p:cNvPr id="306" name="Freeform 199"/>
                <p:cNvSpPr>
                  <a:spLocks noEditPoints="1"/>
                </p:cNvSpPr>
                <p:nvPr/>
              </p:nvSpPr>
              <p:spPr bwMode="auto">
                <a:xfrm>
                  <a:off x="3644401" y="3354805"/>
                  <a:ext cx="47079" cy="52177"/>
                </a:xfrm>
                <a:custGeom>
                  <a:avLst/>
                  <a:gdLst>
                    <a:gd name="T0" fmla="*/ 0 w 640"/>
                    <a:gd name="T1" fmla="*/ 16 h 656"/>
                    <a:gd name="T2" fmla="*/ 16 w 640"/>
                    <a:gd name="T3" fmla="*/ 0 h 656"/>
                    <a:gd name="T4" fmla="*/ 624 w 640"/>
                    <a:gd name="T5" fmla="*/ 0 h 656"/>
                    <a:gd name="T6" fmla="*/ 640 w 640"/>
                    <a:gd name="T7" fmla="*/ 16 h 656"/>
                    <a:gd name="T8" fmla="*/ 640 w 640"/>
                    <a:gd name="T9" fmla="*/ 640 h 656"/>
                    <a:gd name="T10" fmla="*/ 624 w 640"/>
                    <a:gd name="T11" fmla="*/ 656 h 656"/>
                    <a:gd name="T12" fmla="*/ 16 w 640"/>
                    <a:gd name="T13" fmla="*/ 656 h 656"/>
                    <a:gd name="T14" fmla="*/ 0 w 640"/>
                    <a:gd name="T15" fmla="*/ 640 h 656"/>
                    <a:gd name="T16" fmla="*/ 0 w 640"/>
                    <a:gd name="T17" fmla="*/ 16 h 656"/>
                    <a:gd name="T18" fmla="*/ 32 w 640"/>
                    <a:gd name="T19" fmla="*/ 640 h 656"/>
                    <a:gd name="T20" fmla="*/ 16 w 640"/>
                    <a:gd name="T21" fmla="*/ 624 h 656"/>
                    <a:gd name="T22" fmla="*/ 624 w 640"/>
                    <a:gd name="T23" fmla="*/ 624 h 656"/>
                    <a:gd name="T24" fmla="*/ 608 w 640"/>
                    <a:gd name="T25" fmla="*/ 640 h 656"/>
                    <a:gd name="T26" fmla="*/ 608 w 640"/>
                    <a:gd name="T27" fmla="*/ 16 h 656"/>
                    <a:gd name="T28" fmla="*/ 624 w 640"/>
                    <a:gd name="T29" fmla="*/ 32 h 656"/>
                    <a:gd name="T30" fmla="*/ 16 w 640"/>
                    <a:gd name="T31" fmla="*/ 32 h 656"/>
                    <a:gd name="T32" fmla="*/ 32 w 640"/>
                    <a:gd name="T33" fmla="*/ 16 h 656"/>
                    <a:gd name="T34" fmla="*/ 32 w 640"/>
                    <a:gd name="T35" fmla="*/ 640 h 6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640" h="656">
                      <a:moveTo>
                        <a:pt x="0" y="16"/>
                      </a:moveTo>
                      <a:cubicBezTo>
                        <a:pt x="0" y="8"/>
                        <a:pt x="8" y="0"/>
                        <a:pt x="16" y="0"/>
                      </a:cubicBezTo>
                      <a:lnTo>
                        <a:pt x="624" y="0"/>
                      </a:lnTo>
                      <a:cubicBezTo>
                        <a:pt x="633" y="0"/>
                        <a:pt x="640" y="8"/>
                        <a:pt x="640" y="16"/>
                      </a:cubicBezTo>
                      <a:lnTo>
                        <a:pt x="640" y="640"/>
                      </a:lnTo>
                      <a:cubicBezTo>
                        <a:pt x="640" y="649"/>
                        <a:pt x="633" y="656"/>
                        <a:pt x="624" y="656"/>
                      </a:cubicBezTo>
                      <a:lnTo>
                        <a:pt x="16" y="656"/>
                      </a:lnTo>
                      <a:cubicBezTo>
                        <a:pt x="8" y="656"/>
                        <a:pt x="0" y="649"/>
                        <a:pt x="0" y="640"/>
                      </a:cubicBezTo>
                      <a:lnTo>
                        <a:pt x="0" y="16"/>
                      </a:lnTo>
                      <a:close/>
                      <a:moveTo>
                        <a:pt x="32" y="640"/>
                      </a:moveTo>
                      <a:lnTo>
                        <a:pt x="16" y="624"/>
                      </a:lnTo>
                      <a:lnTo>
                        <a:pt x="624" y="624"/>
                      </a:lnTo>
                      <a:lnTo>
                        <a:pt x="608" y="640"/>
                      </a:lnTo>
                      <a:lnTo>
                        <a:pt x="608" y="16"/>
                      </a:lnTo>
                      <a:lnTo>
                        <a:pt x="624" y="32"/>
                      </a:lnTo>
                      <a:lnTo>
                        <a:pt x="16" y="32"/>
                      </a:lnTo>
                      <a:lnTo>
                        <a:pt x="32" y="16"/>
                      </a:lnTo>
                      <a:lnTo>
                        <a:pt x="32" y="64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noProof="1"/>
                </a:p>
              </p:txBody>
            </p:sp>
          </p:grpSp>
        </p:grpSp>
        <p:sp>
          <p:nvSpPr>
            <p:cNvPr id="307" name="Rectangle 306"/>
            <p:cNvSpPr/>
            <p:nvPr/>
          </p:nvSpPr>
          <p:spPr>
            <a:xfrm>
              <a:off x="3123597" y="3270227"/>
              <a:ext cx="6208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Shoots</a:t>
              </a:r>
              <a:endParaRPr lang="en-GB" sz="1200" noProof="1"/>
            </a:p>
          </p:txBody>
        </p:sp>
        <p:sp>
          <p:nvSpPr>
            <p:cNvPr id="317" name="Rectangle 316"/>
            <p:cNvSpPr/>
            <p:nvPr/>
          </p:nvSpPr>
          <p:spPr>
            <a:xfrm>
              <a:off x="4638679" y="3283868"/>
              <a:ext cx="31432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400" b="1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B</a:t>
              </a:r>
              <a:endParaRPr lang="en-GB" sz="1400" noProof="1"/>
            </a:p>
          </p:txBody>
        </p:sp>
        <p:sp>
          <p:nvSpPr>
            <p:cNvPr id="319" name="Freeform 202"/>
            <p:cNvSpPr>
              <a:spLocks noEditPoints="1"/>
            </p:cNvSpPr>
            <p:nvPr/>
          </p:nvSpPr>
          <p:spPr bwMode="auto">
            <a:xfrm>
              <a:off x="2251800" y="4388962"/>
              <a:ext cx="2685981" cy="6690"/>
            </a:xfrm>
            <a:custGeom>
              <a:avLst/>
              <a:gdLst>
                <a:gd name="T0" fmla="*/ 42 w 2168"/>
                <a:gd name="T1" fmla="*/ 0 h 5"/>
                <a:gd name="T2" fmla="*/ 61 w 2168"/>
                <a:gd name="T3" fmla="*/ 4 h 5"/>
                <a:gd name="T4" fmla="*/ 107 w 2168"/>
                <a:gd name="T5" fmla="*/ 0 h 5"/>
                <a:gd name="T6" fmla="*/ 150 w 2168"/>
                <a:gd name="T7" fmla="*/ 4 h 5"/>
                <a:gd name="T8" fmla="*/ 169 w 2168"/>
                <a:gd name="T9" fmla="*/ 0 h 5"/>
                <a:gd name="T10" fmla="*/ 226 w 2168"/>
                <a:gd name="T11" fmla="*/ 0 h 5"/>
                <a:gd name="T12" fmla="*/ 246 w 2168"/>
                <a:gd name="T13" fmla="*/ 4 h 5"/>
                <a:gd name="T14" fmla="*/ 292 w 2168"/>
                <a:gd name="T15" fmla="*/ 0 h 5"/>
                <a:gd name="T16" fmla="*/ 334 w 2168"/>
                <a:gd name="T17" fmla="*/ 4 h 5"/>
                <a:gd name="T18" fmla="*/ 353 w 2168"/>
                <a:gd name="T19" fmla="*/ 0 h 5"/>
                <a:gd name="T20" fmla="*/ 411 w 2168"/>
                <a:gd name="T21" fmla="*/ 0 h 5"/>
                <a:gd name="T22" fmla="*/ 430 w 2168"/>
                <a:gd name="T23" fmla="*/ 4 h 5"/>
                <a:gd name="T24" fmla="*/ 476 w 2168"/>
                <a:gd name="T25" fmla="*/ 0 h 5"/>
                <a:gd name="T26" fmla="*/ 518 w 2168"/>
                <a:gd name="T27" fmla="*/ 4 h 5"/>
                <a:gd name="T28" fmla="*/ 537 w 2168"/>
                <a:gd name="T29" fmla="*/ 0 h 5"/>
                <a:gd name="T30" fmla="*/ 595 w 2168"/>
                <a:gd name="T31" fmla="*/ 0 h 5"/>
                <a:gd name="T32" fmla="*/ 614 w 2168"/>
                <a:gd name="T33" fmla="*/ 4 h 5"/>
                <a:gd name="T34" fmla="*/ 660 w 2168"/>
                <a:gd name="T35" fmla="*/ 0 h 5"/>
                <a:gd name="T36" fmla="*/ 703 w 2168"/>
                <a:gd name="T37" fmla="*/ 4 h 5"/>
                <a:gd name="T38" fmla="*/ 722 w 2168"/>
                <a:gd name="T39" fmla="*/ 0 h 5"/>
                <a:gd name="T40" fmla="*/ 779 w 2168"/>
                <a:gd name="T41" fmla="*/ 0 h 5"/>
                <a:gd name="T42" fmla="*/ 799 w 2168"/>
                <a:gd name="T43" fmla="*/ 4 h 5"/>
                <a:gd name="T44" fmla="*/ 845 w 2168"/>
                <a:gd name="T45" fmla="*/ 0 h 5"/>
                <a:gd name="T46" fmla="*/ 887 w 2168"/>
                <a:gd name="T47" fmla="*/ 4 h 5"/>
                <a:gd name="T48" fmla="*/ 906 w 2168"/>
                <a:gd name="T49" fmla="*/ 0 h 5"/>
                <a:gd name="T50" fmla="*/ 964 w 2168"/>
                <a:gd name="T51" fmla="*/ 0 h 5"/>
                <a:gd name="T52" fmla="*/ 983 w 2168"/>
                <a:gd name="T53" fmla="*/ 4 h 5"/>
                <a:gd name="T54" fmla="*/ 1029 w 2168"/>
                <a:gd name="T55" fmla="*/ 0 h 5"/>
                <a:gd name="T56" fmla="*/ 1071 w 2168"/>
                <a:gd name="T57" fmla="*/ 4 h 5"/>
                <a:gd name="T58" fmla="*/ 1090 w 2168"/>
                <a:gd name="T59" fmla="*/ 0 h 5"/>
                <a:gd name="T60" fmla="*/ 1148 w 2168"/>
                <a:gd name="T61" fmla="*/ 1 h 5"/>
                <a:gd name="T62" fmla="*/ 1167 w 2168"/>
                <a:gd name="T63" fmla="*/ 4 h 5"/>
                <a:gd name="T64" fmla="*/ 1213 w 2168"/>
                <a:gd name="T65" fmla="*/ 1 h 5"/>
                <a:gd name="T66" fmla="*/ 1256 w 2168"/>
                <a:gd name="T67" fmla="*/ 4 h 5"/>
                <a:gd name="T68" fmla="*/ 1275 w 2168"/>
                <a:gd name="T69" fmla="*/ 1 h 5"/>
                <a:gd name="T70" fmla="*/ 1332 w 2168"/>
                <a:gd name="T71" fmla="*/ 1 h 5"/>
                <a:gd name="T72" fmla="*/ 1352 w 2168"/>
                <a:gd name="T73" fmla="*/ 4 h 5"/>
                <a:gd name="T74" fmla="*/ 1398 w 2168"/>
                <a:gd name="T75" fmla="*/ 1 h 5"/>
                <a:gd name="T76" fmla="*/ 1440 w 2168"/>
                <a:gd name="T77" fmla="*/ 4 h 5"/>
                <a:gd name="T78" fmla="*/ 1459 w 2168"/>
                <a:gd name="T79" fmla="*/ 1 h 5"/>
                <a:gd name="T80" fmla="*/ 1517 w 2168"/>
                <a:gd name="T81" fmla="*/ 1 h 5"/>
                <a:gd name="T82" fmla="*/ 1536 w 2168"/>
                <a:gd name="T83" fmla="*/ 4 h 5"/>
                <a:gd name="T84" fmla="*/ 1582 w 2168"/>
                <a:gd name="T85" fmla="*/ 1 h 5"/>
                <a:gd name="T86" fmla="*/ 1624 w 2168"/>
                <a:gd name="T87" fmla="*/ 4 h 5"/>
                <a:gd name="T88" fmla="*/ 1643 w 2168"/>
                <a:gd name="T89" fmla="*/ 1 h 5"/>
                <a:gd name="T90" fmla="*/ 1701 w 2168"/>
                <a:gd name="T91" fmla="*/ 1 h 5"/>
                <a:gd name="T92" fmla="*/ 1720 w 2168"/>
                <a:gd name="T93" fmla="*/ 5 h 5"/>
                <a:gd name="T94" fmla="*/ 1766 w 2168"/>
                <a:gd name="T95" fmla="*/ 1 h 5"/>
                <a:gd name="T96" fmla="*/ 1808 w 2168"/>
                <a:gd name="T97" fmla="*/ 5 h 5"/>
                <a:gd name="T98" fmla="*/ 1828 w 2168"/>
                <a:gd name="T99" fmla="*/ 1 h 5"/>
                <a:gd name="T100" fmla="*/ 1885 w 2168"/>
                <a:gd name="T101" fmla="*/ 1 h 5"/>
                <a:gd name="T102" fmla="*/ 1904 w 2168"/>
                <a:gd name="T103" fmla="*/ 5 h 5"/>
                <a:gd name="T104" fmla="*/ 1951 w 2168"/>
                <a:gd name="T105" fmla="*/ 1 h 5"/>
                <a:gd name="T106" fmla="*/ 1993 w 2168"/>
                <a:gd name="T107" fmla="*/ 5 h 5"/>
                <a:gd name="T108" fmla="*/ 2012 w 2168"/>
                <a:gd name="T109" fmla="*/ 1 h 5"/>
                <a:gd name="T110" fmla="*/ 2070 w 2168"/>
                <a:gd name="T111" fmla="*/ 1 h 5"/>
                <a:gd name="T112" fmla="*/ 2089 w 2168"/>
                <a:gd name="T113" fmla="*/ 5 h 5"/>
                <a:gd name="T114" fmla="*/ 2135 w 2168"/>
                <a:gd name="T115" fmla="*/ 1 h 5"/>
                <a:gd name="T116" fmla="*/ 2168 w 2168"/>
                <a:gd name="T117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2168" h="5">
                  <a:moveTo>
                    <a:pt x="0" y="0"/>
                  </a:moveTo>
                  <a:lnTo>
                    <a:pt x="11" y="0"/>
                  </a:lnTo>
                  <a:lnTo>
                    <a:pt x="11" y="4"/>
                  </a:lnTo>
                  <a:lnTo>
                    <a:pt x="0" y="4"/>
                  </a:lnTo>
                  <a:lnTo>
                    <a:pt x="0" y="0"/>
                  </a:lnTo>
                  <a:close/>
                  <a:moveTo>
                    <a:pt x="15" y="0"/>
                  </a:moveTo>
                  <a:lnTo>
                    <a:pt x="27" y="0"/>
                  </a:lnTo>
                  <a:lnTo>
                    <a:pt x="27" y="4"/>
                  </a:lnTo>
                  <a:lnTo>
                    <a:pt x="15" y="4"/>
                  </a:lnTo>
                  <a:lnTo>
                    <a:pt x="15" y="0"/>
                  </a:lnTo>
                  <a:close/>
                  <a:moveTo>
                    <a:pt x="31" y="0"/>
                  </a:moveTo>
                  <a:lnTo>
                    <a:pt x="42" y="0"/>
                  </a:lnTo>
                  <a:lnTo>
                    <a:pt x="42" y="4"/>
                  </a:lnTo>
                  <a:lnTo>
                    <a:pt x="31" y="4"/>
                  </a:lnTo>
                  <a:lnTo>
                    <a:pt x="31" y="0"/>
                  </a:lnTo>
                  <a:close/>
                  <a:moveTo>
                    <a:pt x="46" y="0"/>
                  </a:moveTo>
                  <a:lnTo>
                    <a:pt x="58" y="0"/>
                  </a:lnTo>
                  <a:lnTo>
                    <a:pt x="58" y="4"/>
                  </a:lnTo>
                  <a:lnTo>
                    <a:pt x="46" y="4"/>
                  </a:lnTo>
                  <a:lnTo>
                    <a:pt x="46" y="0"/>
                  </a:lnTo>
                  <a:close/>
                  <a:moveTo>
                    <a:pt x="61" y="0"/>
                  </a:moveTo>
                  <a:lnTo>
                    <a:pt x="73" y="0"/>
                  </a:lnTo>
                  <a:lnTo>
                    <a:pt x="73" y="4"/>
                  </a:lnTo>
                  <a:lnTo>
                    <a:pt x="61" y="4"/>
                  </a:lnTo>
                  <a:lnTo>
                    <a:pt x="61" y="0"/>
                  </a:lnTo>
                  <a:close/>
                  <a:moveTo>
                    <a:pt x="77" y="0"/>
                  </a:moveTo>
                  <a:lnTo>
                    <a:pt x="88" y="0"/>
                  </a:lnTo>
                  <a:lnTo>
                    <a:pt x="88" y="4"/>
                  </a:lnTo>
                  <a:lnTo>
                    <a:pt x="77" y="4"/>
                  </a:lnTo>
                  <a:lnTo>
                    <a:pt x="77" y="0"/>
                  </a:lnTo>
                  <a:close/>
                  <a:moveTo>
                    <a:pt x="92" y="0"/>
                  </a:moveTo>
                  <a:lnTo>
                    <a:pt x="104" y="0"/>
                  </a:lnTo>
                  <a:lnTo>
                    <a:pt x="104" y="4"/>
                  </a:lnTo>
                  <a:lnTo>
                    <a:pt x="92" y="4"/>
                  </a:lnTo>
                  <a:lnTo>
                    <a:pt x="92" y="0"/>
                  </a:lnTo>
                  <a:close/>
                  <a:moveTo>
                    <a:pt x="107" y="0"/>
                  </a:moveTo>
                  <a:lnTo>
                    <a:pt x="119" y="0"/>
                  </a:lnTo>
                  <a:lnTo>
                    <a:pt x="119" y="4"/>
                  </a:lnTo>
                  <a:lnTo>
                    <a:pt x="107" y="4"/>
                  </a:lnTo>
                  <a:lnTo>
                    <a:pt x="107" y="0"/>
                  </a:lnTo>
                  <a:close/>
                  <a:moveTo>
                    <a:pt x="123" y="0"/>
                  </a:moveTo>
                  <a:lnTo>
                    <a:pt x="134" y="0"/>
                  </a:lnTo>
                  <a:lnTo>
                    <a:pt x="134" y="4"/>
                  </a:lnTo>
                  <a:lnTo>
                    <a:pt x="123" y="4"/>
                  </a:lnTo>
                  <a:lnTo>
                    <a:pt x="123" y="0"/>
                  </a:lnTo>
                  <a:close/>
                  <a:moveTo>
                    <a:pt x="138" y="0"/>
                  </a:moveTo>
                  <a:lnTo>
                    <a:pt x="150" y="0"/>
                  </a:lnTo>
                  <a:lnTo>
                    <a:pt x="150" y="4"/>
                  </a:lnTo>
                  <a:lnTo>
                    <a:pt x="138" y="4"/>
                  </a:lnTo>
                  <a:lnTo>
                    <a:pt x="138" y="0"/>
                  </a:lnTo>
                  <a:close/>
                  <a:moveTo>
                    <a:pt x="154" y="0"/>
                  </a:moveTo>
                  <a:lnTo>
                    <a:pt x="165" y="0"/>
                  </a:lnTo>
                  <a:lnTo>
                    <a:pt x="165" y="4"/>
                  </a:lnTo>
                  <a:lnTo>
                    <a:pt x="154" y="4"/>
                  </a:lnTo>
                  <a:lnTo>
                    <a:pt x="154" y="0"/>
                  </a:lnTo>
                  <a:close/>
                  <a:moveTo>
                    <a:pt x="169" y="0"/>
                  </a:moveTo>
                  <a:lnTo>
                    <a:pt x="180" y="0"/>
                  </a:lnTo>
                  <a:lnTo>
                    <a:pt x="180" y="4"/>
                  </a:lnTo>
                  <a:lnTo>
                    <a:pt x="169" y="4"/>
                  </a:lnTo>
                  <a:lnTo>
                    <a:pt x="169" y="0"/>
                  </a:lnTo>
                  <a:close/>
                  <a:moveTo>
                    <a:pt x="184" y="0"/>
                  </a:moveTo>
                  <a:lnTo>
                    <a:pt x="196" y="0"/>
                  </a:lnTo>
                  <a:lnTo>
                    <a:pt x="196" y="4"/>
                  </a:lnTo>
                  <a:lnTo>
                    <a:pt x="184" y="4"/>
                  </a:lnTo>
                  <a:lnTo>
                    <a:pt x="184" y="0"/>
                  </a:lnTo>
                  <a:close/>
                  <a:moveTo>
                    <a:pt x="200" y="0"/>
                  </a:moveTo>
                  <a:lnTo>
                    <a:pt x="211" y="0"/>
                  </a:lnTo>
                  <a:lnTo>
                    <a:pt x="211" y="4"/>
                  </a:lnTo>
                  <a:lnTo>
                    <a:pt x="200" y="4"/>
                  </a:lnTo>
                  <a:lnTo>
                    <a:pt x="200" y="0"/>
                  </a:lnTo>
                  <a:close/>
                  <a:moveTo>
                    <a:pt x="215" y="0"/>
                  </a:moveTo>
                  <a:lnTo>
                    <a:pt x="226" y="0"/>
                  </a:lnTo>
                  <a:lnTo>
                    <a:pt x="226" y="4"/>
                  </a:lnTo>
                  <a:lnTo>
                    <a:pt x="215" y="4"/>
                  </a:lnTo>
                  <a:lnTo>
                    <a:pt x="215" y="0"/>
                  </a:lnTo>
                  <a:close/>
                  <a:moveTo>
                    <a:pt x="230" y="0"/>
                  </a:moveTo>
                  <a:lnTo>
                    <a:pt x="242" y="0"/>
                  </a:lnTo>
                  <a:lnTo>
                    <a:pt x="242" y="4"/>
                  </a:lnTo>
                  <a:lnTo>
                    <a:pt x="230" y="4"/>
                  </a:lnTo>
                  <a:lnTo>
                    <a:pt x="230" y="0"/>
                  </a:lnTo>
                  <a:close/>
                  <a:moveTo>
                    <a:pt x="246" y="0"/>
                  </a:moveTo>
                  <a:lnTo>
                    <a:pt x="257" y="0"/>
                  </a:lnTo>
                  <a:lnTo>
                    <a:pt x="257" y="4"/>
                  </a:lnTo>
                  <a:lnTo>
                    <a:pt x="246" y="4"/>
                  </a:lnTo>
                  <a:lnTo>
                    <a:pt x="246" y="0"/>
                  </a:lnTo>
                  <a:close/>
                  <a:moveTo>
                    <a:pt x="261" y="0"/>
                  </a:moveTo>
                  <a:lnTo>
                    <a:pt x="273" y="0"/>
                  </a:lnTo>
                  <a:lnTo>
                    <a:pt x="273" y="4"/>
                  </a:lnTo>
                  <a:lnTo>
                    <a:pt x="261" y="4"/>
                  </a:lnTo>
                  <a:lnTo>
                    <a:pt x="261" y="0"/>
                  </a:lnTo>
                  <a:close/>
                  <a:moveTo>
                    <a:pt x="276" y="0"/>
                  </a:moveTo>
                  <a:lnTo>
                    <a:pt x="288" y="0"/>
                  </a:lnTo>
                  <a:lnTo>
                    <a:pt x="288" y="4"/>
                  </a:lnTo>
                  <a:lnTo>
                    <a:pt x="276" y="4"/>
                  </a:lnTo>
                  <a:lnTo>
                    <a:pt x="276" y="0"/>
                  </a:lnTo>
                  <a:close/>
                  <a:moveTo>
                    <a:pt x="292" y="0"/>
                  </a:moveTo>
                  <a:lnTo>
                    <a:pt x="303" y="0"/>
                  </a:lnTo>
                  <a:lnTo>
                    <a:pt x="303" y="4"/>
                  </a:lnTo>
                  <a:lnTo>
                    <a:pt x="292" y="4"/>
                  </a:lnTo>
                  <a:lnTo>
                    <a:pt x="292" y="0"/>
                  </a:lnTo>
                  <a:close/>
                  <a:moveTo>
                    <a:pt x="307" y="0"/>
                  </a:moveTo>
                  <a:lnTo>
                    <a:pt x="319" y="0"/>
                  </a:lnTo>
                  <a:lnTo>
                    <a:pt x="319" y="4"/>
                  </a:lnTo>
                  <a:lnTo>
                    <a:pt x="307" y="4"/>
                  </a:lnTo>
                  <a:lnTo>
                    <a:pt x="307" y="0"/>
                  </a:lnTo>
                  <a:close/>
                  <a:moveTo>
                    <a:pt x="322" y="0"/>
                  </a:moveTo>
                  <a:lnTo>
                    <a:pt x="334" y="0"/>
                  </a:lnTo>
                  <a:lnTo>
                    <a:pt x="334" y="4"/>
                  </a:lnTo>
                  <a:lnTo>
                    <a:pt x="322" y="4"/>
                  </a:lnTo>
                  <a:lnTo>
                    <a:pt x="322" y="0"/>
                  </a:lnTo>
                  <a:close/>
                  <a:moveTo>
                    <a:pt x="338" y="0"/>
                  </a:moveTo>
                  <a:lnTo>
                    <a:pt x="349" y="0"/>
                  </a:lnTo>
                  <a:lnTo>
                    <a:pt x="349" y="4"/>
                  </a:lnTo>
                  <a:lnTo>
                    <a:pt x="338" y="4"/>
                  </a:lnTo>
                  <a:lnTo>
                    <a:pt x="338" y="0"/>
                  </a:lnTo>
                  <a:close/>
                  <a:moveTo>
                    <a:pt x="353" y="0"/>
                  </a:moveTo>
                  <a:lnTo>
                    <a:pt x="365" y="0"/>
                  </a:lnTo>
                  <a:lnTo>
                    <a:pt x="365" y="4"/>
                  </a:lnTo>
                  <a:lnTo>
                    <a:pt x="353" y="4"/>
                  </a:lnTo>
                  <a:lnTo>
                    <a:pt x="353" y="0"/>
                  </a:lnTo>
                  <a:close/>
                  <a:moveTo>
                    <a:pt x="369" y="0"/>
                  </a:moveTo>
                  <a:lnTo>
                    <a:pt x="380" y="0"/>
                  </a:lnTo>
                  <a:lnTo>
                    <a:pt x="380" y="4"/>
                  </a:lnTo>
                  <a:lnTo>
                    <a:pt x="369" y="4"/>
                  </a:lnTo>
                  <a:lnTo>
                    <a:pt x="369" y="0"/>
                  </a:lnTo>
                  <a:close/>
                  <a:moveTo>
                    <a:pt x="384" y="0"/>
                  </a:moveTo>
                  <a:lnTo>
                    <a:pt x="395" y="0"/>
                  </a:lnTo>
                  <a:lnTo>
                    <a:pt x="395" y="4"/>
                  </a:lnTo>
                  <a:lnTo>
                    <a:pt x="384" y="4"/>
                  </a:lnTo>
                  <a:lnTo>
                    <a:pt x="384" y="0"/>
                  </a:lnTo>
                  <a:close/>
                  <a:moveTo>
                    <a:pt x="399" y="0"/>
                  </a:moveTo>
                  <a:lnTo>
                    <a:pt x="411" y="0"/>
                  </a:lnTo>
                  <a:lnTo>
                    <a:pt x="411" y="4"/>
                  </a:lnTo>
                  <a:lnTo>
                    <a:pt x="399" y="4"/>
                  </a:lnTo>
                  <a:lnTo>
                    <a:pt x="399" y="0"/>
                  </a:lnTo>
                  <a:close/>
                  <a:moveTo>
                    <a:pt x="415" y="0"/>
                  </a:moveTo>
                  <a:lnTo>
                    <a:pt x="426" y="0"/>
                  </a:lnTo>
                  <a:lnTo>
                    <a:pt x="426" y="4"/>
                  </a:lnTo>
                  <a:lnTo>
                    <a:pt x="415" y="4"/>
                  </a:lnTo>
                  <a:lnTo>
                    <a:pt x="415" y="0"/>
                  </a:lnTo>
                  <a:close/>
                  <a:moveTo>
                    <a:pt x="430" y="0"/>
                  </a:moveTo>
                  <a:lnTo>
                    <a:pt x="442" y="0"/>
                  </a:lnTo>
                  <a:lnTo>
                    <a:pt x="442" y="4"/>
                  </a:lnTo>
                  <a:lnTo>
                    <a:pt x="430" y="4"/>
                  </a:lnTo>
                  <a:lnTo>
                    <a:pt x="430" y="0"/>
                  </a:lnTo>
                  <a:close/>
                  <a:moveTo>
                    <a:pt x="445" y="0"/>
                  </a:moveTo>
                  <a:lnTo>
                    <a:pt x="457" y="0"/>
                  </a:lnTo>
                  <a:lnTo>
                    <a:pt x="457" y="4"/>
                  </a:lnTo>
                  <a:lnTo>
                    <a:pt x="445" y="4"/>
                  </a:lnTo>
                  <a:lnTo>
                    <a:pt x="445" y="0"/>
                  </a:lnTo>
                  <a:close/>
                  <a:moveTo>
                    <a:pt x="461" y="0"/>
                  </a:moveTo>
                  <a:lnTo>
                    <a:pt x="472" y="0"/>
                  </a:lnTo>
                  <a:lnTo>
                    <a:pt x="472" y="4"/>
                  </a:lnTo>
                  <a:lnTo>
                    <a:pt x="461" y="4"/>
                  </a:lnTo>
                  <a:lnTo>
                    <a:pt x="461" y="0"/>
                  </a:lnTo>
                  <a:close/>
                  <a:moveTo>
                    <a:pt x="476" y="0"/>
                  </a:moveTo>
                  <a:lnTo>
                    <a:pt x="488" y="0"/>
                  </a:lnTo>
                  <a:lnTo>
                    <a:pt x="488" y="4"/>
                  </a:lnTo>
                  <a:lnTo>
                    <a:pt x="476" y="4"/>
                  </a:lnTo>
                  <a:lnTo>
                    <a:pt x="476" y="0"/>
                  </a:lnTo>
                  <a:close/>
                  <a:moveTo>
                    <a:pt x="491" y="0"/>
                  </a:moveTo>
                  <a:lnTo>
                    <a:pt x="503" y="0"/>
                  </a:lnTo>
                  <a:lnTo>
                    <a:pt x="503" y="4"/>
                  </a:lnTo>
                  <a:lnTo>
                    <a:pt x="491" y="4"/>
                  </a:lnTo>
                  <a:lnTo>
                    <a:pt x="491" y="0"/>
                  </a:lnTo>
                  <a:close/>
                  <a:moveTo>
                    <a:pt x="507" y="0"/>
                  </a:moveTo>
                  <a:lnTo>
                    <a:pt x="518" y="0"/>
                  </a:lnTo>
                  <a:lnTo>
                    <a:pt x="518" y="4"/>
                  </a:lnTo>
                  <a:lnTo>
                    <a:pt x="507" y="4"/>
                  </a:lnTo>
                  <a:lnTo>
                    <a:pt x="507" y="0"/>
                  </a:lnTo>
                  <a:close/>
                  <a:moveTo>
                    <a:pt x="522" y="0"/>
                  </a:moveTo>
                  <a:lnTo>
                    <a:pt x="534" y="0"/>
                  </a:lnTo>
                  <a:lnTo>
                    <a:pt x="534" y="4"/>
                  </a:lnTo>
                  <a:lnTo>
                    <a:pt x="522" y="4"/>
                  </a:lnTo>
                  <a:lnTo>
                    <a:pt x="522" y="0"/>
                  </a:lnTo>
                  <a:close/>
                  <a:moveTo>
                    <a:pt x="537" y="0"/>
                  </a:moveTo>
                  <a:lnTo>
                    <a:pt x="549" y="0"/>
                  </a:lnTo>
                  <a:lnTo>
                    <a:pt x="549" y="4"/>
                  </a:lnTo>
                  <a:lnTo>
                    <a:pt x="537" y="4"/>
                  </a:lnTo>
                  <a:lnTo>
                    <a:pt x="537" y="0"/>
                  </a:lnTo>
                  <a:close/>
                  <a:moveTo>
                    <a:pt x="553" y="0"/>
                  </a:moveTo>
                  <a:lnTo>
                    <a:pt x="564" y="0"/>
                  </a:lnTo>
                  <a:lnTo>
                    <a:pt x="564" y="4"/>
                  </a:lnTo>
                  <a:lnTo>
                    <a:pt x="553" y="4"/>
                  </a:lnTo>
                  <a:lnTo>
                    <a:pt x="553" y="0"/>
                  </a:lnTo>
                  <a:close/>
                  <a:moveTo>
                    <a:pt x="568" y="0"/>
                  </a:moveTo>
                  <a:lnTo>
                    <a:pt x="580" y="0"/>
                  </a:lnTo>
                  <a:lnTo>
                    <a:pt x="580" y="4"/>
                  </a:lnTo>
                  <a:lnTo>
                    <a:pt x="568" y="4"/>
                  </a:lnTo>
                  <a:lnTo>
                    <a:pt x="568" y="0"/>
                  </a:lnTo>
                  <a:close/>
                  <a:moveTo>
                    <a:pt x="584" y="0"/>
                  </a:moveTo>
                  <a:lnTo>
                    <a:pt x="595" y="0"/>
                  </a:lnTo>
                  <a:lnTo>
                    <a:pt x="595" y="4"/>
                  </a:lnTo>
                  <a:lnTo>
                    <a:pt x="584" y="4"/>
                  </a:lnTo>
                  <a:lnTo>
                    <a:pt x="584" y="0"/>
                  </a:lnTo>
                  <a:close/>
                  <a:moveTo>
                    <a:pt x="599" y="0"/>
                  </a:moveTo>
                  <a:lnTo>
                    <a:pt x="610" y="0"/>
                  </a:lnTo>
                  <a:lnTo>
                    <a:pt x="610" y="4"/>
                  </a:lnTo>
                  <a:lnTo>
                    <a:pt x="599" y="4"/>
                  </a:lnTo>
                  <a:lnTo>
                    <a:pt x="599" y="0"/>
                  </a:lnTo>
                  <a:close/>
                  <a:moveTo>
                    <a:pt x="614" y="0"/>
                  </a:moveTo>
                  <a:lnTo>
                    <a:pt x="626" y="0"/>
                  </a:lnTo>
                  <a:lnTo>
                    <a:pt x="626" y="4"/>
                  </a:lnTo>
                  <a:lnTo>
                    <a:pt x="614" y="4"/>
                  </a:lnTo>
                  <a:lnTo>
                    <a:pt x="614" y="0"/>
                  </a:lnTo>
                  <a:close/>
                  <a:moveTo>
                    <a:pt x="630" y="0"/>
                  </a:moveTo>
                  <a:lnTo>
                    <a:pt x="641" y="0"/>
                  </a:lnTo>
                  <a:lnTo>
                    <a:pt x="641" y="4"/>
                  </a:lnTo>
                  <a:lnTo>
                    <a:pt x="630" y="4"/>
                  </a:lnTo>
                  <a:lnTo>
                    <a:pt x="630" y="0"/>
                  </a:lnTo>
                  <a:close/>
                  <a:moveTo>
                    <a:pt x="645" y="0"/>
                  </a:moveTo>
                  <a:lnTo>
                    <a:pt x="657" y="0"/>
                  </a:lnTo>
                  <a:lnTo>
                    <a:pt x="657" y="4"/>
                  </a:lnTo>
                  <a:lnTo>
                    <a:pt x="645" y="4"/>
                  </a:lnTo>
                  <a:lnTo>
                    <a:pt x="645" y="0"/>
                  </a:lnTo>
                  <a:close/>
                  <a:moveTo>
                    <a:pt x="660" y="0"/>
                  </a:moveTo>
                  <a:lnTo>
                    <a:pt x="672" y="0"/>
                  </a:lnTo>
                  <a:lnTo>
                    <a:pt x="672" y="4"/>
                  </a:lnTo>
                  <a:lnTo>
                    <a:pt x="660" y="4"/>
                  </a:lnTo>
                  <a:lnTo>
                    <a:pt x="660" y="0"/>
                  </a:lnTo>
                  <a:close/>
                  <a:moveTo>
                    <a:pt x="676" y="0"/>
                  </a:moveTo>
                  <a:lnTo>
                    <a:pt x="687" y="0"/>
                  </a:lnTo>
                  <a:lnTo>
                    <a:pt x="687" y="4"/>
                  </a:lnTo>
                  <a:lnTo>
                    <a:pt x="676" y="4"/>
                  </a:lnTo>
                  <a:lnTo>
                    <a:pt x="676" y="0"/>
                  </a:lnTo>
                  <a:close/>
                  <a:moveTo>
                    <a:pt x="691" y="0"/>
                  </a:moveTo>
                  <a:lnTo>
                    <a:pt x="703" y="0"/>
                  </a:lnTo>
                  <a:lnTo>
                    <a:pt x="703" y="4"/>
                  </a:lnTo>
                  <a:lnTo>
                    <a:pt x="691" y="4"/>
                  </a:lnTo>
                  <a:lnTo>
                    <a:pt x="691" y="0"/>
                  </a:lnTo>
                  <a:close/>
                  <a:moveTo>
                    <a:pt x="706" y="0"/>
                  </a:moveTo>
                  <a:lnTo>
                    <a:pt x="718" y="0"/>
                  </a:lnTo>
                  <a:lnTo>
                    <a:pt x="718" y="4"/>
                  </a:lnTo>
                  <a:lnTo>
                    <a:pt x="706" y="4"/>
                  </a:lnTo>
                  <a:lnTo>
                    <a:pt x="706" y="0"/>
                  </a:lnTo>
                  <a:close/>
                  <a:moveTo>
                    <a:pt x="722" y="0"/>
                  </a:moveTo>
                  <a:lnTo>
                    <a:pt x="733" y="0"/>
                  </a:lnTo>
                  <a:lnTo>
                    <a:pt x="733" y="4"/>
                  </a:lnTo>
                  <a:lnTo>
                    <a:pt x="722" y="4"/>
                  </a:lnTo>
                  <a:lnTo>
                    <a:pt x="722" y="0"/>
                  </a:lnTo>
                  <a:close/>
                  <a:moveTo>
                    <a:pt x="737" y="0"/>
                  </a:moveTo>
                  <a:lnTo>
                    <a:pt x="749" y="0"/>
                  </a:lnTo>
                  <a:lnTo>
                    <a:pt x="749" y="4"/>
                  </a:lnTo>
                  <a:lnTo>
                    <a:pt x="737" y="4"/>
                  </a:lnTo>
                  <a:lnTo>
                    <a:pt x="737" y="0"/>
                  </a:lnTo>
                  <a:close/>
                  <a:moveTo>
                    <a:pt x="753" y="0"/>
                  </a:moveTo>
                  <a:lnTo>
                    <a:pt x="764" y="0"/>
                  </a:lnTo>
                  <a:lnTo>
                    <a:pt x="764" y="4"/>
                  </a:lnTo>
                  <a:lnTo>
                    <a:pt x="753" y="4"/>
                  </a:lnTo>
                  <a:lnTo>
                    <a:pt x="753" y="0"/>
                  </a:lnTo>
                  <a:close/>
                  <a:moveTo>
                    <a:pt x="768" y="0"/>
                  </a:moveTo>
                  <a:lnTo>
                    <a:pt x="779" y="0"/>
                  </a:lnTo>
                  <a:lnTo>
                    <a:pt x="779" y="4"/>
                  </a:lnTo>
                  <a:lnTo>
                    <a:pt x="768" y="4"/>
                  </a:lnTo>
                  <a:lnTo>
                    <a:pt x="768" y="0"/>
                  </a:lnTo>
                  <a:close/>
                  <a:moveTo>
                    <a:pt x="783" y="0"/>
                  </a:moveTo>
                  <a:lnTo>
                    <a:pt x="795" y="0"/>
                  </a:lnTo>
                  <a:lnTo>
                    <a:pt x="795" y="4"/>
                  </a:lnTo>
                  <a:lnTo>
                    <a:pt x="783" y="4"/>
                  </a:lnTo>
                  <a:lnTo>
                    <a:pt x="783" y="0"/>
                  </a:lnTo>
                  <a:close/>
                  <a:moveTo>
                    <a:pt x="799" y="0"/>
                  </a:moveTo>
                  <a:lnTo>
                    <a:pt x="810" y="0"/>
                  </a:lnTo>
                  <a:lnTo>
                    <a:pt x="810" y="4"/>
                  </a:lnTo>
                  <a:lnTo>
                    <a:pt x="799" y="4"/>
                  </a:lnTo>
                  <a:lnTo>
                    <a:pt x="799" y="0"/>
                  </a:lnTo>
                  <a:close/>
                  <a:moveTo>
                    <a:pt x="814" y="0"/>
                  </a:moveTo>
                  <a:lnTo>
                    <a:pt x="825" y="0"/>
                  </a:lnTo>
                  <a:lnTo>
                    <a:pt x="825" y="4"/>
                  </a:lnTo>
                  <a:lnTo>
                    <a:pt x="814" y="4"/>
                  </a:lnTo>
                  <a:lnTo>
                    <a:pt x="814" y="0"/>
                  </a:lnTo>
                  <a:close/>
                  <a:moveTo>
                    <a:pt x="829" y="0"/>
                  </a:moveTo>
                  <a:lnTo>
                    <a:pt x="841" y="0"/>
                  </a:lnTo>
                  <a:lnTo>
                    <a:pt x="841" y="4"/>
                  </a:lnTo>
                  <a:lnTo>
                    <a:pt x="829" y="4"/>
                  </a:lnTo>
                  <a:lnTo>
                    <a:pt x="829" y="0"/>
                  </a:lnTo>
                  <a:close/>
                  <a:moveTo>
                    <a:pt x="845" y="0"/>
                  </a:moveTo>
                  <a:lnTo>
                    <a:pt x="856" y="0"/>
                  </a:lnTo>
                  <a:lnTo>
                    <a:pt x="856" y="4"/>
                  </a:lnTo>
                  <a:lnTo>
                    <a:pt x="845" y="4"/>
                  </a:lnTo>
                  <a:lnTo>
                    <a:pt x="845" y="0"/>
                  </a:lnTo>
                  <a:close/>
                  <a:moveTo>
                    <a:pt x="860" y="0"/>
                  </a:moveTo>
                  <a:lnTo>
                    <a:pt x="872" y="0"/>
                  </a:lnTo>
                  <a:lnTo>
                    <a:pt x="872" y="4"/>
                  </a:lnTo>
                  <a:lnTo>
                    <a:pt x="860" y="4"/>
                  </a:lnTo>
                  <a:lnTo>
                    <a:pt x="860" y="0"/>
                  </a:lnTo>
                  <a:close/>
                  <a:moveTo>
                    <a:pt x="875" y="0"/>
                  </a:moveTo>
                  <a:lnTo>
                    <a:pt x="887" y="0"/>
                  </a:lnTo>
                  <a:lnTo>
                    <a:pt x="887" y="4"/>
                  </a:lnTo>
                  <a:lnTo>
                    <a:pt x="875" y="4"/>
                  </a:lnTo>
                  <a:lnTo>
                    <a:pt x="875" y="0"/>
                  </a:lnTo>
                  <a:close/>
                  <a:moveTo>
                    <a:pt x="891" y="0"/>
                  </a:moveTo>
                  <a:lnTo>
                    <a:pt x="902" y="0"/>
                  </a:lnTo>
                  <a:lnTo>
                    <a:pt x="902" y="4"/>
                  </a:lnTo>
                  <a:lnTo>
                    <a:pt x="891" y="4"/>
                  </a:lnTo>
                  <a:lnTo>
                    <a:pt x="891" y="0"/>
                  </a:lnTo>
                  <a:close/>
                  <a:moveTo>
                    <a:pt x="906" y="0"/>
                  </a:moveTo>
                  <a:lnTo>
                    <a:pt x="918" y="0"/>
                  </a:lnTo>
                  <a:lnTo>
                    <a:pt x="918" y="4"/>
                  </a:lnTo>
                  <a:lnTo>
                    <a:pt x="906" y="4"/>
                  </a:lnTo>
                  <a:lnTo>
                    <a:pt x="906" y="0"/>
                  </a:lnTo>
                  <a:close/>
                  <a:moveTo>
                    <a:pt x="921" y="0"/>
                  </a:moveTo>
                  <a:lnTo>
                    <a:pt x="933" y="0"/>
                  </a:lnTo>
                  <a:lnTo>
                    <a:pt x="933" y="4"/>
                  </a:lnTo>
                  <a:lnTo>
                    <a:pt x="921" y="4"/>
                  </a:lnTo>
                  <a:lnTo>
                    <a:pt x="921" y="0"/>
                  </a:lnTo>
                  <a:close/>
                  <a:moveTo>
                    <a:pt x="937" y="0"/>
                  </a:moveTo>
                  <a:lnTo>
                    <a:pt x="948" y="0"/>
                  </a:lnTo>
                  <a:lnTo>
                    <a:pt x="948" y="4"/>
                  </a:lnTo>
                  <a:lnTo>
                    <a:pt x="937" y="4"/>
                  </a:lnTo>
                  <a:lnTo>
                    <a:pt x="937" y="0"/>
                  </a:lnTo>
                  <a:close/>
                  <a:moveTo>
                    <a:pt x="952" y="0"/>
                  </a:moveTo>
                  <a:lnTo>
                    <a:pt x="964" y="0"/>
                  </a:lnTo>
                  <a:lnTo>
                    <a:pt x="964" y="4"/>
                  </a:lnTo>
                  <a:lnTo>
                    <a:pt x="952" y="4"/>
                  </a:lnTo>
                  <a:lnTo>
                    <a:pt x="952" y="0"/>
                  </a:lnTo>
                  <a:close/>
                  <a:moveTo>
                    <a:pt x="968" y="0"/>
                  </a:moveTo>
                  <a:lnTo>
                    <a:pt x="979" y="0"/>
                  </a:lnTo>
                  <a:lnTo>
                    <a:pt x="979" y="4"/>
                  </a:lnTo>
                  <a:lnTo>
                    <a:pt x="968" y="4"/>
                  </a:lnTo>
                  <a:lnTo>
                    <a:pt x="968" y="0"/>
                  </a:lnTo>
                  <a:close/>
                  <a:moveTo>
                    <a:pt x="983" y="0"/>
                  </a:moveTo>
                  <a:lnTo>
                    <a:pt x="994" y="0"/>
                  </a:lnTo>
                  <a:lnTo>
                    <a:pt x="994" y="4"/>
                  </a:lnTo>
                  <a:lnTo>
                    <a:pt x="983" y="4"/>
                  </a:lnTo>
                  <a:lnTo>
                    <a:pt x="983" y="0"/>
                  </a:lnTo>
                  <a:close/>
                  <a:moveTo>
                    <a:pt x="998" y="0"/>
                  </a:moveTo>
                  <a:lnTo>
                    <a:pt x="1010" y="0"/>
                  </a:lnTo>
                  <a:lnTo>
                    <a:pt x="1010" y="4"/>
                  </a:lnTo>
                  <a:lnTo>
                    <a:pt x="998" y="4"/>
                  </a:lnTo>
                  <a:lnTo>
                    <a:pt x="998" y="0"/>
                  </a:lnTo>
                  <a:close/>
                  <a:moveTo>
                    <a:pt x="1014" y="0"/>
                  </a:moveTo>
                  <a:lnTo>
                    <a:pt x="1025" y="0"/>
                  </a:lnTo>
                  <a:lnTo>
                    <a:pt x="1025" y="4"/>
                  </a:lnTo>
                  <a:lnTo>
                    <a:pt x="1014" y="4"/>
                  </a:lnTo>
                  <a:lnTo>
                    <a:pt x="1014" y="0"/>
                  </a:lnTo>
                  <a:close/>
                  <a:moveTo>
                    <a:pt x="1029" y="0"/>
                  </a:moveTo>
                  <a:lnTo>
                    <a:pt x="1041" y="0"/>
                  </a:lnTo>
                  <a:lnTo>
                    <a:pt x="1041" y="4"/>
                  </a:lnTo>
                  <a:lnTo>
                    <a:pt x="1029" y="4"/>
                  </a:lnTo>
                  <a:lnTo>
                    <a:pt x="1029" y="0"/>
                  </a:lnTo>
                  <a:close/>
                  <a:moveTo>
                    <a:pt x="1044" y="0"/>
                  </a:moveTo>
                  <a:lnTo>
                    <a:pt x="1056" y="0"/>
                  </a:lnTo>
                  <a:lnTo>
                    <a:pt x="1056" y="4"/>
                  </a:lnTo>
                  <a:lnTo>
                    <a:pt x="1044" y="4"/>
                  </a:lnTo>
                  <a:lnTo>
                    <a:pt x="1044" y="0"/>
                  </a:lnTo>
                  <a:close/>
                  <a:moveTo>
                    <a:pt x="1060" y="0"/>
                  </a:moveTo>
                  <a:lnTo>
                    <a:pt x="1071" y="0"/>
                  </a:lnTo>
                  <a:lnTo>
                    <a:pt x="1071" y="4"/>
                  </a:lnTo>
                  <a:lnTo>
                    <a:pt x="1060" y="4"/>
                  </a:lnTo>
                  <a:lnTo>
                    <a:pt x="1060" y="0"/>
                  </a:lnTo>
                  <a:close/>
                  <a:moveTo>
                    <a:pt x="1075" y="0"/>
                  </a:moveTo>
                  <a:lnTo>
                    <a:pt x="1087" y="0"/>
                  </a:lnTo>
                  <a:lnTo>
                    <a:pt x="1087" y="4"/>
                  </a:lnTo>
                  <a:lnTo>
                    <a:pt x="1075" y="4"/>
                  </a:lnTo>
                  <a:lnTo>
                    <a:pt x="1075" y="0"/>
                  </a:lnTo>
                  <a:close/>
                  <a:moveTo>
                    <a:pt x="1090" y="0"/>
                  </a:moveTo>
                  <a:lnTo>
                    <a:pt x="1102" y="1"/>
                  </a:lnTo>
                  <a:lnTo>
                    <a:pt x="1102" y="4"/>
                  </a:lnTo>
                  <a:lnTo>
                    <a:pt x="1090" y="4"/>
                  </a:lnTo>
                  <a:lnTo>
                    <a:pt x="1090" y="0"/>
                  </a:lnTo>
                  <a:close/>
                  <a:moveTo>
                    <a:pt x="1106" y="1"/>
                  </a:moveTo>
                  <a:lnTo>
                    <a:pt x="1117" y="1"/>
                  </a:lnTo>
                  <a:lnTo>
                    <a:pt x="1117" y="4"/>
                  </a:lnTo>
                  <a:lnTo>
                    <a:pt x="1106" y="4"/>
                  </a:lnTo>
                  <a:lnTo>
                    <a:pt x="1106" y="1"/>
                  </a:lnTo>
                  <a:close/>
                  <a:moveTo>
                    <a:pt x="1121" y="1"/>
                  </a:moveTo>
                  <a:lnTo>
                    <a:pt x="1133" y="1"/>
                  </a:lnTo>
                  <a:lnTo>
                    <a:pt x="1133" y="4"/>
                  </a:lnTo>
                  <a:lnTo>
                    <a:pt x="1121" y="4"/>
                  </a:lnTo>
                  <a:lnTo>
                    <a:pt x="1121" y="1"/>
                  </a:lnTo>
                  <a:close/>
                  <a:moveTo>
                    <a:pt x="1136" y="1"/>
                  </a:moveTo>
                  <a:lnTo>
                    <a:pt x="1148" y="1"/>
                  </a:lnTo>
                  <a:lnTo>
                    <a:pt x="1148" y="4"/>
                  </a:lnTo>
                  <a:lnTo>
                    <a:pt x="1136" y="4"/>
                  </a:lnTo>
                  <a:lnTo>
                    <a:pt x="1136" y="1"/>
                  </a:lnTo>
                  <a:close/>
                  <a:moveTo>
                    <a:pt x="1152" y="1"/>
                  </a:moveTo>
                  <a:lnTo>
                    <a:pt x="1163" y="1"/>
                  </a:lnTo>
                  <a:lnTo>
                    <a:pt x="1163" y="4"/>
                  </a:lnTo>
                  <a:lnTo>
                    <a:pt x="1152" y="4"/>
                  </a:lnTo>
                  <a:lnTo>
                    <a:pt x="1152" y="1"/>
                  </a:lnTo>
                  <a:close/>
                  <a:moveTo>
                    <a:pt x="1167" y="1"/>
                  </a:moveTo>
                  <a:lnTo>
                    <a:pt x="1179" y="1"/>
                  </a:lnTo>
                  <a:lnTo>
                    <a:pt x="1179" y="4"/>
                  </a:lnTo>
                  <a:lnTo>
                    <a:pt x="1167" y="4"/>
                  </a:lnTo>
                  <a:lnTo>
                    <a:pt x="1167" y="1"/>
                  </a:lnTo>
                  <a:close/>
                  <a:moveTo>
                    <a:pt x="1183" y="1"/>
                  </a:moveTo>
                  <a:lnTo>
                    <a:pt x="1194" y="1"/>
                  </a:lnTo>
                  <a:lnTo>
                    <a:pt x="1194" y="4"/>
                  </a:lnTo>
                  <a:lnTo>
                    <a:pt x="1183" y="4"/>
                  </a:lnTo>
                  <a:lnTo>
                    <a:pt x="1183" y="1"/>
                  </a:lnTo>
                  <a:close/>
                  <a:moveTo>
                    <a:pt x="1198" y="1"/>
                  </a:moveTo>
                  <a:lnTo>
                    <a:pt x="1209" y="1"/>
                  </a:lnTo>
                  <a:lnTo>
                    <a:pt x="1209" y="4"/>
                  </a:lnTo>
                  <a:lnTo>
                    <a:pt x="1198" y="4"/>
                  </a:lnTo>
                  <a:lnTo>
                    <a:pt x="1198" y="1"/>
                  </a:lnTo>
                  <a:close/>
                  <a:moveTo>
                    <a:pt x="1213" y="1"/>
                  </a:moveTo>
                  <a:lnTo>
                    <a:pt x="1225" y="1"/>
                  </a:lnTo>
                  <a:lnTo>
                    <a:pt x="1225" y="4"/>
                  </a:lnTo>
                  <a:lnTo>
                    <a:pt x="1213" y="4"/>
                  </a:lnTo>
                  <a:lnTo>
                    <a:pt x="1213" y="1"/>
                  </a:lnTo>
                  <a:close/>
                  <a:moveTo>
                    <a:pt x="1229" y="1"/>
                  </a:moveTo>
                  <a:lnTo>
                    <a:pt x="1240" y="1"/>
                  </a:lnTo>
                  <a:lnTo>
                    <a:pt x="1240" y="4"/>
                  </a:lnTo>
                  <a:lnTo>
                    <a:pt x="1229" y="4"/>
                  </a:lnTo>
                  <a:lnTo>
                    <a:pt x="1229" y="1"/>
                  </a:lnTo>
                  <a:close/>
                  <a:moveTo>
                    <a:pt x="1244" y="1"/>
                  </a:moveTo>
                  <a:lnTo>
                    <a:pt x="1256" y="1"/>
                  </a:lnTo>
                  <a:lnTo>
                    <a:pt x="1256" y="4"/>
                  </a:lnTo>
                  <a:lnTo>
                    <a:pt x="1244" y="4"/>
                  </a:lnTo>
                  <a:lnTo>
                    <a:pt x="1244" y="1"/>
                  </a:lnTo>
                  <a:close/>
                  <a:moveTo>
                    <a:pt x="1259" y="1"/>
                  </a:moveTo>
                  <a:lnTo>
                    <a:pt x="1271" y="1"/>
                  </a:lnTo>
                  <a:lnTo>
                    <a:pt x="1271" y="4"/>
                  </a:lnTo>
                  <a:lnTo>
                    <a:pt x="1259" y="4"/>
                  </a:lnTo>
                  <a:lnTo>
                    <a:pt x="1259" y="1"/>
                  </a:lnTo>
                  <a:close/>
                  <a:moveTo>
                    <a:pt x="1275" y="1"/>
                  </a:moveTo>
                  <a:lnTo>
                    <a:pt x="1286" y="1"/>
                  </a:lnTo>
                  <a:lnTo>
                    <a:pt x="1286" y="4"/>
                  </a:lnTo>
                  <a:lnTo>
                    <a:pt x="1275" y="4"/>
                  </a:lnTo>
                  <a:lnTo>
                    <a:pt x="1275" y="1"/>
                  </a:lnTo>
                  <a:close/>
                  <a:moveTo>
                    <a:pt x="1290" y="1"/>
                  </a:moveTo>
                  <a:lnTo>
                    <a:pt x="1302" y="1"/>
                  </a:lnTo>
                  <a:lnTo>
                    <a:pt x="1302" y="4"/>
                  </a:lnTo>
                  <a:lnTo>
                    <a:pt x="1290" y="4"/>
                  </a:lnTo>
                  <a:lnTo>
                    <a:pt x="1290" y="1"/>
                  </a:lnTo>
                  <a:close/>
                  <a:moveTo>
                    <a:pt x="1305" y="1"/>
                  </a:moveTo>
                  <a:lnTo>
                    <a:pt x="1317" y="1"/>
                  </a:lnTo>
                  <a:lnTo>
                    <a:pt x="1317" y="4"/>
                  </a:lnTo>
                  <a:lnTo>
                    <a:pt x="1305" y="4"/>
                  </a:lnTo>
                  <a:lnTo>
                    <a:pt x="1305" y="1"/>
                  </a:lnTo>
                  <a:close/>
                  <a:moveTo>
                    <a:pt x="1321" y="1"/>
                  </a:moveTo>
                  <a:lnTo>
                    <a:pt x="1332" y="1"/>
                  </a:lnTo>
                  <a:lnTo>
                    <a:pt x="1332" y="4"/>
                  </a:lnTo>
                  <a:lnTo>
                    <a:pt x="1321" y="4"/>
                  </a:lnTo>
                  <a:lnTo>
                    <a:pt x="1321" y="1"/>
                  </a:lnTo>
                  <a:close/>
                  <a:moveTo>
                    <a:pt x="1336" y="1"/>
                  </a:moveTo>
                  <a:lnTo>
                    <a:pt x="1348" y="1"/>
                  </a:lnTo>
                  <a:lnTo>
                    <a:pt x="1348" y="4"/>
                  </a:lnTo>
                  <a:lnTo>
                    <a:pt x="1336" y="4"/>
                  </a:lnTo>
                  <a:lnTo>
                    <a:pt x="1336" y="1"/>
                  </a:lnTo>
                  <a:close/>
                  <a:moveTo>
                    <a:pt x="1352" y="1"/>
                  </a:moveTo>
                  <a:lnTo>
                    <a:pt x="1363" y="1"/>
                  </a:lnTo>
                  <a:lnTo>
                    <a:pt x="1363" y="4"/>
                  </a:lnTo>
                  <a:lnTo>
                    <a:pt x="1352" y="4"/>
                  </a:lnTo>
                  <a:lnTo>
                    <a:pt x="1352" y="1"/>
                  </a:lnTo>
                  <a:close/>
                  <a:moveTo>
                    <a:pt x="1367" y="1"/>
                  </a:moveTo>
                  <a:lnTo>
                    <a:pt x="1378" y="1"/>
                  </a:lnTo>
                  <a:lnTo>
                    <a:pt x="1378" y="4"/>
                  </a:lnTo>
                  <a:lnTo>
                    <a:pt x="1367" y="4"/>
                  </a:lnTo>
                  <a:lnTo>
                    <a:pt x="1367" y="1"/>
                  </a:lnTo>
                  <a:close/>
                  <a:moveTo>
                    <a:pt x="1382" y="1"/>
                  </a:moveTo>
                  <a:lnTo>
                    <a:pt x="1394" y="1"/>
                  </a:lnTo>
                  <a:lnTo>
                    <a:pt x="1394" y="4"/>
                  </a:lnTo>
                  <a:lnTo>
                    <a:pt x="1382" y="4"/>
                  </a:lnTo>
                  <a:lnTo>
                    <a:pt x="1382" y="1"/>
                  </a:lnTo>
                  <a:close/>
                  <a:moveTo>
                    <a:pt x="1398" y="1"/>
                  </a:moveTo>
                  <a:lnTo>
                    <a:pt x="1409" y="1"/>
                  </a:lnTo>
                  <a:lnTo>
                    <a:pt x="1409" y="4"/>
                  </a:lnTo>
                  <a:lnTo>
                    <a:pt x="1398" y="4"/>
                  </a:lnTo>
                  <a:lnTo>
                    <a:pt x="1398" y="1"/>
                  </a:lnTo>
                  <a:close/>
                  <a:moveTo>
                    <a:pt x="1413" y="1"/>
                  </a:moveTo>
                  <a:lnTo>
                    <a:pt x="1424" y="1"/>
                  </a:lnTo>
                  <a:lnTo>
                    <a:pt x="1424" y="4"/>
                  </a:lnTo>
                  <a:lnTo>
                    <a:pt x="1413" y="4"/>
                  </a:lnTo>
                  <a:lnTo>
                    <a:pt x="1413" y="1"/>
                  </a:lnTo>
                  <a:close/>
                  <a:moveTo>
                    <a:pt x="1428" y="1"/>
                  </a:moveTo>
                  <a:lnTo>
                    <a:pt x="1440" y="1"/>
                  </a:lnTo>
                  <a:lnTo>
                    <a:pt x="1440" y="4"/>
                  </a:lnTo>
                  <a:lnTo>
                    <a:pt x="1428" y="4"/>
                  </a:lnTo>
                  <a:lnTo>
                    <a:pt x="1428" y="1"/>
                  </a:lnTo>
                  <a:close/>
                  <a:moveTo>
                    <a:pt x="1444" y="1"/>
                  </a:moveTo>
                  <a:lnTo>
                    <a:pt x="1455" y="1"/>
                  </a:lnTo>
                  <a:lnTo>
                    <a:pt x="1455" y="4"/>
                  </a:lnTo>
                  <a:lnTo>
                    <a:pt x="1444" y="4"/>
                  </a:lnTo>
                  <a:lnTo>
                    <a:pt x="1444" y="1"/>
                  </a:lnTo>
                  <a:close/>
                  <a:moveTo>
                    <a:pt x="1459" y="1"/>
                  </a:moveTo>
                  <a:lnTo>
                    <a:pt x="1471" y="1"/>
                  </a:lnTo>
                  <a:lnTo>
                    <a:pt x="1471" y="4"/>
                  </a:lnTo>
                  <a:lnTo>
                    <a:pt x="1459" y="4"/>
                  </a:lnTo>
                  <a:lnTo>
                    <a:pt x="1459" y="1"/>
                  </a:lnTo>
                  <a:close/>
                  <a:moveTo>
                    <a:pt x="1474" y="1"/>
                  </a:moveTo>
                  <a:lnTo>
                    <a:pt x="1486" y="1"/>
                  </a:lnTo>
                  <a:lnTo>
                    <a:pt x="1486" y="4"/>
                  </a:lnTo>
                  <a:lnTo>
                    <a:pt x="1474" y="4"/>
                  </a:lnTo>
                  <a:lnTo>
                    <a:pt x="1474" y="1"/>
                  </a:lnTo>
                  <a:close/>
                  <a:moveTo>
                    <a:pt x="1490" y="1"/>
                  </a:moveTo>
                  <a:lnTo>
                    <a:pt x="1501" y="1"/>
                  </a:lnTo>
                  <a:lnTo>
                    <a:pt x="1501" y="4"/>
                  </a:lnTo>
                  <a:lnTo>
                    <a:pt x="1490" y="4"/>
                  </a:lnTo>
                  <a:lnTo>
                    <a:pt x="1490" y="1"/>
                  </a:lnTo>
                  <a:close/>
                  <a:moveTo>
                    <a:pt x="1505" y="1"/>
                  </a:moveTo>
                  <a:lnTo>
                    <a:pt x="1517" y="1"/>
                  </a:lnTo>
                  <a:lnTo>
                    <a:pt x="1517" y="4"/>
                  </a:lnTo>
                  <a:lnTo>
                    <a:pt x="1505" y="4"/>
                  </a:lnTo>
                  <a:lnTo>
                    <a:pt x="1505" y="1"/>
                  </a:lnTo>
                  <a:close/>
                  <a:moveTo>
                    <a:pt x="1520" y="1"/>
                  </a:moveTo>
                  <a:lnTo>
                    <a:pt x="1532" y="1"/>
                  </a:lnTo>
                  <a:lnTo>
                    <a:pt x="1532" y="4"/>
                  </a:lnTo>
                  <a:lnTo>
                    <a:pt x="1520" y="4"/>
                  </a:lnTo>
                  <a:lnTo>
                    <a:pt x="1520" y="1"/>
                  </a:lnTo>
                  <a:close/>
                  <a:moveTo>
                    <a:pt x="1536" y="1"/>
                  </a:moveTo>
                  <a:lnTo>
                    <a:pt x="1547" y="1"/>
                  </a:lnTo>
                  <a:lnTo>
                    <a:pt x="1547" y="4"/>
                  </a:lnTo>
                  <a:lnTo>
                    <a:pt x="1536" y="4"/>
                  </a:lnTo>
                  <a:lnTo>
                    <a:pt x="1536" y="1"/>
                  </a:lnTo>
                  <a:close/>
                  <a:moveTo>
                    <a:pt x="1551" y="1"/>
                  </a:moveTo>
                  <a:lnTo>
                    <a:pt x="1563" y="1"/>
                  </a:lnTo>
                  <a:lnTo>
                    <a:pt x="1563" y="4"/>
                  </a:lnTo>
                  <a:lnTo>
                    <a:pt x="1551" y="4"/>
                  </a:lnTo>
                  <a:lnTo>
                    <a:pt x="1551" y="1"/>
                  </a:lnTo>
                  <a:close/>
                  <a:moveTo>
                    <a:pt x="1567" y="1"/>
                  </a:moveTo>
                  <a:lnTo>
                    <a:pt x="1578" y="1"/>
                  </a:lnTo>
                  <a:lnTo>
                    <a:pt x="1578" y="4"/>
                  </a:lnTo>
                  <a:lnTo>
                    <a:pt x="1567" y="4"/>
                  </a:lnTo>
                  <a:lnTo>
                    <a:pt x="1567" y="1"/>
                  </a:lnTo>
                  <a:close/>
                  <a:moveTo>
                    <a:pt x="1582" y="1"/>
                  </a:moveTo>
                  <a:lnTo>
                    <a:pt x="1593" y="1"/>
                  </a:lnTo>
                  <a:lnTo>
                    <a:pt x="1593" y="4"/>
                  </a:lnTo>
                  <a:lnTo>
                    <a:pt x="1582" y="4"/>
                  </a:lnTo>
                  <a:lnTo>
                    <a:pt x="1582" y="1"/>
                  </a:lnTo>
                  <a:close/>
                  <a:moveTo>
                    <a:pt x="1597" y="1"/>
                  </a:moveTo>
                  <a:lnTo>
                    <a:pt x="1609" y="1"/>
                  </a:lnTo>
                  <a:lnTo>
                    <a:pt x="1609" y="4"/>
                  </a:lnTo>
                  <a:lnTo>
                    <a:pt x="1597" y="4"/>
                  </a:lnTo>
                  <a:lnTo>
                    <a:pt x="1597" y="1"/>
                  </a:lnTo>
                  <a:close/>
                  <a:moveTo>
                    <a:pt x="1613" y="1"/>
                  </a:moveTo>
                  <a:lnTo>
                    <a:pt x="1624" y="1"/>
                  </a:lnTo>
                  <a:lnTo>
                    <a:pt x="1624" y="4"/>
                  </a:lnTo>
                  <a:lnTo>
                    <a:pt x="1613" y="4"/>
                  </a:lnTo>
                  <a:lnTo>
                    <a:pt x="1613" y="1"/>
                  </a:lnTo>
                  <a:close/>
                  <a:moveTo>
                    <a:pt x="1628" y="1"/>
                  </a:moveTo>
                  <a:lnTo>
                    <a:pt x="1640" y="1"/>
                  </a:lnTo>
                  <a:lnTo>
                    <a:pt x="1640" y="5"/>
                  </a:lnTo>
                  <a:lnTo>
                    <a:pt x="1628" y="4"/>
                  </a:lnTo>
                  <a:lnTo>
                    <a:pt x="1628" y="1"/>
                  </a:lnTo>
                  <a:close/>
                  <a:moveTo>
                    <a:pt x="1643" y="1"/>
                  </a:moveTo>
                  <a:lnTo>
                    <a:pt x="1655" y="1"/>
                  </a:lnTo>
                  <a:lnTo>
                    <a:pt x="1655" y="5"/>
                  </a:lnTo>
                  <a:lnTo>
                    <a:pt x="1643" y="5"/>
                  </a:lnTo>
                  <a:lnTo>
                    <a:pt x="1643" y="1"/>
                  </a:lnTo>
                  <a:close/>
                  <a:moveTo>
                    <a:pt x="1659" y="1"/>
                  </a:moveTo>
                  <a:lnTo>
                    <a:pt x="1670" y="1"/>
                  </a:lnTo>
                  <a:lnTo>
                    <a:pt x="1670" y="5"/>
                  </a:lnTo>
                  <a:lnTo>
                    <a:pt x="1659" y="5"/>
                  </a:lnTo>
                  <a:lnTo>
                    <a:pt x="1659" y="1"/>
                  </a:lnTo>
                  <a:close/>
                  <a:moveTo>
                    <a:pt x="1674" y="1"/>
                  </a:moveTo>
                  <a:lnTo>
                    <a:pt x="1686" y="1"/>
                  </a:lnTo>
                  <a:lnTo>
                    <a:pt x="1686" y="5"/>
                  </a:lnTo>
                  <a:lnTo>
                    <a:pt x="1674" y="5"/>
                  </a:lnTo>
                  <a:lnTo>
                    <a:pt x="1674" y="1"/>
                  </a:lnTo>
                  <a:close/>
                  <a:moveTo>
                    <a:pt x="1689" y="1"/>
                  </a:moveTo>
                  <a:lnTo>
                    <a:pt x="1701" y="1"/>
                  </a:lnTo>
                  <a:lnTo>
                    <a:pt x="1701" y="5"/>
                  </a:lnTo>
                  <a:lnTo>
                    <a:pt x="1689" y="5"/>
                  </a:lnTo>
                  <a:lnTo>
                    <a:pt x="1689" y="1"/>
                  </a:lnTo>
                  <a:close/>
                  <a:moveTo>
                    <a:pt x="1705" y="1"/>
                  </a:moveTo>
                  <a:lnTo>
                    <a:pt x="1716" y="1"/>
                  </a:lnTo>
                  <a:lnTo>
                    <a:pt x="1716" y="5"/>
                  </a:lnTo>
                  <a:lnTo>
                    <a:pt x="1705" y="5"/>
                  </a:lnTo>
                  <a:lnTo>
                    <a:pt x="1705" y="1"/>
                  </a:lnTo>
                  <a:close/>
                  <a:moveTo>
                    <a:pt x="1720" y="1"/>
                  </a:moveTo>
                  <a:lnTo>
                    <a:pt x="1732" y="1"/>
                  </a:lnTo>
                  <a:lnTo>
                    <a:pt x="1732" y="5"/>
                  </a:lnTo>
                  <a:lnTo>
                    <a:pt x="1720" y="5"/>
                  </a:lnTo>
                  <a:lnTo>
                    <a:pt x="1720" y="1"/>
                  </a:lnTo>
                  <a:close/>
                  <a:moveTo>
                    <a:pt x="1735" y="1"/>
                  </a:moveTo>
                  <a:lnTo>
                    <a:pt x="1747" y="1"/>
                  </a:lnTo>
                  <a:lnTo>
                    <a:pt x="1747" y="5"/>
                  </a:lnTo>
                  <a:lnTo>
                    <a:pt x="1735" y="5"/>
                  </a:lnTo>
                  <a:lnTo>
                    <a:pt x="1735" y="1"/>
                  </a:lnTo>
                  <a:close/>
                  <a:moveTo>
                    <a:pt x="1751" y="1"/>
                  </a:moveTo>
                  <a:lnTo>
                    <a:pt x="1762" y="1"/>
                  </a:lnTo>
                  <a:lnTo>
                    <a:pt x="1762" y="5"/>
                  </a:lnTo>
                  <a:lnTo>
                    <a:pt x="1751" y="5"/>
                  </a:lnTo>
                  <a:lnTo>
                    <a:pt x="1751" y="1"/>
                  </a:lnTo>
                  <a:close/>
                  <a:moveTo>
                    <a:pt x="1766" y="1"/>
                  </a:moveTo>
                  <a:lnTo>
                    <a:pt x="1778" y="1"/>
                  </a:lnTo>
                  <a:lnTo>
                    <a:pt x="1778" y="5"/>
                  </a:lnTo>
                  <a:lnTo>
                    <a:pt x="1766" y="5"/>
                  </a:lnTo>
                  <a:lnTo>
                    <a:pt x="1766" y="1"/>
                  </a:lnTo>
                  <a:close/>
                  <a:moveTo>
                    <a:pt x="1782" y="1"/>
                  </a:moveTo>
                  <a:lnTo>
                    <a:pt x="1793" y="1"/>
                  </a:lnTo>
                  <a:lnTo>
                    <a:pt x="1793" y="5"/>
                  </a:lnTo>
                  <a:lnTo>
                    <a:pt x="1782" y="5"/>
                  </a:lnTo>
                  <a:lnTo>
                    <a:pt x="1782" y="1"/>
                  </a:lnTo>
                  <a:close/>
                  <a:moveTo>
                    <a:pt x="1797" y="1"/>
                  </a:moveTo>
                  <a:lnTo>
                    <a:pt x="1808" y="1"/>
                  </a:lnTo>
                  <a:lnTo>
                    <a:pt x="1808" y="5"/>
                  </a:lnTo>
                  <a:lnTo>
                    <a:pt x="1797" y="5"/>
                  </a:lnTo>
                  <a:lnTo>
                    <a:pt x="1797" y="1"/>
                  </a:lnTo>
                  <a:close/>
                  <a:moveTo>
                    <a:pt x="1812" y="1"/>
                  </a:moveTo>
                  <a:lnTo>
                    <a:pt x="1824" y="1"/>
                  </a:lnTo>
                  <a:lnTo>
                    <a:pt x="1824" y="5"/>
                  </a:lnTo>
                  <a:lnTo>
                    <a:pt x="1812" y="5"/>
                  </a:lnTo>
                  <a:lnTo>
                    <a:pt x="1812" y="1"/>
                  </a:lnTo>
                  <a:close/>
                  <a:moveTo>
                    <a:pt x="1828" y="1"/>
                  </a:moveTo>
                  <a:lnTo>
                    <a:pt x="1839" y="1"/>
                  </a:lnTo>
                  <a:lnTo>
                    <a:pt x="1839" y="5"/>
                  </a:lnTo>
                  <a:lnTo>
                    <a:pt x="1828" y="5"/>
                  </a:lnTo>
                  <a:lnTo>
                    <a:pt x="1828" y="1"/>
                  </a:lnTo>
                  <a:close/>
                  <a:moveTo>
                    <a:pt x="1843" y="1"/>
                  </a:moveTo>
                  <a:lnTo>
                    <a:pt x="1855" y="1"/>
                  </a:lnTo>
                  <a:lnTo>
                    <a:pt x="1855" y="5"/>
                  </a:lnTo>
                  <a:lnTo>
                    <a:pt x="1843" y="5"/>
                  </a:lnTo>
                  <a:lnTo>
                    <a:pt x="1843" y="1"/>
                  </a:lnTo>
                  <a:close/>
                  <a:moveTo>
                    <a:pt x="1858" y="1"/>
                  </a:moveTo>
                  <a:lnTo>
                    <a:pt x="1870" y="1"/>
                  </a:lnTo>
                  <a:lnTo>
                    <a:pt x="1870" y="5"/>
                  </a:lnTo>
                  <a:lnTo>
                    <a:pt x="1858" y="5"/>
                  </a:lnTo>
                  <a:lnTo>
                    <a:pt x="1858" y="1"/>
                  </a:lnTo>
                  <a:close/>
                  <a:moveTo>
                    <a:pt x="1874" y="1"/>
                  </a:moveTo>
                  <a:lnTo>
                    <a:pt x="1885" y="1"/>
                  </a:lnTo>
                  <a:lnTo>
                    <a:pt x="1885" y="5"/>
                  </a:lnTo>
                  <a:lnTo>
                    <a:pt x="1874" y="5"/>
                  </a:lnTo>
                  <a:lnTo>
                    <a:pt x="1874" y="1"/>
                  </a:lnTo>
                  <a:close/>
                  <a:moveTo>
                    <a:pt x="1889" y="1"/>
                  </a:moveTo>
                  <a:lnTo>
                    <a:pt x="1901" y="1"/>
                  </a:lnTo>
                  <a:lnTo>
                    <a:pt x="1901" y="5"/>
                  </a:lnTo>
                  <a:lnTo>
                    <a:pt x="1889" y="5"/>
                  </a:lnTo>
                  <a:lnTo>
                    <a:pt x="1889" y="1"/>
                  </a:lnTo>
                  <a:close/>
                  <a:moveTo>
                    <a:pt x="1904" y="1"/>
                  </a:moveTo>
                  <a:lnTo>
                    <a:pt x="1916" y="1"/>
                  </a:lnTo>
                  <a:lnTo>
                    <a:pt x="1916" y="5"/>
                  </a:lnTo>
                  <a:lnTo>
                    <a:pt x="1904" y="5"/>
                  </a:lnTo>
                  <a:lnTo>
                    <a:pt x="1904" y="1"/>
                  </a:lnTo>
                  <a:close/>
                  <a:moveTo>
                    <a:pt x="1920" y="1"/>
                  </a:moveTo>
                  <a:lnTo>
                    <a:pt x="1931" y="1"/>
                  </a:lnTo>
                  <a:lnTo>
                    <a:pt x="1931" y="5"/>
                  </a:lnTo>
                  <a:lnTo>
                    <a:pt x="1920" y="5"/>
                  </a:lnTo>
                  <a:lnTo>
                    <a:pt x="1920" y="1"/>
                  </a:lnTo>
                  <a:close/>
                  <a:moveTo>
                    <a:pt x="1935" y="1"/>
                  </a:moveTo>
                  <a:lnTo>
                    <a:pt x="1947" y="1"/>
                  </a:lnTo>
                  <a:lnTo>
                    <a:pt x="1947" y="5"/>
                  </a:lnTo>
                  <a:lnTo>
                    <a:pt x="1935" y="5"/>
                  </a:lnTo>
                  <a:lnTo>
                    <a:pt x="1935" y="1"/>
                  </a:lnTo>
                  <a:close/>
                  <a:moveTo>
                    <a:pt x="1951" y="1"/>
                  </a:moveTo>
                  <a:lnTo>
                    <a:pt x="1962" y="1"/>
                  </a:lnTo>
                  <a:lnTo>
                    <a:pt x="1962" y="5"/>
                  </a:lnTo>
                  <a:lnTo>
                    <a:pt x="1951" y="5"/>
                  </a:lnTo>
                  <a:lnTo>
                    <a:pt x="1951" y="1"/>
                  </a:lnTo>
                  <a:close/>
                  <a:moveTo>
                    <a:pt x="1966" y="1"/>
                  </a:moveTo>
                  <a:lnTo>
                    <a:pt x="1977" y="1"/>
                  </a:lnTo>
                  <a:lnTo>
                    <a:pt x="1977" y="5"/>
                  </a:lnTo>
                  <a:lnTo>
                    <a:pt x="1966" y="5"/>
                  </a:lnTo>
                  <a:lnTo>
                    <a:pt x="1966" y="1"/>
                  </a:lnTo>
                  <a:close/>
                  <a:moveTo>
                    <a:pt x="1981" y="1"/>
                  </a:moveTo>
                  <a:lnTo>
                    <a:pt x="1993" y="1"/>
                  </a:lnTo>
                  <a:lnTo>
                    <a:pt x="1993" y="5"/>
                  </a:lnTo>
                  <a:lnTo>
                    <a:pt x="1981" y="5"/>
                  </a:lnTo>
                  <a:lnTo>
                    <a:pt x="1981" y="1"/>
                  </a:lnTo>
                  <a:close/>
                  <a:moveTo>
                    <a:pt x="1997" y="1"/>
                  </a:moveTo>
                  <a:lnTo>
                    <a:pt x="2008" y="1"/>
                  </a:lnTo>
                  <a:lnTo>
                    <a:pt x="2008" y="5"/>
                  </a:lnTo>
                  <a:lnTo>
                    <a:pt x="1997" y="5"/>
                  </a:lnTo>
                  <a:lnTo>
                    <a:pt x="1997" y="1"/>
                  </a:lnTo>
                  <a:close/>
                  <a:moveTo>
                    <a:pt x="2012" y="1"/>
                  </a:moveTo>
                  <a:lnTo>
                    <a:pt x="2023" y="1"/>
                  </a:lnTo>
                  <a:lnTo>
                    <a:pt x="2023" y="5"/>
                  </a:lnTo>
                  <a:lnTo>
                    <a:pt x="2012" y="5"/>
                  </a:lnTo>
                  <a:lnTo>
                    <a:pt x="2012" y="1"/>
                  </a:lnTo>
                  <a:close/>
                  <a:moveTo>
                    <a:pt x="2027" y="1"/>
                  </a:moveTo>
                  <a:lnTo>
                    <a:pt x="2039" y="1"/>
                  </a:lnTo>
                  <a:lnTo>
                    <a:pt x="2039" y="5"/>
                  </a:lnTo>
                  <a:lnTo>
                    <a:pt x="2027" y="5"/>
                  </a:lnTo>
                  <a:lnTo>
                    <a:pt x="2027" y="1"/>
                  </a:lnTo>
                  <a:close/>
                  <a:moveTo>
                    <a:pt x="2043" y="1"/>
                  </a:moveTo>
                  <a:lnTo>
                    <a:pt x="2054" y="1"/>
                  </a:lnTo>
                  <a:lnTo>
                    <a:pt x="2054" y="5"/>
                  </a:lnTo>
                  <a:lnTo>
                    <a:pt x="2043" y="5"/>
                  </a:lnTo>
                  <a:lnTo>
                    <a:pt x="2043" y="1"/>
                  </a:lnTo>
                  <a:close/>
                  <a:moveTo>
                    <a:pt x="2058" y="1"/>
                  </a:moveTo>
                  <a:lnTo>
                    <a:pt x="2070" y="1"/>
                  </a:lnTo>
                  <a:lnTo>
                    <a:pt x="2070" y="5"/>
                  </a:lnTo>
                  <a:lnTo>
                    <a:pt x="2058" y="5"/>
                  </a:lnTo>
                  <a:lnTo>
                    <a:pt x="2058" y="1"/>
                  </a:lnTo>
                  <a:close/>
                  <a:moveTo>
                    <a:pt x="2073" y="1"/>
                  </a:moveTo>
                  <a:lnTo>
                    <a:pt x="2085" y="1"/>
                  </a:lnTo>
                  <a:lnTo>
                    <a:pt x="2085" y="5"/>
                  </a:lnTo>
                  <a:lnTo>
                    <a:pt x="2073" y="5"/>
                  </a:lnTo>
                  <a:lnTo>
                    <a:pt x="2073" y="1"/>
                  </a:lnTo>
                  <a:close/>
                  <a:moveTo>
                    <a:pt x="2089" y="1"/>
                  </a:moveTo>
                  <a:lnTo>
                    <a:pt x="2100" y="1"/>
                  </a:lnTo>
                  <a:lnTo>
                    <a:pt x="2100" y="5"/>
                  </a:lnTo>
                  <a:lnTo>
                    <a:pt x="2089" y="5"/>
                  </a:lnTo>
                  <a:lnTo>
                    <a:pt x="2089" y="1"/>
                  </a:lnTo>
                  <a:close/>
                  <a:moveTo>
                    <a:pt x="2104" y="1"/>
                  </a:moveTo>
                  <a:lnTo>
                    <a:pt x="2116" y="1"/>
                  </a:lnTo>
                  <a:lnTo>
                    <a:pt x="2116" y="5"/>
                  </a:lnTo>
                  <a:lnTo>
                    <a:pt x="2104" y="5"/>
                  </a:lnTo>
                  <a:lnTo>
                    <a:pt x="2104" y="1"/>
                  </a:lnTo>
                  <a:close/>
                  <a:moveTo>
                    <a:pt x="2119" y="1"/>
                  </a:moveTo>
                  <a:lnTo>
                    <a:pt x="2131" y="1"/>
                  </a:lnTo>
                  <a:lnTo>
                    <a:pt x="2131" y="5"/>
                  </a:lnTo>
                  <a:lnTo>
                    <a:pt x="2119" y="5"/>
                  </a:lnTo>
                  <a:lnTo>
                    <a:pt x="2119" y="1"/>
                  </a:lnTo>
                  <a:close/>
                  <a:moveTo>
                    <a:pt x="2135" y="1"/>
                  </a:moveTo>
                  <a:lnTo>
                    <a:pt x="2146" y="1"/>
                  </a:lnTo>
                  <a:lnTo>
                    <a:pt x="2146" y="5"/>
                  </a:lnTo>
                  <a:lnTo>
                    <a:pt x="2135" y="5"/>
                  </a:lnTo>
                  <a:lnTo>
                    <a:pt x="2135" y="1"/>
                  </a:lnTo>
                  <a:close/>
                  <a:moveTo>
                    <a:pt x="2150" y="1"/>
                  </a:moveTo>
                  <a:lnTo>
                    <a:pt x="2162" y="1"/>
                  </a:lnTo>
                  <a:lnTo>
                    <a:pt x="2162" y="5"/>
                  </a:lnTo>
                  <a:lnTo>
                    <a:pt x="2150" y="5"/>
                  </a:lnTo>
                  <a:lnTo>
                    <a:pt x="2150" y="1"/>
                  </a:lnTo>
                  <a:close/>
                  <a:moveTo>
                    <a:pt x="2166" y="1"/>
                  </a:moveTo>
                  <a:lnTo>
                    <a:pt x="2168" y="1"/>
                  </a:lnTo>
                  <a:lnTo>
                    <a:pt x="2168" y="5"/>
                  </a:lnTo>
                  <a:lnTo>
                    <a:pt x="2166" y="5"/>
                  </a:lnTo>
                  <a:lnTo>
                    <a:pt x="2166" y="1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noProof="1"/>
            </a:p>
          </p:txBody>
        </p:sp>
        <p:sp>
          <p:nvSpPr>
            <p:cNvPr id="322" name="Rectangle 278"/>
            <p:cNvSpPr>
              <a:spLocks noChangeArrowheads="1"/>
            </p:cNvSpPr>
            <p:nvPr/>
          </p:nvSpPr>
          <p:spPr bwMode="auto">
            <a:xfrm rot="16200000">
              <a:off x="552423" y="3981423"/>
              <a:ext cx="258055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GB" sz="1000" b="1" noProof="1" smtClean="0">
                  <a:latin typeface="Times New Roman"/>
                  <a:cs typeface="Times New Roman"/>
                </a:rPr>
                <a:t>Mean of ratios [AA]</a:t>
              </a:r>
              <a:r>
                <a:rPr lang="en-GB" sz="800" b="1" baseline="-25000" noProof="1" smtClean="0">
                  <a:latin typeface="Times New Roman"/>
                  <a:cs typeface="Times New Roman"/>
                </a:rPr>
                <a:t>AVG or AVG + Glu </a:t>
              </a:r>
              <a:r>
                <a:rPr lang="en-GB" sz="1000" b="1" noProof="1" smtClean="0">
                  <a:latin typeface="Times New Roman"/>
                  <a:cs typeface="Times New Roman"/>
                </a:rPr>
                <a:t>/ [AA]</a:t>
              </a:r>
              <a:r>
                <a:rPr lang="en-GB" sz="1000" b="1" baseline="-25000" noProof="1" smtClean="0">
                  <a:latin typeface="Times New Roman"/>
                  <a:cs typeface="Times New Roman"/>
                </a:rPr>
                <a:t>K</a:t>
              </a:r>
              <a:r>
                <a:rPr lang="en-GB" sz="800" b="1" baseline="-25000" noProof="1" smtClean="0">
                  <a:latin typeface="Times New Roman"/>
                  <a:cs typeface="Times New Roman"/>
                </a:rPr>
                <a:t>NO3</a:t>
              </a:r>
              <a:r>
                <a:rPr lang="en-GB" sz="1000" b="1" baseline="-25000" noProof="1" smtClean="0">
                  <a:latin typeface="Times New Roman"/>
                  <a:cs typeface="Times New Roman"/>
                </a:rPr>
                <a:t> </a:t>
              </a:r>
              <a:endParaRPr lang="en-GB" sz="1000" b="1" noProof="1" smtClean="0">
                <a:latin typeface="Times New Roman"/>
                <a:cs typeface="Times New Roman"/>
              </a:endParaRPr>
            </a:p>
            <a:p>
              <a:pPr lvl="0" algn="ctr" defTabSz="9144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sz="800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(</a:t>
              </a:r>
              <a:r>
                <a:rPr kumimoji="0" lang="en-GB" sz="800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Symbol" charset="2"/>
                  <a:cs typeface="Symbol" charset="2"/>
                </a:rPr>
                <a:t>m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m</a:t>
              </a:r>
              <a:r>
                <a:rPr kumimoji="0" lang="en-GB" sz="800" i="0" u="none" strike="noStrike" cap="none" normalizeH="0" baseline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oles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. g</a:t>
              </a:r>
              <a:r>
                <a:rPr lang="en-GB" sz="800" baseline="300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-1 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DW</a:t>
              </a:r>
              <a:r>
                <a:rPr kumimoji="0" lang="en-GB" sz="800" i="0" u="none" strike="noStrike" cap="none" normalizeH="0" noProof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/>
                  <a:cs typeface="Times New Roman"/>
                </a:rPr>
                <a:t>/ </a:t>
              </a:r>
              <a:r>
                <a:rPr lang="en-GB" sz="800" noProof="1" smtClean="0">
                  <a:solidFill>
                    <a:srgbClr val="000000"/>
                  </a:solidFill>
                  <a:latin typeface="Symbol" charset="2"/>
                  <a:cs typeface="Symbol" charset="2"/>
                </a:rPr>
                <a:t>m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moles. g</a:t>
              </a:r>
              <a:r>
                <a:rPr lang="en-GB" sz="800" baseline="300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-1 </a:t>
              </a:r>
              <a:r>
                <a:rPr lang="en-GB" sz="800" noProof="1" smtClean="0">
                  <a:solidFill>
                    <a:srgbClr val="000000"/>
                  </a:solidFill>
                  <a:latin typeface="Times New Roman"/>
                  <a:cs typeface="Times New Roman"/>
                </a:rPr>
                <a:t>DW)</a:t>
              </a:r>
              <a:endParaRPr kumimoji="0" lang="en-GB" sz="800" i="0" u="none" strike="noStrike" cap="none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/>
                <a:cs typeface="Times New Roman"/>
              </a:endParaRPr>
            </a:p>
          </p:txBody>
        </p:sp>
      </p:grpSp>
      <p:sp>
        <p:nvSpPr>
          <p:cNvPr id="325" name="Rectangle 324"/>
          <p:cNvSpPr/>
          <p:nvPr/>
        </p:nvSpPr>
        <p:spPr>
          <a:xfrm>
            <a:off x="2288996" y="738299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27" name="Rectangle 326"/>
          <p:cNvSpPr/>
          <p:nvPr/>
        </p:nvSpPr>
        <p:spPr>
          <a:xfrm>
            <a:off x="3168878" y="1219200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28" name="Rectangle 327"/>
          <p:cNvSpPr/>
          <p:nvPr/>
        </p:nvSpPr>
        <p:spPr>
          <a:xfrm>
            <a:off x="3581400" y="1295400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29" name="Rectangle 328"/>
          <p:cNvSpPr/>
          <p:nvPr/>
        </p:nvSpPr>
        <p:spPr>
          <a:xfrm>
            <a:off x="4076712" y="1284719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0" name="Rectangle 329"/>
          <p:cNvSpPr/>
          <p:nvPr/>
        </p:nvSpPr>
        <p:spPr>
          <a:xfrm>
            <a:off x="4524537" y="1278527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1" name="Rectangle 330"/>
          <p:cNvSpPr/>
          <p:nvPr/>
        </p:nvSpPr>
        <p:spPr>
          <a:xfrm>
            <a:off x="2693829" y="1125093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2" name="Rectangle 331"/>
          <p:cNvSpPr/>
          <p:nvPr/>
        </p:nvSpPr>
        <p:spPr>
          <a:xfrm>
            <a:off x="2396349" y="1215317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3" name="Rectangle 332"/>
          <p:cNvSpPr/>
          <p:nvPr/>
        </p:nvSpPr>
        <p:spPr>
          <a:xfrm>
            <a:off x="2823515" y="1192182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4" name="Rectangle 333"/>
          <p:cNvSpPr/>
          <p:nvPr/>
        </p:nvSpPr>
        <p:spPr>
          <a:xfrm>
            <a:off x="4653140" y="1377257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5" name="Rectangle 334"/>
          <p:cNvSpPr/>
          <p:nvPr/>
        </p:nvSpPr>
        <p:spPr>
          <a:xfrm>
            <a:off x="2249036" y="3340767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6" name="Rectangle 335"/>
          <p:cNvSpPr/>
          <p:nvPr/>
        </p:nvSpPr>
        <p:spPr>
          <a:xfrm>
            <a:off x="3586118" y="4050268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7" name="Rectangle 336"/>
          <p:cNvSpPr/>
          <p:nvPr/>
        </p:nvSpPr>
        <p:spPr>
          <a:xfrm>
            <a:off x="4500518" y="4355068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8" name="Rectangle 337"/>
          <p:cNvSpPr/>
          <p:nvPr/>
        </p:nvSpPr>
        <p:spPr>
          <a:xfrm>
            <a:off x="2401436" y="3124200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39" name="Rectangle 338"/>
          <p:cNvSpPr/>
          <p:nvPr/>
        </p:nvSpPr>
        <p:spPr>
          <a:xfrm>
            <a:off x="3281318" y="3810000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  <p:sp>
        <p:nvSpPr>
          <p:cNvPr id="340" name="Rectangle 339"/>
          <p:cNvSpPr/>
          <p:nvPr/>
        </p:nvSpPr>
        <p:spPr>
          <a:xfrm>
            <a:off x="2819400" y="3745468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noProof="1" smtClean="0">
                <a:latin typeface="Times New Roman"/>
                <a:cs typeface="Times New Roman"/>
              </a:rPr>
              <a:t>*</a:t>
            </a:r>
            <a:endParaRPr lang="en-GB" b="1" noProof="1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01</Words>
  <Application>Microsoft Macintosh PowerPoint</Application>
  <PresentationFormat>Présentation à l'écran (4:3)</PresentationFormat>
  <Paragraphs>5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Calibri</vt:lpstr>
      <vt:lpstr>Symbol</vt:lpstr>
      <vt:lpstr>Times New Roman</vt:lpstr>
      <vt:lpstr>Arial</vt:lpstr>
      <vt:lpstr>Thème Office</vt:lpstr>
      <vt:lpstr>Présentation PowerPoint</vt:lpstr>
    </vt:vector>
  </TitlesOfParts>
  <Company>Universite de Caen</Company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Erwan Le Deunff</dc:creator>
  <cp:lastModifiedBy>Utilisateur de Microsoft Office</cp:lastModifiedBy>
  <cp:revision>4</cp:revision>
  <dcterms:created xsi:type="dcterms:W3CDTF">2019-09-27T17:36:53Z</dcterms:created>
  <dcterms:modified xsi:type="dcterms:W3CDTF">2019-10-21T19:13:45Z</dcterms:modified>
</cp:coreProperties>
</file>